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324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27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485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13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518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821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463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860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354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056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206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C4438B-5DE7-4E04-B38D-C81A122A0833}" type="datetimeFigureOut">
              <a:rPr lang="en-US" smtClean="0"/>
              <a:t>10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DF54C5-89CB-4832-B1C3-27182FC43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131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Rectangle 264">
            <a:extLst>
              <a:ext uri="{FF2B5EF4-FFF2-40B4-BE49-F238E27FC236}">
                <a16:creationId xmlns:a16="http://schemas.microsoft.com/office/drawing/2014/main" id="{D1D2E498-2D51-4468-C7F1-ECA5AA3FBA53}"/>
              </a:ext>
            </a:extLst>
          </p:cNvPr>
          <p:cNvSpPr/>
          <p:nvPr/>
        </p:nvSpPr>
        <p:spPr>
          <a:xfrm>
            <a:off x="186262" y="2194688"/>
            <a:ext cx="5641600" cy="2064900"/>
          </a:xfrm>
          <a:prstGeom prst="rect">
            <a:avLst/>
          </a:prstGeom>
          <a:solidFill>
            <a:srgbClr val="FFEBEB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00880CC9-BB42-C707-B3C3-4723305E7401}"/>
              </a:ext>
            </a:extLst>
          </p:cNvPr>
          <p:cNvSpPr/>
          <p:nvPr/>
        </p:nvSpPr>
        <p:spPr>
          <a:xfrm>
            <a:off x="175680" y="7538024"/>
            <a:ext cx="5643105" cy="1352362"/>
          </a:xfrm>
          <a:prstGeom prst="rect">
            <a:avLst/>
          </a:prstGeom>
          <a:solidFill>
            <a:schemeClr val="bg1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7" name="Rectangle 266">
            <a:extLst>
              <a:ext uri="{FF2B5EF4-FFF2-40B4-BE49-F238E27FC236}">
                <a16:creationId xmlns:a16="http://schemas.microsoft.com/office/drawing/2014/main" id="{0F986C3C-68DC-E971-218F-DC84E6B97D8F}"/>
              </a:ext>
            </a:extLst>
          </p:cNvPr>
          <p:cNvSpPr/>
          <p:nvPr/>
        </p:nvSpPr>
        <p:spPr>
          <a:xfrm>
            <a:off x="425308" y="7613196"/>
            <a:ext cx="1260000" cy="1198293"/>
          </a:xfrm>
          <a:prstGeom prst="rect">
            <a:avLst/>
          </a:prstGeom>
          <a:solidFill>
            <a:schemeClr val="bg1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8" name="Rectangle 267">
            <a:extLst>
              <a:ext uri="{FF2B5EF4-FFF2-40B4-BE49-F238E27FC236}">
                <a16:creationId xmlns:a16="http://schemas.microsoft.com/office/drawing/2014/main" id="{61DAC744-D96E-2D93-0358-3CFE1C77236C}"/>
              </a:ext>
            </a:extLst>
          </p:cNvPr>
          <p:cNvSpPr/>
          <p:nvPr/>
        </p:nvSpPr>
        <p:spPr>
          <a:xfrm>
            <a:off x="1746536" y="7613196"/>
            <a:ext cx="1260000" cy="119829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9" name="Rectangle 268">
            <a:extLst>
              <a:ext uri="{FF2B5EF4-FFF2-40B4-BE49-F238E27FC236}">
                <a16:creationId xmlns:a16="http://schemas.microsoft.com/office/drawing/2014/main" id="{D4B7B03E-7345-E118-8042-DE37503F95D1}"/>
              </a:ext>
            </a:extLst>
          </p:cNvPr>
          <p:cNvSpPr/>
          <p:nvPr/>
        </p:nvSpPr>
        <p:spPr>
          <a:xfrm>
            <a:off x="3089950" y="7612685"/>
            <a:ext cx="1260000" cy="119829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0" name="Rectangle 269">
            <a:extLst>
              <a:ext uri="{FF2B5EF4-FFF2-40B4-BE49-F238E27FC236}">
                <a16:creationId xmlns:a16="http://schemas.microsoft.com/office/drawing/2014/main" id="{42D9C429-7E7D-6FB9-2888-5CE208D0BBD2}"/>
              </a:ext>
            </a:extLst>
          </p:cNvPr>
          <p:cNvSpPr/>
          <p:nvPr/>
        </p:nvSpPr>
        <p:spPr>
          <a:xfrm>
            <a:off x="4427155" y="7612685"/>
            <a:ext cx="1260000" cy="1198293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1" name="Rectangle 270">
            <a:extLst>
              <a:ext uri="{FF2B5EF4-FFF2-40B4-BE49-F238E27FC236}">
                <a16:creationId xmlns:a16="http://schemas.microsoft.com/office/drawing/2014/main" id="{25AB04FB-7FF2-F3A3-300D-C71EECC5B22A}"/>
              </a:ext>
            </a:extLst>
          </p:cNvPr>
          <p:cNvSpPr/>
          <p:nvPr/>
        </p:nvSpPr>
        <p:spPr>
          <a:xfrm>
            <a:off x="182409" y="4272771"/>
            <a:ext cx="5643104" cy="3177329"/>
          </a:xfrm>
          <a:prstGeom prst="rect">
            <a:avLst/>
          </a:prstGeom>
          <a:solidFill>
            <a:srgbClr val="FFF8E5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72" name="Rectangle 271">
            <a:extLst>
              <a:ext uri="{FF2B5EF4-FFF2-40B4-BE49-F238E27FC236}">
                <a16:creationId xmlns:a16="http://schemas.microsoft.com/office/drawing/2014/main" id="{7DB0D99D-15AC-F5BF-48B4-B0D702EC7BF6}"/>
              </a:ext>
            </a:extLst>
          </p:cNvPr>
          <p:cNvSpPr/>
          <p:nvPr/>
        </p:nvSpPr>
        <p:spPr>
          <a:xfrm>
            <a:off x="183083" y="259079"/>
            <a:ext cx="5642430" cy="1927989"/>
          </a:xfrm>
          <a:prstGeom prst="rect">
            <a:avLst/>
          </a:prstGeom>
          <a:solidFill>
            <a:srgbClr val="FFEBEB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73" name="Rectangle 272">
            <a:extLst>
              <a:ext uri="{FF2B5EF4-FFF2-40B4-BE49-F238E27FC236}">
                <a16:creationId xmlns:a16="http://schemas.microsoft.com/office/drawing/2014/main" id="{440E628E-D854-6F85-3628-22BC7CF39BFA}"/>
              </a:ext>
            </a:extLst>
          </p:cNvPr>
          <p:cNvSpPr/>
          <p:nvPr/>
        </p:nvSpPr>
        <p:spPr>
          <a:xfrm>
            <a:off x="828000" y="378634"/>
            <a:ext cx="4320000" cy="22572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BD-associated SNPs</a:t>
            </a:r>
          </a:p>
        </p:txBody>
      </p:sp>
      <p:sp>
        <p:nvSpPr>
          <p:cNvPr id="274" name="Rectangle 273">
            <a:extLst>
              <a:ext uri="{FF2B5EF4-FFF2-40B4-BE49-F238E27FC236}">
                <a16:creationId xmlns:a16="http://schemas.microsoft.com/office/drawing/2014/main" id="{7137537F-1443-544A-7F3C-1B0338C9CB44}"/>
              </a:ext>
            </a:extLst>
          </p:cNvPr>
          <p:cNvSpPr/>
          <p:nvPr/>
        </p:nvSpPr>
        <p:spPr>
          <a:xfrm>
            <a:off x="831689" y="876529"/>
            <a:ext cx="4320000" cy="31681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uven IBD Biobank </a:t>
            </a:r>
            <a:r>
              <a:rPr lang="en-GB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chip</a:t>
            </a:r>
            <a:r>
              <a:rPr lang="en-GB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</a:t>
            </a:r>
          </a:p>
          <a:p>
            <a:pPr algn="ctr"/>
            <a:r>
              <a:rPr lang="en-GB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,636 patients (1,695 Crohn’s disease, 941 ulcerative colitis)</a:t>
            </a:r>
          </a:p>
        </p:txBody>
      </p:sp>
      <p:sp>
        <p:nvSpPr>
          <p:cNvPr id="275" name="Oval 274">
            <a:extLst>
              <a:ext uri="{FF2B5EF4-FFF2-40B4-BE49-F238E27FC236}">
                <a16:creationId xmlns:a16="http://schemas.microsoft.com/office/drawing/2014/main" id="{4B75CDE5-DF8E-C958-5D55-4A5871A6CFD8}"/>
              </a:ext>
            </a:extLst>
          </p:cNvPr>
          <p:cNvSpPr/>
          <p:nvPr/>
        </p:nvSpPr>
        <p:spPr>
          <a:xfrm>
            <a:off x="2982659" y="3742261"/>
            <a:ext cx="144000" cy="144000"/>
          </a:xfrm>
          <a:prstGeom prst="ellipse">
            <a:avLst/>
          </a:prstGeom>
          <a:solidFill>
            <a:srgbClr val="CC66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6" name="Group 275">
            <a:extLst>
              <a:ext uri="{FF2B5EF4-FFF2-40B4-BE49-F238E27FC236}">
                <a16:creationId xmlns:a16="http://schemas.microsoft.com/office/drawing/2014/main" id="{D4A0B804-2994-3038-09D3-782BB2A0887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73120" y="2629902"/>
            <a:ext cx="720000" cy="141906"/>
            <a:chOff x="1088" y="1817"/>
            <a:chExt cx="3477" cy="685"/>
          </a:xfrm>
        </p:grpSpPr>
        <p:sp>
          <p:nvSpPr>
            <p:cNvPr id="277" name="Freeform 4">
              <a:extLst>
                <a:ext uri="{FF2B5EF4-FFF2-40B4-BE49-F238E27FC236}">
                  <a16:creationId xmlns:a16="http://schemas.microsoft.com/office/drawing/2014/main" id="{F05F105C-A33D-408C-61AA-04F9001973A0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088" y="1817"/>
              <a:ext cx="739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8 w 313"/>
                <a:gd name="T5" fmla="*/ 32 h 290"/>
                <a:gd name="T6" fmla="*/ 77 w 313"/>
                <a:gd name="T7" fmla="*/ 65 h 290"/>
                <a:gd name="T8" fmla="*/ 25 w 313"/>
                <a:gd name="T9" fmla="*/ 164 h 290"/>
                <a:gd name="T10" fmla="*/ 8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1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0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1 w 313"/>
                <a:gd name="T33" fmla="*/ 230 h 290"/>
                <a:gd name="T34" fmla="*/ 288 w 313"/>
                <a:gd name="T35" fmla="*/ 218 h 290"/>
                <a:gd name="T36" fmla="*/ 288 w 313"/>
                <a:gd name="T37" fmla="*/ 218 h 290"/>
                <a:gd name="T38" fmla="*/ 305 w 313"/>
                <a:gd name="T39" fmla="*/ 214 h 290"/>
                <a:gd name="T40" fmla="*/ 309 w 313"/>
                <a:gd name="T41" fmla="*/ 231 h 290"/>
                <a:gd name="T42" fmla="*/ 302 w 313"/>
                <a:gd name="T43" fmla="*/ 244 h 290"/>
                <a:gd name="T44" fmla="*/ 302 w 313"/>
                <a:gd name="T45" fmla="*/ 243 h 290"/>
                <a:gd name="T46" fmla="*/ 302 w 313"/>
                <a:gd name="T47" fmla="*/ 244 h 290"/>
                <a:gd name="T48" fmla="*/ 302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294 w 313"/>
                <a:gd name="T55" fmla="*/ 258 h 290"/>
                <a:gd name="T56" fmla="*/ 258 w 313"/>
                <a:gd name="T57" fmla="*/ 290 h 290"/>
                <a:gd name="T58" fmla="*/ 302 w 313"/>
                <a:gd name="T59" fmla="*/ 244 h 290"/>
                <a:gd name="T60" fmla="*/ 302 w 313"/>
                <a:gd name="T61" fmla="*/ 244 h 290"/>
                <a:gd name="T62" fmla="*/ 302 w 313"/>
                <a:gd name="T63" fmla="*/ 244 h 290"/>
                <a:gd name="T64" fmla="*/ 303 w 313"/>
                <a:gd name="T65" fmla="*/ 241 h 290"/>
                <a:gd name="T66" fmla="*/ 303 w 313"/>
                <a:gd name="T67" fmla="*/ 238 h 290"/>
                <a:gd name="T68" fmla="*/ 291 w 313"/>
                <a:gd name="T69" fmla="*/ 225 h 290"/>
                <a:gd name="T70" fmla="*/ 291 w 313"/>
                <a:gd name="T71" fmla="*/ 225 h 290"/>
                <a:gd name="T72" fmla="*/ 302 w 313"/>
                <a:gd name="T73" fmla="*/ 244 h 290"/>
                <a:gd name="T74" fmla="*/ 302 w 313"/>
                <a:gd name="T75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313" h="290">
                  <a:moveTo>
                    <a:pt x="225" y="261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2" y="26"/>
                    <a:pt x="108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4" y="26"/>
                    <a:pt x="98" y="32"/>
                  </a:cubicBezTo>
                  <a:cubicBezTo>
                    <a:pt x="98" y="32"/>
                    <a:pt x="98" y="32"/>
                    <a:pt x="98" y="32"/>
                  </a:cubicBezTo>
                  <a:cubicBezTo>
                    <a:pt x="93" y="39"/>
                    <a:pt x="85" y="50"/>
                    <a:pt x="77" y="65"/>
                  </a:cubicBezTo>
                  <a:cubicBezTo>
                    <a:pt x="77" y="65"/>
                    <a:pt x="77" y="65"/>
                    <a:pt x="77" y="65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2" y="170"/>
                    <a:pt x="14" y="173"/>
                    <a:pt x="8" y="170"/>
                  </a:cubicBezTo>
                  <a:cubicBezTo>
                    <a:pt x="8" y="170"/>
                    <a:pt x="8" y="170"/>
                    <a:pt x="8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4" y="0"/>
                    <a:pt x="134" y="13"/>
                    <a:pt x="141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55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8" y="264"/>
                    <a:pt x="259" y="263"/>
                    <a:pt x="260" y="262"/>
                  </a:cubicBezTo>
                  <a:cubicBezTo>
                    <a:pt x="260" y="262"/>
                    <a:pt x="260" y="262"/>
                    <a:pt x="260" y="262"/>
                  </a:cubicBezTo>
                  <a:cubicBezTo>
                    <a:pt x="263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0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09" y="231"/>
                  </a:cubicBezTo>
                  <a:cubicBezTo>
                    <a:pt x="309" y="231"/>
                    <a:pt x="309" y="231"/>
                    <a:pt x="309" y="231"/>
                  </a:cubicBezTo>
                  <a:cubicBezTo>
                    <a:pt x="304" y="240"/>
                    <a:pt x="303" y="243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5"/>
                    <a:pt x="301" y="246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3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1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  <a:moveTo>
                    <a:pt x="303" y="241"/>
                  </a:moveTo>
                  <a:cubicBezTo>
                    <a:pt x="303" y="240"/>
                    <a:pt x="304" y="240"/>
                    <a:pt x="303" y="238"/>
                  </a:cubicBezTo>
                  <a:cubicBezTo>
                    <a:pt x="303" y="238"/>
                    <a:pt x="303" y="238"/>
                    <a:pt x="303" y="238"/>
                  </a:cubicBezTo>
                  <a:cubicBezTo>
                    <a:pt x="303" y="239"/>
                    <a:pt x="303" y="240"/>
                    <a:pt x="303" y="241"/>
                  </a:cubicBezTo>
                  <a:close/>
                  <a:moveTo>
                    <a:pt x="291" y="225"/>
                  </a:moveTo>
                  <a:cubicBezTo>
                    <a:pt x="291" y="225"/>
                    <a:pt x="291" y="225"/>
                    <a:pt x="291" y="225"/>
                  </a:cubicBezTo>
                  <a:cubicBezTo>
                    <a:pt x="291" y="225"/>
                    <a:pt x="291" y="225"/>
                    <a:pt x="291" y="225"/>
                  </a:cubicBezTo>
                  <a:cubicBezTo>
                    <a:pt x="291" y="225"/>
                    <a:pt x="291" y="225"/>
                    <a:pt x="291" y="225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78" name="Freeform 5">
              <a:extLst>
                <a:ext uri="{FF2B5EF4-FFF2-40B4-BE49-F238E27FC236}">
                  <a16:creationId xmlns:a16="http://schemas.microsoft.com/office/drawing/2014/main" id="{3D14301E-BF77-1744-594B-FE745B1D7755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494" y="1817"/>
              <a:ext cx="742" cy="685"/>
            </a:xfrm>
            <a:custGeom>
              <a:avLst/>
              <a:gdLst>
                <a:gd name="T0" fmla="*/ 66 w 314"/>
                <a:gd name="T1" fmla="*/ 41 h 290"/>
                <a:gd name="T2" fmla="*/ 55 w 314"/>
                <a:gd name="T3" fmla="*/ 26 h 290"/>
                <a:gd name="T4" fmla="*/ 53 w 314"/>
                <a:gd name="T5" fmla="*/ 28 h 290"/>
                <a:gd name="T6" fmla="*/ 41 w 314"/>
                <a:gd name="T7" fmla="*/ 45 h 290"/>
                <a:gd name="T8" fmla="*/ 34 w 314"/>
                <a:gd name="T9" fmla="*/ 58 h 290"/>
                <a:gd name="T10" fmla="*/ 34 w 314"/>
                <a:gd name="T11" fmla="*/ 58 h 290"/>
                <a:gd name="T12" fmla="*/ 34 w 314"/>
                <a:gd name="T13" fmla="*/ 58 h 290"/>
                <a:gd name="T14" fmla="*/ 34 w 314"/>
                <a:gd name="T15" fmla="*/ 58 h 290"/>
                <a:gd name="T16" fmla="*/ 33 w 314"/>
                <a:gd name="T17" fmla="*/ 59 h 290"/>
                <a:gd name="T18" fmla="*/ 33 w 314"/>
                <a:gd name="T19" fmla="*/ 60 h 290"/>
                <a:gd name="T20" fmla="*/ 26 w 314"/>
                <a:gd name="T21" fmla="*/ 72 h 290"/>
                <a:gd name="T22" fmla="*/ 26 w 314"/>
                <a:gd name="T23" fmla="*/ 72 h 290"/>
                <a:gd name="T24" fmla="*/ 9 w 314"/>
                <a:gd name="T25" fmla="*/ 77 h 290"/>
                <a:gd name="T26" fmla="*/ 4 w 314"/>
                <a:gd name="T27" fmla="*/ 59 h 290"/>
                <a:gd name="T28" fmla="*/ 11 w 314"/>
                <a:gd name="T29" fmla="*/ 46 h 290"/>
                <a:gd name="T30" fmla="*/ 11 w 314"/>
                <a:gd name="T31" fmla="*/ 46 h 290"/>
                <a:gd name="T32" fmla="*/ 12 w 314"/>
                <a:gd name="T33" fmla="*/ 46 h 290"/>
                <a:gd name="T34" fmla="*/ 19 w 314"/>
                <a:gd name="T35" fmla="*/ 33 h 290"/>
                <a:gd name="T36" fmla="*/ 56 w 314"/>
                <a:gd name="T37" fmla="*/ 0 h 290"/>
                <a:gd name="T38" fmla="*/ 88 w 314"/>
                <a:gd name="T39" fmla="*/ 30 h 290"/>
                <a:gd name="T40" fmla="*/ 195 w 314"/>
                <a:gd name="T41" fmla="*/ 252 h 290"/>
                <a:gd name="T42" fmla="*/ 202 w 314"/>
                <a:gd name="T43" fmla="*/ 263 h 290"/>
                <a:gd name="T44" fmla="*/ 205 w 314"/>
                <a:gd name="T45" fmla="*/ 265 h 290"/>
                <a:gd name="T46" fmla="*/ 215 w 314"/>
                <a:gd name="T47" fmla="*/ 258 h 290"/>
                <a:gd name="T48" fmla="*/ 236 w 314"/>
                <a:gd name="T49" fmla="*/ 225 h 290"/>
                <a:gd name="T50" fmla="*/ 288 w 314"/>
                <a:gd name="T51" fmla="*/ 126 h 290"/>
                <a:gd name="T52" fmla="*/ 305 w 314"/>
                <a:gd name="T53" fmla="*/ 121 h 290"/>
                <a:gd name="T54" fmla="*/ 310 w 314"/>
                <a:gd name="T55" fmla="*/ 138 h 290"/>
                <a:gd name="T56" fmla="*/ 258 w 314"/>
                <a:gd name="T57" fmla="*/ 237 h 290"/>
                <a:gd name="T58" fmla="*/ 205 w 314"/>
                <a:gd name="T59" fmla="*/ 290 h 290"/>
                <a:gd name="T60" fmla="*/ 172 w 314"/>
                <a:gd name="T61" fmla="*/ 264 h 290"/>
                <a:gd name="T62" fmla="*/ 10 w 314"/>
                <a:gd name="T63" fmla="*/ 51 h 290"/>
                <a:gd name="T64" fmla="*/ 10 w 314"/>
                <a:gd name="T65" fmla="*/ 50 h 290"/>
                <a:gd name="T66" fmla="*/ 11 w 314"/>
                <a:gd name="T67" fmla="*/ 48 h 290"/>
                <a:gd name="T68" fmla="*/ 10 w 314"/>
                <a:gd name="T69" fmla="*/ 49 h 290"/>
                <a:gd name="T70" fmla="*/ 10 w 314"/>
                <a:gd name="T71" fmla="*/ 49 h 290"/>
                <a:gd name="T72" fmla="*/ 11 w 314"/>
                <a:gd name="T73" fmla="*/ 48 h 290"/>
                <a:gd name="T74" fmla="*/ 11 w 314"/>
                <a:gd name="T75" fmla="*/ 46 h 290"/>
                <a:gd name="T76" fmla="*/ 11 w 314"/>
                <a:gd name="T77" fmla="*/ 46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314" h="290">
                  <a:moveTo>
                    <a:pt x="172" y="264"/>
                  </a:moveTo>
                  <a:cubicBezTo>
                    <a:pt x="158" y="237"/>
                    <a:pt x="83" y="77"/>
                    <a:pt x="66" y="41"/>
                  </a:cubicBezTo>
                  <a:cubicBezTo>
                    <a:pt x="66" y="41"/>
                    <a:pt x="66" y="41"/>
                    <a:pt x="66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6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4"/>
                    <a:pt x="34" y="57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60"/>
                  </a:cubicBezTo>
                  <a:cubicBezTo>
                    <a:pt x="33" y="60"/>
                    <a:pt x="33" y="60"/>
                    <a:pt x="33" y="60"/>
                  </a:cubicBezTo>
                  <a:cubicBezTo>
                    <a:pt x="32" y="62"/>
                    <a:pt x="30" y="65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2" y="78"/>
                    <a:pt x="15" y="80"/>
                    <a:pt x="9" y="77"/>
                  </a:cubicBezTo>
                  <a:cubicBezTo>
                    <a:pt x="9" y="77"/>
                    <a:pt x="9" y="77"/>
                    <a:pt x="9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11" y="48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2" y="46"/>
                    <a:pt x="12" y="46"/>
                  </a:cubicBezTo>
                  <a:cubicBezTo>
                    <a:pt x="12" y="46"/>
                    <a:pt x="12" y="46"/>
                    <a:pt x="12" y="46"/>
                  </a:cubicBezTo>
                  <a:cubicBezTo>
                    <a:pt x="12" y="46"/>
                    <a:pt x="12" y="46"/>
                    <a:pt x="12" y="46"/>
                  </a:cubicBezTo>
                  <a:cubicBezTo>
                    <a:pt x="12" y="46"/>
                    <a:pt x="12" y="46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6" y="0"/>
                  </a:cubicBezTo>
                  <a:cubicBezTo>
                    <a:pt x="56" y="0"/>
                    <a:pt x="56" y="0"/>
                    <a:pt x="56" y="0"/>
                  </a:cubicBezTo>
                  <a:cubicBezTo>
                    <a:pt x="72" y="1"/>
                    <a:pt x="80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5" y="252"/>
                  </a:cubicBezTo>
                  <a:cubicBezTo>
                    <a:pt x="195" y="252"/>
                    <a:pt x="195" y="252"/>
                    <a:pt x="195" y="252"/>
                  </a:cubicBezTo>
                  <a:cubicBezTo>
                    <a:pt x="198" y="258"/>
                    <a:pt x="200" y="262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1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4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80" y="278"/>
                    <a:pt x="172" y="264"/>
                  </a:cubicBezTo>
                  <a:close/>
                  <a:moveTo>
                    <a:pt x="10" y="51"/>
                  </a:moveTo>
                  <a:cubicBezTo>
                    <a:pt x="10" y="51"/>
                    <a:pt x="10" y="51"/>
                    <a:pt x="10" y="51"/>
                  </a:cubicBezTo>
                  <a:cubicBezTo>
                    <a:pt x="10" y="50"/>
                    <a:pt x="10" y="50"/>
                    <a:pt x="10" y="50"/>
                  </a:cubicBezTo>
                  <a:cubicBezTo>
                    <a:pt x="10" y="50"/>
                    <a:pt x="10" y="50"/>
                    <a:pt x="10" y="50"/>
                  </a:cubicBezTo>
                  <a:cubicBezTo>
                    <a:pt x="10" y="50"/>
                    <a:pt x="10" y="50"/>
                    <a:pt x="10" y="51"/>
                  </a:cubicBezTo>
                  <a:close/>
                  <a:moveTo>
                    <a:pt x="11" y="48"/>
                  </a:moveTo>
                  <a:cubicBezTo>
                    <a:pt x="10" y="48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lose/>
                  <a:moveTo>
                    <a:pt x="11" y="46"/>
                  </a:move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79" name="Freeform 6">
              <a:extLst>
                <a:ext uri="{FF2B5EF4-FFF2-40B4-BE49-F238E27FC236}">
                  <a16:creationId xmlns:a16="http://schemas.microsoft.com/office/drawing/2014/main" id="{51CFAC46-4DDD-E814-A7C6-55EF27624637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863" y="1817"/>
              <a:ext cx="741" cy="685"/>
            </a:xfrm>
            <a:custGeom>
              <a:avLst/>
              <a:gdLst>
                <a:gd name="T0" fmla="*/ 119 w 314"/>
                <a:gd name="T1" fmla="*/ 38 h 290"/>
                <a:gd name="T2" fmla="*/ 109 w 314"/>
                <a:gd name="T3" fmla="*/ 25 h 290"/>
                <a:gd name="T4" fmla="*/ 99 w 314"/>
                <a:gd name="T5" fmla="*/ 32 h 290"/>
                <a:gd name="T6" fmla="*/ 78 w 314"/>
                <a:gd name="T7" fmla="*/ 65 h 290"/>
                <a:gd name="T8" fmla="*/ 26 w 314"/>
                <a:gd name="T9" fmla="*/ 164 h 290"/>
                <a:gd name="T10" fmla="*/ 9 w 314"/>
                <a:gd name="T11" fmla="*/ 170 h 290"/>
                <a:gd name="T12" fmla="*/ 4 w 314"/>
                <a:gd name="T13" fmla="*/ 152 h 290"/>
                <a:gd name="T14" fmla="*/ 56 w 314"/>
                <a:gd name="T15" fmla="*/ 53 h 290"/>
                <a:gd name="T16" fmla="*/ 109 w 314"/>
                <a:gd name="T17" fmla="*/ 0 h 290"/>
                <a:gd name="T18" fmla="*/ 142 w 314"/>
                <a:gd name="T19" fmla="*/ 27 h 290"/>
                <a:gd name="T20" fmla="*/ 248 w 314"/>
                <a:gd name="T21" fmla="*/ 249 h 290"/>
                <a:gd name="T22" fmla="*/ 258 w 314"/>
                <a:gd name="T23" fmla="*/ 265 h 290"/>
                <a:gd name="T24" fmla="*/ 261 w 314"/>
                <a:gd name="T25" fmla="*/ 262 h 290"/>
                <a:gd name="T26" fmla="*/ 273 w 314"/>
                <a:gd name="T27" fmla="*/ 245 h 290"/>
                <a:gd name="T28" fmla="*/ 280 w 314"/>
                <a:gd name="T29" fmla="*/ 232 h 290"/>
                <a:gd name="T30" fmla="*/ 280 w 314"/>
                <a:gd name="T31" fmla="*/ 232 h 290"/>
                <a:gd name="T32" fmla="*/ 280 w 314"/>
                <a:gd name="T33" fmla="*/ 232 h 290"/>
                <a:gd name="T34" fmla="*/ 281 w 314"/>
                <a:gd name="T35" fmla="*/ 232 h 290"/>
                <a:gd name="T36" fmla="*/ 281 w 314"/>
                <a:gd name="T37" fmla="*/ 230 h 290"/>
                <a:gd name="T38" fmla="*/ 288 w 314"/>
                <a:gd name="T39" fmla="*/ 218 h 290"/>
                <a:gd name="T40" fmla="*/ 306 w 314"/>
                <a:gd name="T41" fmla="*/ 214 h 290"/>
                <a:gd name="T42" fmla="*/ 310 w 314"/>
                <a:gd name="T43" fmla="*/ 231 h 290"/>
                <a:gd name="T44" fmla="*/ 303 w 314"/>
                <a:gd name="T45" fmla="*/ 244 h 290"/>
                <a:gd name="T46" fmla="*/ 303 w 314"/>
                <a:gd name="T47" fmla="*/ 243 h 290"/>
                <a:gd name="T48" fmla="*/ 303 w 314"/>
                <a:gd name="T49" fmla="*/ 244 h 290"/>
                <a:gd name="T50" fmla="*/ 303 w 314"/>
                <a:gd name="T51" fmla="*/ 244 h 290"/>
                <a:gd name="T52" fmla="*/ 302 w 314"/>
                <a:gd name="T53" fmla="*/ 244 h 290"/>
                <a:gd name="T54" fmla="*/ 295 w 314"/>
                <a:gd name="T55" fmla="*/ 258 h 290"/>
                <a:gd name="T56" fmla="*/ 258 w 314"/>
                <a:gd name="T57" fmla="*/ 290 h 290"/>
                <a:gd name="T58" fmla="*/ 226 w 314"/>
                <a:gd name="T59" fmla="*/ 260 h 290"/>
                <a:gd name="T60" fmla="*/ 304 w 314"/>
                <a:gd name="T61" fmla="*/ 242 h 290"/>
                <a:gd name="T62" fmla="*/ 303 w 314"/>
                <a:gd name="T63" fmla="*/ 242 h 290"/>
                <a:gd name="T64" fmla="*/ 303 w 314"/>
                <a:gd name="T65" fmla="*/ 242 h 290"/>
                <a:gd name="T66" fmla="*/ 304 w 314"/>
                <a:gd name="T67" fmla="*/ 237 h 290"/>
                <a:gd name="T68" fmla="*/ 304 w 314"/>
                <a:gd name="T69" fmla="*/ 237 h 290"/>
                <a:gd name="T70" fmla="*/ 304 w 314"/>
                <a:gd name="T71" fmla="*/ 238 h 290"/>
                <a:gd name="T72" fmla="*/ 304 w 314"/>
                <a:gd name="T73" fmla="*/ 238 h 290"/>
                <a:gd name="T74" fmla="*/ 304 w 314"/>
                <a:gd name="T75" fmla="*/ 238 h 290"/>
                <a:gd name="T76" fmla="*/ 304 w 314"/>
                <a:gd name="T77" fmla="*/ 239 h 290"/>
                <a:gd name="T78" fmla="*/ 304 w 314"/>
                <a:gd name="T79" fmla="*/ 239 h 290"/>
                <a:gd name="T80" fmla="*/ 304 w 314"/>
                <a:gd name="T81" fmla="*/ 239 h 290"/>
                <a:gd name="T82" fmla="*/ 304 w 314"/>
                <a:gd name="T83" fmla="*/ 241 h 290"/>
                <a:gd name="T84" fmla="*/ 292 w 314"/>
                <a:gd name="T85" fmla="*/ 225 h 290"/>
                <a:gd name="T86" fmla="*/ 292 w 314"/>
                <a:gd name="T87" fmla="*/ 225 h 290"/>
                <a:gd name="T88" fmla="*/ 303 w 314"/>
                <a:gd name="T89" fmla="*/ 244 h 290"/>
                <a:gd name="T90" fmla="*/ 303 w 314"/>
                <a:gd name="T91" fmla="*/ 244 h 290"/>
                <a:gd name="T92" fmla="*/ 303 w 314"/>
                <a:gd name="T93" fmla="*/ 244 h 290"/>
                <a:gd name="T94" fmla="*/ 303 w 314"/>
                <a:gd name="T95" fmla="*/ 244 h 290"/>
                <a:gd name="T96" fmla="*/ 303 w 314"/>
                <a:gd name="T97" fmla="*/ 244 h 290"/>
                <a:gd name="T98" fmla="*/ 303 w 314"/>
                <a:gd name="T99" fmla="*/ 244 h 290"/>
                <a:gd name="T100" fmla="*/ 303 w 314"/>
                <a:gd name="T101" fmla="*/ 244 h 290"/>
                <a:gd name="T102" fmla="*/ 303 w 314"/>
                <a:gd name="T103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314" h="290">
                  <a:moveTo>
                    <a:pt x="226" y="260"/>
                  </a:moveTo>
                  <a:cubicBezTo>
                    <a:pt x="208" y="224"/>
                    <a:pt x="133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9" y="25"/>
                    <a:pt x="109" y="25"/>
                  </a:cubicBezTo>
                  <a:cubicBezTo>
                    <a:pt x="109" y="25"/>
                    <a:pt x="109" y="25"/>
                    <a:pt x="109" y="25"/>
                  </a:cubicBezTo>
                  <a:cubicBezTo>
                    <a:pt x="109" y="25"/>
                    <a:pt x="105" y="26"/>
                    <a:pt x="99" y="32"/>
                  </a:cubicBezTo>
                  <a:cubicBezTo>
                    <a:pt x="99" y="32"/>
                    <a:pt x="99" y="32"/>
                    <a:pt x="99" y="32"/>
                  </a:cubicBezTo>
                  <a:cubicBezTo>
                    <a:pt x="93" y="39"/>
                    <a:pt x="86" y="50"/>
                    <a:pt x="78" y="65"/>
                  </a:cubicBezTo>
                  <a:cubicBezTo>
                    <a:pt x="78" y="65"/>
                    <a:pt x="78" y="65"/>
                    <a:pt x="78" y="65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3" y="170"/>
                    <a:pt x="15" y="173"/>
                    <a:pt x="9" y="170"/>
                  </a:cubicBezTo>
                  <a:cubicBezTo>
                    <a:pt x="9" y="170"/>
                    <a:pt x="9" y="170"/>
                    <a:pt x="9" y="170"/>
                  </a:cubicBezTo>
                  <a:cubicBezTo>
                    <a:pt x="3" y="166"/>
                    <a:pt x="0" y="159"/>
                    <a:pt x="4" y="152"/>
                  </a:cubicBezTo>
                  <a:cubicBezTo>
                    <a:pt x="4" y="152"/>
                    <a:pt x="4" y="152"/>
                    <a:pt x="4" y="152"/>
                  </a:cubicBezTo>
                  <a:cubicBezTo>
                    <a:pt x="4" y="152"/>
                    <a:pt x="4" y="152"/>
                    <a:pt x="56" y="53"/>
                  </a:cubicBezTo>
                  <a:cubicBezTo>
                    <a:pt x="56" y="53"/>
                    <a:pt x="56" y="53"/>
                    <a:pt x="56" y="53"/>
                  </a:cubicBezTo>
                  <a:cubicBezTo>
                    <a:pt x="73" y="21"/>
                    <a:pt x="86" y="2"/>
                    <a:pt x="109" y="0"/>
                  </a:cubicBezTo>
                  <a:cubicBezTo>
                    <a:pt x="109" y="0"/>
                    <a:pt x="109" y="0"/>
                    <a:pt x="109" y="0"/>
                  </a:cubicBezTo>
                  <a:cubicBezTo>
                    <a:pt x="125" y="0"/>
                    <a:pt x="134" y="13"/>
                    <a:pt x="142" y="27"/>
                  </a:cubicBezTo>
                  <a:cubicBezTo>
                    <a:pt x="142" y="27"/>
                    <a:pt x="142" y="27"/>
                    <a:pt x="142" y="27"/>
                  </a:cubicBezTo>
                  <a:cubicBezTo>
                    <a:pt x="156" y="54"/>
                    <a:pt x="231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3" y="258"/>
                    <a:pt x="257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9" y="264"/>
                    <a:pt x="260" y="263"/>
                    <a:pt x="261" y="262"/>
                  </a:cubicBezTo>
                  <a:cubicBezTo>
                    <a:pt x="261" y="262"/>
                    <a:pt x="261" y="262"/>
                    <a:pt x="261" y="262"/>
                  </a:cubicBezTo>
                  <a:cubicBezTo>
                    <a:pt x="264" y="259"/>
                    <a:pt x="268" y="253"/>
                    <a:pt x="273" y="245"/>
                  </a:cubicBezTo>
                  <a:cubicBezTo>
                    <a:pt x="273" y="245"/>
                    <a:pt x="273" y="245"/>
                    <a:pt x="273" y="245"/>
                  </a:cubicBezTo>
                  <a:cubicBezTo>
                    <a:pt x="278" y="237"/>
                    <a:pt x="279" y="234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1" y="232"/>
                    <a:pt x="281" y="232"/>
                    <a:pt x="281" y="232"/>
                  </a:cubicBezTo>
                  <a:cubicBezTo>
                    <a:pt x="281" y="231"/>
                    <a:pt x="281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2" y="212"/>
                    <a:pt x="299" y="210"/>
                    <a:pt x="306" y="214"/>
                  </a:cubicBezTo>
                  <a:cubicBezTo>
                    <a:pt x="306" y="214"/>
                    <a:pt x="306" y="214"/>
                    <a:pt x="306" y="214"/>
                  </a:cubicBezTo>
                  <a:cubicBezTo>
                    <a:pt x="312" y="217"/>
                    <a:pt x="314" y="225"/>
                    <a:pt x="310" y="231"/>
                  </a:cubicBezTo>
                  <a:cubicBezTo>
                    <a:pt x="310" y="231"/>
                    <a:pt x="310" y="231"/>
                    <a:pt x="310" y="231"/>
                  </a:cubicBezTo>
                  <a:cubicBezTo>
                    <a:pt x="305" y="240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295" y="258"/>
                  </a:cubicBezTo>
                  <a:cubicBezTo>
                    <a:pt x="295" y="258"/>
                    <a:pt x="295" y="258"/>
                    <a:pt x="295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2" y="289"/>
                    <a:pt x="234" y="277"/>
                    <a:pt x="226" y="260"/>
                  </a:cubicBezTo>
                  <a:close/>
                  <a:moveTo>
                    <a:pt x="303" y="242"/>
                  </a:moveTo>
                  <a:cubicBezTo>
                    <a:pt x="303" y="242"/>
                    <a:pt x="303" y="242"/>
                    <a:pt x="304" y="242"/>
                  </a:cubicBezTo>
                  <a:cubicBezTo>
                    <a:pt x="304" y="242"/>
                    <a:pt x="304" y="242"/>
                    <a:pt x="304" y="242"/>
                  </a:cubicBezTo>
                  <a:cubicBezTo>
                    <a:pt x="304" y="242"/>
                    <a:pt x="304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lose/>
                  <a:moveTo>
                    <a:pt x="304" y="241"/>
                  </a:moveTo>
                  <a:cubicBezTo>
                    <a:pt x="304" y="240"/>
                    <a:pt x="304" y="240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40"/>
                    <a:pt x="304" y="240"/>
                    <a:pt x="304" y="241"/>
                  </a:cubicBezTo>
                  <a:close/>
                  <a:moveTo>
                    <a:pt x="292" y="225"/>
                  </a:move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0" name="Freeform 7">
              <a:extLst>
                <a:ext uri="{FF2B5EF4-FFF2-40B4-BE49-F238E27FC236}">
                  <a16:creationId xmlns:a16="http://schemas.microsoft.com/office/drawing/2014/main" id="{539C0C5C-14E9-C9DA-71EB-F1435EFB4542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2271" y="1817"/>
              <a:ext cx="740" cy="685"/>
            </a:xfrm>
            <a:custGeom>
              <a:avLst/>
              <a:gdLst>
                <a:gd name="T0" fmla="*/ 65 w 313"/>
                <a:gd name="T1" fmla="*/ 41 h 290"/>
                <a:gd name="T2" fmla="*/ 55 w 313"/>
                <a:gd name="T3" fmla="*/ 26 h 290"/>
                <a:gd name="T4" fmla="*/ 53 w 313"/>
                <a:gd name="T5" fmla="*/ 28 h 290"/>
                <a:gd name="T6" fmla="*/ 41 w 313"/>
                <a:gd name="T7" fmla="*/ 45 h 290"/>
                <a:gd name="T8" fmla="*/ 33 w 313"/>
                <a:gd name="T9" fmla="*/ 58 h 290"/>
                <a:gd name="T10" fmla="*/ 33 w 313"/>
                <a:gd name="T11" fmla="*/ 58 h 290"/>
                <a:gd name="T12" fmla="*/ 33 w 313"/>
                <a:gd name="T13" fmla="*/ 59 h 290"/>
                <a:gd name="T14" fmla="*/ 33 w 313"/>
                <a:gd name="T15" fmla="*/ 59 h 290"/>
                <a:gd name="T16" fmla="*/ 32 w 313"/>
                <a:gd name="T17" fmla="*/ 60 h 290"/>
                <a:gd name="T18" fmla="*/ 25 w 313"/>
                <a:gd name="T19" fmla="*/ 72 h 290"/>
                <a:gd name="T20" fmla="*/ 25 w 313"/>
                <a:gd name="T21" fmla="*/ 72 h 290"/>
                <a:gd name="T22" fmla="*/ 8 w 313"/>
                <a:gd name="T23" fmla="*/ 77 h 290"/>
                <a:gd name="T24" fmla="*/ 4 w 313"/>
                <a:gd name="T25" fmla="*/ 59 h 290"/>
                <a:gd name="T26" fmla="*/ 11 w 313"/>
                <a:gd name="T27" fmla="*/ 47 h 290"/>
                <a:gd name="T28" fmla="*/ 11 w 313"/>
                <a:gd name="T29" fmla="*/ 46 h 290"/>
                <a:gd name="T30" fmla="*/ 19 w 313"/>
                <a:gd name="T31" fmla="*/ 33 h 290"/>
                <a:gd name="T32" fmla="*/ 55 w 313"/>
                <a:gd name="T33" fmla="*/ 0 h 290"/>
                <a:gd name="T34" fmla="*/ 88 w 313"/>
                <a:gd name="T35" fmla="*/ 30 h 290"/>
                <a:gd name="T36" fmla="*/ 194 w 313"/>
                <a:gd name="T37" fmla="*/ 252 h 290"/>
                <a:gd name="T38" fmla="*/ 202 w 313"/>
                <a:gd name="T39" fmla="*/ 263 h 290"/>
                <a:gd name="T40" fmla="*/ 205 w 313"/>
                <a:gd name="T41" fmla="*/ 265 h 290"/>
                <a:gd name="T42" fmla="*/ 215 w 313"/>
                <a:gd name="T43" fmla="*/ 258 h 290"/>
                <a:gd name="T44" fmla="*/ 236 w 313"/>
                <a:gd name="T45" fmla="*/ 225 h 290"/>
                <a:gd name="T46" fmla="*/ 288 w 313"/>
                <a:gd name="T47" fmla="*/ 126 h 290"/>
                <a:gd name="T48" fmla="*/ 305 w 313"/>
                <a:gd name="T49" fmla="*/ 121 h 290"/>
                <a:gd name="T50" fmla="*/ 310 w 313"/>
                <a:gd name="T51" fmla="*/ 138 h 290"/>
                <a:gd name="T52" fmla="*/ 258 w 313"/>
                <a:gd name="T53" fmla="*/ 237 h 290"/>
                <a:gd name="T54" fmla="*/ 205 w 313"/>
                <a:gd name="T55" fmla="*/ 290 h 290"/>
                <a:gd name="T56" fmla="*/ 172 w 313"/>
                <a:gd name="T57" fmla="*/ 264 h 290"/>
                <a:gd name="T58" fmla="*/ 10 w 313"/>
                <a:gd name="T59" fmla="*/ 49 h 290"/>
                <a:gd name="T60" fmla="*/ 10 w 313"/>
                <a:gd name="T61" fmla="*/ 49 h 290"/>
                <a:gd name="T62" fmla="*/ 10 w 313"/>
                <a:gd name="T63" fmla="*/ 49 h 290"/>
                <a:gd name="T64" fmla="*/ 10 w 313"/>
                <a:gd name="T65" fmla="*/ 48 h 290"/>
                <a:gd name="T66" fmla="*/ 10 w 313"/>
                <a:gd name="T67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313" h="290">
                  <a:moveTo>
                    <a:pt x="172" y="264"/>
                  </a:moveTo>
                  <a:cubicBezTo>
                    <a:pt x="158" y="237"/>
                    <a:pt x="83" y="77"/>
                    <a:pt x="65" y="41"/>
                  </a:cubicBezTo>
                  <a:cubicBezTo>
                    <a:pt x="65" y="41"/>
                    <a:pt x="65" y="41"/>
                    <a:pt x="65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5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5" y="55"/>
                    <a:pt x="34" y="57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2" y="60"/>
                    <a:pt x="32" y="60"/>
                  </a:cubicBezTo>
                  <a:cubicBezTo>
                    <a:pt x="32" y="60"/>
                    <a:pt x="32" y="60"/>
                    <a:pt x="32" y="60"/>
                  </a:cubicBezTo>
                  <a:cubicBezTo>
                    <a:pt x="31" y="62"/>
                    <a:pt x="29" y="65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2" y="78"/>
                    <a:pt x="14" y="80"/>
                    <a:pt x="8" y="77"/>
                  </a:cubicBezTo>
                  <a:cubicBezTo>
                    <a:pt x="8" y="77"/>
                    <a:pt x="8" y="77"/>
                    <a:pt x="8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9" y="51"/>
                    <a:pt x="10" y="48"/>
                    <a:pt x="11" y="47"/>
                  </a:cubicBezTo>
                  <a:cubicBezTo>
                    <a:pt x="11" y="47"/>
                    <a:pt x="11" y="47"/>
                    <a:pt x="11" y="47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5" y="0"/>
                  </a:cubicBezTo>
                  <a:cubicBezTo>
                    <a:pt x="55" y="0"/>
                    <a:pt x="55" y="0"/>
                    <a:pt x="55" y="0"/>
                  </a:cubicBezTo>
                  <a:cubicBezTo>
                    <a:pt x="72" y="1"/>
                    <a:pt x="79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4" y="252"/>
                  </a:cubicBezTo>
                  <a:cubicBezTo>
                    <a:pt x="194" y="252"/>
                    <a:pt x="194" y="252"/>
                    <a:pt x="194" y="252"/>
                  </a:cubicBezTo>
                  <a:cubicBezTo>
                    <a:pt x="197" y="258"/>
                    <a:pt x="200" y="261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4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0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3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79" y="278"/>
                    <a:pt x="172" y="264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0" y="48"/>
                  </a:moveTo>
                  <a:cubicBezTo>
                    <a:pt x="10" y="48"/>
                    <a:pt x="10" y="48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1" name="Freeform 8">
              <a:extLst>
                <a:ext uri="{FF2B5EF4-FFF2-40B4-BE49-F238E27FC236}">
                  <a16:creationId xmlns:a16="http://schemas.microsoft.com/office/drawing/2014/main" id="{6B3D8DBE-9A01-88D4-A143-F7AB8B394199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2640" y="1817"/>
              <a:ext cx="739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9 w 313"/>
                <a:gd name="T5" fmla="*/ 32 h 290"/>
                <a:gd name="T6" fmla="*/ 78 w 313"/>
                <a:gd name="T7" fmla="*/ 65 h 290"/>
                <a:gd name="T8" fmla="*/ 26 w 313"/>
                <a:gd name="T9" fmla="*/ 164 h 290"/>
                <a:gd name="T10" fmla="*/ 9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2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1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0 w 313"/>
                <a:gd name="T33" fmla="*/ 232 h 290"/>
                <a:gd name="T34" fmla="*/ 280 w 313"/>
                <a:gd name="T35" fmla="*/ 232 h 290"/>
                <a:gd name="T36" fmla="*/ 281 w 313"/>
                <a:gd name="T37" fmla="*/ 230 h 290"/>
                <a:gd name="T38" fmla="*/ 288 w 313"/>
                <a:gd name="T39" fmla="*/ 218 h 290"/>
                <a:gd name="T40" fmla="*/ 305 w 313"/>
                <a:gd name="T41" fmla="*/ 214 h 290"/>
                <a:gd name="T42" fmla="*/ 310 w 313"/>
                <a:gd name="T43" fmla="*/ 231 h 290"/>
                <a:gd name="T44" fmla="*/ 303 w 313"/>
                <a:gd name="T45" fmla="*/ 243 h 290"/>
                <a:gd name="T46" fmla="*/ 303 w 313"/>
                <a:gd name="T47" fmla="*/ 243 h 290"/>
                <a:gd name="T48" fmla="*/ 303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302 w 313"/>
                <a:gd name="T55" fmla="*/ 244 h 290"/>
                <a:gd name="T56" fmla="*/ 294 w 313"/>
                <a:gd name="T57" fmla="*/ 258 h 290"/>
                <a:gd name="T58" fmla="*/ 258 w 313"/>
                <a:gd name="T59" fmla="*/ 290 h 290"/>
                <a:gd name="T60" fmla="*/ 225 w 313"/>
                <a:gd name="T61" fmla="*/ 260 h 290"/>
                <a:gd name="T62" fmla="*/ 259 w 313"/>
                <a:gd name="T63" fmla="*/ 265 h 290"/>
                <a:gd name="T64" fmla="*/ 259 w 313"/>
                <a:gd name="T65" fmla="*/ 265 h 290"/>
                <a:gd name="T66" fmla="*/ 303 w 313"/>
                <a:gd name="T67" fmla="*/ 242 h 290"/>
                <a:gd name="T68" fmla="*/ 303 w 313"/>
                <a:gd name="T69" fmla="*/ 242 h 290"/>
                <a:gd name="T70" fmla="*/ 303 w 313"/>
                <a:gd name="T71" fmla="*/ 242 h 290"/>
                <a:gd name="T72" fmla="*/ 304 w 313"/>
                <a:gd name="T73" fmla="*/ 238 h 290"/>
                <a:gd name="T74" fmla="*/ 304 w 313"/>
                <a:gd name="T75" fmla="*/ 239 h 290"/>
                <a:gd name="T76" fmla="*/ 303 w 313"/>
                <a:gd name="T77" fmla="*/ 241 h 290"/>
                <a:gd name="T78" fmla="*/ 302 w 313"/>
                <a:gd name="T79" fmla="*/ 231 h 290"/>
                <a:gd name="T80" fmla="*/ 302 w 313"/>
                <a:gd name="T81" fmla="*/ 231 h 290"/>
                <a:gd name="T82" fmla="*/ 292 w 313"/>
                <a:gd name="T83" fmla="*/ 225 h 290"/>
                <a:gd name="T84" fmla="*/ 292 w 313"/>
                <a:gd name="T85" fmla="*/ 225 h 290"/>
                <a:gd name="T86" fmla="*/ 303 w 313"/>
                <a:gd name="T87" fmla="*/ 244 h 290"/>
                <a:gd name="T88" fmla="*/ 303 w 313"/>
                <a:gd name="T89" fmla="*/ 243 h 290"/>
                <a:gd name="T90" fmla="*/ 302 w 313"/>
                <a:gd name="T91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13" h="290">
                  <a:moveTo>
                    <a:pt x="225" y="260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9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5" y="26"/>
                    <a:pt x="99" y="32"/>
                  </a:cubicBezTo>
                  <a:cubicBezTo>
                    <a:pt x="99" y="32"/>
                    <a:pt x="99" y="32"/>
                    <a:pt x="99" y="32"/>
                  </a:cubicBezTo>
                  <a:cubicBezTo>
                    <a:pt x="93" y="39"/>
                    <a:pt x="86" y="50"/>
                    <a:pt x="78" y="65"/>
                  </a:cubicBezTo>
                  <a:cubicBezTo>
                    <a:pt x="78" y="65"/>
                    <a:pt x="78" y="65"/>
                    <a:pt x="78" y="65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2" y="170"/>
                    <a:pt x="15" y="173"/>
                    <a:pt x="9" y="170"/>
                  </a:cubicBezTo>
                  <a:cubicBezTo>
                    <a:pt x="9" y="170"/>
                    <a:pt x="9" y="170"/>
                    <a:pt x="9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5" y="0"/>
                    <a:pt x="134" y="13"/>
                    <a:pt x="142" y="27"/>
                  </a:cubicBezTo>
                  <a:cubicBezTo>
                    <a:pt x="142" y="27"/>
                    <a:pt x="142" y="27"/>
                    <a:pt x="142" y="27"/>
                  </a:cubicBezTo>
                  <a:cubicBezTo>
                    <a:pt x="156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9" y="264"/>
                    <a:pt x="260" y="263"/>
                    <a:pt x="261" y="262"/>
                  </a:cubicBezTo>
                  <a:cubicBezTo>
                    <a:pt x="261" y="262"/>
                    <a:pt x="261" y="262"/>
                    <a:pt x="261" y="262"/>
                  </a:cubicBezTo>
                  <a:cubicBezTo>
                    <a:pt x="264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77" y="237"/>
                    <a:pt x="279" y="234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1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10" y="231"/>
                  </a:cubicBezTo>
                  <a:cubicBezTo>
                    <a:pt x="310" y="231"/>
                    <a:pt x="310" y="231"/>
                    <a:pt x="310" y="231"/>
                  </a:cubicBezTo>
                  <a:cubicBezTo>
                    <a:pt x="305" y="240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0"/>
                  </a:cubicBezTo>
                  <a:close/>
                  <a:moveTo>
                    <a:pt x="259" y="265"/>
                  </a:moveTo>
                  <a:cubicBezTo>
                    <a:pt x="259" y="265"/>
                    <a:pt x="259" y="265"/>
                    <a:pt x="259" y="265"/>
                  </a:cubicBezTo>
                  <a:cubicBezTo>
                    <a:pt x="259" y="265"/>
                    <a:pt x="259" y="265"/>
                    <a:pt x="259" y="265"/>
                  </a:cubicBezTo>
                  <a:cubicBezTo>
                    <a:pt x="259" y="265"/>
                    <a:pt x="259" y="265"/>
                    <a:pt x="259" y="265"/>
                  </a:cubicBezTo>
                  <a:close/>
                  <a:moveTo>
                    <a:pt x="303" y="242"/>
                  </a:move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lose/>
                  <a:moveTo>
                    <a:pt x="303" y="241"/>
                  </a:moveTo>
                  <a:cubicBezTo>
                    <a:pt x="304" y="240"/>
                    <a:pt x="304" y="240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40"/>
                    <a:pt x="304" y="240"/>
                    <a:pt x="303" y="241"/>
                  </a:cubicBezTo>
                  <a:close/>
                  <a:moveTo>
                    <a:pt x="302" y="231"/>
                  </a:move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lose/>
                  <a:moveTo>
                    <a:pt x="292" y="225"/>
                  </a:move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lose/>
                  <a:moveTo>
                    <a:pt x="303" y="244"/>
                  </a:move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3" y="244"/>
                    <a:pt x="303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2" name="Freeform 9">
              <a:extLst>
                <a:ext uri="{FF2B5EF4-FFF2-40B4-BE49-F238E27FC236}">
                  <a16:creationId xmlns:a16="http://schemas.microsoft.com/office/drawing/2014/main" id="{1943B002-82C7-600C-7F5C-254FC570AEBE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049" y="1817"/>
              <a:ext cx="739" cy="685"/>
            </a:xfrm>
            <a:custGeom>
              <a:avLst/>
              <a:gdLst>
                <a:gd name="T0" fmla="*/ 65 w 313"/>
                <a:gd name="T1" fmla="*/ 41 h 290"/>
                <a:gd name="T2" fmla="*/ 55 w 313"/>
                <a:gd name="T3" fmla="*/ 26 h 290"/>
                <a:gd name="T4" fmla="*/ 52 w 313"/>
                <a:gd name="T5" fmla="*/ 28 h 290"/>
                <a:gd name="T6" fmla="*/ 41 w 313"/>
                <a:gd name="T7" fmla="*/ 45 h 290"/>
                <a:gd name="T8" fmla="*/ 33 w 313"/>
                <a:gd name="T9" fmla="*/ 58 h 290"/>
                <a:gd name="T10" fmla="*/ 33 w 313"/>
                <a:gd name="T11" fmla="*/ 58 h 290"/>
                <a:gd name="T12" fmla="*/ 33 w 313"/>
                <a:gd name="T13" fmla="*/ 58 h 290"/>
                <a:gd name="T14" fmla="*/ 33 w 313"/>
                <a:gd name="T15" fmla="*/ 58 h 290"/>
                <a:gd name="T16" fmla="*/ 33 w 313"/>
                <a:gd name="T17" fmla="*/ 59 h 290"/>
                <a:gd name="T18" fmla="*/ 32 w 313"/>
                <a:gd name="T19" fmla="*/ 60 h 290"/>
                <a:gd name="T20" fmla="*/ 25 w 313"/>
                <a:gd name="T21" fmla="*/ 72 h 290"/>
                <a:gd name="T22" fmla="*/ 8 w 313"/>
                <a:gd name="T23" fmla="*/ 77 h 290"/>
                <a:gd name="T24" fmla="*/ 3 w 313"/>
                <a:gd name="T25" fmla="*/ 59 h 290"/>
                <a:gd name="T26" fmla="*/ 10 w 313"/>
                <a:gd name="T27" fmla="*/ 47 h 290"/>
                <a:gd name="T28" fmla="*/ 11 w 313"/>
                <a:gd name="T29" fmla="*/ 46 h 290"/>
                <a:gd name="T30" fmla="*/ 19 w 313"/>
                <a:gd name="T31" fmla="*/ 33 h 290"/>
                <a:gd name="T32" fmla="*/ 55 w 313"/>
                <a:gd name="T33" fmla="*/ 0 h 290"/>
                <a:gd name="T34" fmla="*/ 88 w 313"/>
                <a:gd name="T35" fmla="*/ 30 h 290"/>
                <a:gd name="T36" fmla="*/ 194 w 313"/>
                <a:gd name="T37" fmla="*/ 252 h 290"/>
                <a:gd name="T38" fmla="*/ 202 w 313"/>
                <a:gd name="T39" fmla="*/ 263 h 290"/>
                <a:gd name="T40" fmla="*/ 205 w 313"/>
                <a:gd name="T41" fmla="*/ 265 h 290"/>
                <a:gd name="T42" fmla="*/ 214 w 313"/>
                <a:gd name="T43" fmla="*/ 258 h 290"/>
                <a:gd name="T44" fmla="*/ 235 w 313"/>
                <a:gd name="T45" fmla="*/ 225 h 290"/>
                <a:gd name="T46" fmla="*/ 287 w 313"/>
                <a:gd name="T47" fmla="*/ 126 h 290"/>
                <a:gd name="T48" fmla="*/ 304 w 313"/>
                <a:gd name="T49" fmla="*/ 121 h 290"/>
                <a:gd name="T50" fmla="*/ 310 w 313"/>
                <a:gd name="T51" fmla="*/ 138 h 290"/>
                <a:gd name="T52" fmla="*/ 258 w 313"/>
                <a:gd name="T53" fmla="*/ 237 h 290"/>
                <a:gd name="T54" fmla="*/ 205 w 313"/>
                <a:gd name="T55" fmla="*/ 290 h 290"/>
                <a:gd name="T56" fmla="*/ 172 w 313"/>
                <a:gd name="T57" fmla="*/ 264 h 290"/>
                <a:gd name="T58" fmla="*/ 10 w 313"/>
                <a:gd name="T59" fmla="*/ 49 h 290"/>
                <a:gd name="T60" fmla="*/ 10 w 313"/>
                <a:gd name="T61" fmla="*/ 49 h 290"/>
                <a:gd name="T62" fmla="*/ 10 w 313"/>
                <a:gd name="T63" fmla="*/ 48 h 290"/>
                <a:gd name="T64" fmla="*/ 10 w 313"/>
                <a:gd name="T65" fmla="*/ 48 h 290"/>
                <a:gd name="T66" fmla="*/ 10 w 313"/>
                <a:gd name="T67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313" h="290">
                  <a:moveTo>
                    <a:pt x="172" y="264"/>
                  </a:moveTo>
                  <a:cubicBezTo>
                    <a:pt x="157" y="237"/>
                    <a:pt x="83" y="77"/>
                    <a:pt x="65" y="41"/>
                  </a:cubicBezTo>
                  <a:cubicBezTo>
                    <a:pt x="65" y="41"/>
                    <a:pt x="65" y="41"/>
                    <a:pt x="65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4" y="26"/>
                    <a:pt x="53" y="27"/>
                    <a:pt x="52" y="28"/>
                  </a:cubicBezTo>
                  <a:cubicBezTo>
                    <a:pt x="52" y="28"/>
                    <a:pt x="52" y="28"/>
                    <a:pt x="52" y="28"/>
                  </a:cubicBezTo>
                  <a:cubicBezTo>
                    <a:pt x="49" y="31"/>
                    <a:pt x="45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4"/>
                    <a:pt x="34" y="57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2" y="59"/>
                    <a:pt x="32" y="60"/>
                  </a:cubicBezTo>
                  <a:cubicBezTo>
                    <a:pt x="32" y="60"/>
                    <a:pt x="32" y="60"/>
                    <a:pt x="32" y="60"/>
                  </a:cubicBezTo>
                  <a:cubicBezTo>
                    <a:pt x="31" y="62"/>
                    <a:pt x="29" y="65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2" y="78"/>
                    <a:pt x="14" y="80"/>
                    <a:pt x="8" y="77"/>
                  </a:cubicBezTo>
                  <a:cubicBezTo>
                    <a:pt x="8" y="77"/>
                    <a:pt x="8" y="77"/>
                    <a:pt x="8" y="77"/>
                  </a:cubicBezTo>
                  <a:cubicBezTo>
                    <a:pt x="2" y="73"/>
                    <a:pt x="0" y="65"/>
                    <a:pt x="3" y="59"/>
                  </a:cubicBezTo>
                  <a:cubicBezTo>
                    <a:pt x="3" y="59"/>
                    <a:pt x="3" y="59"/>
                    <a:pt x="3" y="59"/>
                  </a:cubicBezTo>
                  <a:cubicBezTo>
                    <a:pt x="8" y="51"/>
                    <a:pt x="10" y="48"/>
                    <a:pt x="10" y="47"/>
                  </a:cubicBezTo>
                  <a:cubicBezTo>
                    <a:pt x="10" y="47"/>
                    <a:pt x="10" y="47"/>
                    <a:pt x="10" y="47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2" y="45"/>
                    <a:pt x="13" y="42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29" y="16"/>
                    <a:pt x="36" y="2"/>
                    <a:pt x="55" y="0"/>
                  </a:cubicBezTo>
                  <a:cubicBezTo>
                    <a:pt x="55" y="0"/>
                    <a:pt x="55" y="0"/>
                    <a:pt x="55" y="0"/>
                  </a:cubicBezTo>
                  <a:cubicBezTo>
                    <a:pt x="72" y="1"/>
                    <a:pt x="79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4" y="252"/>
                  </a:cubicBezTo>
                  <a:cubicBezTo>
                    <a:pt x="194" y="252"/>
                    <a:pt x="194" y="252"/>
                    <a:pt x="194" y="252"/>
                  </a:cubicBezTo>
                  <a:cubicBezTo>
                    <a:pt x="197" y="258"/>
                    <a:pt x="200" y="261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4" y="265"/>
                    <a:pt x="204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8" y="264"/>
                    <a:pt x="214" y="258"/>
                  </a:cubicBezTo>
                  <a:cubicBezTo>
                    <a:pt x="214" y="258"/>
                    <a:pt x="214" y="258"/>
                    <a:pt x="214" y="258"/>
                  </a:cubicBezTo>
                  <a:cubicBezTo>
                    <a:pt x="220" y="251"/>
                    <a:pt x="227" y="241"/>
                    <a:pt x="235" y="225"/>
                  </a:cubicBezTo>
                  <a:cubicBezTo>
                    <a:pt x="235" y="225"/>
                    <a:pt x="235" y="225"/>
                    <a:pt x="235" y="225"/>
                  </a:cubicBezTo>
                  <a:cubicBezTo>
                    <a:pt x="287" y="126"/>
                    <a:pt x="287" y="126"/>
                    <a:pt x="287" y="126"/>
                  </a:cubicBezTo>
                  <a:cubicBezTo>
                    <a:pt x="287" y="126"/>
                    <a:pt x="287" y="126"/>
                    <a:pt x="287" y="126"/>
                  </a:cubicBezTo>
                  <a:cubicBezTo>
                    <a:pt x="291" y="120"/>
                    <a:pt x="298" y="118"/>
                    <a:pt x="304" y="121"/>
                  </a:cubicBezTo>
                  <a:cubicBezTo>
                    <a:pt x="304" y="121"/>
                    <a:pt x="304" y="121"/>
                    <a:pt x="304" y="121"/>
                  </a:cubicBezTo>
                  <a:cubicBezTo>
                    <a:pt x="311" y="124"/>
                    <a:pt x="313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8" y="290"/>
                    <a:pt x="179" y="278"/>
                    <a:pt x="172" y="264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0" y="48"/>
                  </a:move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3" name="Freeform 10">
              <a:extLst>
                <a:ext uri="{FF2B5EF4-FFF2-40B4-BE49-F238E27FC236}">
                  <a16:creationId xmlns:a16="http://schemas.microsoft.com/office/drawing/2014/main" id="{B0402703-F94C-759A-CF39-275EE00B139A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417" y="1817"/>
              <a:ext cx="740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8 w 313"/>
                <a:gd name="T5" fmla="*/ 32 h 290"/>
                <a:gd name="T6" fmla="*/ 77 w 313"/>
                <a:gd name="T7" fmla="*/ 65 h 290"/>
                <a:gd name="T8" fmla="*/ 25 w 313"/>
                <a:gd name="T9" fmla="*/ 164 h 290"/>
                <a:gd name="T10" fmla="*/ 8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1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0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1 w 313"/>
                <a:gd name="T33" fmla="*/ 230 h 290"/>
                <a:gd name="T34" fmla="*/ 288 w 313"/>
                <a:gd name="T35" fmla="*/ 218 h 290"/>
                <a:gd name="T36" fmla="*/ 288 w 313"/>
                <a:gd name="T37" fmla="*/ 218 h 290"/>
                <a:gd name="T38" fmla="*/ 305 w 313"/>
                <a:gd name="T39" fmla="*/ 214 h 290"/>
                <a:gd name="T40" fmla="*/ 309 w 313"/>
                <a:gd name="T41" fmla="*/ 231 h 290"/>
                <a:gd name="T42" fmla="*/ 302 w 313"/>
                <a:gd name="T43" fmla="*/ 244 h 290"/>
                <a:gd name="T44" fmla="*/ 302 w 313"/>
                <a:gd name="T45" fmla="*/ 243 h 290"/>
                <a:gd name="T46" fmla="*/ 302 w 313"/>
                <a:gd name="T47" fmla="*/ 244 h 290"/>
                <a:gd name="T48" fmla="*/ 302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294 w 313"/>
                <a:gd name="T55" fmla="*/ 258 h 290"/>
                <a:gd name="T56" fmla="*/ 258 w 313"/>
                <a:gd name="T57" fmla="*/ 290 h 290"/>
                <a:gd name="T58" fmla="*/ 302 w 313"/>
                <a:gd name="T59" fmla="*/ 244 h 290"/>
                <a:gd name="T60" fmla="*/ 302 w 313"/>
                <a:gd name="T61" fmla="*/ 244 h 290"/>
                <a:gd name="T62" fmla="*/ 302 w 313"/>
                <a:gd name="T63" fmla="*/ 244 h 290"/>
                <a:gd name="T64" fmla="*/ 303 w 313"/>
                <a:gd name="T65" fmla="*/ 241 h 290"/>
                <a:gd name="T66" fmla="*/ 303 w 313"/>
                <a:gd name="T67" fmla="*/ 237 h 290"/>
                <a:gd name="T68" fmla="*/ 291 w 313"/>
                <a:gd name="T69" fmla="*/ 238 h 290"/>
                <a:gd name="T70" fmla="*/ 291 w 313"/>
                <a:gd name="T71" fmla="*/ 238 h 290"/>
                <a:gd name="T72" fmla="*/ 291 w 313"/>
                <a:gd name="T73" fmla="*/ 238 h 290"/>
                <a:gd name="T74" fmla="*/ 302 w 313"/>
                <a:gd name="T75" fmla="*/ 244 h 290"/>
                <a:gd name="T76" fmla="*/ 302 w 313"/>
                <a:gd name="T77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313" h="290">
                  <a:moveTo>
                    <a:pt x="225" y="260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8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4" y="26"/>
                    <a:pt x="98" y="32"/>
                  </a:cubicBezTo>
                  <a:cubicBezTo>
                    <a:pt x="98" y="32"/>
                    <a:pt x="98" y="32"/>
                    <a:pt x="98" y="32"/>
                  </a:cubicBezTo>
                  <a:cubicBezTo>
                    <a:pt x="93" y="39"/>
                    <a:pt x="85" y="50"/>
                    <a:pt x="77" y="65"/>
                  </a:cubicBezTo>
                  <a:cubicBezTo>
                    <a:pt x="77" y="65"/>
                    <a:pt x="77" y="65"/>
                    <a:pt x="77" y="65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2" y="170"/>
                    <a:pt x="14" y="173"/>
                    <a:pt x="8" y="170"/>
                  </a:cubicBezTo>
                  <a:cubicBezTo>
                    <a:pt x="8" y="170"/>
                    <a:pt x="8" y="170"/>
                    <a:pt x="8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4" y="0"/>
                    <a:pt x="134" y="13"/>
                    <a:pt x="141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55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8" y="264"/>
                    <a:pt x="259" y="263"/>
                    <a:pt x="260" y="262"/>
                  </a:cubicBezTo>
                  <a:cubicBezTo>
                    <a:pt x="260" y="262"/>
                    <a:pt x="260" y="262"/>
                    <a:pt x="260" y="262"/>
                  </a:cubicBezTo>
                  <a:cubicBezTo>
                    <a:pt x="263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0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09" y="231"/>
                  </a:cubicBezTo>
                  <a:cubicBezTo>
                    <a:pt x="309" y="231"/>
                    <a:pt x="309" y="231"/>
                    <a:pt x="309" y="231"/>
                  </a:cubicBezTo>
                  <a:cubicBezTo>
                    <a:pt x="304" y="240"/>
                    <a:pt x="303" y="243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1" y="245"/>
                    <a:pt x="300" y="247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0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  <a:moveTo>
                    <a:pt x="303" y="241"/>
                  </a:moveTo>
                  <a:cubicBezTo>
                    <a:pt x="304" y="240"/>
                    <a:pt x="304" y="239"/>
                    <a:pt x="303" y="237"/>
                  </a:cubicBezTo>
                  <a:cubicBezTo>
                    <a:pt x="303" y="237"/>
                    <a:pt x="303" y="237"/>
                    <a:pt x="303" y="237"/>
                  </a:cubicBezTo>
                  <a:cubicBezTo>
                    <a:pt x="304" y="239"/>
                    <a:pt x="303" y="240"/>
                    <a:pt x="303" y="241"/>
                  </a:cubicBezTo>
                  <a:close/>
                  <a:moveTo>
                    <a:pt x="291" y="238"/>
                  </a:moveTo>
                  <a:cubicBezTo>
                    <a:pt x="291" y="238"/>
                    <a:pt x="291" y="238"/>
                    <a:pt x="291" y="238"/>
                  </a:cubicBezTo>
                  <a:cubicBezTo>
                    <a:pt x="291" y="238"/>
                    <a:pt x="291" y="238"/>
                    <a:pt x="291" y="238"/>
                  </a:cubicBezTo>
                  <a:close/>
                  <a:moveTo>
                    <a:pt x="291" y="238"/>
                  </a:moveTo>
                  <a:cubicBezTo>
                    <a:pt x="291" y="238"/>
                    <a:pt x="291" y="238"/>
                    <a:pt x="291" y="238"/>
                  </a:cubicBezTo>
                  <a:cubicBezTo>
                    <a:pt x="291" y="238"/>
                    <a:pt x="291" y="238"/>
                    <a:pt x="291" y="238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4" name="Freeform 11">
              <a:extLst>
                <a:ext uri="{FF2B5EF4-FFF2-40B4-BE49-F238E27FC236}">
                  <a16:creationId xmlns:a16="http://schemas.microsoft.com/office/drawing/2014/main" id="{15D0C827-7DF3-1D00-B82B-7CC4886BABF1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823" y="1817"/>
              <a:ext cx="742" cy="685"/>
            </a:xfrm>
            <a:custGeom>
              <a:avLst/>
              <a:gdLst>
                <a:gd name="T0" fmla="*/ 66 w 314"/>
                <a:gd name="T1" fmla="*/ 41 h 290"/>
                <a:gd name="T2" fmla="*/ 55 w 314"/>
                <a:gd name="T3" fmla="*/ 26 h 290"/>
                <a:gd name="T4" fmla="*/ 53 w 314"/>
                <a:gd name="T5" fmla="*/ 28 h 290"/>
                <a:gd name="T6" fmla="*/ 41 w 314"/>
                <a:gd name="T7" fmla="*/ 45 h 290"/>
                <a:gd name="T8" fmla="*/ 34 w 314"/>
                <a:gd name="T9" fmla="*/ 58 h 290"/>
                <a:gd name="T10" fmla="*/ 34 w 314"/>
                <a:gd name="T11" fmla="*/ 58 h 290"/>
                <a:gd name="T12" fmla="*/ 34 w 314"/>
                <a:gd name="T13" fmla="*/ 58 h 290"/>
                <a:gd name="T14" fmla="*/ 33 w 314"/>
                <a:gd name="T15" fmla="*/ 59 h 290"/>
                <a:gd name="T16" fmla="*/ 33 w 314"/>
                <a:gd name="T17" fmla="*/ 59 h 290"/>
                <a:gd name="T18" fmla="*/ 33 w 314"/>
                <a:gd name="T19" fmla="*/ 60 h 290"/>
                <a:gd name="T20" fmla="*/ 26 w 314"/>
                <a:gd name="T21" fmla="*/ 72 h 290"/>
                <a:gd name="T22" fmla="*/ 9 w 314"/>
                <a:gd name="T23" fmla="*/ 77 h 290"/>
                <a:gd name="T24" fmla="*/ 4 w 314"/>
                <a:gd name="T25" fmla="*/ 59 h 290"/>
                <a:gd name="T26" fmla="*/ 11 w 314"/>
                <a:gd name="T27" fmla="*/ 47 h 290"/>
                <a:gd name="T28" fmla="*/ 12 w 314"/>
                <a:gd name="T29" fmla="*/ 45 h 290"/>
                <a:gd name="T30" fmla="*/ 19 w 314"/>
                <a:gd name="T31" fmla="*/ 33 h 290"/>
                <a:gd name="T32" fmla="*/ 56 w 314"/>
                <a:gd name="T33" fmla="*/ 0 h 290"/>
                <a:gd name="T34" fmla="*/ 88 w 314"/>
                <a:gd name="T35" fmla="*/ 30 h 290"/>
                <a:gd name="T36" fmla="*/ 195 w 314"/>
                <a:gd name="T37" fmla="*/ 252 h 290"/>
                <a:gd name="T38" fmla="*/ 203 w 314"/>
                <a:gd name="T39" fmla="*/ 263 h 290"/>
                <a:gd name="T40" fmla="*/ 205 w 314"/>
                <a:gd name="T41" fmla="*/ 265 h 290"/>
                <a:gd name="T42" fmla="*/ 215 w 314"/>
                <a:gd name="T43" fmla="*/ 258 h 290"/>
                <a:gd name="T44" fmla="*/ 236 w 314"/>
                <a:gd name="T45" fmla="*/ 225 h 290"/>
                <a:gd name="T46" fmla="*/ 288 w 314"/>
                <a:gd name="T47" fmla="*/ 126 h 290"/>
                <a:gd name="T48" fmla="*/ 305 w 314"/>
                <a:gd name="T49" fmla="*/ 121 h 290"/>
                <a:gd name="T50" fmla="*/ 311 w 314"/>
                <a:gd name="T51" fmla="*/ 138 h 290"/>
                <a:gd name="T52" fmla="*/ 258 w 314"/>
                <a:gd name="T53" fmla="*/ 237 h 290"/>
                <a:gd name="T54" fmla="*/ 205 w 314"/>
                <a:gd name="T55" fmla="*/ 290 h 290"/>
                <a:gd name="T56" fmla="*/ 10 w 314"/>
                <a:gd name="T57" fmla="*/ 51 h 290"/>
                <a:gd name="T58" fmla="*/ 10 w 314"/>
                <a:gd name="T59" fmla="*/ 51 h 290"/>
                <a:gd name="T60" fmla="*/ 10 w 314"/>
                <a:gd name="T61" fmla="*/ 51 h 290"/>
                <a:gd name="T62" fmla="*/ 10 w 314"/>
                <a:gd name="T63" fmla="*/ 49 h 290"/>
                <a:gd name="T64" fmla="*/ 10 w 314"/>
                <a:gd name="T65" fmla="*/ 49 h 290"/>
                <a:gd name="T66" fmla="*/ 11 w 314"/>
                <a:gd name="T67" fmla="*/ 48 h 290"/>
                <a:gd name="T68" fmla="*/ 11 w 314"/>
                <a:gd name="T69" fmla="*/ 48 h 290"/>
                <a:gd name="T70" fmla="*/ 11 w 314"/>
                <a:gd name="T71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314" h="290">
                  <a:moveTo>
                    <a:pt x="172" y="264"/>
                  </a:moveTo>
                  <a:cubicBezTo>
                    <a:pt x="158" y="237"/>
                    <a:pt x="84" y="77"/>
                    <a:pt x="66" y="41"/>
                  </a:cubicBezTo>
                  <a:cubicBezTo>
                    <a:pt x="66" y="41"/>
                    <a:pt x="66" y="41"/>
                    <a:pt x="66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6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5"/>
                    <a:pt x="34" y="57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9"/>
                    <a:pt x="34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60"/>
                  </a:cubicBezTo>
                  <a:cubicBezTo>
                    <a:pt x="33" y="60"/>
                    <a:pt x="33" y="60"/>
                    <a:pt x="33" y="60"/>
                  </a:cubicBezTo>
                  <a:cubicBezTo>
                    <a:pt x="32" y="62"/>
                    <a:pt x="30" y="65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2" y="78"/>
                    <a:pt x="15" y="80"/>
                    <a:pt x="9" y="77"/>
                  </a:cubicBezTo>
                  <a:cubicBezTo>
                    <a:pt x="9" y="77"/>
                    <a:pt x="9" y="77"/>
                    <a:pt x="9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9" y="51"/>
                    <a:pt x="11" y="48"/>
                    <a:pt x="11" y="47"/>
                  </a:cubicBezTo>
                  <a:cubicBezTo>
                    <a:pt x="11" y="47"/>
                    <a:pt x="11" y="47"/>
                    <a:pt x="11" y="47"/>
                  </a:cubicBezTo>
                  <a:cubicBezTo>
                    <a:pt x="11" y="46"/>
                    <a:pt x="12" y="45"/>
                    <a:pt x="12" y="45"/>
                  </a:cubicBezTo>
                  <a:cubicBezTo>
                    <a:pt x="12" y="45"/>
                    <a:pt x="12" y="45"/>
                    <a:pt x="12" y="45"/>
                  </a:cubicBezTo>
                  <a:cubicBezTo>
                    <a:pt x="13" y="44"/>
                    <a:pt x="15" y="40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6" y="0"/>
                  </a:cubicBezTo>
                  <a:cubicBezTo>
                    <a:pt x="56" y="0"/>
                    <a:pt x="56" y="0"/>
                    <a:pt x="56" y="0"/>
                  </a:cubicBezTo>
                  <a:cubicBezTo>
                    <a:pt x="72" y="1"/>
                    <a:pt x="80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5" y="252"/>
                  </a:cubicBezTo>
                  <a:cubicBezTo>
                    <a:pt x="195" y="252"/>
                    <a:pt x="195" y="252"/>
                    <a:pt x="195" y="252"/>
                  </a:cubicBezTo>
                  <a:cubicBezTo>
                    <a:pt x="198" y="258"/>
                    <a:pt x="201" y="262"/>
                    <a:pt x="203" y="263"/>
                  </a:cubicBezTo>
                  <a:cubicBezTo>
                    <a:pt x="203" y="263"/>
                    <a:pt x="203" y="263"/>
                    <a:pt x="203" y="263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1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4" y="132"/>
                    <a:pt x="311" y="138"/>
                  </a:cubicBezTo>
                  <a:cubicBezTo>
                    <a:pt x="311" y="138"/>
                    <a:pt x="311" y="138"/>
                    <a:pt x="311" y="138"/>
                  </a:cubicBezTo>
                  <a:cubicBezTo>
                    <a:pt x="310" y="138"/>
                    <a:pt x="311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80" y="278"/>
                    <a:pt x="172" y="264"/>
                  </a:cubicBezTo>
                  <a:close/>
                  <a:moveTo>
                    <a:pt x="10" y="51"/>
                  </a:move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1" y="48"/>
                  </a:move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5" name="Freeform 12">
              <a:extLst>
                <a:ext uri="{FF2B5EF4-FFF2-40B4-BE49-F238E27FC236}">
                  <a16:creationId xmlns:a16="http://schemas.microsoft.com/office/drawing/2014/main" id="{795E64FA-2001-09AB-A438-3EB962048052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265" y="2103"/>
              <a:ext cx="191" cy="297"/>
            </a:xfrm>
            <a:custGeom>
              <a:avLst/>
              <a:gdLst>
                <a:gd name="T0" fmla="*/ 9 w 81"/>
                <a:gd name="T1" fmla="*/ 124 h 126"/>
                <a:gd name="T2" fmla="*/ 4 w 81"/>
                <a:gd name="T3" fmla="*/ 107 h 126"/>
                <a:gd name="T4" fmla="*/ 4 w 81"/>
                <a:gd name="T5" fmla="*/ 107 h 126"/>
                <a:gd name="T6" fmla="*/ 56 w 81"/>
                <a:gd name="T7" fmla="*/ 8 h 126"/>
                <a:gd name="T8" fmla="*/ 56 w 81"/>
                <a:gd name="T9" fmla="*/ 8 h 126"/>
                <a:gd name="T10" fmla="*/ 56 w 81"/>
                <a:gd name="T11" fmla="*/ 8 h 126"/>
                <a:gd name="T12" fmla="*/ 73 w 81"/>
                <a:gd name="T13" fmla="*/ 3 h 126"/>
                <a:gd name="T14" fmla="*/ 73 w 81"/>
                <a:gd name="T15" fmla="*/ 3 h 126"/>
                <a:gd name="T16" fmla="*/ 78 w 81"/>
                <a:gd name="T17" fmla="*/ 20 h 126"/>
                <a:gd name="T18" fmla="*/ 78 w 81"/>
                <a:gd name="T19" fmla="*/ 20 h 126"/>
                <a:gd name="T20" fmla="*/ 26 w 81"/>
                <a:gd name="T21" fmla="*/ 119 h 126"/>
                <a:gd name="T22" fmla="*/ 26 w 81"/>
                <a:gd name="T23" fmla="*/ 119 h 126"/>
                <a:gd name="T24" fmla="*/ 15 w 81"/>
                <a:gd name="T25" fmla="*/ 126 h 126"/>
                <a:gd name="T26" fmla="*/ 15 w 81"/>
                <a:gd name="T27" fmla="*/ 126 h 126"/>
                <a:gd name="T28" fmla="*/ 9 w 81"/>
                <a:gd name="T29" fmla="*/ 124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81" h="126">
                  <a:moveTo>
                    <a:pt x="9" y="124"/>
                  </a:moveTo>
                  <a:cubicBezTo>
                    <a:pt x="3" y="121"/>
                    <a:pt x="0" y="114"/>
                    <a:pt x="4" y="107"/>
                  </a:cubicBezTo>
                  <a:cubicBezTo>
                    <a:pt x="4" y="107"/>
                    <a:pt x="4" y="107"/>
                    <a:pt x="4" y="107"/>
                  </a:cubicBezTo>
                  <a:cubicBezTo>
                    <a:pt x="4" y="107"/>
                    <a:pt x="4" y="107"/>
                    <a:pt x="56" y="8"/>
                  </a:cubicBezTo>
                  <a:cubicBezTo>
                    <a:pt x="56" y="8"/>
                    <a:pt x="56" y="8"/>
                    <a:pt x="56" y="8"/>
                  </a:cubicBezTo>
                  <a:cubicBezTo>
                    <a:pt x="56" y="8"/>
                    <a:pt x="56" y="8"/>
                    <a:pt x="56" y="8"/>
                  </a:cubicBezTo>
                  <a:cubicBezTo>
                    <a:pt x="59" y="2"/>
                    <a:pt x="67" y="0"/>
                    <a:pt x="73" y="3"/>
                  </a:cubicBezTo>
                  <a:cubicBezTo>
                    <a:pt x="73" y="3"/>
                    <a:pt x="73" y="3"/>
                    <a:pt x="73" y="3"/>
                  </a:cubicBezTo>
                  <a:cubicBezTo>
                    <a:pt x="79" y="6"/>
                    <a:pt x="81" y="14"/>
                    <a:pt x="78" y="20"/>
                  </a:cubicBezTo>
                  <a:cubicBezTo>
                    <a:pt x="78" y="20"/>
                    <a:pt x="78" y="20"/>
                    <a:pt x="78" y="20"/>
                  </a:cubicBezTo>
                  <a:cubicBezTo>
                    <a:pt x="26" y="119"/>
                    <a:pt x="26" y="119"/>
                    <a:pt x="26" y="119"/>
                  </a:cubicBezTo>
                  <a:cubicBezTo>
                    <a:pt x="26" y="119"/>
                    <a:pt x="26" y="119"/>
                    <a:pt x="26" y="119"/>
                  </a:cubicBezTo>
                  <a:cubicBezTo>
                    <a:pt x="24" y="123"/>
                    <a:pt x="19" y="126"/>
                    <a:pt x="15" y="126"/>
                  </a:cubicBezTo>
                  <a:cubicBezTo>
                    <a:pt x="15" y="126"/>
                    <a:pt x="15" y="126"/>
                    <a:pt x="15" y="126"/>
                  </a:cubicBezTo>
                  <a:cubicBezTo>
                    <a:pt x="13" y="126"/>
                    <a:pt x="11" y="125"/>
                    <a:pt x="9" y="124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86" name="Freeform 13">
              <a:extLst>
                <a:ext uri="{FF2B5EF4-FFF2-40B4-BE49-F238E27FC236}">
                  <a16:creationId xmlns:a16="http://schemas.microsoft.com/office/drawing/2014/main" id="{D9E788C2-25BF-0C7C-46AA-6B748012E4C1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4192" y="1893"/>
              <a:ext cx="191" cy="297"/>
            </a:xfrm>
            <a:custGeom>
              <a:avLst/>
              <a:gdLst>
                <a:gd name="T0" fmla="*/ 9 w 81"/>
                <a:gd name="T1" fmla="*/ 125 h 126"/>
                <a:gd name="T2" fmla="*/ 4 w 81"/>
                <a:gd name="T3" fmla="*/ 108 h 126"/>
                <a:gd name="T4" fmla="*/ 4 w 81"/>
                <a:gd name="T5" fmla="*/ 108 h 126"/>
                <a:gd name="T6" fmla="*/ 56 w 81"/>
                <a:gd name="T7" fmla="*/ 9 h 126"/>
                <a:gd name="T8" fmla="*/ 56 w 81"/>
                <a:gd name="T9" fmla="*/ 9 h 126"/>
                <a:gd name="T10" fmla="*/ 73 w 81"/>
                <a:gd name="T11" fmla="*/ 3 h 126"/>
                <a:gd name="T12" fmla="*/ 73 w 81"/>
                <a:gd name="T13" fmla="*/ 3 h 126"/>
                <a:gd name="T14" fmla="*/ 78 w 81"/>
                <a:gd name="T15" fmla="*/ 20 h 126"/>
                <a:gd name="T16" fmla="*/ 78 w 81"/>
                <a:gd name="T17" fmla="*/ 20 h 126"/>
                <a:gd name="T18" fmla="*/ 26 w 81"/>
                <a:gd name="T19" fmla="*/ 120 h 126"/>
                <a:gd name="T20" fmla="*/ 26 w 81"/>
                <a:gd name="T21" fmla="*/ 120 h 126"/>
                <a:gd name="T22" fmla="*/ 15 w 81"/>
                <a:gd name="T23" fmla="*/ 126 h 126"/>
                <a:gd name="T24" fmla="*/ 15 w 81"/>
                <a:gd name="T25" fmla="*/ 126 h 126"/>
                <a:gd name="T26" fmla="*/ 9 w 81"/>
                <a:gd name="T27" fmla="*/ 125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81" h="126">
                  <a:moveTo>
                    <a:pt x="9" y="125"/>
                  </a:moveTo>
                  <a:cubicBezTo>
                    <a:pt x="3" y="122"/>
                    <a:pt x="0" y="114"/>
                    <a:pt x="4" y="108"/>
                  </a:cubicBezTo>
                  <a:cubicBezTo>
                    <a:pt x="4" y="108"/>
                    <a:pt x="4" y="108"/>
                    <a:pt x="4" y="108"/>
                  </a:cubicBezTo>
                  <a:cubicBezTo>
                    <a:pt x="4" y="108"/>
                    <a:pt x="4" y="108"/>
                    <a:pt x="56" y="9"/>
                  </a:cubicBezTo>
                  <a:cubicBezTo>
                    <a:pt x="56" y="9"/>
                    <a:pt x="56" y="9"/>
                    <a:pt x="56" y="9"/>
                  </a:cubicBezTo>
                  <a:cubicBezTo>
                    <a:pt x="59" y="3"/>
                    <a:pt x="67" y="0"/>
                    <a:pt x="73" y="3"/>
                  </a:cubicBezTo>
                  <a:cubicBezTo>
                    <a:pt x="73" y="3"/>
                    <a:pt x="73" y="3"/>
                    <a:pt x="73" y="3"/>
                  </a:cubicBezTo>
                  <a:cubicBezTo>
                    <a:pt x="79" y="7"/>
                    <a:pt x="81" y="14"/>
                    <a:pt x="78" y="20"/>
                  </a:cubicBezTo>
                  <a:cubicBezTo>
                    <a:pt x="78" y="20"/>
                    <a:pt x="78" y="20"/>
                    <a:pt x="78" y="20"/>
                  </a:cubicBezTo>
                  <a:cubicBezTo>
                    <a:pt x="26" y="120"/>
                    <a:pt x="26" y="120"/>
                    <a:pt x="26" y="120"/>
                  </a:cubicBezTo>
                  <a:cubicBezTo>
                    <a:pt x="26" y="120"/>
                    <a:pt x="26" y="120"/>
                    <a:pt x="26" y="120"/>
                  </a:cubicBezTo>
                  <a:cubicBezTo>
                    <a:pt x="24" y="124"/>
                    <a:pt x="19" y="126"/>
                    <a:pt x="15" y="126"/>
                  </a:cubicBezTo>
                  <a:cubicBezTo>
                    <a:pt x="15" y="126"/>
                    <a:pt x="15" y="126"/>
                    <a:pt x="15" y="126"/>
                  </a:cubicBezTo>
                  <a:cubicBezTo>
                    <a:pt x="13" y="126"/>
                    <a:pt x="11" y="126"/>
                    <a:pt x="9" y="125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</p:grpSp>
      <p:sp>
        <p:nvSpPr>
          <p:cNvPr id="287" name="Rectangle 286">
            <a:extLst>
              <a:ext uri="{FF2B5EF4-FFF2-40B4-BE49-F238E27FC236}">
                <a16:creationId xmlns:a16="http://schemas.microsoft.com/office/drawing/2014/main" id="{DE48EFEE-6377-7445-A36A-D4E5764F818C}"/>
              </a:ext>
            </a:extLst>
          </p:cNvPr>
          <p:cNvSpPr/>
          <p:nvPr/>
        </p:nvSpPr>
        <p:spPr>
          <a:xfrm>
            <a:off x="827057" y="2578148"/>
            <a:ext cx="412492" cy="126469"/>
          </a:xfrm>
          <a:prstGeom prst="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Enhancer</a:t>
            </a:r>
          </a:p>
        </p:txBody>
      </p:sp>
      <p:grpSp>
        <p:nvGrpSpPr>
          <p:cNvPr id="288" name="Group 287">
            <a:extLst>
              <a:ext uri="{FF2B5EF4-FFF2-40B4-BE49-F238E27FC236}">
                <a16:creationId xmlns:a16="http://schemas.microsoft.com/office/drawing/2014/main" id="{55D5B73C-048A-9513-3293-79538D52F94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315881" y="2631031"/>
            <a:ext cx="720000" cy="141906"/>
            <a:chOff x="1088" y="1817"/>
            <a:chExt cx="3477" cy="685"/>
          </a:xfrm>
        </p:grpSpPr>
        <p:sp>
          <p:nvSpPr>
            <p:cNvPr id="289" name="Freeform 4">
              <a:extLst>
                <a:ext uri="{FF2B5EF4-FFF2-40B4-BE49-F238E27FC236}">
                  <a16:creationId xmlns:a16="http://schemas.microsoft.com/office/drawing/2014/main" id="{80BA3C7A-AE1C-1DF2-48B4-3002F9661932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088" y="1817"/>
              <a:ext cx="739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8 w 313"/>
                <a:gd name="T5" fmla="*/ 32 h 290"/>
                <a:gd name="T6" fmla="*/ 77 w 313"/>
                <a:gd name="T7" fmla="*/ 65 h 290"/>
                <a:gd name="T8" fmla="*/ 25 w 313"/>
                <a:gd name="T9" fmla="*/ 164 h 290"/>
                <a:gd name="T10" fmla="*/ 8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1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0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1 w 313"/>
                <a:gd name="T33" fmla="*/ 230 h 290"/>
                <a:gd name="T34" fmla="*/ 288 w 313"/>
                <a:gd name="T35" fmla="*/ 218 h 290"/>
                <a:gd name="T36" fmla="*/ 288 w 313"/>
                <a:gd name="T37" fmla="*/ 218 h 290"/>
                <a:gd name="T38" fmla="*/ 305 w 313"/>
                <a:gd name="T39" fmla="*/ 214 h 290"/>
                <a:gd name="T40" fmla="*/ 309 w 313"/>
                <a:gd name="T41" fmla="*/ 231 h 290"/>
                <a:gd name="T42" fmla="*/ 302 w 313"/>
                <a:gd name="T43" fmla="*/ 244 h 290"/>
                <a:gd name="T44" fmla="*/ 302 w 313"/>
                <a:gd name="T45" fmla="*/ 243 h 290"/>
                <a:gd name="T46" fmla="*/ 302 w 313"/>
                <a:gd name="T47" fmla="*/ 244 h 290"/>
                <a:gd name="T48" fmla="*/ 302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294 w 313"/>
                <a:gd name="T55" fmla="*/ 258 h 290"/>
                <a:gd name="T56" fmla="*/ 258 w 313"/>
                <a:gd name="T57" fmla="*/ 290 h 290"/>
                <a:gd name="T58" fmla="*/ 302 w 313"/>
                <a:gd name="T59" fmla="*/ 244 h 290"/>
                <a:gd name="T60" fmla="*/ 302 w 313"/>
                <a:gd name="T61" fmla="*/ 244 h 290"/>
                <a:gd name="T62" fmla="*/ 302 w 313"/>
                <a:gd name="T63" fmla="*/ 244 h 290"/>
                <a:gd name="T64" fmla="*/ 303 w 313"/>
                <a:gd name="T65" fmla="*/ 241 h 290"/>
                <a:gd name="T66" fmla="*/ 303 w 313"/>
                <a:gd name="T67" fmla="*/ 238 h 290"/>
                <a:gd name="T68" fmla="*/ 291 w 313"/>
                <a:gd name="T69" fmla="*/ 225 h 290"/>
                <a:gd name="T70" fmla="*/ 291 w 313"/>
                <a:gd name="T71" fmla="*/ 225 h 290"/>
                <a:gd name="T72" fmla="*/ 302 w 313"/>
                <a:gd name="T73" fmla="*/ 244 h 290"/>
                <a:gd name="T74" fmla="*/ 302 w 313"/>
                <a:gd name="T75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313" h="290">
                  <a:moveTo>
                    <a:pt x="225" y="261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2" y="26"/>
                    <a:pt x="108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4" y="26"/>
                    <a:pt x="98" y="32"/>
                  </a:cubicBezTo>
                  <a:cubicBezTo>
                    <a:pt x="98" y="32"/>
                    <a:pt x="98" y="32"/>
                    <a:pt x="98" y="32"/>
                  </a:cubicBezTo>
                  <a:cubicBezTo>
                    <a:pt x="93" y="39"/>
                    <a:pt x="85" y="50"/>
                    <a:pt x="77" y="65"/>
                  </a:cubicBezTo>
                  <a:cubicBezTo>
                    <a:pt x="77" y="65"/>
                    <a:pt x="77" y="65"/>
                    <a:pt x="77" y="65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2" y="170"/>
                    <a:pt x="14" y="173"/>
                    <a:pt x="8" y="170"/>
                  </a:cubicBezTo>
                  <a:cubicBezTo>
                    <a:pt x="8" y="170"/>
                    <a:pt x="8" y="170"/>
                    <a:pt x="8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4" y="0"/>
                    <a:pt x="134" y="13"/>
                    <a:pt x="141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55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8" y="264"/>
                    <a:pt x="259" y="263"/>
                    <a:pt x="260" y="262"/>
                  </a:cubicBezTo>
                  <a:cubicBezTo>
                    <a:pt x="260" y="262"/>
                    <a:pt x="260" y="262"/>
                    <a:pt x="260" y="262"/>
                  </a:cubicBezTo>
                  <a:cubicBezTo>
                    <a:pt x="263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0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09" y="231"/>
                  </a:cubicBezTo>
                  <a:cubicBezTo>
                    <a:pt x="309" y="231"/>
                    <a:pt x="309" y="231"/>
                    <a:pt x="309" y="231"/>
                  </a:cubicBezTo>
                  <a:cubicBezTo>
                    <a:pt x="304" y="240"/>
                    <a:pt x="303" y="243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5"/>
                    <a:pt x="301" y="246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3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1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  <a:moveTo>
                    <a:pt x="303" y="241"/>
                  </a:moveTo>
                  <a:cubicBezTo>
                    <a:pt x="303" y="240"/>
                    <a:pt x="304" y="240"/>
                    <a:pt x="303" y="238"/>
                  </a:cubicBezTo>
                  <a:cubicBezTo>
                    <a:pt x="303" y="238"/>
                    <a:pt x="303" y="238"/>
                    <a:pt x="303" y="238"/>
                  </a:cubicBezTo>
                  <a:cubicBezTo>
                    <a:pt x="303" y="239"/>
                    <a:pt x="303" y="240"/>
                    <a:pt x="303" y="241"/>
                  </a:cubicBezTo>
                  <a:close/>
                  <a:moveTo>
                    <a:pt x="291" y="225"/>
                  </a:moveTo>
                  <a:cubicBezTo>
                    <a:pt x="291" y="225"/>
                    <a:pt x="291" y="225"/>
                    <a:pt x="291" y="225"/>
                  </a:cubicBezTo>
                  <a:cubicBezTo>
                    <a:pt x="291" y="225"/>
                    <a:pt x="291" y="225"/>
                    <a:pt x="291" y="225"/>
                  </a:cubicBezTo>
                  <a:cubicBezTo>
                    <a:pt x="291" y="225"/>
                    <a:pt x="291" y="225"/>
                    <a:pt x="291" y="225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0" name="Freeform 5">
              <a:extLst>
                <a:ext uri="{FF2B5EF4-FFF2-40B4-BE49-F238E27FC236}">
                  <a16:creationId xmlns:a16="http://schemas.microsoft.com/office/drawing/2014/main" id="{579CA98A-5FF5-5C2C-0600-6CC63D9E284A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494" y="1817"/>
              <a:ext cx="742" cy="685"/>
            </a:xfrm>
            <a:custGeom>
              <a:avLst/>
              <a:gdLst>
                <a:gd name="T0" fmla="*/ 66 w 314"/>
                <a:gd name="T1" fmla="*/ 41 h 290"/>
                <a:gd name="T2" fmla="*/ 55 w 314"/>
                <a:gd name="T3" fmla="*/ 26 h 290"/>
                <a:gd name="T4" fmla="*/ 53 w 314"/>
                <a:gd name="T5" fmla="*/ 28 h 290"/>
                <a:gd name="T6" fmla="*/ 41 w 314"/>
                <a:gd name="T7" fmla="*/ 45 h 290"/>
                <a:gd name="T8" fmla="*/ 34 w 314"/>
                <a:gd name="T9" fmla="*/ 58 h 290"/>
                <a:gd name="T10" fmla="*/ 34 w 314"/>
                <a:gd name="T11" fmla="*/ 58 h 290"/>
                <a:gd name="T12" fmla="*/ 34 w 314"/>
                <a:gd name="T13" fmla="*/ 58 h 290"/>
                <a:gd name="T14" fmla="*/ 34 w 314"/>
                <a:gd name="T15" fmla="*/ 58 h 290"/>
                <a:gd name="T16" fmla="*/ 33 w 314"/>
                <a:gd name="T17" fmla="*/ 59 h 290"/>
                <a:gd name="T18" fmla="*/ 33 w 314"/>
                <a:gd name="T19" fmla="*/ 60 h 290"/>
                <a:gd name="T20" fmla="*/ 26 w 314"/>
                <a:gd name="T21" fmla="*/ 72 h 290"/>
                <a:gd name="T22" fmla="*/ 26 w 314"/>
                <a:gd name="T23" fmla="*/ 72 h 290"/>
                <a:gd name="T24" fmla="*/ 9 w 314"/>
                <a:gd name="T25" fmla="*/ 77 h 290"/>
                <a:gd name="T26" fmla="*/ 4 w 314"/>
                <a:gd name="T27" fmla="*/ 59 h 290"/>
                <a:gd name="T28" fmla="*/ 11 w 314"/>
                <a:gd name="T29" fmla="*/ 46 h 290"/>
                <a:gd name="T30" fmla="*/ 11 w 314"/>
                <a:gd name="T31" fmla="*/ 46 h 290"/>
                <a:gd name="T32" fmla="*/ 12 w 314"/>
                <a:gd name="T33" fmla="*/ 46 h 290"/>
                <a:gd name="T34" fmla="*/ 19 w 314"/>
                <a:gd name="T35" fmla="*/ 33 h 290"/>
                <a:gd name="T36" fmla="*/ 56 w 314"/>
                <a:gd name="T37" fmla="*/ 0 h 290"/>
                <a:gd name="T38" fmla="*/ 88 w 314"/>
                <a:gd name="T39" fmla="*/ 30 h 290"/>
                <a:gd name="T40" fmla="*/ 195 w 314"/>
                <a:gd name="T41" fmla="*/ 252 h 290"/>
                <a:gd name="T42" fmla="*/ 202 w 314"/>
                <a:gd name="T43" fmla="*/ 263 h 290"/>
                <a:gd name="T44" fmla="*/ 205 w 314"/>
                <a:gd name="T45" fmla="*/ 265 h 290"/>
                <a:gd name="T46" fmla="*/ 215 w 314"/>
                <a:gd name="T47" fmla="*/ 258 h 290"/>
                <a:gd name="T48" fmla="*/ 236 w 314"/>
                <a:gd name="T49" fmla="*/ 225 h 290"/>
                <a:gd name="T50" fmla="*/ 288 w 314"/>
                <a:gd name="T51" fmla="*/ 126 h 290"/>
                <a:gd name="T52" fmla="*/ 305 w 314"/>
                <a:gd name="T53" fmla="*/ 121 h 290"/>
                <a:gd name="T54" fmla="*/ 310 w 314"/>
                <a:gd name="T55" fmla="*/ 138 h 290"/>
                <a:gd name="T56" fmla="*/ 258 w 314"/>
                <a:gd name="T57" fmla="*/ 237 h 290"/>
                <a:gd name="T58" fmla="*/ 205 w 314"/>
                <a:gd name="T59" fmla="*/ 290 h 290"/>
                <a:gd name="T60" fmla="*/ 172 w 314"/>
                <a:gd name="T61" fmla="*/ 264 h 290"/>
                <a:gd name="T62" fmla="*/ 10 w 314"/>
                <a:gd name="T63" fmla="*/ 51 h 290"/>
                <a:gd name="T64" fmla="*/ 10 w 314"/>
                <a:gd name="T65" fmla="*/ 50 h 290"/>
                <a:gd name="T66" fmla="*/ 11 w 314"/>
                <a:gd name="T67" fmla="*/ 48 h 290"/>
                <a:gd name="T68" fmla="*/ 10 w 314"/>
                <a:gd name="T69" fmla="*/ 49 h 290"/>
                <a:gd name="T70" fmla="*/ 10 w 314"/>
                <a:gd name="T71" fmla="*/ 49 h 290"/>
                <a:gd name="T72" fmla="*/ 11 w 314"/>
                <a:gd name="T73" fmla="*/ 48 h 290"/>
                <a:gd name="T74" fmla="*/ 11 w 314"/>
                <a:gd name="T75" fmla="*/ 46 h 290"/>
                <a:gd name="T76" fmla="*/ 11 w 314"/>
                <a:gd name="T77" fmla="*/ 46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314" h="290">
                  <a:moveTo>
                    <a:pt x="172" y="264"/>
                  </a:moveTo>
                  <a:cubicBezTo>
                    <a:pt x="158" y="237"/>
                    <a:pt x="83" y="77"/>
                    <a:pt x="66" y="41"/>
                  </a:cubicBezTo>
                  <a:cubicBezTo>
                    <a:pt x="66" y="41"/>
                    <a:pt x="66" y="41"/>
                    <a:pt x="66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6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4"/>
                    <a:pt x="34" y="57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60"/>
                  </a:cubicBezTo>
                  <a:cubicBezTo>
                    <a:pt x="33" y="60"/>
                    <a:pt x="33" y="60"/>
                    <a:pt x="33" y="60"/>
                  </a:cubicBezTo>
                  <a:cubicBezTo>
                    <a:pt x="32" y="62"/>
                    <a:pt x="30" y="65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2" y="78"/>
                    <a:pt x="15" y="80"/>
                    <a:pt x="9" y="77"/>
                  </a:cubicBezTo>
                  <a:cubicBezTo>
                    <a:pt x="9" y="77"/>
                    <a:pt x="9" y="77"/>
                    <a:pt x="9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11" y="48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2" y="46"/>
                    <a:pt x="12" y="46"/>
                  </a:cubicBezTo>
                  <a:cubicBezTo>
                    <a:pt x="12" y="46"/>
                    <a:pt x="12" y="46"/>
                    <a:pt x="12" y="46"/>
                  </a:cubicBezTo>
                  <a:cubicBezTo>
                    <a:pt x="12" y="46"/>
                    <a:pt x="12" y="46"/>
                    <a:pt x="12" y="46"/>
                  </a:cubicBezTo>
                  <a:cubicBezTo>
                    <a:pt x="12" y="46"/>
                    <a:pt x="12" y="46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6" y="0"/>
                  </a:cubicBezTo>
                  <a:cubicBezTo>
                    <a:pt x="56" y="0"/>
                    <a:pt x="56" y="0"/>
                    <a:pt x="56" y="0"/>
                  </a:cubicBezTo>
                  <a:cubicBezTo>
                    <a:pt x="72" y="1"/>
                    <a:pt x="80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5" y="252"/>
                  </a:cubicBezTo>
                  <a:cubicBezTo>
                    <a:pt x="195" y="252"/>
                    <a:pt x="195" y="252"/>
                    <a:pt x="195" y="252"/>
                  </a:cubicBezTo>
                  <a:cubicBezTo>
                    <a:pt x="198" y="258"/>
                    <a:pt x="200" y="262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1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4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80" y="278"/>
                    <a:pt x="172" y="264"/>
                  </a:cubicBezTo>
                  <a:close/>
                  <a:moveTo>
                    <a:pt x="10" y="51"/>
                  </a:moveTo>
                  <a:cubicBezTo>
                    <a:pt x="10" y="51"/>
                    <a:pt x="10" y="51"/>
                    <a:pt x="10" y="51"/>
                  </a:cubicBezTo>
                  <a:cubicBezTo>
                    <a:pt x="10" y="50"/>
                    <a:pt x="10" y="50"/>
                    <a:pt x="10" y="50"/>
                  </a:cubicBezTo>
                  <a:cubicBezTo>
                    <a:pt x="10" y="50"/>
                    <a:pt x="10" y="50"/>
                    <a:pt x="10" y="50"/>
                  </a:cubicBezTo>
                  <a:cubicBezTo>
                    <a:pt x="10" y="50"/>
                    <a:pt x="10" y="50"/>
                    <a:pt x="10" y="51"/>
                  </a:cubicBezTo>
                  <a:close/>
                  <a:moveTo>
                    <a:pt x="11" y="48"/>
                  </a:moveTo>
                  <a:cubicBezTo>
                    <a:pt x="10" y="48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lose/>
                  <a:moveTo>
                    <a:pt x="11" y="46"/>
                  </a:move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1" name="Freeform 6">
              <a:extLst>
                <a:ext uri="{FF2B5EF4-FFF2-40B4-BE49-F238E27FC236}">
                  <a16:creationId xmlns:a16="http://schemas.microsoft.com/office/drawing/2014/main" id="{23CA7BB8-444B-7A8D-46AA-CD3B561C827D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863" y="1817"/>
              <a:ext cx="741" cy="685"/>
            </a:xfrm>
            <a:custGeom>
              <a:avLst/>
              <a:gdLst>
                <a:gd name="T0" fmla="*/ 119 w 314"/>
                <a:gd name="T1" fmla="*/ 38 h 290"/>
                <a:gd name="T2" fmla="*/ 109 w 314"/>
                <a:gd name="T3" fmla="*/ 25 h 290"/>
                <a:gd name="T4" fmla="*/ 99 w 314"/>
                <a:gd name="T5" fmla="*/ 32 h 290"/>
                <a:gd name="T6" fmla="*/ 78 w 314"/>
                <a:gd name="T7" fmla="*/ 65 h 290"/>
                <a:gd name="T8" fmla="*/ 26 w 314"/>
                <a:gd name="T9" fmla="*/ 164 h 290"/>
                <a:gd name="T10" fmla="*/ 9 w 314"/>
                <a:gd name="T11" fmla="*/ 170 h 290"/>
                <a:gd name="T12" fmla="*/ 4 w 314"/>
                <a:gd name="T13" fmla="*/ 152 h 290"/>
                <a:gd name="T14" fmla="*/ 56 w 314"/>
                <a:gd name="T15" fmla="*/ 53 h 290"/>
                <a:gd name="T16" fmla="*/ 109 w 314"/>
                <a:gd name="T17" fmla="*/ 0 h 290"/>
                <a:gd name="T18" fmla="*/ 142 w 314"/>
                <a:gd name="T19" fmla="*/ 27 h 290"/>
                <a:gd name="T20" fmla="*/ 248 w 314"/>
                <a:gd name="T21" fmla="*/ 249 h 290"/>
                <a:gd name="T22" fmla="*/ 258 w 314"/>
                <a:gd name="T23" fmla="*/ 265 h 290"/>
                <a:gd name="T24" fmla="*/ 261 w 314"/>
                <a:gd name="T25" fmla="*/ 262 h 290"/>
                <a:gd name="T26" fmla="*/ 273 w 314"/>
                <a:gd name="T27" fmla="*/ 245 h 290"/>
                <a:gd name="T28" fmla="*/ 280 w 314"/>
                <a:gd name="T29" fmla="*/ 232 h 290"/>
                <a:gd name="T30" fmla="*/ 280 w 314"/>
                <a:gd name="T31" fmla="*/ 232 h 290"/>
                <a:gd name="T32" fmla="*/ 280 w 314"/>
                <a:gd name="T33" fmla="*/ 232 h 290"/>
                <a:gd name="T34" fmla="*/ 281 w 314"/>
                <a:gd name="T35" fmla="*/ 232 h 290"/>
                <a:gd name="T36" fmla="*/ 281 w 314"/>
                <a:gd name="T37" fmla="*/ 230 h 290"/>
                <a:gd name="T38" fmla="*/ 288 w 314"/>
                <a:gd name="T39" fmla="*/ 218 h 290"/>
                <a:gd name="T40" fmla="*/ 306 w 314"/>
                <a:gd name="T41" fmla="*/ 214 h 290"/>
                <a:gd name="T42" fmla="*/ 310 w 314"/>
                <a:gd name="T43" fmla="*/ 231 h 290"/>
                <a:gd name="T44" fmla="*/ 303 w 314"/>
                <a:gd name="T45" fmla="*/ 244 h 290"/>
                <a:gd name="T46" fmla="*/ 303 w 314"/>
                <a:gd name="T47" fmla="*/ 243 h 290"/>
                <a:gd name="T48" fmla="*/ 303 w 314"/>
                <a:gd name="T49" fmla="*/ 244 h 290"/>
                <a:gd name="T50" fmla="*/ 303 w 314"/>
                <a:gd name="T51" fmla="*/ 244 h 290"/>
                <a:gd name="T52" fmla="*/ 302 w 314"/>
                <a:gd name="T53" fmla="*/ 244 h 290"/>
                <a:gd name="T54" fmla="*/ 295 w 314"/>
                <a:gd name="T55" fmla="*/ 258 h 290"/>
                <a:gd name="T56" fmla="*/ 258 w 314"/>
                <a:gd name="T57" fmla="*/ 290 h 290"/>
                <a:gd name="T58" fmla="*/ 226 w 314"/>
                <a:gd name="T59" fmla="*/ 260 h 290"/>
                <a:gd name="T60" fmla="*/ 304 w 314"/>
                <a:gd name="T61" fmla="*/ 242 h 290"/>
                <a:gd name="T62" fmla="*/ 303 w 314"/>
                <a:gd name="T63" fmla="*/ 242 h 290"/>
                <a:gd name="T64" fmla="*/ 303 w 314"/>
                <a:gd name="T65" fmla="*/ 242 h 290"/>
                <a:gd name="T66" fmla="*/ 304 w 314"/>
                <a:gd name="T67" fmla="*/ 237 h 290"/>
                <a:gd name="T68" fmla="*/ 304 w 314"/>
                <a:gd name="T69" fmla="*/ 237 h 290"/>
                <a:gd name="T70" fmla="*/ 304 w 314"/>
                <a:gd name="T71" fmla="*/ 238 h 290"/>
                <a:gd name="T72" fmla="*/ 304 w 314"/>
                <a:gd name="T73" fmla="*/ 238 h 290"/>
                <a:gd name="T74" fmla="*/ 304 w 314"/>
                <a:gd name="T75" fmla="*/ 238 h 290"/>
                <a:gd name="T76" fmla="*/ 304 w 314"/>
                <a:gd name="T77" fmla="*/ 239 h 290"/>
                <a:gd name="T78" fmla="*/ 304 w 314"/>
                <a:gd name="T79" fmla="*/ 239 h 290"/>
                <a:gd name="T80" fmla="*/ 304 w 314"/>
                <a:gd name="T81" fmla="*/ 239 h 290"/>
                <a:gd name="T82" fmla="*/ 304 w 314"/>
                <a:gd name="T83" fmla="*/ 241 h 290"/>
                <a:gd name="T84" fmla="*/ 292 w 314"/>
                <a:gd name="T85" fmla="*/ 225 h 290"/>
                <a:gd name="T86" fmla="*/ 292 w 314"/>
                <a:gd name="T87" fmla="*/ 225 h 290"/>
                <a:gd name="T88" fmla="*/ 303 w 314"/>
                <a:gd name="T89" fmla="*/ 244 h 290"/>
                <a:gd name="T90" fmla="*/ 303 w 314"/>
                <a:gd name="T91" fmla="*/ 244 h 290"/>
                <a:gd name="T92" fmla="*/ 303 w 314"/>
                <a:gd name="T93" fmla="*/ 244 h 290"/>
                <a:gd name="T94" fmla="*/ 303 w 314"/>
                <a:gd name="T95" fmla="*/ 244 h 290"/>
                <a:gd name="T96" fmla="*/ 303 w 314"/>
                <a:gd name="T97" fmla="*/ 244 h 290"/>
                <a:gd name="T98" fmla="*/ 303 w 314"/>
                <a:gd name="T99" fmla="*/ 244 h 290"/>
                <a:gd name="T100" fmla="*/ 303 w 314"/>
                <a:gd name="T101" fmla="*/ 244 h 290"/>
                <a:gd name="T102" fmla="*/ 303 w 314"/>
                <a:gd name="T103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314" h="290">
                  <a:moveTo>
                    <a:pt x="226" y="260"/>
                  </a:moveTo>
                  <a:cubicBezTo>
                    <a:pt x="208" y="224"/>
                    <a:pt x="133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9" y="25"/>
                    <a:pt x="109" y="25"/>
                  </a:cubicBezTo>
                  <a:cubicBezTo>
                    <a:pt x="109" y="25"/>
                    <a:pt x="109" y="25"/>
                    <a:pt x="109" y="25"/>
                  </a:cubicBezTo>
                  <a:cubicBezTo>
                    <a:pt x="109" y="25"/>
                    <a:pt x="105" y="26"/>
                    <a:pt x="99" y="32"/>
                  </a:cubicBezTo>
                  <a:cubicBezTo>
                    <a:pt x="99" y="32"/>
                    <a:pt x="99" y="32"/>
                    <a:pt x="99" y="32"/>
                  </a:cubicBezTo>
                  <a:cubicBezTo>
                    <a:pt x="93" y="39"/>
                    <a:pt x="86" y="50"/>
                    <a:pt x="78" y="65"/>
                  </a:cubicBezTo>
                  <a:cubicBezTo>
                    <a:pt x="78" y="65"/>
                    <a:pt x="78" y="65"/>
                    <a:pt x="78" y="65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3" y="170"/>
                    <a:pt x="15" y="173"/>
                    <a:pt x="9" y="170"/>
                  </a:cubicBezTo>
                  <a:cubicBezTo>
                    <a:pt x="9" y="170"/>
                    <a:pt x="9" y="170"/>
                    <a:pt x="9" y="170"/>
                  </a:cubicBezTo>
                  <a:cubicBezTo>
                    <a:pt x="3" y="166"/>
                    <a:pt x="0" y="159"/>
                    <a:pt x="4" y="152"/>
                  </a:cubicBezTo>
                  <a:cubicBezTo>
                    <a:pt x="4" y="152"/>
                    <a:pt x="4" y="152"/>
                    <a:pt x="4" y="152"/>
                  </a:cubicBezTo>
                  <a:cubicBezTo>
                    <a:pt x="4" y="152"/>
                    <a:pt x="4" y="152"/>
                    <a:pt x="56" y="53"/>
                  </a:cubicBezTo>
                  <a:cubicBezTo>
                    <a:pt x="56" y="53"/>
                    <a:pt x="56" y="53"/>
                    <a:pt x="56" y="53"/>
                  </a:cubicBezTo>
                  <a:cubicBezTo>
                    <a:pt x="73" y="21"/>
                    <a:pt x="86" y="2"/>
                    <a:pt x="109" y="0"/>
                  </a:cubicBezTo>
                  <a:cubicBezTo>
                    <a:pt x="109" y="0"/>
                    <a:pt x="109" y="0"/>
                    <a:pt x="109" y="0"/>
                  </a:cubicBezTo>
                  <a:cubicBezTo>
                    <a:pt x="125" y="0"/>
                    <a:pt x="134" y="13"/>
                    <a:pt x="142" y="27"/>
                  </a:cubicBezTo>
                  <a:cubicBezTo>
                    <a:pt x="142" y="27"/>
                    <a:pt x="142" y="27"/>
                    <a:pt x="142" y="27"/>
                  </a:cubicBezTo>
                  <a:cubicBezTo>
                    <a:pt x="156" y="54"/>
                    <a:pt x="231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3" y="258"/>
                    <a:pt x="257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9" y="264"/>
                    <a:pt x="260" y="263"/>
                    <a:pt x="261" y="262"/>
                  </a:cubicBezTo>
                  <a:cubicBezTo>
                    <a:pt x="261" y="262"/>
                    <a:pt x="261" y="262"/>
                    <a:pt x="261" y="262"/>
                  </a:cubicBezTo>
                  <a:cubicBezTo>
                    <a:pt x="264" y="259"/>
                    <a:pt x="268" y="253"/>
                    <a:pt x="273" y="245"/>
                  </a:cubicBezTo>
                  <a:cubicBezTo>
                    <a:pt x="273" y="245"/>
                    <a:pt x="273" y="245"/>
                    <a:pt x="273" y="245"/>
                  </a:cubicBezTo>
                  <a:cubicBezTo>
                    <a:pt x="278" y="237"/>
                    <a:pt x="279" y="234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1" y="232"/>
                    <a:pt x="281" y="232"/>
                    <a:pt x="281" y="232"/>
                  </a:cubicBezTo>
                  <a:cubicBezTo>
                    <a:pt x="281" y="231"/>
                    <a:pt x="281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2" y="212"/>
                    <a:pt x="299" y="210"/>
                    <a:pt x="306" y="214"/>
                  </a:cubicBezTo>
                  <a:cubicBezTo>
                    <a:pt x="306" y="214"/>
                    <a:pt x="306" y="214"/>
                    <a:pt x="306" y="214"/>
                  </a:cubicBezTo>
                  <a:cubicBezTo>
                    <a:pt x="312" y="217"/>
                    <a:pt x="314" y="225"/>
                    <a:pt x="310" y="231"/>
                  </a:cubicBezTo>
                  <a:cubicBezTo>
                    <a:pt x="310" y="231"/>
                    <a:pt x="310" y="231"/>
                    <a:pt x="310" y="231"/>
                  </a:cubicBezTo>
                  <a:cubicBezTo>
                    <a:pt x="305" y="240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295" y="258"/>
                  </a:cubicBezTo>
                  <a:cubicBezTo>
                    <a:pt x="295" y="258"/>
                    <a:pt x="295" y="258"/>
                    <a:pt x="295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2" y="289"/>
                    <a:pt x="234" y="277"/>
                    <a:pt x="226" y="260"/>
                  </a:cubicBezTo>
                  <a:close/>
                  <a:moveTo>
                    <a:pt x="303" y="242"/>
                  </a:moveTo>
                  <a:cubicBezTo>
                    <a:pt x="303" y="242"/>
                    <a:pt x="303" y="242"/>
                    <a:pt x="304" y="242"/>
                  </a:cubicBezTo>
                  <a:cubicBezTo>
                    <a:pt x="304" y="242"/>
                    <a:pt x="304" y="242"/>
                    <a:pt x="304" y="242"/>
                  </a:cubicBezTo>
                  <a:cubicBezTo>
                    <a:pt x="304" y="242"/>
                    <a:pt x="304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lose/>
                  <a:moveTo>
                    <a:pt x="304" y="241"/>
                  </a:moveTo>
                  <a:cubicBezTo>
                    <a:pt x="304" y="240"/>
                    <a:pt x="304" y="240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40"/>
                    <a:pt x="304" y="240"/>
                    <a:pt x="304" y="241"/>
                  </a:cubicBezTo>
                  <a:close/>
                  <a:moveTo>
                    <a:pt x="292" y="225"/>
                  </a:move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2" name="Freeform 7">
              <a:extLst>
                <a:ext uri="{FF2B5EF4-FFF2-40B4-BE49-F238E27FC236}">
                  <a16:creationId xmlns:a16="http://schemas.microsoft.com/office/drawing/2014/main" id="{C2466212-38FE-CBCA-61F5-3048B3B8D067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2271" y="1817"/>
              <a:ext cx="740" cy="685"/>
            </a:xfrm>
            <a:custGeom>
              <a:avLst/>
              <a:gdLst>
                <a:gd name="T0" fmla="*/ 65 w 313"/>
                <a:gd name="T1" fmla="*/ 41 h 290"/>
                <a:gd name="T2" fmla="*/ 55 w 313"/>
                <a:gd name="T3" fmla="*/ 26 h 290"/>
                <a:gd name="T4" fmla="*/ 53 w 313"/>
                <a:gd name="T5" fmla="*/ 28 h 290"/>
                <a:gd name="T6" fmla="*/ 41 w 313"/>
                <a:gd name="T7" fmla="*/ 45 h 290"/>
                <a:gd name="T8" fmla="*/ 33 w 313"/>
                <a:gd name="T9" fmla="*/ 58 h 290"/>
                <a:gd name="T10" fmla="*/ 33 w 313"/>
                <a:gd name="T11" fmla="*/ 58 h 290"/>
                <a:gd name="T12" fmla="*/ 33 w 313"/>
                <a:gd name="T13" fmla="*/ 59 h 290"/>
                <a:gd name="T14" fmla="*/ 33 w 313"/>
                <a:gd name="T15" fmla="*/ 59 h 290"/>
                <a:gd name="T16" fmla="*/ 32 w 313"/>
                <a:gd name="T17" fmla="*/ 60 h 290"/>
                <a:gd name="T18" fmla="*/ 25 w 313"/>
                <a:gd name="T19" fmla="*/ 72 h 290"/>
                <a:gd name="T20" fmla="*/ 25 w 313"/>
                <a:gd name="T21" fmla="*/ 72 h 290"/>
                <a:gd name="T22" fmla="*/ 8 w 313"/>
                <a:gd name="T23" fmla="*/ 77 h 290"/>
                <a:gd name="T24" fmla="*/ 4 w 313"/>
                <a:gd name="T25" fmla="*/ 59 h 290"/>
                <a:gd name="T26" fmla="*/ 11 w 313"/>
                <a:gd name="T27" fmla="*/ 47 h 290"/>
                <a:gd name="T28" fmla="*/ 11 w 313"/>
                <a:gd name="T29" fmla="*/ 46 h 290"/>
                <a:gd name="T30" fmla="*/ 19 w 313"/>
                <a:gd name="T31" fmla="*/ 33 h 290"/>
                <a:gd name="T32" fmla="*/ 55 w 313"/>
                <a:gd name="T33" fmla="*/ 0 h 290"/>
                <a:gd name="T34" fmla="*/ 88 w 313"/>
                <a:gd name="T35" fmla="*/ 30 h 290"/>
                <a:gd name="T36" fmla="*/ 194 w 313"/>
                <a:gd name="T37" fmla="*/ 252 h 290"/>
                <a:gd name="T38" fmla="*/ 202 w 313"/>
                <a:gd name="T39" fmla="*/ 263 h 290"/>
                <a:gd name="T40" fmla="*/ 205 w 313"/>
                <a:gd name="T41" fmla="*/ 265 h 290"/>
                <a:gd name="T42" fmla="*/ 215 w 313"/>
                <a:gd name="T43" fmla="*/ 258 h 290"/>
                <a:gd name="T44" fmla="*/ 236 w 313"/>
                <a:gd name="T45" fmla="*/ 225 h 290"/>
                <a:gd name="T46" fmla="*/ 288 w 313"/>
                <a:gd name="T47" fmla="*/ 126 h 290"/>
                <a:gd name="T48" fmla="*/ 305 w 313"/>
                <a:gd name="T49" fmla="*/ 121 h 290"/>
                <a:gd name="T50" fmla="*/ 310 w 313"/>
                <a:gd name="T51" fmla="*/ 138 h 290"/>
                <a:gd name="T52" fmla="*/ 258 w 313"/>
                <a:gd name="T53" fmla="*/ 237 h 290"/>
                <a:gd name="T54" fmla="*/ 205 w 313"/>
                <a:gd name="T55" fmla="*/ 290 h 290"/>
                <a:gd name="T56" fmla="*/ 172 w 313"/>
                <a:gd name="T57" fmla="*/ 264 h 290"/>
                <a:gd name="T58" fmla="*/ 10 w 313"/>
                <a:gd name="T59" fmla="*/ 49 h 290"/>
                <a:gd name="T60" fmla="*/ 10 w 313"/>
                <a:gd name="T61" fmla="*/ 49 h 290"/>
                <a:gd name="T62" fmla="*/ 10 w 313"/>
                <a:gd name="T63" fmla="*/ 49 h 290"/>
                <a:gd name="T64" fmla="*/ 10 w 313"/>
                <a:gd name="T65" fmla="*/ 48 h 290"/>
                <a:gd name="T66" fmla="*/ 10 w 313"/>
                <a:gd name="T67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313" h="290">
                  <a:moveTo>
                    <a:pt x="172" y="264"/>
                  </a:moveTo>
                  <a:cubicBezTo>
                    <a:pt x="158" y="237"/>
                    <a:pt x="83" y="77"/>
                    <a:pt x="65" y="41"/>
                  </a:cubicBezTo>
                  <a:cubicBezTo>
                    <a:pt x="65" y="41"/>
                    <a:pt x="65" y="41"/>
                    <a:pt x="65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5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5" y="55"/>
                    <a:pt x="34" y="57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2" y="60"/>
                    <a:pt x="32" y="60"/>
                  </a:cubicBezTo>
                  <a:cubicBezTo>
                    <a:pt x="32" y="60"/>
                    <a:pt x="32" y="60"/>
                    <a:pt x="32" y="60"/>
                  </a:cubicBezTo>
                  <a:cubicBezTo>
                    <a:pt x="31" y="62"/>
                    <a:pt x="29" y="65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2" y="78"/>
                    <a:pt x="14" y="80"/>
                    <a:pt x="8" y="77"/>
                  </a:cubicBezTo>
                  <a:cubicBezTo>
                    <a:pt x="8" y="77"/>
                    <a:pt x="8" y="77"/>
                    <a:pt x="8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9" y="51"/>
                    <a:pt x="10" y="48"/>
                    <a:pt x="11" y="47"/>
                  </a:cubicBezTo>
                  <a:cubicBezTo>
                    <a:pt x="11" y="47"/>
                    <a:pt x="11" y="47"/>
                    <a:pt x="11" y="47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5" y="0"/>
                  </a:cubicBezTo>
                  <a:cubicBezTo>
                    <a:pt x="55" y="0"/>
                    <a:pt x="55" y="0"/>
                    <a:pt x="55" y="0"/>
                  </a:cubicBezTo>
                  <a:cubicBezTo>
                    <a:pt x="72" y="1"/>
                    <a:pt x="79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4" y="252"/>
                  </a:cubicBezTo>
                  <a:cubicBezTo>
                    <a:pt x="194" y="252"/>
                    <a:pt x="194" y="252"/>
                    <a:pt x="194" y="252"/>
                  </a:cubicBezTo>
                  <a:cubicBezTo>
                    <a:pt x="197" y="258"/>
                    <a:pt x="200" y="261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4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0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3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79" y="278"/>
                    <a:pt x="172" y="264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0" y="48"/>
                  </a:moveTo>
                  <a:cubicBezTo>
                    <a:pt x="10" y="48"/>
                    <a:pt x="10" y="48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3" name="Freeform 8">
              <a:extLst>
                <a:ext uri="{FF2B5EF4-FFF2-40B4-BE49-F238E27FC236}">
                  <a16:creationId xmlns:a16="http://schemas.microsoft.com/office/drawing/2014/main" id="{C7056672-76CF-4942-D713-684068FDB8F7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2640" y="1817"/>
              <a:ext cx="739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9 w 313"/>
                <a:gd name="T5" fmla="*/ 32 h 290"/>
                <a:gd name="T6" fmla="*/ 78 w 313"/>
                <a:gd name="T7" fmla="*/ 65 h 290"/>
                <a:gd name="T8" fmla="*/ 26 w 313"/>
                <a:gd name="T9" fmla="*/ 164 h 290"/>
                <a:gd name="T10" fmla="*/ 9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2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1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0 w 313"/>
                <a:gd name="T33" fmla="*/ 232 h 290"/>
                <a:gd name="T34" fmla="*/ 280 w 313"/>
                <a:gd name="T35" fmla="*/ 232 h 290"/>
                <a:gd name="T36" fmla="*/ 281 w 313"/>
                <a:gd name="T37" fmla="*/ 230 h 290"/>
                <a:gd name="T38" fmla="*/ 288 w 313"/>
                <a:gd name="T39" fmla="*/ 218 h 290"/>
                <a:gd name="T40" fmla="*/ 305 w 313"/>
                <a:gd name="T41" fmla="*/ 214 h 290"/>
                <a:gd name="T42" fmla="*/ 310 w 313"/>
                <a:gd name="T43" fmla="*/ 231 h 290"/>
                <a:gd name="T44" fmla="*/ 303 w 313"/>
                <a:gd name="T45" fmla="*/ 243 h 290"/>
                <a:gd name="T46" fmla="*/ 303 w 313"/>
                <a:gd name="T47" fmla="*/ 243 h 290"/>
                <a:gd name="T48" fmla="*/ 303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302 w 313"/>
                <a:gd name="T55" fmla="*/ 244 h 290"/>
                <a:gd name="T56" fmla="*/ 294 w 313"/>
                <a:gd name="T57" fmla="*/ 258 h 290"/>
                <a:gd name="T58" fmla="*/ 258 w 313"/>
                <a:gd name="T59" fmla="*/ 290 h 290"/>
                <a:gd name="T60" fmla="*/ 225 w 313"/>
                <a:gd name="T61" fmla="*/ 260 h 290"/>
                <a:gd name="T62" fmla="*/ 259 w 313"/>
                <a:gd name="T63" fmla="*/ 265 h 290"/>
                <a:gd name="T64" fmla="*/ 259 w 313"/>
                <a:gd name="T65" fmla="*/ 265 h 290"/>
                <a:gd name="T66" fmla="*/ 303 w 313"/>
                <a:gd name="T67" fmla="*/ 242 h 290"/>
                <a:gd name="T68" fmla="*/ 303 w 313"/>
                <a:gd name="T69" fmla="*/ 242 h 290"/>
                <a:gd name="T70" fmla="*/ 303 w 313"/>
                <a:gd name="T71" fmla="*/ 242 h 290"/>
                <a:gd name="T72" fmla="*/ 304 w 313"/>
                <a:gd name="T73" fmla="*/ 238 h 290"/>
                <a:gd name="T74" fmla="*/ 304 w 313"/>
                <a:gd name="T75" fmla="*/ 239 h 290"/>
                <a:gd name="T76" fmla="*/ 303 w 313"/>
                <a:gd name="T77" fmla="*/ 241 h 290"/>
                <a:gd name="T78" fmla="*/ 302 w 313"/>
                <a:gd name="T79" fmla="*/ 231 h 290"/>
                <a:gd name="T80" fmla="*/ 302 w 313"/>
                <a:gd name="T81" fmla="*/ 231 h 290"/>
                <a:gd name="T82" fmla="*/ 292 w 313"/>
                <a:gd name="T83" fmla="*/ 225 h 290"/>
                <a:gd name="T84" fmla="*/ 292 w 313"/>
                <a:gd name="T85" fmla="*/ 225 h 290"/>
                <a:gd name="T86" fmla="*/ 303 w 313"/>
                <a:gd name="T87" fmla="*/ 244 h 290"/>
                <a:gd name="T88" fmla="*/ 303 w 313"/>
                <a:gd name="T89" fmla="*/ 243 h 290"/>
                <a:gd name="T90" fmla="*/ 302 w 313"/>
                <a:gd name="T91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13" h="290">
                  <a:moveTo>
                    <a:pt x="225" y="260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9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5" y="26"/>
                    <a:pt x="99" y="32"/>
                  </a:cubicBezTo>
                  <a:cubicBezTo>
                    <a:pt x="99" y="32"/>
                    <a:pt x="99" y="32"/>
                    <a:pt x="99" y="32"/>
                  </a:cubicBezTo>
                  <a:cubicBezTo>
                    <a:pt x="93" y="39"/>
                    <a:pt x="86" y="50"/>
                    <a:pt x="78" y="65"/>
                  </a:cubicBezTo>
                  <a:cubicBezTo>
                    <a:pt x="78" y="65"/>
                    <a:pt x="78" y="65"/>
                    <a:pt x="78" y="65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2" y="170"/>
                    <a:pt x="15" y="173"/>
                    <a:pt x="9" y="170"/>
                  </a:cubicBezTo>
                  <a:cubicBezTo>
                    <a:pt x="9" y="170"/>
                    <a:pt x="9" y="170"/>
                    <a:pt x="9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5" y="0"/>
                    <a:pt x="134" y="13"/>
                    <a:pt x="142" y="27"/>
                  </a:cubicBezTo>
                  <a:cubicBezTo>
                    <a:pt x="142" y="27"/>
                    <a:pt x="142" y="27"/>
                    <a:pt x="142" y="27"/>
                  </a:cubicBezTo>
                  <a:cubicBezTo>
                    <a:pt x="156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9" y="264"/>
                    <a:pt x="260" y="263"/>
                    <a:pt x="261" y="262"/>
                  </a:cubicBezTo>
                  <a:cubicBezTo>
                    <a:pt x="261" y="262"/>
                    <a:pt x="261" y="262"/>
                    <a:pt x="261" y="262"/>
                  </a:cubicBezTo>
                  <a:cubicBezTo>
                    <a:pt x="264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77" y="237"/>
                    <a:pt x="279" y="234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1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10" y="231"/>
                  </a:cubicBezTo>
                  <a:cubicBezTo>
                    <a:pt x="310" y="231"/>
                    <a:pt x="310" y="231"/>
                    <a:pt x="310" y="231"/>
                  </a:cubicBezTo>
                  <a:cubicBezTo>
                    <a:pt x="305" y="240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0"/>
                  </a:cubicBezTo>
                  <a:close/>
                  <a:moveTo>
                    <a:pt x="259" y="265"/>
                  </a:moveTo>
                  <a:cubicBezTo>
                    <a:pt x="259" y="265"/>
                    <a:pt x="259" y="265"/>
                    <a:pt x="259" y="265"/>
                  </a:cubicBezTo>
                  <a:cubicBezTo>
                    <a:pt x="259" y="265"/>
                    <a:pt x="259" y="265"/>
                    <a:pt x="259" y="265"/>
                  </a:cubicBezTo>
                  <a:cubicBezTo>
                    <a:pt x="259" y="265"/>
                    <a:pt x="259" y="265"/>
                    <a:pt x="259" y="265"/>
                  </a:cubicBezTo>
                  <a:close/>
                  <a:moveTo>
                    <a:pt x="303" y="242"/>
                  </a:move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lose/>
                  <a:moveTo>
                    <a:pt x="303" y="241"/>
                  </a:moveTo>
                  <a:cubicBezTo>
                    <a:pt x="304" y="240"/>
                    <a:pt x="304" y="240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40"/>
                    <a:pt x="304" y="240"/>
                    <a:pt x="303" y="241"/>
                  </a:cubicBezTo>
                  <a:close/>
                  <a:moveTo>
                    <a:pt x="302" y="231"/>
                  </a:move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lose/>
                  <a:moveTo>
                    <a:pt x="292" y="225"/>
                  </a:move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lose/>
                  <a:moveTo>
                    <a:pt x="303" y="244"/>
                  </a:move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3" y="244"/>
                    <a:pt x="303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4" name="Freeform 9">
              <a:extLst>
                <a:ext uri="{FF2B5EF4-FFF2-40B4-BE49-F238E27FC236}">
                  <a16:creationId xmlns:a16="http://schemas.microsoft.com/office/drawing/2014/main" id="{A0EC2C01-5BE1-8C0D-DC76-32E0E94632C9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049" y="1817"/>
              <a:ext cx="739" cy="685"/>
            </a:xfrm>
            <a:custGeom>
              <a:avLst/>
              <a:gdLst>
                <a:gd name="T0" fmla="*/ 65 w 313"/>
                <a:gd name="T1" fmla="*/ 41 h 290"/>
                <a:gd name="T2" fmla="*/ 55 w 313"/>
                <a:gd name="T3" fmla="*/ 26 h 290"/>
                <a:gd name="T4" fmla="*/ 52 w 313"/>
                <a:gd name="T5" fmla="*/ 28 h 290"/>
                <a:gd name="T6" fmla="*/ 41 w 313"/>
                <a:gd name="T7" fmla="*/ 45 h 290"/>
                <a:gd name="T8" fmla="*/ 33 w 313"/>
                <a:gd name="T9" fmla="*/ 58 h 290"/>
                <a:gd name="T10" fmla="*/ 33 w 313"/>
                <a:gd name="T11" fmla="*/ 58 h 290"/>
                <a:gd name="T12" fmla="*/ 33 w 313"/>
                <a:gd name="T13" fmla="*/ 58 h 290"/>
                <a:gd name="T14" fmla="*/ 33 w 313"/>
                <a:gd name="T15" fmla="*/ 58 h 290"/>
                <a:gd name="T16" fmla="*/ 33 w 313"/>
                <a:gd name="T17" fmla="*/ 59 h 290"/>
                <a:gd name="T18" fmla="*/ 32 w 313"/>
                <a:gd name="T19" fmla="*/ 60 h 290"/>
                <a:gd name="T20" fmla="*/ 25 w 313"/>
                <a:gd name="T21" fmla="*/ 72 h 290"/>
                <a:gd name="T22" fmla="*/ 8 w 313"/>
                <a:gd name="T23" fmla="*/ 77 h 290"/>
                <a:gd name="T24" fmla="*/ 3 w 313"/>
                <a:gd name="T25" fmla="*/ 59 h 290"/>
                <a:gd name="T26" fmla="*/ 10 w 313"/>
                <a:gd name="T27" fmla="*/ 47 h 290"/>
                <a:gd name="T28" fmla="*/ 11 w 313"/>
                <a:gd name="T29" fmla="*/ 46 h 290"/>
                <a:gd name="T30" fmla="*/ 19 w 313"/>
                <a:gd name="T31" fmla="*/ 33 h 290"/>
                <a:gd name="T32" fmla="*/ 55 w 313"/>
                <a:gd name="T33" fmla="*/ 0 h 290"/>
                <a:gd name="T34" fmla="*/ 88 w 313"/>
                <a:gd name="T35" fmla="*/ 30 h 290"/>
                <a:gd name="T36" fmla="*/ 194 w 313"/>
                <a:gd name="T37" fmla="*/ 252 h 290"/>
                <a:gd name="T38" fmla="*/ 202 w 313"/>
                <a:gd name="T39" fmla="*/ 263 h 290"/>
                <a:gd name="T40" fmla="*/ 205 w 313"/>
                <a:gd name="T41" fmla="*/ 265 h 290"/>
                <a:gd name="T42" fmla="*/ 214 w 313"/>
                <a:gd name="T43" fmla="*/ 258 h 290"/>
                <a:gd name="T44" fmla="*/ 235 w 313"/>
                <a:gd name="T45" fmla="*/ 225 h 290"/>
                <a:gd name="T46" fmla="*/ 287 w 313"/>
                <a:gd name="T47" fmla="*/ 126 h 290"/>
                <a:gd name="T48" fmla="*/ 304 w 313"/>
                <a:gd name="T49" fmla="*/ 121 h 290"/>
                <a:gd name="T50" fmla="*/ 310 w 313"/>
                <a:gd name="T51" fmla="*/ 138 h 290"/>
                <a:gd name="T52" fmla="*/ 258 w 313"/>
                <a:gd name="T53" fmla="*/ 237 h 290"/>
                <a:gd name="T54" fmla="*/ 205 w 313"/>
                <a:gd name="T55" fmla="*/ 290 h 290"/>
                <a:gd name="T56" fmla="*/ 172 w 313"/>
                <a:gd name="T57" fmla="*/ 264 h 290"/>
                <a:gd name="T58" fmla="*/ 10 w 313"/>
                <a:gd name="T59" fmla="*/ 49 h 290"/>
                <a:gd name="T60" fmla="*/ 10 w 313"/>
                <a:gd name="T61" fmla="*/ 49 h 290"/>
                <a:gd name="T62" fmla="*/ 10 w 313"/>
                <a:gd name="T63" fmla="*/ 48 h 290"/>
                <a:gd name="T64" fmla="*/ 10 w 313"/>
                <a:gd name="T65" fmla="*/ 48 h 290"/>
                <a:gd name="T66" fmla="*/ 10 w 313"/>
                <a:gd name="T67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313" h="290">
                  <a:moveTo>
                    <a:pt x="172" y="264"/>
                  </a:moveTo>
                  <a:cubicBezTo>
                    <a:pt x="157" y="237"/>
                    <a:pt x="83" y="77"/>
                    <a:pt x="65" y="41"/>
                  </a:cubicBezTo>
                  <a:cubicBezTo>
                    <a:pt x="65" y="41"/>
                    <a:pt x="65" y="41"/>
                    <a:pt x="65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4" y="26"/>
                    <a:pt x="53" y="27"/>
                    <a:pt x="52" y="28"/>
                  </a:cubicBezTo>
                  <a:cubicBezTo>
                    <a:pt x="52" y="28"/>
                    <a:pt x="52" y="28"/>
                    <a:pt x="52" y="28"/>
                  </a:cubicBezTo>
                  <a:cubicBezTo>
                    <a:pt x="49" y="31"/>
                    <a:pt x="45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4"/>
                    <a:pt x="34" y="57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2" y="59"/>
                    <a:pt x="32" y="60"/>
                  </a:cubicBezTo>
                  <a:cubicBezTo>
                    <a:pt x="32" y="60"/>
                    <a:pt x="32" y="60"/>
                    <a:pt x="32" y="60"/>
                  </a:cubicBezTo>
                  <a:cubicBezTo>
                    <a:pt x="31" y="62"/>
                    <a:pt x="29" y="65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2" y="78"/>
                    <a:pt x="14" y="80"/>
                    <a:pt x="8" y="77"/>
                  </a:cubicBezTo>
                  <a:cubicBezTo>
                    <a:pt x="8" y="77"/>
                    <a:pt x="8" y="77"/>
                    <a:pt x="8" y="77"/>
                  </a:cubicBezTo>
                  <a:cubicBezTo>
                    <a:pt x="2" y="73"/>
                    <a:pt x="0" y="65"/>
                    <a:pt x="3" y="59"/>
                  </a:cubicBezTo>
                  <a:cubicBezTo>
                    <a:pt x="3" y="59"/>
                    <a:pt x="3" y="59"/>
                    <a:pt x="3" y="59"/>
                  </a:cubicBezTo>
                  <a:cubicBezTo>
                    <a:pt x="8" y="51"/>
                    <a:pt x="10" y="48"/>
                    <a:pt x="10" y="47"/>
                  </a:cubicBezTo>
                  <a:cubicBezTo>
                    <a:pt x="10" y="47"/>
                    <a:pt x="10" y="47"/>
                    <a:pt x="10" y="47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2" y="45"/>
                    <a:pt x="13" y="42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29" y="16"/>
                    <a:pt x="36" y="2"/>
                    <a:pt x="55" y="0"/>
                  </a:cubicBezTo>
                  <a:cubicBezTo>
                    <a:pt x="55" y="0"/>
                    <a:pt x="55" y="0"/>
                    <a:pt x="55" y="0"/>
                  </a:cubicBezTo>
                  <a:cubicBezTo>
                    <a:pt x="72" y="1"/>
                    <a:pt x="79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4" y="252"/>
                  </a:cubicBezTo>
                  <a:cubicBezTo>
                    <a:pt x="194" y="252"/>
                    <a:pt x="194" y="252"/>
                    <a:pt x="194" y="252"/>
                  </a:cubicBezTo>
                  <a:cubicBezTo>
                    <a:pt x="197" y="258"/>
                    <a:pt x="200" y="261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4" y="265"/>
                    <a:pt x="204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8" y="264"/>
                    <a:pt x="214" y="258"/>
                  </a:cubicBezTo>
                  <a:cubicBezTo>
                    <a:pt x="214" y="258"/>
                    <a:pt x="214" y="258"/>
                    <a:pt x="214" y="258"/>
                  </a:cubicBezTo>
                  <a:cubicBezTo>
                    <a:pt x="220" y="251"/>
                    <a:pt x="227" y="241"/>
                    <a:pt x="235" y="225"/>
                  </a:cubicBezTo>
                  <a:cubicBezTo>
                    <a:pt x="235" y="225"/>
                    <a:pt x="235" y="225"/>
                    <a:pt x="235" y="225"/>
                  </a:cubicBezTo>
                  <a:cubicBezTo>
                    <a:pt x="287" y="126"/>
                    <a:pt x="287" y="126"/>
                    <a:pt x="287" y="126"/>
                  </a:cubicBezTo>
                  <a:cubicBezTo>
                    <a:pt x="287" y="126"/>
                    <a:pt x="287" y="126"/>
                    <a:pt x="287" y="126"/>
                  </a:cubicBezTo>
                  <a:cubicBezTo>
                    <a:pt x="291" y="120"/>
                    <a:pt x="298" y="118"/>
                    <a:pt x="304" y="121"/>
                  </a:cubicBezTo>
                  <a:cubicBezTo>
                    <a:pt x="304" y="121"/>
                    <a:pt x="304" y="121"/>
                    <a:pt x="304" y="121"/>
                  </a:cubicBezTo>
                  <a:cubicBezTo>
                    <a:pt x="311" y="124"/>
                    <a:pt x="313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8" y="290"/>
                    <a:pt x="179" y="278"/>
                    <a:pt x="172" y="264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0" y="48"/>
                  </a:move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5" name="Freeform 10">
              <a:extLst>
                <a:ext uri="{FF2B5EF4-FFF2-40B4-BE49-F238E27FC236}">
                  <a16:creationId xmlns:a16="http://schemas.microsoft.com/office/drawing/2014/main" id="{EAB0D9FC-BCD4-3CAF-B7E9-6EB6B795379F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417" y="1817"/>
              <a:ext cx="740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8 w 313"/>
                <a:gd name="T5" fmla="*/ 32 h 290"/>
                <a:gd name="T6" fmla="*/ 77 w 313"/>
                <a:gd name="T7" fmla="*/ 65 h 290"/>
                <a:gd name="T8" fmla="*/ 25 w 313"/>
                <a:gd name="T9" fmla="*/ 164 h 290"/>
                <a:gd name="T10" fmla="*/ 8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1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0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1 w 313"/>
                <a:gd name="T33" fmla="*/ 230 h 290"/>
                <a:gd name="T34" fmla="*/ 288 w 313"/>
                <a:gd name="T35" fmla="*/ 218 h 290"/>
                <a:gd name="T36" fmla="*/ 288 w 313"/>
                <a:gd name="T37" fmla="*/ 218 h 290"/>
                <a:gd name="T38" fmla="*/ 305 w 313"/>
                <a:gd name="T39" fmla="*/ 214 h 290"/>
                <a:gd name="T40" fmla="*/ 309 w 313"/>
                <a:gd name="T41" fmla="*/ 231 h 290"/>
                <a:gd name="T42" fmla="*/ 302 w 313"/>
                <a:gd name="T43" fmla="*/ 244 h 290"/>
                <a:gd name="T44" fmla="*/ 302 w 313"/>
                <a:gd name="T45" fmla="*/ 243 h 290"/>
                <a:gd name="T46" fmla="*/ 302 w 313"/>
                <a:gd name="T47" fmla="*/ 244 h 290"/>
                <a:gd name="T48" fmla="*/ 302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294 w 313"/>
                <a:gd name="T55" fmla="*/ 258 h 290"/>
                <a:gd name="T56" fmla="*/ 258 w 313"/>
                <a:gd name="T57" fmla="*/ 290 h 290"/>
                <a:gd name="T58" fmla="*/ 302 w 313"/>
                <a:gd name="T59" fmla="*/ 244 h 290"/>
                <a:gd name="T60" fmla="*/ 302 w 313"/>
                <a:gd name="T61" fmla="*/ 244 h 290"/>
                <a:gd name="T62" fmla="*/ 302 w 313"/>
                <a:gd name="T63" fmla="*/ 244 h 290"/>
                <a:gd name="T64" fmla="*/ 303 w 313"/>
                <a:gd name="T65" fmla="*/ 241 h 290"/>
                <a:gd name="T66" fmla="*/ 303 w 313"/>
                <a:gd name="T67" fmla="*/ 237 h 290"/>
                <a:gd name="T68" fmla="*/ 291 w 313"/>
                <a:gd name="T69" fmla="*/ 238 h 290"/>
                <a:gd name="T70" fmla="*/ 291 w 313"/>
                <a:gd name="T71" fmla="*/ 238 h 290"/>
                <a:gd name="T72" fmla="*/ 291 w 313"/>
                <a:gd name="T73" fmla="*/ 238 h 290"/>
                <a:gd name="T74" fmla="*/ 302 w 313"/>
                <a:gd name="T75" fmla="*/ 244 h 290"/>
                <a:gd name="T76" fmla="*/ 302 w 313"/>
                <a:gd name="T77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313" h="290">
                  <a:moveTo>
                    <a:pt x="225" y="260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8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4" y="26"/>
                    <a:pt x="98" y="32"/>
                  </a:cubicBezTo>
                  <a:cubicBezTo>
                    <a:pt x="98" y="32"/>
                    <a:pt x="98" y="32"/>
                    <a:pt x="98" y="32"/>
                  </a:cubicBezTo>
                  <a:cubicBezTo>
                    <a:pt x="93" y="39"/>
                    <a:pt x="85" y="50"/>
                    <a:pt x="77" y="65"/>
                  </a:cubicBezTo>
                  <a:cubicBezTo>
                    <a:pt x="77" y="65"/>
                    <a:pt x="77" y="65"/>
                    <a:pt x="77" y="65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2" y="170"/>
                    <a:pt x="14" y="173"/>
                    <a:pt x="8" y="170"/>
                  </a:cubicBezTo>
                  <a:cubicBezTo>
                    <a:pt x="8" y="170"/>
                    <a:pt x="8" y="170"/>
                    <a:pt x="8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4" y="0"/>
                    <a:pt x="134" y="13"/>
                    <a:pt x="141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55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8" y="264"/>
                    <a:pt x="259" y="263"/>
                    <a:pt x="260" y="262"/>
                  </a:cubicBezTo>
                  <a:cubicBezTo>
                    <a:pt x="260" y="262"/>
                    <a:pt x="260" y="262"/>
                    <a:pt x="260" y="262"/>
                  </a:cubicBezTo>
                  <a:cubicBezTo>
                    <a:pt x="263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0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09" y="231"/>
                  </a:cubicBezTo>
                  <a:cubicBezTo>
                    <a:pt x="309" y="231"/>
                    <a:pt x="309" y="231"/>
                    <a:pt x="309" y="231"/>
                  </a:cubicBezTo>
                  <a:cubicBezTo>
                    <a:pt x="304" y="240"/>
                    <a:pt x="303" y="243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1" y="245"/>
                    <a:pt x="300" y="247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0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  <a:moveTo>
                    <a:pt x="303" y="241"/>
                  </a:moveTo>
                  <a:cubicBezTo>
                    <a:pt x="304" y="240"/>
                    <a:pt x="304" y="239"/>
                    <a:pt x="303" y="237"/>
                  </a:cubicBezTo>
                  <a:cubicBezTo>
                    <a:pt x="303" y="237"/>
                    <a:pt x="303" y="237"/>
                    <a:pt x="303" y="237"/>
                  </a:cubicBezTo>
                  <a:cubicBezTo>
                    <a:pt x="304" y="239"/>
                    <a:pt x="303" y="240"/>
                    <a:pt x="303" y="241"/>
                  </a:cubicBezTo>
                  <a:close/>
                  <a:moveTo>
                    <a:pt x="291" y="238"/>
                  </a:moveTo>
                  <a:cubicBezTo>
                    <a:pt x="291" y="238"/>
                    <a:pt x="291" y="238"/>
                    <a:pt x="291" y="238"/>
                  </a:cubicBezTo>
                  <a:cubicBezTo>
                    <a:pt x="291" y="238"/>
                    <a:pt x="291" y="238"/>
                    <a:pt x="291" y="238"/>
                  </a:cubicBezTo>
                  <a:close/>
                  <a:moveTo>
                    <a:pt x="291" y="238"/>
                  </a:moveTo>
                  <a:cubicBezTo>
                    <a:pt x="291" y="238"/>
                    <a:pt x="291" y="238"/>
                    <a:pt x="291" y="238"/>
                  </a:cubicBezTo>
                  <a:cubicBezTo>
                    <a:pt x="291" y="238"/>
                    <a:pt x="291" y="238"/>
                    <a:pt x="291" y="238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6" name="Freeform 11">
              <a:extLst>
                <a:ext uri="{FF2B5EF4-FFF2-40B4-BE49-F238E27FC236}">
                  <a16:creationId xmlns:a16="http://schemas.microsoft.com/office/drawing/2014/main" id="{CE3D4E73-44AE-D086-5A80-DCFD8976BD38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823" y="1817"/>
              <a:ext cx="742" cy="685"/>
            </a:xfrm>
            <a:custGeom>
              <a:avLst/>
              <a:gdLst>
                <a:gd name="T0" fmla="*/ 66 w 314"/>
                <a:gd name="T1" fmla="*/ 41 h 290"/>
                <a:gd name="T2" fmla="*/ 55 w 314"/>
                <a:gd name="T3" fmla="*/ 26 h 290"/>
                <a:gd name="T4" fmla="*/ 53 w 314"/>
                <a:gd name="T5" fmla="*/ 28 h 290"/>
                <a:gd name="T6" fmla="*/ 41 w 314"/>
                <a:gd name="T7" fmla="*/ 45 h 290"/>
                <a:gd name="T8" fmla="*/ 34 w 314"/>
                <a:gd name="T9" fmla="*/ 58 h 290"/>
                <a:gd name="T10" fmla="*/ 34 w 314"/>
                <a:gd name="T11" fmla="*/ 58 h 290"/>
                <a:gd name="T12" fmla="*/ 34 w 314"/>
                <a:gd name="T13" fmla="*/ 58 h 290"/>
                <a:gd name="T14" fmla="*/ 33 w 314"/>
                <a:gd name="T15" fmla="*/ 59 h 290"/>
                <a:gd name="T16" fmla="*/ 33 w 314"/>
                <a:gd name="T17" fmla="*/ 59 h 290"/>
                <a:gd name="T18" fmla="*/ 33 w 314"/>
                <a:gd name="T19" fmla="*/ 60 h 290"/>
                <a:gd name="T20" fmla="*/ 26 w 314"/>
                <a:gd name="T21" fmla="*/ 72 h 290"/>
                <a:gd name="T22" fmla="*/ 9 w 314"/>
                <a:gd name="T23" fmla="*/ 77 h 290"/>
                <a:gd name="T24" fmla="*/ 4 w 314"/>
                <a:gd name="T25" fmla="*/ 59 h 290"/>
                <a:gd name="T26" fmla="*/ 11 w 314"/>
                <a:gd name="T27" fmla="*/ 47 h 290"/>
                <a:gd name="T28" fmla="*/ 12 w 314"/>
                <a:gd name="T29" fmla="*/ 45 h 290"/>
                <a:gd name="T30" fmla="*/ 19 w 314"/>
                <a:gd name="T31" fmla="*/ 33 h 290"/>
                <a:gd name="T32" fmla="*/ 56 w 314"/>
                <a:gd name="T33" fmla="*/ 0 h 290"/>
                <a:gd name="T34" fmla="*/ 88 w 314"/>
                <a:gd name="T35" fmla="*/ 30 h 290"/>
                <a:gd name="T36" fmla="*/ 195 w 314"/>
                <a:gd name="T37" fmla="*/ 252 h 290"/>
                <a:gd name="T38" fmla="*/ 203 w 314"/>
                <a:gd name="T39" fmla="*/ 263 h 290"/>
                <a:gd name="T40" fmla="*/ 205 w 314"/>
                <a:gd name="T41" fmla="*/ 265 h 290"/>
                <a:gd name="T42" fmla="*/ 215 w 314"/>
                <a:gd name="T43" fmla="*/ 258 h 290"/>
                <a:gd name="T44" fmla="*/ 236 w 314"/>
                <a:gd name="T45" fmla="*/ 225 h 290"/>
                <a:gd name="T46" fmla="*/ 288 w 314"/>
                <a:gd name="T47" fmla="*/ 126 h 290"/>
                <a:gd name="T48" fmla="*/ 305 w 314"/>
                <a:gd name="T49" fmla="*/ 121 h 290"/>
                <a:gd name="T50" fmla="*/ 311 w 314"/>
                <a:gd name="T51" fmla="*/ 138 h 290"/>
                <a:gd name="T52" fmla="*/ 258 w 314"/>
                <a:gd name="T53" fmla="*/ 237 h 290"/>
                <a:gd name="T54" fmla="*/ 205 w 314"/>
                <a:gd name="T55" fmla="*/ 290 h 290"/>
                <a:gd name="T56" fmla="*/ 10 w 314"/>
                <a:gd name="T57" fmla="*/ 51 h 290"/>
                <a:gd name="T58" fmla="*/ 10 w 314"/>
                <a:gd name="T59" fmla="*/ 51 h 290"/>
                <a:gd name="T60" fmla="*/ 10 w 314"/>
                <a:gd name="T61" fmla="*/ 51 h 290"/>
                <a:gd name="T62" fmla="*/ 10 w 314"/>
                <a:gd name="T63" fmla="*/ 49 h 290"/>
                <a:gd name="T64" fmla="*/ 10 w 314"/>
                <a:gd name="T65" fmla="*/ 49 h 290"/>
                <a:gd name="T66" fmla="*/ 11 w 314"/>
                <a:gd name="T67" fmla="*/ 48 h 290"/>
                <a:gd name="T68" fmla="*/ 11 w 314"/>
                <a:gd name="T69" fmla="*/ 48 h 290"/>
                <a:gd name="T70" fmla="*/ 11 w 314"/>
                <a:gd name="T71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314" h="290">
                  <a:moveTo>
                    <a:pt x="172" y="264"/>
                  </a:moveTo>
                  <a:cubicBezTo>
                    <a:pt x="158" y="237"/>
                    <a:pt x="84" y="77"/>
                    <a:pt x="66" y="41"/>
                  </a:cubicBezTo>
                  <a:cubicBezTo>
                    <a:pt x="66" y="41"/>
                    <a:pt x="66" y="41"/>
                    <a:pt x="66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6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5"/>
                    <a:pt x="34" y="57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9"/>
                    <a:pt x="34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60"/>
                  </a:cubicBezTo>
                  <a:cubicBezTo>
                    <a:pt x="33" y="60"/>
                    <a:pt x="33" y="60"/>
                    <a:pt x="33" y="60"/>
                  </a:cubicBezTo>
                  <a:cubicBezTo>
                    <a:pt x="32" y="62"/>
                    <a:pt x="30" y="65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2" y="78"/>
                    <a:pt x="15" y="80"/>
                    <a:pt x="9" y="77"/>
                  </a:cubicBezTo>
                  <a:cubicBezTo>
                    <a:pt x="9" y="77"/>
                    <a:pt x="9" y="77"/>
                    <a:pt x="9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9" y="51"/>
                    <a:pt x="11" y="48"/>
                    <a:pt x="11" y="47"/>
                  </a:cubicBezTo>
                  <a:cubicBezTo>
                    <a:pt x="11" y="47"/>
                    <a:pt x="11" y="47"/>
                    <a:pt x="11" y="47"/>
                  </a:cubicBezTo>
                  <a:cubicBezTo>
                    <a:pt x="11" y="46"/>
                    <a:pt x="12" y="45"/>
                    <a:pt x="12" y="45"/>
                  </a:cubicBezTo>
                  <a:cubicBezTo>
                    <a:pt x="12" y="45"/>
                    <a:pt x="12" y="45"/>
                    <a:pt x="12" y="45"/>
                  </a:cubicBezTo>
                  <a:cubicBezTo>
                    <a:pt x="13" y="44"/>
                    <a:pt x="15" y="40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6" y="0"/>
                  </a:cubicBezTo>
                  <a:cubicBezTo>
                    <a:pt x="56" y="0"/>
                    <a:pt x="56" y="0"/>
                    <a:pt x="56" y="0"/>
                  </a:cubicBezTo>
                  <a:cubicBezTo>
                    <a:pt x="72" y="1"/>
                    <a:pt x="80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5" y="252"/>
                  </a:cubicBezTo>
                  <a:cubicBezTo>
                    <a:pt x="195" y="252"/>
                    <a:pt x="195" y="252"/>
                    <a:pt x="195" y="252"/>
                  </a:cubicBezTo>
                  <a:cubicBezTo>
                    <a:pt x="198" y="258"/>
                    <a:pt x="201" y="262"/>
                    <a:pt x="203" y="263"/>
                  </a:cubicBezTo>
                  <a:cubicBezTo>
                    <a:pt x="203" y="263"/>
                    <a:pt x="203" y="263"/>
                    <a:pt x="203" y="263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1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4" y="132"/>
                    <a:pt x="311" y="138"/>
                  </a:cubicBezTo>
                  <a:cubicBezTo>
                    <a:pt x="311" y="138"/>
                    <a:pt x="311" y="138"/>
                    <a:pt x="311" y="138"/>
                  </a:cubicBezTo>
                  <a:cubicBezTo>
                    <a:pt x="310" y="138"/>
                    <a:pt x="311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80" y="278"/>
                    <a:pt x="172" y="264"/>
                  </a:cubicBezTo>
                  <a:close/>
                  <a:moveTo>
                    <a:pt x="10" y="51"/>
                  </a:move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1" y="48"/>
                  </a:move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7" name="Freeform 12">
              <a:extLst>
                <a:ext uri="{FF2B5EF4-FFF2-40B4-BE49-F238E27FC236}">
                  <a16:creationId xmlns:a16="http://schemas.microsoft.com/office/drawing/2014/main" id="{62560B6C-F138-6303-9AA4-EE9E24CA0B12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265" y="2103"/>
              <a:ext cx="191" cy="297"/>
            </a:xfrm>
            <a:custGeom>
              <a:avLst/>
              <a:gdLst>
                <a:gd name="T0" fmla="*/ 9 w 81"/>
                <a:gd name="T1" fmla="*/ 124 h 126"/>
                <a:gd name="T2" fmla="*/ 4 w 81"/>
                <a:gd name="T3" fmla="*/ 107 h 126"/>
                <a:gd name="T4" fmla="*/ 4 w 81"/>
                <a:gd name="T5" fmla="*/ 107 h 126"/>
                <a:gd name="T6" fmla="*/ 56 w 81"/>
                <a:gd name="T7" fmla="*/ 8 h 126"/>
                <a:gd name="T8" fmla="*/ 56 w 81"/>
                <a:gd name="T9" fmla="*/ 8 h 126"/>
                <a:gd name="T10" fmla="*/ 56 w 81"/>
                <a:gd name="T11" fmla="*/ 8 h 126"/>
                <a:gd name="T12" fmla="*/ 73 w 81"/>
                <a:gd name="T13" fmla="*/ 3 h 126"/>
                <a:gd name="T14" fmla="*/ 73 w 81"/>
                <a:gd name="T15" fmla="*/ 3 h 126"/>
                <a:gd name="T16" fmla="*/ 78 w 81"/>
                <a:gd name="T17" fmla="*/ 20 h 126"/>
                <a:gd name="T18" fmla="*/ 78 w 81"/>
                <a:gd name="T19" fmla="*/ 20 h 126"/>
                <a:gd name="T20" fmla="*/ 26 w 81"/>
                <a:gd name="T21" fmla="*/ 119 h 126"/>
                <a:gd name="T22" fmla="*/ 26 w 81"/>
                <a:gd name="T23" fmla="*/ 119 h 126"/>
                <a:gd name="T24" fmla="*/ 15 w 81"/>
                <a:gd name="T25" fmla="*/ 126 h 126"/>
                <a:gd name="T26" fmla="*/ 15 w 81"/>
                <a:gd name="T27" fmla="*/ 126 h 126"/>
                <a:gd name="T28" fmla="*/ 9 w 81"/>
                <a:gd name="T29" fmla="*/ 124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81" h="126">
                  <a:moveTo>
                    <a:pt x="9" y="124"/>
                  </a:moveTo>
                  <a:cubicBezTo>
                    <a:pt x="3" y="121"/>
                    <a:pt x="0" y="114"/>
                    <a:pt x="4" y="107"/>
                  </a:cubicBezTo>
                  <a:cubicBezTo>
                    <a:pt x="4" y="107"/>
                    <a:pt x="4" y="107"/>
                    <a:pt x="4" y="107"/>
                  </a:cubicBezTo>
                  <a:cubicBezTo>
                    <a:pt x="4" y="107"/>
                    <a:pt x="4" y="107"/>
                    <a:pt x="56" y="8"/>
                  </a:cubicBezTo>
                  <a:cubicBezTo>
                    <a:pt x="56" y="8"/>
                    <a:pt x="56" y="8"/>
                    <a:pt x="56" y="8"/>
                  </a:cubicBezTo>
                  <a:cubicBezTo>
                    <a:pt x="56" y="8"/>
                    <a:pt x="56" y="8"/>
                    <a:pt x="56" y="8"/>
                  </a:cubicBezTo>
                  <a:cubicBezTo>
                    <a:pt x="59" y="2"/>
                    <a:pt x="67" y="0"/>
                    <a:pt x="73" y="3"/>
                  </a:cubicBezTo>
                  <a:cubicBezTo>
                    <a:pt x="73" y="3"/>
                    <a:pt x="73" y="3"/>
                    <a:pt x="73" y="3"/>
                  </a:cubicBezTo>
                  <a:cubicBezTo>
                    <a:pt x="79" y="6"/>
                    <a:pt x="81" y="14"/>
                    <a:pt x="78" y="20"/>
                  </a:cubicBezTo>
                  <a:cubicBezTo>
                    <a:pt x="78" y="20"/>
                    <a:pt x="78" y="20"/>
                    <a:pt x="78" y="20"/>
                  </a:cubicBezTo>
                  <a:cubicBezTo>
                    <a:pt x="26" y="119"/>
                    <a:pt x="26" y="119"/>
                    <a:pt x="26" y="119"/>
                  </a:cubicBezTo>
                  <a:cubicBezTo>
                    <a:pt x="26" y="119"/>
                    <a:pt x="26" y="119"/>
                    <a:pt x="26" y="119"/>
                  </a:cubicBezTo>
                  <a:cubicBezTo>
                    <a:pt x="24" y="123"/>
                    <a:pt x="19" y="126"/>
                    <a:pt x="15" y="126"/>
                  </a:cubicBezTo>
                  <a:cubicBezTo>
                    <a:pt x="15" y="126"/>
                    <a:pt x="15" y="126"/>
                    <a:pt x="15" y="126"/>
                  </a:cubicBezTo>
                  <a:cubicBezTo>
                    <a:pt x="13" y="126"/>
                    <a:pt x="11" y="125"/>
                    <a:pt x="9" y="124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298" name="Freeform 13">
              <a:extLst>
                <a:ext uri="{FF2B5EF4-FFF2-40B4-BE49-F238E27FC236}">
                  <a16:creationId xmlns:a16="http://schemas.microsoft.com/office/drawing/2014/main" id="{10C592E7-DF3E-7620-3D30-F358DD528D25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4192" y="1893"/>
              <a:ext cx="191" cy="297"/>
            </a:xfrm>
            <a:custGeom>
              <a:avLst/>
              <a:gdLst>
                <a:gd name="T0" fmla="*/ 9 w 81"/>
                <a:gd name="T1" fmla="*/ 125 h 126"/>
                <a:gd name="T2" fmla="*/ 4 w 81"/>
                <a:gd name="T3" fmla="*/ 108 h 126"/>
                <a:gd name="T4" fmla="*/ 4 w 81"/>
                <a:gd name="T5" fmla="*/ 108 h 126"/>
                <a:gd name="T6" fmla="*/ 56 w 81"/>
                <a:gd name="T7" fmla="*/ 9 h 126"/>
                <a:gd name="T8" fmla="*/ 56 w 81"/>
                <a:gd name="T9" fmla="*/ 9 h 126"/>
                <a:gd name="T10" fmla="*/ 73 w 81"/>
                <a:gd name="T11" fmla="*/ 3 h 126"/>
                <a:gd name="T12" fmla="*/ 73 w 81"/>
                <a:gd name="T13" fmla="*/ 3 h 126"/>
                <a:gd name="T14" fmla="*/ 78 w 81"/>
                <a:gd name="T15" fmla="*/ 20 h 126"/>
                <a:gd name="T16" fmla="*/ 78 w 81"/>
                <a:gd name="T17" fmla="*/ 20 h 126"/>
                <a:gd name="T18" fmla="*/ 26 w 81"/>
                <a:gd name="T19" fmla="*/ 120 h 126"/>
                <a:gd name="T20" fmla="*/ 26 w 81"/>
                <a:gd name="T21" fmla="*/ 120 h 126"/>
                <a:gd name="T22" fmla="*/ 15 w 81"/>
                <a:gd name="T23" fmla="*/ 126 h 126"/>
                <a:gd name="T24" fmla="*/ 15 w 81"/>
                <a:gd name="T25" fmla="*/ 126 h 126"/>
                <a:gd name="T26" fmla="*/ 9 w 81"/>
                <a:gd name="T27" fmla="*/ 125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81" h="126">
                  <a:moveTo>
                    <a:pt x="9" y="125"/>
                  </a:moveTo>
                  <a:cubicBezTo>
                    <a:pt x="3" y="122"/>
                    <a:pt x="0" y="114"/>
                    <a:pt x="4" y="108"/>
                  </a:cubicBezTo>
                  <a:cubicBezTo>
                    <a:pt x="4" y="108"/>
                    <a:pt x="4" y="108"/>
                    <a:pt x="4" y="108"/>
                  </a:cubicBezTo>
                  <a:cubicBezTo>
                    <a:pt x="4" y="108"/>
                    <a:pt x="4" y="108"/>
                    <a:pt x="56" y="9"/>
                  </a:cubicBezTo>
                  <a:cubicBezTo>
                    <a:pt x="56" y="9"/>
                    <a:pt x="56" y="9"/>
                    <a:pt x="56" y="9"/>
                  </a:cubicBezTo>
                  <a:cubicBezTo>
                    <a:pt x="59" y="3"/>
                    <a:pt x="67" y="0"/>
                    <a:pt x="73" y="3"/>
                  </a:cubicBezTo>
                  <a:cubicBezTo>
                    <a:pt x="73" y="3"/>
                    <a:pt x="73" y="3"/>
                    <a:pt x="73" y="3"/>
                  </a:cubicBezTo>
                  <a:cubicBezTo>
                    <a:pt x="79" y="7"/>
                    <a:pt x="81" y="14"/>
                    <a:pt x="78" y="20"/>
                  </a:cubicBezTo>
                  <a:cubicBezTo>
                    <a:pt x="78" y="20"/>
                    <a:pt x="78" y="20"/>
                    <a:pt x="78" y="20"/>
                  </a:cubicBezTo>
                  <a:cubicBezTo>
                    <a:pt x="26" y="120"/>
                    <a:pt x="26" y="120"/>
                    <a:pt x="26" y="120"/>
                  </a:cubicBezTo>
                  <a:cubicBezTo>
                    <a:pt x="26" y="120"/>
                    <a:pt x="26" y="120"/>
                    <a:pt x="26" y="120"/>
                  </a:cubicBezTo>
                  <a:cubicBezTo>
                    <a:pt x="24" y="124"/>
                    <a:pt x="19" y="126"/>
                    <a:pt x="15" y="126"/>
                  </a:cubicBezTo>
                  <a:cubicBezTo>
                    <a:pt x="15" y="126"/>
                    <a:pt x="15" y="126"/>
                    <a:pt x="15" y="126"/>
                  </a:cubicBezTo>
                  <a:cubicBezTo>
                    <a:pt x="13" y="126"/>
                    <a:pt x="11" y="126"/>
                    <a:pt x="9" y="125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</p:grpSp>
      <p:sp>
        <p:nvSpPr>
          <p:cNvPr id="299" name="Rectangle 298">
            <a:extLst>
              <a:ext uri="{FF2B5EF4-FFF2-40B4-BE49-F238E27FC236}">
                <a16:creationId xmlns:a16="http://schemas.microsoft.com/office/drawing/2014/main" id="{44C50293-BF7E-00AE-7849-859BEF5E6E72}"/>
              </a:ext>
            </a:extLst>
          </p:cNvPr>
          <p:cNvSpPr/>
          <p:nvPr/>
        </p:nvSpPr>
        <p:spPr>
          <a:xfrm>
            <a:off x="1414662" y="2582957"/>
            <a:ext cx="414770" cy="116850"/>
          </a:xfrm>
          <a:prstGeom prst="rect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lIns="36000" tIns="0" rIns="36000" bIns="0" rtlCol="0" anchor="ctr"/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</a:p>
        </p:txBody>
      </p:sp>
      <p:grpSp>
        <p:nvGrpSpPr>
          <p:cNvPr id="300" name="Group 299">
            <a:extLst>
              <a:ext uri="{FF2B5EF4-FFF2-40B4-BE49-F238E27FC236}">
                <a16:creationId xmlns:a16="http://schemas.microsoft.com/office/drawing/2014/main" id="{1EDBC12D-B470-96D1-539F-B6D1E83C774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55467" y="2630897"/>
            <a:ext cx="720000" cy="141906"/>
            <a:chOff x="1088" y="1817"/>
            <a:chExt cx="3477" cy="685"/>
          </a:xfrm>
        </p:grpSpPr>
        <p:sp>
          <p:nvSpPr>
            <p:cNvPr id="301" name="Freeform 4">
              <a:extLst>
                <a:ext uri="{FF2B5EF4-FFF2-40B4-BE49-F238E27FC236}">
                  <a16:creationId xmlns:a16="http://schemas.microsoft.com/office/drawing/2014/main" id="{80FA43F4-6738-B053-6853-02FB548BEED0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088" y="1817"/>
              <a:ext cx="739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8 w 313"/>
                <a:gd name="T5" fmla="*/ 32 h 290"/>
                <a:gd name="T6" fmla="*/ 77 w 313"/>
                <a:gd name="T7" fmla="*/ 65 h 290"/>
                <a:gd name="T8" fmla="*/ 25 w 313"/>
                <a:gd name="T9" fmla="*/ 164 h 290"/>
                <a:gd name="T10" fmla="*/ 8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1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0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1 w 313"/>
                <a:gd name="T33" fmla="*/ 230 h 290"/>
                <a:gd name="T34" fmla="*/ 288 w 313"/>
                <a:gd name="T35" fmla="*/ 218 h 290"/>
                <a:gd name="T36" fmla="*/ 288 w 313"/>
                <a:gd name="T37" fmla="*/ 218 h 290"/>
                <a:gd name="T38" fmla="*/ 305 w 313"/>
                <a:gd name="T39" fmla="*/ 214 h 290"/>
                <a:gd name="T40" fmla="*/ 309 w 313"/>
                <a:gd name="T41" fmla="*/ 231 h 290"/>
                <a:gd name="T42" fmla="*/ 302 w 313"/>
                <a:gd name="T43" fmla="*/ 244 h 290"/>
                <a:gd name="T44" fmla="*/ 302 w 313"/>
                <a:gd name="T45" fmla="*/ 243 h 290"/>
                <a:gd name="T46" fmla="*/ 302 w 313"/>
                <a:gd name="T47" fmla="*/ 244 h 290"/>
                <a:gd name="T48" fmla="*/ 302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294 w 313"/>
                <a:gd name="T55" fmla="*/ 258 h 290"/>
                <a:gd name="T56" fmla="*/ 258 w 313"/>
                <a:gd name="T57" fmla="*/ 290 h 290"/>
                <a:gd name="T58" fmla="*/ 302 w 313"/>
                <a:gd name="T59" fmla="*/ 244 h 290"/>
                <a:gd name="T60" fmla="*/ 302 w 313"/>
                <a:gd name="T61" fmla="*/ 244 h 290"/>
                <a:gd name="T62" fmla="*/ 302 w 313"/>
                <a:gd name="T63" fmla="*/ 244 h 290"/>
                <a:gd name="T64" fmla="*/ 303 w 313"/>
                <a:gd name="T65" fmla="*/ 241 h 290"/>
                <a:gd name="T66" fmla="*/ 303 w 313"/>
                <a:gd name="T67" fmla="*/ 238 h 290"/>
                <a:gd name="T68" fmla="*/ 291 w 313"/>
                <a:gd name="T69" fmla="*/ 225 h 290"/>
                <a:gd name="T70" fmla="*/ 291 w 313"/>
                <a:gd name="T71" fmla="*/ 225 h 290"/>
                <a:gd name="T72" fmla="*/ 302 w 313"/>
                <a:gd name="T73" fmla="*/ 244 h 290"/>
                <a:gd name="T74" fmla="*/ 302 w 313"/>
                <a:gd name="T75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313" h="290">
                  <a:moveTo>
                    <a:pt x="225" y="261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2" y="26"/>
                    <a:pt x="108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4" y="26"/>
                    <a:pt x="98" y="32"/>
                  </a:cubicBezTo>
                  <a:cubicBezTo>
                    <a:pt x="98" y="32"/>
                    <a:pt x="98" y="32"/>
                    <a:pt x="98" y="32"/>
                  </a:cubicBezTo>
                  <a:cubicBezTo>
                    <a:pt x="93" y="39"/>
                    <a:pt x="85" y="50"/>
                    <a:pt x="77" y="65"/>
                  </a:cubicBezTo>
                  <a:cubicBezTo>
                    <a:pt x="77" y="65"/>
                    <a:pt x="77" y="65"/>
                    <a:pt x="77" y="65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2" y="170"/>
                    <a:pt x="14" y="173"/>
                    <a:pt x="8" y="170"/>
                  </a:cubicBezTo>
                  <a:cubicBezTo>
                    <a:pt x="8" y="170"/>
                    <a:pt x="8" y="170"/>
                    <a:pt x="8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4" y="0"/>
                    <a:pt x="134" y="13"/>
                    <a:pt x="141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55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8" y="264"/>
                    <a:pt x="259" y="263"/>
                    <a:pt x="260" y="262"/>
                  </a:cubicBezTo>
                  <a:cubicBezTo>
                    <a:pt x="260" y="262"/>
                    <a:pt x="260" y="262"/>
                    <a:pt x="260" y="262"/>
                  </a:cubicBezTo>
                  <a:cubicBezTo>
                    <a:pt x="263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0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09" y="231"/>
                  </a:cubicBezTo>
                  <a:cubicBezTo>
                    <a:pt x="309" y="231"/>
                    <a:pt x="309" y="231"/>
                    <a:pt x="309" y="231"/>
                  </a:cubicBezTo>
                  <a:cubicBezTo>
                    <a:pt x="304" y="240"/>
                    <a:pt x="303" y="243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5"/>
                    <a:pt x="301" y="246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3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1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  <a:moveTo>
                    <a:pt x="303" y="241"/>
                  </a:moveTo>
                  <a:cubicBezTo>
                    <a:pt x="303" y="240"/>
                    <a:pt x="304" y="240"/>
                    <a:pt x="303" y="238"/>
                  </a:cubicBezTo>
                  <a:cubicBezTo>
                    <a:pt x="303" y="238"/>
                    <a:pt x="303" y="238"/>
                    <a:pt x="303" y="238"/>
                  </a:cubicBezTo>
                  <a:cubicBezTo>
                    <a:pt x="303" y="239"/>
                    <a:pt x="303" y="240"/>
                    <a:pt x="303" y="241"/>
                  </a:cubicBezTo>
                  <a:close/>
                  <a:moveTo>
                    <a:pt x="291" y="225"/>
                  </a:moveTo>
                  <a:cubicBezTo>
                    <a:pt x="291" y="225"/>
                    <a:pt x="291" y="225"/>
                    <a:pt x="291" y="225"/>
                  </a:cubicBezTo>
                  <a:cubicBezTo>
                    <a:pt x="291" y="225"/>
                    <a:pt x="291" y="225"/>
                    <a:pt x="291" y="225"/>
                  </a:cubicBezTo>
                  <a:cubicBezTo>
                    <a:pt x="291" y="225"/>
                    <a:pt x="291" y="225"/>
                    <a:pt x="291" y="225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2" name="Freeform 5">
              <a:extLst>
                <a:ext uri="{FF2B5EF4-FFF2-40B4-BE49-F238E27FC236}">
                  <a16:creationId xmlns:a16="http://schemas.microsoft.com/office/drawing/2014/main" id="{54500E73-2215-AACC-919A-830B506FE469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494" y="1817"/>
              <a:ext cx="742" cy="685"/>
            </a:xfrm>
            <a:custGeom>
              <a:avLst/>
              <a:gdLst>
                <a:gd name="T0" fmla="*/ 66 w 314"/>
                <a:gd name="T1" fmla="*/ 41 h 290"/>
                <a:gd name="T2" fmla="*/ 55 w 314"/>
                <a:gd name="T3" fmla="*/ 26 h 290"/>
                <a:gd name="T4" fmla="*/ 53 w 314"/>
                <a:gd name="T5" fmla="*/ 28 h 290"/>
                <a:gd name="T6" fmla="*/ 41 w 314"/>
                <a:gd name="T7" fmla="*/ 45 h 290"/>
                <a:gd name="T8" fmla="*/ 34 w 314"/>
                <a:gd name="T9" fmla="*/ 58 h 290"/>
                <a:gd name="T10" fmla="*/ 34 w 314"/>
                <a:gd name="T11" fmla="*/ 58 h 290"/>
                <a:gd name="T12" fmla="*/ 34 w 314"/>
                <a:gd name="T13" fmla="*/ 58 h 290"/>
                <a:gd name="T14" fmla="*/ 34 w 314"/>
                <a:gd name="T15" fmla="*/ 58 h 290"/>
                <a:gd name="T16" fmla="*/ 33 w 314"/>
                <a:gd name="T17" fmla="*/ 59 h 290"/>
                <a:gd name="T18" fmla="*/ 33 w 314"/>
                <a:gd name="T19" fmla="*/ 60 h 290"/>
                <a:gd name="T20" fmla="*/ 26 w 314"/>
                <a:gd name="T21" fmla="*/ 72 h 290"/>
                <a:gd name="T22" fmla="*/ 26 w 314"/>
                <a:gd name="T23" fmla="*/ 72 h 290"/>
                <a:gd name="T24" fmla="*/ 9 w 314"/>
                <a:gd name="T25" fmla="*/ 77 h 290"/>
                <a:gd name="T26" fmla="*/ 4 w 314"/>
                <a:gd name="T27" fmla="*/ 59 h 290"/>
                <a:gd name="T28" fmla="*/ 11 w 314"/>
                <a:gd name="T29" fmla="*/ 46 h 290"/>
                <a:gd name="T30" fmla="*/ 11 w 314"/>
                <a:gd name="T31" fmla="*/ 46 h 290"/>
                <a:gd name="T32" fmla="*/ 12 w 314"/>
                <a:gd name="T33" fmla="*/ 46 h 290"/>
                <a:gd name="T34" fmla="*/ 19 w 314"/>
                <a:gd name="T35" fmla="*/ 33 h 290"/>
                <a:gd name="T36" fmla="*/ 56 w 314"/>
                <a:gd name="T37" fmla="*/ 0 h 290"/>
                <a:gd name="T38" fmla="*/ 88 w 314"/>
                <a:gd name="T39" fmla="*/ 30 h 290"/>
                <a:gd name="T40" fmla="*/ 195 w 314"/>
                <a:gd name="T41" fmla="*/ 252 h 290"/>
                <a:gd name="T42" fmla="*/ 202 w 314"/>
                <a:gd name="T43" fmla="*/ 263 h 290"/>
                <a:gd name="T44" fmla="*/ 205 w 314"/>
                <a:gd name="T45" fmla="*/ 265 h 290"/>
                <a:gd name="T46" fmla="*/ 215 w 314"/>
                <a:gd name="T47" fmla="*/ 258 h 290"/>
                <a:gd name="T48" fmla="*/ 236 w 314"/>
                <a:gd name="T49" fmla="*/ 225 h 290"/>
                <a:gd name="T50" fmla="*/ 288 w 314"/>
                <a:gd name="T51" fmla="*/ 126 h 290"/>
                <a:gd name="T52" fmla="*/ 305 w 314"/>
                <a:gd name="T53" fmla="*/ 121 h 290"/>
                <a:gd name="T54" fmla="*/ 310 w 314"/>
                <a:gd name="T55" fmla="*/ 138 h 290"/>
                <a:gd name="T56" fmla="*/ 258 w 314"/>
                <a:gd name="T57" fmla="*/ 237 h 290"/>
                <a:gd name="T58" fmla="*/ 205 w 314"/>
                <a:gd name="T59" fmla="*/ 290 h 290"/>
                <a:gd name="T60" fmla="*/ 172 w 314"/>
                <a:gd name="T61" fmla="*/ 264 h 290"/>
                <a:gd name="T62" fmla="*/ 10 w 314"/>
                <a:gd name="T63" fmla="*/ 51 h 290"/>
                <a:gd name="T64" fmla="*/ 10 w 314"/>
                <a:gd name="T65" fmla="*/ 50 h 290"/>
                <a:gd name="T66" fmla="*/ 11 w 314"/>
                <a:gd name="T67" fmla="*/ 48 h 290"/>
                <a:gd name="T68" fmla="*/ 10 w 314"/>
                <a:gd name="T69" fmla="*/ 49 h 290"/>
                <a:gd name="T70" fmla="*/ 10 w 314"/>
                <a:gd name="T71" fmla="*/ 49 h 290"/>
                <a:gd name="T72" fmla="*/ 11 w 314"/>
                <a:gd name="T73" fmla="*/ 48 h 290"/>
                <a:gd name="T74" fmla="*/ 11 w 314"/>
                <a:gd name="T75" fmla="*/ 46 h 290"/>
                <a:gd name="T76" fmla="*/ 11 w 314"/>
                <a:gd name="T77" fmla="*/ 46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314" h="290">
                  <a:moveTo>
                    <a:pt x="172" y="264"/>
                  </a:moveTo>
                  <a:cubicBezTo>
                    <a:pt x="158" y="237"/>
                    <a:pt x="83" y="77"/>
                    <a:pt x="66" y="41"/>
                  </a:cubicBezTo>
                  <a:cubicBezTo>
                    <a:pt x="66" y="41"/>
                    <a:pt x="66" y="41"/>
                    <a:pt x="66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6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4"/>
                    <a:pt x="34" y="57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60"/>
                  </a:cubicBezTo>
                  <a:cubicBezTo>
                    <a:pt x="33" y="60"/>
                    <a:pt x="33" y="60"/>
                    <a:pt x="33" y="60"/>
                  </a:cubicBezTo>
                  <a:cubicBezTo>
                    <a:pt x="32" y="62"/>
                    <a:pt x="30" y="65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2" y="78"/>
                    <a:pt x="15" y="80"/>
                    <a:pt x="9" y="77"/>
                  </a:cubicBezTo>
                  <a:cubicBezTo>
                    <a:pt x="9" y="77"/>
                    <a:pt x="9" y="77"/>
                    <a:pt x="9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11" y="48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2" y="46"/>
                    <a:pt x="12" y="46"/>
                  </a:cubicBezTo>
                  <a:cubicBezTo>
                    <a:pt x="12" y="46"/>
                    <a:pt x="12" y="46"/>
                    <a:pt x="12" y="46"/>
                  </a:cubicBezTo>
                  <a:cubicBezTo>
                    <a:pt x="12" y="46"/>
                    <a:pt x="12" y="46"/>
                    <a:pt x="12" y="46"/>
                  </a:cubicBezTo>
                  <a:cubicBezTo>
                    <a:pt x="12" y="46"/>
                    <a:pt x="12" y="46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6" y="0"/>
                  </a:cubicBezTo>
                  <a:cubicBezTo>
                    <a:pt x="56" y="0"/>
                    <a:pt x="56" y="0"/>
                    <a:pt x="56" y="0"/>
                  </a:cubicBezTo>
                  <a:cubicBezTo>
                    <a:pt x="72" y="1"/>
                    <a:pt x="80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5" y="252"/>
                  </a:cubicBezTo>
                  <a:cubicBezTo>
                    <a:pt x="195" y="252"/>
                    <a:pt x="195" y="252"/>
                    <a:pt x="195" y="252"/>
                  </a:cubicBezTo>
                  <a:cubicBezTo>
                    <a:pt x="198" y="258"/>
                    <a:pt x="200" y="262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1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4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80" y="278"/>
                    <a:pt x="172" y="264"/>
                  </a:cubicBezTo>
                  <a:close/>
                  <a:moveTo>
                    <a:pt x="10" y="51"/>
                  </a:moveTo>
                  <a:cubicBezTo>
                    <a:pt x="10" y="51"/>
                    <a:pt x="10" y="51"/>
                    <a:pt x="10" y="51"/>
                  </a:cubicBezTo>
                  <a:cubicBezTo>
                    <a:pt x="10" y="50"/>
                    <a:pt x="10" y="50"/>
                    <a:pt x="10" y="50"/>
                  </a:cubicBezTo>
                  <a:cubicBezTo>
                    <a:pt x="10" y="50"/>
                    <a:pt x="10" y="50"/>
                    <a:pt x="10" y="50"/>
                  </a:cubicBezTo>
                  <a:cubicBezTo>
                    <a:pt x="10" y="50"/>
                    <a:pt x="10" y="50"/>
                    <a:pt x="10" y="51"/>
                  </a:cubicBezTo>
                  <a:close/>
                  <a:moveTo>
                    <a:pt x="11" y="48"/>
                  </a:moveTo>
                  <a:cubicBezTo>
                    <a:pt x="10" y="48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lose/>
                  <a:moveTo>
                    <a:pt x="11" y="46"/>
                  </a:move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3" name="Freeform 6">
              <a:extLst>
                <a:ext uri="{FF2B5EF4-FFF2-40B4-BE49-F238E27FC236}">
                  <a16:creationId xmlns:a16="http://schemas.microsoft.com/office/drawing/2014/main" id="{A4E75AD4-BE9E-7F7B-8F4C-1E6126E334CE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1863" y="1817"/>
              <a:ext cx="741" cy="685"/>
            </a:xfrm>
            <a:custGeom>
              <a:avLst/>
              <a:gdLst>
                <a:gd name="T0" fmla="*/ 119 w 314"/>
                <a:gd name="T1" fmla="*/ 38 h 290"/>
                <a:gd name="T2" fmla="*/ 109 w 314"/>
                <a:gd name="T3" fmla="*/ 25 h 290"/>
                <a:gd name="T4" fmla="*/ 99 w 314"/>
                <a:gd name="T5" fmla="*/ 32 h 290"/>
                <a:gd name="T6" fmla="*/ 78 w 314"/>
                <a:gd name="T7" fmla="*/ 65 h 290"/>
                <a:gd name="T8" fmla="*/ 26 w 314"/>
                <a:gd name="T9" fmla="*/ 164 h 290"/>
                <a:gd name="T10" fmla="*/ 9 w 314"/>
                <a:gd name="T11" fmla="*/ 170 h 290"/>
                <a:gd name="T12" fmla="*/ 4 w 314"/>
                <a:gd name="T13" fmla="*/ 152 h 290"/>
                <a:gd name="T14" fmla="*/ 56 w 314"/>
                <a:gd name="T15" fmla="*/ 53 h 290"/>
                <a:gd name="T16" fmla="*/ 109 w 314"/>
                <a:gd name="T17" fmla="*/ 0 h 290"/>
                <a:gd name="T18" fmla="*/ 142 w 314"/>
                <a:gd name="T19" fmla="*/ 27 h 290"/>
                <a:gd name="T20" fmla="*/ 248 w 314"/>
                <a:gd name="T21" fmla="*/ 249 h 290"/>
                <a:gd name="T22" fmla="*/ 258 w 314"/>
                <a:gd name="T23" fmla="*/ 265 h 290"/>
                <a:gd name="T24" fmla="*/ 261 w 314"/>
                <a:gd name="T25" fmla="*/ 262 h 290"/>
                <a:gd name="T26" fmla="*/ 273 w 314"/>
                <a:gd name="T27" fmla="*/ 245 h 290"/>
                <a:gd name="T28" fmla="*/ 280 w 314"/>
                <a:gd name="T29" fmla="*/ 232 h 290"/>
                <a:gd name="T30" fmla="*/ 280 w 314"/>
                <a:gd name="T31" fmla="*/ 232 h 290"/>
                <a:gd name="T32" fmla="*/ 280 w 314"/>
                <a:gd name="T33" fmla="*/ 232 h 290"/>
                <a:gd name="T34" fmla="*/ 281 w 314"/>
                <a:gd name="T35" fmla="*/ 232 h 290"/>
                <a:gd name="T36" fmla="*/ 281 w 314"/>
                <a:gd name="T37" fmla="*/ 230 h 290"/>
                <a:gd name="T38" fmla="*/ 288 w 314"/>
                <a:gd name="T39" fmla="*/ 218 h 290"/>
                <a:gd name="T40" fmla="*/ 306 w 314"/>
                <a:gd name="T41" fmla="*/ 214 h 290"/>
                <a:gd name="T42" fmla="*/ 310 w 314"/>
                <a:gd name="T43" fmla="*/ 231 h 290"/>
                <a:gd name="T44" fmla="*/ 303 w 314"/>
                <a:gd name="T45" fmla="*/ 244 h 290"/>
                <a:gd name="T46" fmla="*/ 303 w 314"/>
                <a:gd name="T47" fmla="*/ 243 h 290"/>
                <a:gd name="T48" fmla="*/ 303 w 314"/>
                <a:gd name="T49" fmla="*/ 244 h 290"/>
                <a:gd name="T50" fmla="*/ 303 w 314"/>
                <a:gd name="T51" fmla="*/ 244 h 290"/>
                <a:gd name="T52" fmla="*/ 302 w 314"/>
                <a:gd name="T53" fmla="*/ 244 h 290"/>
                <a:gd name="T54" fmla="*/ 295 w 314"/>
                <a:gd name="T55" fmla="*/ 258 h 290"/>
                <a:gd name="T56" fmla="*/ 258 w 314"/>
                <a:gd name="T57" fmla="*/ 290 h 290"/>
                <a:gd name="T58" fmla="*/ 226 w 314"/>
                <a:gd name="T59" fmla="*/ 260 h 290"/>
                <a:gd name="T60" fmla="*/ 304 w 314"/>
                <a:gd name="T61" fmla="*/ 242 h 290"/>
                <a:gd name="T62" fmla="*/ 303 w 314"/>
                <a:gd name="T63" fmla="*/ 242 h 290"/>
                <a:gd name="T64" fmla="*/ 303 w 314"/>
                <a:gd name="T65" fmla="*/ 242 h 290"/>
                <a:gd name="T66" fmla="*/ 304 w 314"/>
                <a:gd name="T67" fmla="*/ 237 h 290"/>
                <a:gd name="T68" fmla="*/ 304 w 314"/>
                <a:gd name="T69" fmla="*/ 237 h 290"/>
                <a:gd name="T70" fmla="*/ 304 w 314"/>
                <a:gd name="T71" fmla="*/ 238 h 290"/>
                <a:gd name="T72" fmla="*/ 304 w 314"/>
                <a:gd name="T73" fmla="*/ 238 h 290"/>
                <a:gd name="T74" fmla="*/ 304 w 314"/>
                <a:gd name="T75" fmla="*/ 238 h 290"/>
                <a:gd name="T76" fmla="*/ 304 w 314"/>
                <a:gd name="T77" fmla="*/ 239 h 290"/>
                <a:gd name="T78" fmla="*/ 304 w 314"/>
                <a:gd name="T79" fmla="*/ 239 h 290"/>
                <a:gd name="T80" fmla="*/ 304 w 314"/>
                <a:gd name="T81" fmla="*/ 239 h 290"/>
                <a:gd name="T82" fmla="*/ 304 w 314"/>
                <a:gd name="T83" fmla="*/ 241 h 290"/>
                <a:gd name="T84" fmla="*/ 292 w 314"/>
                <a:gd name="T85" fmla="*/ 225 h 290"/>
                <a:gd name="T86" fmla="*/ 292 w 314"/>
                <a:gd name="T87" fmla="*/ 225 h 290"/>
                <a:gd name="T88" fmla="*/ 303 w 314"/>
                <a:gd name="T89" fmla="*/ 244 h 290"/>
                <a:gd name="T90" fmla="*/ 303 w 314"/>
                <a:gd name="T91" fmla="*/ 244 h 290"/>
                <a:gd name="T92" fmla="*/ 303 w 314"/>
                <a:gd name="T93" fmla="*/ 244 h 290"/>
                <a:gd name="T94" fmla="*/ 303 w 314"/>
                <a:gd name="T95" fmla="*/ 244 h 290"/>
                <a:gd name="T96" fmla="*/ 303 w 314"/>
                <a:gd name="T97" fmla="*/ 244 h 290"/>
                <a:gd name="T98" fmla="*/ 303 w 314"/>
                <a:gd name="T99" fmla="*/ 244 h 290"/>
                <a:gd name="T100" fmla="*/ 303 w 314"/>
                <a:gd name="T101" fmla="*/ 244 h 290"/>
                <a:gd name="T102" fmla="*/ 303 w 314"/>
                <a:gd name="T103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314" h="290">
                  <a:moveTo>
                    <a:pt x="226" y="260"/>
                  </a:moveTo>
                  <a:cubicBezTo>
                    <a:pt x="208" y="224"/>
                    <a:pt x="133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9" y="25"/>
                    <a:pt x="109" y="25"/>
                  </a:cubicBezTo>
                  <a:cubicBezTo>
                    <a:pt x="109" y="25"/>
                    <a:pt x="109" y="25"/>
                    <a:pt x="109" y="25"/>
                  </a:cubicBezTo>
                  <a:cubicBezTo>
                    <a:pt x="109" y="25"/>
                    <a:pt x="105" y="26"/>
                    <a:pt x="99" y="32"/>
                  </a:cubicBezTo>
                  <a:cubicBezTo>
                    <a:pt x="99" y="32"/>
                    <a:pt x="99" y="32"/>
                    <a:pt x="99" y="32"/>
                  </a:cubicBezTo>
                  <a:cubicBezTo>
                    <a:pt x="93" y="39"/>
                    <a:pt x="86" y="50"/>
                    <a:pt x="78" y="65"/>
                  </a:cubicBezTo>
                  <a:cubicBezTo>
                    <a:pt x="78" y="65"/>
                    <a:pt x="78" y="65"/>
                    <a:pt x="78" y="65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3" y="170"/>
                    <a:pt x="15" y="173"/>
                    <a:pt x="9" y="170"/>
                  </a:cubicBezTo>
                  <a:cubicBezTo>
                    <a:pt x="9" y="170"/>
                    <a:pt x="9" y="170"/>
                    <a:pt x="9" y="170"/>
                  </a:cubicBezTo>
                  <a:cubicBezTo>
                    <a:pt x="3" y="166"/>
                    <a:pt x="0" y="159"/>
                    <a:pt x="4" y="152"/>
                  </a:cubicBezTo>
                  <a:cubicBezTo>
                    <a:pt x="4" y="152"/>
                    <a:pt x="4" y="152"/>
                    <a:pt x="4" y="152"/>
                  </a:cubicBezTo>
                  <a:cubicBezTo>
                    <a:pt x="4" y="152"/>
                    <a:pt x="4" y="152"/>
                    <a:pt x="56" y="53"/>
                  </a:cubicBezTo>
                  <a:cubicBezTo>
                    <a:pt x="56" y="53"/>
                    <a:pt x="56" y="53"/>
                    <a:pt x="56" y="53"/>
                  </a:cubicBezTo>
                  <a:cubicBezTo>
                    <a:pt x="73" y="21"/>
                    <a:pt x="86" y="2"/>
                    <a:pt x="109" y="0"/>
                  </a:cubicBezTo>
                  <a:cubicBezTo>
                    <a:pt x="109" y="0"/>
                    <a:pt x="109" y="0"/>
                    <a:pt x="109" y="0"/>
                  </a:cubicBezTo>
                  <a:cubicBezTo>
                    <a:pt x="125" y="0"/>
                    <a:pt x="134" y="13"/>
                    <a:pt x="142" y="27"/>
                  </a:cubicBezTo>
                  <a:cubicBezTo>
                    <a:pt x="142" y="27"/>
                    <a:pt x="142" y="27"/>
                    <a:pt x="142" y="27"/>
                  </a:cubicBezTo>
                  <a:cubicBezTo>
                    <a:pt x="156" y="54"/>
                    <a:pt x="231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3" y="258"/>
                    <a:pt x="257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9" y="264"/>
                    <a:pt x="260" y="263"/>
                    <a:pt x="261" y="262"/>
                  </a:cubicBezTo>
                  <a:cubicBezTo>
                    <a:pt x="261" y="262"/>
                    <a:pt x="261" y="262"/>
                    <a:pt x="261" y="262"/>
                  </a:cubicBezTo>
                  <a:cubicBezTo>
                    <a:pt x="264" y="259"/>
                    <a:pt x="268" y="253"/>
                    <a:pt x="273" y="245"/>
                  </a:cubicBezTo>
                  <a:cubicBezTo>
                    <a:pt x="273" y="245"/>
                    <a:pt x="273" y="245"/>
                    <a:pt x="273" y="245"/>
                  </a:cubicBezTo>
                  <a:cubicBezTo>
                    <a:pt x="278" y="237"/>
                    <a:pt x="279" y="234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1" y="232"/>
                    <a:pt x="281" y="232"/>
                    <a:pt x="281" y="232"/>
                  </a:cubicBezTo>
                  <a:cubicBezTo>
                    <a:pt x="281" y="231"/>
                    <a:pt x="281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2" y="212"/>
                    <a:pt x="299" y="210"/>
                    <a:pt x="306" y="214"/>
                  </a:cubicBezTo>
                  <a:cubicBezTo>
                    <a:pt x="306" y="214"/>
                    <a:pt x="306" y="214"/>
                    <a:pt x="306" y="214"/>
                  </a:cubicBezTo>
                  <a:cubicBezTo>
                    <a:pt x="312" y="217"/>
                    <a:pt x="314" y="225"/>
                    <a:pt x="310" y="231"/>
                  </a:cubicBezTo>
                  <a:cubicBezTo>
                    <a:pt x="310" y="231"/>
                    <a:pt x="310" y="231"/>
                    <a:pt x="310" y="231"/>
                  </a:cubicBezTo>
                  <a:cubicBezTo>
                    <a:pt x="305" y="240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295" y="258"/>
                  </a:cubicBezTo>
                  <a:cubicBezTo>
                    <a:pt x="295" y="258"/>
                    <a:pt x="295" y="258"/>
                    <a:pt x="295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2" y="289"/>
                    <a:pt x="234" y="277"/>
                    <a:pt x="226" y="260"/>
                  </a:cubicBezTo>
                  <a:close/>
                  <a:moveTo>
                    <a:pt x="303" y="242"/>
                  </a:moveTo>
                  <a:cubicBezTo>
                    <a:pt x="303" y="242"/>
                    <a:pt x="303" y="242"/>
                    <a:pt x="304" y="242"/>
                  </a:cubicBezTo>
                  <a:cubicBezTo>
                    <a:pt x="304" y="242"/>
                    <a:pt x="304" y="242"/>
                    <a:pt x="304" y="242"/>
                  </a:cubicBezTo>
                  <a:cubicBezTo>
                    <a:pt x="304" y="242"/>
                    <a:pt x="304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lose/>
                  <a:moveTo>
                    <a:pt x="304" y="241"/>
                  </a:moveTo>
                  <a:cubicBezTo>
                    <a:pt x="304" y="240"/>
                    <a:pt x="304" y="240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7"/>
                    <a:pt x="304" y="237"/>
                    <a:pt x="304" y="237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8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40"/>
                    <a:pt x="304" y="240"/>
                    <a:pt x="304" y="241"/>
                  </a:cubicBezTo>
                  <a:close/>
                  <a:moveTo>
                    <a:pt x="292" y="225"/>
                  </a:move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  <a:moveTo>
                    <a:pt x="303" y="244"/>
                  </a:move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4" name="Freeform 7">
              <a:extLst>
                <a:ext uri="{FF2B5EF4-FFF2-40B4-BE49-F238E27FC236}">
                  <a16:creationId xmlns:a16="http://schemas.microsoft.com/office/drawing/2014/main" id="{DEF40E3A-D09C-BCD3-B9BF-2804C0E60DD8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2271" y="1817"/>
              <a:ext cx="740" cy="685"/>
            </a:xfrm>
            <a:custGeom>
              <a:avLst/>
              <a:gdLst>
                <a:gd name="T0" fmla="*/ 65 w 313"/>
                <a:gd name="T1" fmla="*/ 41 h 290"/>
                <a:gd name="T2" fmla="*/ 55 w 313"/>
                <a:gd name="T3" fmla="*/ 26 h 290"/>
                <a:gd name="T4" fmla="*/ 53 w 313"/>
                <a:gd name="T5" fmla="*/ 28 h 290"/>
                <a:gd name="T6" fmla="*/ 41 w 313"/>
                <a:gd name="T7" fmla="*/ 45 h 290"/>
                <a:gd name="T8" fmla="*/ 33 w 313"/>
                <a:gd name="T9" fmla="*/ 58 h 290"/>
                <a:gd name="T10" fmla="*/ 33 w 313"/>
                <a:gd name="T11" fmla="*/ 58 h 290"/>
                <a:gd name="T12" fmla="*/ 33 w 313"/>
                <a:gd name="T13" fmla="*/ 59 h 290"/>
                <a:gd name="T14" fmla="*/ 33 w 313"/>
                <a:gd name="T15" fmla="*/ 59 h 290"/>
                <a:gd name="T16" fmla="*/ 32 w 313"/>
                <a:gd name="T17" fmla="*/ 60 h 290"/>
                <a:gd name="T18" fmla="*/ 25 w 313"/>
                <a:gd name="T19" fmla="*/ 72 h 290"/>
                <a:gd name="T20" fmla="*/ 25 w 313"/>
                <a:gd name="T21" fmla="*/ 72 h 290"/>
                <a:gd name="T22" fmla="*/ 8 w 313"/>
                <a:gd name="T23" fmla="*/ 77 h 290"/>
                <a:gd name="T24" fmla="*/ 4 w 313"/>
                <a:gd name="T25" fmla="*/ 59 h 290"/>
                <a:gd name="T26" fmla="*/ 11 w 313"/>
                <a:gd name="T27" fmla="*/ 47 h 290"/>
                <a:gd name="T28" fmla="*/ 11 w 313"/>
                <a:gd name="T29" fmla="*/ 46 h 290"/>
                <a:gd name="T30" fmla="*/ 19 w 313"/>
                <a:gd name="T31" fmla="*/ 33 h 290"/>
                <a:gd name="T32" fmla="*/ 55 w 313"/>
                <a:gd name="T33" fmla="*/ 0 h 290"/>
                <a:gd name="T34" fmla="*/ 88 w 313"/>
                <a:gd name="T35" fmla="*/ 30 h 290"/>
                <a:gd name="T36" fmla="*/ 194 w 313"/>
                <a:gd name="T37" fmla="*/ 252 h 290"/>
                <a:gd name="T38" fmla="*/ 202 w 313"/>
                <a:gd name="T39" fmla="*/ 263 h 290"/>
                <a:gd name="T40" fmla="*/ 205 w 313"/>
                <a:gd name="T41" fmla="*/ 265 h 290"/>
                <a:gd name="T42" fmla="*/ 215 w 313"/>
                <a:gd name="T43" fmla="*/ 258 h 290"/>
                <a:gd name="T44" fmla="*/ 236 w 313"/>
                <a:gd name="T45" fmla="*/ 225 h 290"/>
                <a:gd name="T46" fmla="*/ 288 w 313"/>
                <a:gd name="T47" fmla="*/ 126 h 290"/>
                <a:gd name="T48" fmla="*/ 305 w 313"/>
                <a:gd name="T49" fmla="*/ 121 h 290"/>
                <a:gd name="T50" fmla="*/ 310 w 313"/>
                <a:gd name="T51" fmla="*/ 138 h 290"/>
                <a:gd name="T52" fmla="*/ 258 w 313"/>
                <a:gd name="T53" fmla="*/ 237 h 290"/>
                <a:gd name="T54" fmla="*/ 205 w 313"/>
                <a:gd name="T55" fmla="*/ 290 h 290"/>
                <a:gd name="T56" fmla="*/ 172 w 313"/>
                <a:gd name="T57" fmla="*/ 264 h 290"/>
                <a:gd name="T58" fmla="*/ 10 w 313"/>
                <a:gd name="T59" fmla="*/ 49 h 290"/>
                <a:gd name="T60" fmla="*/ 10 w 313"/>
                <a:gd name="T61" fmla="*/ 49 h 290"/>
                <a:gd name="T62" fmla="*/ 10 w 313"/>
                <a:gd name="T63" fmla="*/ 49 h 290"/>
                <a:gd name="T64" fmla="*/ 10 w 313"/>
                <a:gd name="T65" fmla="*/ 48 h 290"/>
                <a:gd name="T66" fmla="*/ 10 w 313"/>
                <a:gd name="T67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313" h="290">
                  <a:moveTo>
                    <a:pt x="172" y="264"/>
                  </a:moveTo>
                  <a:cubicBezTo>
                    <a:pt x="158" y="237"/>
                    <a:pt x="83" y="77"/>
                    <a:pt x="65" y="41"/>
                  </a:cubicBezTo>
                  <a:cubicBezTo>
                    <a:pt x="65" y="41"/>
                    <a:pt x="65" y="41"/>
                    <a:pt x="65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5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5" y="55"/>
                    <a:pt x="34" y="57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2" y="60"/>
                    <a:pt x="32" y="60"/>
                  </a:cubicBezTo>
                  <a:cubicBezTo>
                    <a:pt x="32" y="60"/>
                    <a:pt x="32" y="60"/>
                    <a:pt x="32" y="60"/>
                  </a:cubicBezTo>
                  <a:cubicBezTo>
                    <a:pt x="31" y="62"/>
                    <a:pt x="29" y="65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2" y="78"/>
                    <a:pt x="14" y="80"/>
                    <a:pt x="8" y="77"/>
                  </a:cubicBezTo>
                  <a:cubicBezTo>
                    <a:pt x="8" y="77"/>
                    <a:pt x="8" y="77"/>
                    <a:pt x="8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9" y="51"/>
                    <a:pt x="10" y="48"/>
                    <a:pt x="11" y="47"/>
                  </a:cubicBezTo>
                  <a:cubicBezTo>
                    <a:pt x="11" y="47"/>
                    <a:pt x="11" y="47"/>
                    <a:pt x="11" y="47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5" y="0"/>
                  </a:cubicBezTo>
                  <a:cubicBezTo>
                    <a:pt x="55" y="0"/>
                    <a:pt x="55" y="0"/>
                    <a:pt x="55" y="0"/>
                  </a:cubicBezTo>
                  <a:cubicBezTo>
                    <a:pt x="72" y="1"/>
                    <a:pt x="79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4" y="252"/>
                  </a:cubicBezTo>
                  <a:cubicBezTo>
                    <a:pt x="194" y="252"/>
                    <a:pt x="194" y="252"/>
                    <a:pt x="194" y="252"/>
                  </a:cubicBezTo>
                  <a:cubicBezTo>
                    <a:pt x="197" y="258"/>
                    <a:pt x="200" y="261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4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0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3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79" y="278"/>
                    <a:pt x="172" y="264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0" y="48"/>
                  </a:moveTo>
                  <a:cubicBezTo>
                    <a:pt x="10" y="48"/>
                    <a:pt x="10" y="48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5" name="Freeform 8">
              <a:extLst>
                <a:ext uri="{FF2B5EF4-FFF2-40B4-BE49-F238E27FC236}">
                  <a16:creationId xmlns:a16="http://schemas.microsoft.com/office/drawing/2014/main" id="{51BB09EB-4EBD-A40E-CF37-618790D1C3AA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2640" y="1817"/>
              <a:ext cx="739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9 w 313"/>
                <a:gd name="T5" fmla="*/ 32 h 290"/>
                <a:gd name="T6" fmla="*/ 78 w 313"/>
                <a:gd name="T7" fmla="*/ 65 h 290"/>
                <a:gd name="T8" fmla="*/ 26 w 313"/>
                <a:gd name="T9" fmla="*/ 164 h 290"/>
                <a:gd name="T10" fmla="*/ 9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2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1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0 w 313"/>
                <a:gd name="T33" fmla="*/ 232 h 290"/>
                <a:gd name="T34" fmla="*/ 280 w 313"/>
                <a:gd name="T35" fmla="*/ 232 h 290"/>
                <a:gd name="T36" fmla="*/ 281 w 313"/>
                <a:gd name="T37" fmla="*/ 230 h 290"/>
                <a:gd name="T38" fmla="*/ 288 w 313"/>
                <a:gd name="T39" fmla="*/ 218 h 290"/>
                <a:gd name="T40" fmla="*/ 305 w 313"/>
                <a:gd name="T41" fmla="*/ 214 h 290"/>
                <a:gd name="T42" fmla="*/ 310 w 313"/>
                <a:gd name="T43" fmla="*/ 231 h 290"/>
                <a:gd name="T44" fmla="*/ 303 w 313"/>
                <a:gd name="T45" fmla="*/ 243 h 290"/>
                <a:gd name="T46" fmla="*/ 303 w 313"/>
                <a:gd name="T47" fmla="*/ 243 h 290"/>
                <a:gd name="T48" fmla="*/ 303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302 w 313"/>
                <a:gd name="T55" fmla="*/ 244 h 290"/>
                <a:gd name="T56" fmla="*/ 294 w 313"/>
                <a:gd name="T57" fmla="*/ 258 h 290"/>
                <a:gd name="T58" fmla="*/ 258 w 313"/>
                <a:gd name="T59" fmla="*/ 290 h 290"/>
                <a:gd name="T60" fmla="*/ 225 w 313"/>
                <a:gd name="T61" fmla="*/ 260 h 290"/>
                <a:gd name="T62" fmla="*/ 259 w 313"/>
                <a:gd name="T63" fmla="*/ 265 h 290"/>
                <a:gd name="T64" fmla="*/ 259 w 313"/>
                <a:gd name="T65" fmla="*/ 265 h 290"/>
                <a:gd name="T66" fmla="*/ 303 w 313"/>
                <a:gd name="T67" fmla="*/ 242 h 290"/>
                <a:gd name="T68" fmla="*/ 303 w 313"/>
                <a:gd name="T69" fmla="*/ 242 h 290"/>
                <a:gd name="T70" fmla="*/ 303 w 313"/>
                <a:gd name="T71" fmla="*/ 242 h 290"/>
                <a:gd name="T72" fmla="*/ 304 w 313"/>
                <a:gd name="T73" fmla="*/ 238 h 290"/>
                <a:gd name="T74" fmla="*/ 304 w 313"/>
                <a:gd name="T75" fmla="*/ 239 h 290"/>
                <a:gd name="T76" fmla="*/ 303 w 313"/>
                <a:gd name="T77" fmla="*/ 241 h 290"/>
                <a:gd name="T78" fmla="*/ 302 w 313"/>
                <a:gd name="T79" fmla="*/ 231 h 290"/>
                <a:gd name="T80" fmla="*/ 302 w 313"/>
                <a:gd name="T81" fmla="*/ 231 h 290"/>
                <a:gd name="T82" fmla="*/ 292 w 313"/>
                <a:gd name="T83" fmla="*/ 225 h 290"/>
                <a:gd name="T84" fmla="*/ 292 w 313"/>
                <a:gd name="T85" fmla="*/ 225 h 290"/>
                <a:gd name="T86" fmla="*/ 303 w 313"/>
                <a:gd name="T87" fmla="*/ 244 h 290"/>
                <a:gd name="T88" fmla="*/ 303 w 313"/>
                <a:gd name="T89" fmla="*/ 243 h 290"/>
                <a:gd name="T90" fmla="*/ 302 w 313"/>
                <a:gd name="T91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313" h="290">
                  <a:moveTo>
                    <a:pt x="225" y="260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9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5" y="26"/>
                    <a:pt x="99" y="32"/>
                  </a:cubicBezTo>
                  <a:cubicBezTo>
                    <a:pt x="99" y="32"/>
                    <a:pt x="99" y="32"/>
                    <a:pt x="99" y="32"/>
                  </a:cubicBezTo>
                  <a:cubicBezTo>
                    <a:pt x="93" y="39"/>
                    <a:pt x="86" y="50"/>
                    <a:pt x="78" y="65"/>
                  </a:cubicBezTo>
                  <a:cubicBezTo>
                    <a:pt x="78" y="65"/>
                    <a:pt x="78" y="65"/>
                    <a:pt x="78" y="65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6" y="164"/>
                    <a:pt x="26" y="164"/>
                    <a:pt x="26" y="164"/>
                  </a:cubicBezTo>
                  <a:cubicBezTo>
                    <a:pt x="22" y="170"/>
                    <a:pt x="15" y="173"/>
                    <a:pt x="9" y="170"/>
                  </a:cubicBezTo>
                  <a:cubicBezTo>
                    <a:pt x="9" y="170"/>
                    <a:pt x="9" y="170"/>
                    <a:pt x="9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5" y="0"/>
                    <a:pt x="134" y="13"/>
                    <a:pt x="142" y="27"/>
                  </a:cubicBezTo>
                  <a:cubicBezTo>
                    <a:pt x="142" y="27"/>
                    <a:pt x="142" y="27"/>
                    <a:pt x="142" y="27"/>
                  </a:cubicBezTo>
                  <a:cubicBezTo>
                    <a:pt x="156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9" y="264"/>
                    <a:pt x="260" y="263"/>
                    <a:pt x="261" y="262"/>
                  </a:cubicBezTo>
                  <a:cubicBezTo>
                    <a:pt x="261" y="262"/>
                    <a:pt x="261" y="262"/>
                    <a:pt x="261" y="262"/>
                  </a:cubicBezTo>
                  <a:cubicBezTo>
                    <a:pt x="264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77" y="237"/>
                    <a:pt x="279" y="234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1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10" y="231"/>
                  </a:cubicBezTo>
                  <a:cubicBezTo>
                    <a:pt x="310" y="231"/>
                    <a:pt x="310" y="231"/>
                    <a:pt x="310" y="231"/>
                  </a:cubicBezTo>
                  <a:cubicBezTo>
                    <a:pt x="305" y="240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4"/>
                  </a:cubicBezTo>
                  <a:cubicBezTo>
                    <a:pt x="303" y="244"/>
                    <a:pt x="303" y="244"/>
                    <a:pt x="303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0"/>
                  </a:cubicBezTo>
                  <a:close/>
                  <a:moveTo>
                    <a:pt x="259" y="265"/>
                  </a:moveTo>
                  <a:cubicBezTo>
                    <a:pt x="259" y="265"/>
                    <a:pt x="259" y="265"/>
                    <a:pt x="259" y="265"/>
                  </a:cubicBezTo>
                  <a:cubicBezTo>
                    <a:pt x="259" y="265"/>
                    <a:pt x="259" y="265"/>
                    <a:pt x="259" y="265"/>
                  </a:cubicBezTo>
                  <a:cubicBezTo>
                    <a:pt x="259" y="265"/>
                    <a:pt x="259" y="265"/>
                    <a:pt x="259" y="265"/>
                  </a:cubicBezTo>
                  <a:close/>
                  <a:moveTo>
                    <a:pt x="303" y="242"/>
                  </a:move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ubicBezTo>
                    <a:pt x="303" y="242"/>
                    <a:pt x="303" y="242"/>
                    <a:pt x="303" y="242"/>
                  </a:cubicBezTo>
                  <a:close/>
                  <a:moveTo>
                    <a:pt x="303" y="241"/>
                  </a:moveTo>
                  <a:cubicBezTo>
                    <a:pt x="304" y="240"/>
                    <a:pt x="304" y="240"/>
                    <a:pt x="304" y="238"/>
                  </a:cubicBezTo>
                  <a:cubicBezTo>
                    <a:pt x="304" y="238"/>
                    <a:pt x="304" y="238"/>
                    <a:pt x="304" y="238"/>
                  </a:cubicBezTo>
                  <a:cubicBezTo>
                    <a:pt x="304" y="238"/>
                    <a:pt x="304" y="239"/>
                    <a:pt x="304" y="239"/>
                  </a:cubicBezTo>
                  <a:cubicBezTo>
                    <a:pt x="304" y="239"/>
                    <a:pt x="304" y="239"/>
                    <a:pt x="304" y="239"/>
                  </a:cubicBezTo>
                  <a:cubicBezTo>
                    <a:pt x="304" y="240"/>
                    <a:pt x="304" y="240"/>
                    <a:pt x="303" y="241"/>
                  </a:cubicBezTo>
                  <a:close/>
                  <a:moveTo>
                    <a:pt x="302" y="231"/>
                  </a:move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ubicBezTo>
                    <a:pt x="302" y="231"/>
                    <a:pt x="302" y="231"/>
                    <a:pt x="302" y="231"/>
                  </a:cubicBezTo>
                  <a:close/>
                  <a:moveTo>
                    <a:pt x="292" y="225"/>
                  </a:move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ubicBezTo>
                    <a:pt x="292" y="225"/>
                    <a:pt x="292" y="225"/>
                    <a:pt x="292" y="225"/>
                  </a:cubicBezTo>
                  <a:close/>
                  <a:moveTo>
                    <a:pt x="303" y="244"/>
                  </a:moveTo>
                  <a:cubicBezTo>
                    <a:pt x="303" y="243"/>
                    <a:pt x="303" y="243"/>
                    <a:pt x="303" y="243"/>
                  </a:cubicBezTo>
                  <a:cubicBezTo>
                    <a:pt x="303" y="243"/>
                    <a:pt x="303" y="243"/>
                    <a:pt x="303" y="243"/>
                  </a:cubicBezTo>
                  <a:cubicBezTo>
                    <a:pt x="303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3" y="244"/>
                    <a:pt x="303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6" name="Freeform 9">
              <a:extLst>
                <a:ext uri="{FF2B5EF4-FFF2-40B4-BE49-F238E27FC236}">
                  <a16:creationId xmlns:a16="http://schemas.microsoft.com/office/drawing/2014/main" id="{E9440ED7-ED48-7EF2-A79B-FD3A0E202C04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049" y="1817"/>
              <a:ext cx="739" cy="685"/>
            </a:xfrm>
            <a:custGeom>
              <a:avLst/>
              <a:gdLst>
                <a:gd name="T0" fmla="*/ 65 w 313"/>
                <a:gd name="T1" fmla="*/ 41 h 290"/>
                <a:gd name="T2" fmla="*/ 55 w 313"/>
                <a:gd name="T3" fmla="*/ 26 h 290"/>
                <a:gd name="T4" fmla="*/ 52 w 313"/>
                <a:gd name="T5" fmla="*/ 28 h 290"/>
                <a:gd name="T6" fmla="*/ 41 w 313"/>
                <a:gd name="T7" fmla="*/ 45 h 290"/>
                <a:gd name="T8" fmla="*/ 33 w 313"/>
                <a:gd name="T9" fmla="*/ 58 h 290"/>
                <a:gd name="T10" fmla="*/ 33 w 313"/>
                <a:gd name="T11" fmla="*/ 58 h 290"/>
                <a:gd name="T12" fmla="*/ 33 w 313"/>
                <a:gd name="T13" fmla="*/ 58 h 290"/>
                <a:gd name="T14" fmla="*/ 33 w 313"/>
                <a:gd name="T15" fmla="*/ 58 h 290"/>
                <a:gd name="T16" fmla="*/ 33 w 313"/>
                <a:gd name="T17" fmla="*/ 59 h 290"/>
                <a:gd name="T18" fmla="*/ 32 w 313"/>
                <a:gd name="T19" fmla="*/ 60 h 290"/>
                <a:gd name="T20" fmla="*/ 25 w 313"/>
                <a:gd name="T21" fmla="*/ 72 h 290"/>
                <a:gd name="T22" fmla="*/ 8 w 313"/>
                <a:gd name="T23" fmla="*/ 77 h 290"/>
                <a:gd name="T24" fmla="*/ 3 w 313"/>
                <a:gd name="T25" fmla="*/ 59 h 290"/>
                <a:gd name="T26" fmla="*/ 10 w 313"/>
                <a:gd name="T27" fmla="*/ 47 h 290"/>
                <a:gd name="T28" fmla="*/ 11 w 313"/>
                <a:gd name="T29" fmla="*/ 46 h 290"/>
                <a:gd name="T30" fmla="*/ 19 w 313"/>
                <a:gd name="T31" fmla="*/ 33 h 290"/>
                <a:gd name="T32" fmla="*/ 55 w 313"/>
                <a:gd name="T33" fmla="*/ 0 h 290"/>
                <a:gd name="T34" fmla="*/ 88 w 313"/>
                <a:gd name="T35" fmla="*/ 30 h 290"/>
                <a:gd name="T36" fmla="*/ 194 w 313"/>
                <a:gd name="T37" fmla="*/ 252 h 290"/>
                <a:gd name="T38" fmla="*/ 202 w 313"/>
                <a:gd name="T39" fmla="*/ 263 h 290"/>
                <a:gd name="T40" fmla="*/ 205 w 313"/>
                <a:gd name="T41" fmla="*/ 265 h 290"/>
                <a:gd name="T42" fmla="*/ 214 w 313"/>
                <a:gd name="T43" fmla="*/ 258 h 290"/>
                <a:gd name="T44" fmla="*/ 235 w 313"/>
                <a:gd name="T45" fmla="*/ 225 h 290"/>
                <a:gd name="T46" fmla="*/ 287 w 313"/>
                <a:gd name="T47" fmla="*/ 126 h 290"/>
                <a:gd name="T48" fmla="*/ 304 w 313"/>
                <a:gd name="T49" fmla="*/ 121 h 290"/>
                <a:gd name="T50" fmla="*/ 310 w 313"/>
                <a:gd name="T51" fmla="*/ 138 h 290"/>
                <a:gd name="T52" fmla="*/ 258 w 313"/>
                <a:gd name="T53" fmla="*/ 237 h 290"/>
                <a:gd name="T54" fmla="*/ 205 w 313"/>
                <a:gd name="T55" fmla="*/ 290 h 290"/>
                <a:gd name="T56" fmla="*/ 172 w 313"/>
                <a:gd name="T57" fmla="*/ 264 h 290"/>
                <a:gd name="T58" fmla="*/ 10 w 313"/>
                <a:gd name="T59" fmla="*/ 49 h 290"/>
                <a:gd name="T60" fmla="*/ 10 w 313"/>
                <a:gd name="T61" fmla="*/ 49 h 290"/>
                <a:gd name="T62" fmla="*/ 10 w 313"/>
                <a:gd name="T63" fmla="*/ 48 h 290"/>
                <a:gd name="T64" fmla="*/ 10 w 313"/>
                <a:gd name="T65" fmla="*/ 48 h 290"/>
                <a:gd name="T66" fmla="*/ 10 w 313"/>
                <a:gd name="T67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313" h="290">
                  <a:moveTo>
                    <a:pt x="172" y="264"/>
                  </a:moveTo>
                  <a:cubicBezTo>
                    <a:pt x="157" y="237"/>
                    <a:pt x="83" y="77"/>
                    <a:pt x="65" y="41"/>
                  </a:cubicBezTo>
                  <a:cubicBezTo>
                    <a:pt x="65" y="41"/>
                    <a:pt x="65" y="41"/>
                    <a:pt x="65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4" y="26"/>
                    <a:pt x="53" y="27"/>
                    <a:pt x="52" y="28"/>
                  </a:cubicBezTo>
                  <a:cubicBezTo>
                    <a:pt x="52" y="28"/>
                    <a:pt x="52" y="28"/>
                    <a:pt x="52" y="28"/>
                  </a:cubicBezTo>
                  <a:cubicBezTo>
                    <a:pt x="49" y="31"/>
                    <a:pt x="45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4"/>
                    <a:pt x="34" y="57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8"/>
                    <a:pt x="33" y="58"/>
                    <a:pt x="33" y="58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2" y="59"/>
                    <a:pt x="32" y="60"/>
                  </a:cubicBezTo>
                  <a:cubicBezTo>
                    <a:pt x="32" y="60"/>
                    <a:pt x="32" y="60"/>
                    <a:pt x="32" y="60"/>
                  </a:cubicBezTo>
                  <a:cubicBezTo>
                    <a:pt x="31" y="62"/>
                    <a:pt x="29" y="65"/>
                    <a:pt x="25" y="72"/>
                  </a:cubicBezTo>
                  <a:cubicBezTo>
                    <a:pt x="25" y="72"/>
                    <a:pt x="25" y="72"/>
                    <a:pt x="25" y="72"/>
                  </a:cubicBezTo>
                  <a:cubicBezTo>
                    <a:pt x="22" y="78"/>
                    <a:pt x="14" y="80"/>
                    <a:pt x="8" y="77"/>
                  </a:cubicBezTo>
                  <a:cubicBezTo>
                    <a:pt x="8" y="77"/>
                    <a:pt x="8" y="77"/>
                    <a:pt x="8" y="77"/>
                  </a:cubicBezTo>
                  <a:cubicBezTo>
                    <a:pt x="2" y="73"/>
                    <a:pt x="0" y="65"/>
                    <a:pt x="3" y="59"/>
                  </a:cubicBezTo>
                  <a:cubicBezTo>
                    <a:pt x="3" y="59"/>
                    <a:pt x="3" y="59"/>
                    <a:pt x="3" y="59"/>
                  </a:cubicBezTo>
                  <a:cubicBezTo>
                    <a:pt x="8" y="51"/>
                    <a:pt x="10" y="48"/>
                    <a:pt x="10" y="47"/>
                  </a:cubicBezTo>
                  <a:cubicBezTo>
                    <a:pt x="10" y="47"/>
                    <a:pt x="10" y="47"/>
                    <a:pt x="10" y="47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1" y="46"/>
                    <a:pt x="11" y="46"/>
                    <a:pt x="11" y="46"/>
                  </a:cubicBezTo>
                  <a:cubicBezTo>
                    <a:pt x="12" y="45"/>
                    <a:pt x="13" y="42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29" y="16"/>
                    <a:pt x="36" y="2"/>
                    <a:pt x="55" y="0"/>
                  </a:cubicBezTo>
                  <a:cubicBezTo>
                    <a:pt x="55" y="0"/>
                    <a:pt x="55" y="0"/>
                    <a:pt x="55" y="0"/>
                  </a:cubicBezTo>
                  <a:cubicBezTo>
                    <a:pt x="72" y="1"/>
                    <a:pt x="79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4" y="252"/>
                  </a:cubicBezTo>
                  <a:cubicBezTo>
                    <a:pt x="194" y="252"/>
                    <a:pt x="194" y="252"/>
                    <a:pt x="194" y="252"/>
                  </a:cubicBezTo>
                  <a:cubicBezTo>
                    <a:pt x="197" y="258"/>
                    <a:pt x="200" y="261"/>
                    <a:pt x="202" y="263"/>
                  </a:cubicBezTo>
                  <a:cubicBezTo>
                    <a:pt x="202" y="263"/>
                    <a:pt x="202" y="263"/>
                    <a:pt x="202" y="263"/>
                  </a:cubicBezTo>
                  <a:cubicBezTo>
                    <a:pt x="204" y="265"/>
                    <a:pt x="204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8" y="264"/>
                    <a:pt x="214" y="258"/>
                  </a:cubicBezTo>
                  <a:cubicBezTo>
                    <a:pt x="214" y="258"/>
                    <a:pt x="214" y="258"/>
                    <a:pt x="214" y="258"/>
                  </a:cubicBezTo>
                  <a:cubicBezTo>
                    <a:pt x="220" y="251"/>
                    <a:pt x="227" y="241"/>
                    <a:pt x="235" y="225"/>
                  </a:cubicBezTo>
                  <a:cubicBezTo>
                    <a:pt x="235" y="225"/>
                    <a:pt x="235" y="225"/>
                    <a:pt x="235" y="225"/>
                  </a:cubicBezTo>
                  <a:cubicBezTo>
                    <a:pt x="287" y="126"/>
                    <a:pt x="287" y="126"/>
                    <a:pt x="287" y="126"/>
                  </a:cubicBezTo>
                  <a:cubicBezTo>
                    <a:pt x="287" y="126"/>
                    <a:pt x="287" y="126"/>
                    <a:pt x="287" y="126"/>
                  </a:cubicBezTo>
                  <a:cubicBezTo>
                    <a:pt x="291" y="120"/>
                    <a:pt x="298" y="118"/>
                    <a:pt x="304" y="121"/>
                  </a:cubicBezTo>
                  <a:cubicBezTo>
                    <a:pt x="304" y="121"/>
                    <a:pt x="304" y="121"/>
                    <a:pt x="304" y="121"/>
                  </a:cubicBezTo>
                  <a:cubicBezTo>
                    <a:pt x="311" y="124"/>
                    <a:pt x="313" y="132"/>
                    <a:pt x="310" y="138"/>
                  </a:cubicBezTo>
                  <a:cubicBezTo>
                    <a:pt x="310" y="138"/>
                    <a:pt x="310" y="138"/>
                    <a:pt x="310" y="138"/>
                  </a:cubicBezTo>
                  <a:cubicBezTo>
                    <a:pt x="310" y="138"/>
                    <a:pt x="310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8" y="290"/>
                    <a:pt x="179" y="278"/>
                    <a:pt x="172" y="264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0" y="48"/>
                  </a:move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ubicBezTo>
                    <a:pt x="10" y="48"/>
                    <a:pt x="10" y="48"/>
                    <a:pt x="10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7" name="Freeform 10">
              <a:extLst>
                <a:ext uri="{FF2B5EF4-FFF2-40B4-BE49-F238E27FC236}">
                  <a16:creationId xmlns:a16="http://schemas.microsoft.com/office/drawing/2014/main" id="{2FD6743F-ECA8-C208-5611-80BBF3FF533B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417" y="1817"/>
              <a:ext cx="740" cy="685"/>
            </a:xfrm>
            <a:custGeom>
              <a:avLst/>
              <a:gdLst>
                <a:gd name="T0" fmla="*/ 119 w 313"/>
                <a:gd name="T1" fmla="*/ 38 h 290"/>
                <a:gd name="T2" fmla="*/ 108 w 313"/>
                <a:gd name="T3" fmla="*/ 25 h 290"/>
                <a:gd name="T4" fmla="*/ 98 w 313"/>
                <a:gd name="T5" fmla="*/ 32 h 290"/>
                <a:gd name="T6" fmla="*/ 77 w 313"/>
                <a:gd name="T7" fmla="*/ 65 h 290"/>
                <a:gd name="T8" fmla="*/ 25 w 313"/>
                <a:gd name="T9" fmla="*/ 164 h 290"/>
                <a:gd name="T10" fmla="*/ 8 w 313"/>
                <a:gd name="T11" fmla="*/ 170 h 290"/>
                <a:gd name="T12" fmla="*/ 3 w 313"/>
                <a:gd name="T13" fmla="*/ 152 h 290"/>
                <a:gd name="T14" fmla="*/ 55 w 313"/>
                <a:gd name="T15" fmla="*/ 53 h 290"/>
                <a:gd name="T16" fmla="*/ 108 w 313"/>
                <a:gd name="T17" fmla="*/ 0 h 290"/>
                <a:gd name="T18" fmla="*/ 141 w 313"/>
                <a:gd name="T19" fmla="*/ 27 h 290"/>
                <a:gd name="T20" fmla="*/ 248 w 313"/>
                <a:gd name="T21" fmla="*/ 249 h 290"/>
                <a:gd name="T22" fmla="*/ 258 w 313"/>
                <a:gd name="T23" fmla="*/ 265 h 290"/>
                <a:gd name="T24" fmla="*/ 260 w 313"/>
                <a:gd name="T25" fmla="*/ 262 h 290"/>
                <a:gd name="T26" fmla="*/ 272 w 313"/>
                <a:gd name="T27" fmla="*/ 245 h 290"/>
                <a:gd name="T28" fmla="*/ 280 w 313"/>
                <a:gd name="T29" fmla="*/ 232 h 290"/>
                <a:gd name="T30" fmla="*/ 280 w 313"/>
                <a:gd name="T31" fmla="*/ 232 h 290"/>
                <a:gd name="T32" fmla="*/ 281 w 313"/>
                <a:gd name="T33" fmla="*/ 230 h 290"/>
                <a:gd name="T34" fmla="*/ 288 w 313"/>
                <a:gd name="T35" fmla="*/ 218 h 290"/>
                <a:gd name="T36" fmla="*/ 288 w 313"/>
                <a:gd name="T37" fmla="*/ 218 h 290"/>
                <a:gd name="T38" fmla="*/ 305 w 313"/>
                <a:gd name="T39" fmla="*/ 214 h 290"/>
                <a:gd name="T40" fmla="*/ 309 w 313"/>
                <a:gd name="T41" fmla="*/ 231 h 290"/>
                <a:gd name="T42" fmla="*/ 302 w 313"/>
                <a:gd name="T43" fmla="*/ 244 h 290"/>
                <a:gd name="T44" fmla="*/ 302 w 313"/>
                <a:gd name="T45" fmla="*/ 243 h 290"/>
                <a:gd name="T46" fmla="*/ 302 w 313"/>
                <a:gd name="T47" fmla="*/ 244 h 290"/>
                <a:gd name="T48" fmla="*/ 302 w 313"/>
                <a:gd name="T49" fmla="*/ 244 h 290"/>
                <a:gd name="T50" fmla="*/ 302 w 313"/>
                <a:gd name="T51" fmla="*/ 244 h 290"/>
                <a:gd name="T52" fmla="*/ 302 w 313"/>
                <a:gd name="T53" fmla="*/ 244 h 290"/>
                <a:gd name="T54" fmla="*/ 294 w 313"/>
                <a:gd name="T55" fmla="*/ 258 h 290"/>
                <a:gd name="T56" fmla="*/ 258 w 313"/>
                <a:gd name="T57" fmla="*/ 290 h 290"/>
                <a:gd name="T58" fmla="*/ 302 w 313"/>
                <a:gd name="T59" fmla="*/ 244 h 290"/>
                <a:gd name="T60" fmla="*/ 302 w 313"/>
                <a:gd name="T61" fmla="*/ 244 h 290"/>
                <a:gd name="T62" fmla="*/ 302 w 313"/>
                <a:gd name="T63" fmla="*/ 244 h 290"/>
                <a:gd name="T64" fmla="*/ 303 w 313"/>
                <a:gd name="T65" fmla="*/ 241 h 290"/>
                <a:gd name="T66" fmla="*/ 303 w 313"/>
                <a:gd name="T67" fmla="*/ 237 h 290"/>
                <a:gd name="T68" fmla="*/ 291 w 313"/>
                <a:gd name="T69" fmla="*/ 238 h 290"/>
                <a:gd name="T70" fmla="*/ 291 w 313"/>
                <a:gd name="T71" fmla="*/ 238 h 290"/>
                <a:gd name="T72" fmla="*/ 291 w 313"/>
                <a:gd name="T73" fmla="*/ 238 h 290"/>
                <a:gd name="T74" fmla="*/ 302 w 313"/>
                <a:gd name="T75" fmla="*/ 244 h 290"/>
                <a:gd name="T76" fmla="*/ 302 w 313"/>
                <a:gd name="T77" fmla="*/ 244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313" h="290">
                  <a:moveTo>
                    <a:pt x="225" y="260"/>
                  </a:moveTo>
                  <a:cubicBezTo>
                    <a:pt x="207" y="224"/>
                    <a:pt x="132" y="64"/>
                    <a:pt x="119" y="38"/>
                  </a:cubicBezTo>
                  <a:cubicBezTo>
                    <a:pt x="119" y="38"/>
                    <a:pt x="119" y="38"/>
                    <a:pt x="119" y="38"/>
                  </a:cubicBezTo>
                  <a:cubicBezTo>
                    <a:pt x="113" y="26"/>
                    <a:pt x="108" y="25"/>
                    <a:pt x="108" y="25"/>
                  </a:cubicBezTo>
                  <a:cubicBezTo>
                    <a:pt x="108" y="25"/>
                    <a:pt x="108" y="25"/>
                    <a:pt x="108" y="25"/>
                  </a:cubicBezTo>
                  <a:cubicBezTo>
                    <a:pt x="108" y="25"/>
                    <a:pt x="104" y="26"/>
                    <a:pt x="98" y="32"/>
                  </a:cubicBezTo>
                  <a:cubicBezTo>
                    <a:pt x="98" y="32"/>
                    <a:pt x="98" y="32"/>
                    <a:pt x="98" y="32"/>
                  </a:cubicBezTo>
                  <a:cubicBezTo>
                    <a:pt x="93" y="39"/>
                    <a:pt x="85" y="50"/>
                    <a:pt x="77" y="65"/>
                  </a:cubicBezTo>
                  <a:cubicBezTo>
                    <a:pt x="77" y="65"/>
                    <a:pt x="77" y="65"/>
                    <a:pt x="77" y="65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5" y="164"/>
                    <a:pt x="25" y="164"/>
                    <a:pt x="25" y="164"/>
                  </a:cubicBezTo>
                  <a:cubicBezTo>
                    <a:pt x="22" y="170"/>
                    <a:pt x="14" y="173"/>
                    <a:pt x="8" y="170"/>
                  </a:cubicBezTo>
                  <a:cubicBezTo>
                    <a:pt x="8" y="170"/>
                    <a:pt x="8" y="170"/>
                    <a:pt x="8" y="170"/>
                  </a:cubicBezTo>
                  <a:cubicBezTo>
                    <a:pt x="2" y="166"/>
                    <a:pt x="0" y="159"/>
                    <a:pt x="3" y="152"/>
                  </a:cubicBezTo>
                  <a:cubicBezTo>
                    <a:pt x="3" y="152"/>
                    <a:pt x="3" y="152"/>
                    <a:pt x="3" y="152"/>
                  </a:cubicBezTo>
                  <a:cubicBezTo>
                    <a:pt x="3" y="152"/>
                    <a:pt x="3" y="152"/>
                    <a:pt x="55" y="53"/>
                  </a:cubicBezTo>
                  <a:cubicBezTo>
                    <a:pt x="55" y="53"/>
                    <a:pt x="55" y="53"/>
                    <a:pt x="55" y="53"/>
                  </a:cubicBezTo>
                  <a:cubicBezTo>
                    <a:pt x="73" y="21"/>
                    <a:pt x="85" y="2"/>
                    <a:pt x="108" y="0"/>
                  </a:cubicBezTo>
                  <a:cubicBezTo>
                    <a:pt x="108" y="0"/>
                    <a:pt x="108" y="0"/>
                    <a:pt x="108" y="0"/>
                  </a:cubicBezTo>
                  <a:cubicBezTo>
                    <a:pt x="124" y="0"/>
                    <a:pt x="134" y="13"/>
                    <a:pt x="141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55" y="54"/>
                    <a:pt x="230" y="214"/>
                    <a:pt x="248" y="249"/>
                  </a:cubicBezTo>
                  <a:cubicBezTo>
                    <a:pt x="248" y="249"/>
                    <a:pt x="248" y="249"/>
                    <a:pt x="248" y="249"/>
                  </a:cubicBezTo>
                  <a:cubicBezTo>
                    <a:pt x="252" y="258"/>
                    <a:pt x="256" y="263"/>
                    <a:pt x="258" y="265"/>
                  </a:cubicBezTo>
                  <a:cubicBezTo>
                    <a:pt x="258" y="265"/>
                    <a:pt x="258" y="265"/>
                    <a:pt x="258" y="265"/>
                  </a:cubicBezTo>
                  <a:cubicBezTo>
                    <a:pt x="258" y="264"/>
                    <a:pt x="259" y="263"/>
                    <a:pt x="260" y="262"/>
                  </a:cubicBezTo>
                  <a:cubicBezTo>
                    <a:pt x="260" y="262"/>
                    <a:pt x="260" y="262"/>
                    <a:pt x="260" y="262"/>
                  </a:cubicBezTo>
                  <a:cubicBezTo>
                    <a:pt x="263" y="259"/>
                    <a:pt x="268" y="253"/>
                    <a:pt x="272" y="245"/>
                  </a:cubicBezTo>
                  <a:cubicBezTo>
                    <a:pt x="272" y="245"/>
                    <a:pt x="272" y="245"/>
                    <a:pt x="272" y="245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2"/>
                    <a:pt x="280" y="232"/>
                    <a:pt x="280" y="232"/>
                  </a:cubicBezTo>
                  <a:cubicBezTo>
                    <a:pt x="280" y="231"/>
                    <a:pt x="280" y="231"/>
                    <a:pt x="281" y="230"/>
                  </a:cubicBezTo>
                  <a:cubicBezTo>
                    <a:pt x="281" y="230"/>
                    <a:pt x="281" y="230"/>
                    <a:pt x="281" y="230"/>
                  </a:cubicBezTo>
                  <a:cubicBezTo>
                    <a:pt x="282" y="228"/>
                    <a:pt x="284" y="225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88" y="218"/>
                    <a:pt x="288" y="218"/>
                    <a:pt x="288" y="218"/>
                  </a:cubicBezTo>
                  <a:cubicBezTo>
                    <a:pt x="291" y="212"/>
                    <a:pt x="299" y="210"/>
                    <a:pt x="305" y="214"/>
                  </a:cubicBezTo>
                  <a:cubicBezTo>
                    <a:pt x="305" y="214"/>
                    <a:pt x="305" y="214"/>
                    <a:pt x="305" y="214"/>
                  </a:cubicBezTo>
                  <a:cubicBezTo>
                    <a:pt x="311" y="217"/>
                    <a:pt x="313" y="225"/>
                    <a:pt x="309" y="231"/>
                  </a:cubicBezTo>
                  <a:cubicBezTo>
                    <a:pt x="309" y="231"/>
                    <a:pt x="309" y="231"/>
                    <a:pt x="309" y="231"/>
                  </a:cubicBezTo>
                  <a:cubicBezTo>
                    <a:pt x="304" y="240"/>
                    <a:pt x="303" y="243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3"/>
                    <a:pt x="302" y="243"/>
                  </a:cubicBezTo>
                  <a:cubicBezTo>
                    <a:pt x="302" y="243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1" y="245"/>
                    <a:pt x="300" y="247"/>
                    <a:pt x="294" y="258"/>
                  </a:cubicBezTo>
                  <a:cubicBezTo>
                    <a:pt x="294" y="258"/>
                    <a:pt x="294" y="258"/>
                    <a:pt x="294" y="258"/>
                  </a:cubicBezTo>
                  <a:cubicBezTo>
                    <a:pt x="284" y="274"/>
                    <a:pt x="277" y="288"/>
                    <a:pt x="258" y="290"/>
                  </a:cubicBezTo>
                  <a:cubicBezTo>
                    <a:pt x="258" y="290"/>
                    <a:pt x="258" y="290"/>
                    <a:pt x="258" y="290"/>
                  </a:cubicBezTo>
                  <a:cubicBezTo>
                    <a:pt x="241" y="289"/>
                    <a:pt x="234" y="277"/>
                    <a:pt x="225" y="260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  <a:moveTo>
                    <a:pt x="303" y="241"/>
                  </a:moveTo>
                  <a:cubicBezTo>
                    <a:pt x="304" y="240"/>
                    <a:pt x="304" y="239"/>
                    <a:pt x="303" y="237"/>
                  </a:cubicBezTo>
                  <a:cubicBezTo>
                    <a:pt x="303" y="237"/>
                    <a:pt x="303" y="237"/>
                    <a:pt x="303" y="237"/>
                  </a:cubicBezTo>
                  <a:cubicBezTo>
                    <a:pt x="304" y="239"/>
                    <a:pt x="303" y="240"/>
                    <a:pt x="303" y="241"/>
                  </a:cubicBezTo>
                  <a:close/>
                  <a:moveTo>
                    <a:pt x="291" y="238"/>
                  </a:moveTo>
                  <a:cubicBezTo>
                    <a:pt x="291" y="238"/>
                    <a:pt x="291" y="238"/>
                    <a:pt x="291" y="238"/>
                  </a:cubicBezTo>
                  <a:cubicBezTo>
                    <a:pt x="291" y="238"/>
                    <a:pt x="291" y="238"/>
                    <a:pt x="291" y="238"/>
                  </a:cubicBezTo>
                  <a:close/>
                  <a:moveTo>
                    <a:pt x="291" y="238"/>
                  </a:moveTo>
                  <a:cubicBezTo>
                    <a:pt x="291" y="238"/>
                    <a:pt x="291" y="238"/>
                    <a:pt x="291" y="238"/>
                  </a:cubicBezTo>
                  <a:cubicBezTo>
                    <a:pt x="291" y="238"/>
                    <a:pt x="291" y="238"/>
                    <a:pt x="291" y="238"/>
                  </a:cubicBezTo>
                  <a:close/>
                  <a:moveTo>
                    <a:pt x="302" y="244"/>
                  </a:move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ubicBezTo>
                    <a:pt x="302" y="244"/>
                    <a:pt x="302" y="244"/>
                    <a:pt x="302" y="244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8" name="Freeform 11">
              <a:extLst>
                <a:ext uri="{FF2B5EF4-FFF2-40B4-BE49-F238E27FC236}">
                  <a16:creationId xmlns:a16="http://schemas.microsoft.com/office/drawing/2014/main" id="{756F7AEB-D7D8-4D9C-6636-D9E94FDC070E}"/>
                </a:ext>
              </a:extLst>
            </p:cNvPr>
            <p:cNvSpPr>
              <a:spLocks noChangeAspect="1" noEditPoints="1"/>
            </p:cNvSpPr>
            <p:nvPr/>
          </p:nvSpPr>
          <p:spPr bwMode="auto">
            <a:xfrm>
              <a:off x="3823" y="1817"/>
              <a:ext cx="742" cy="685"/>
            </a:xfrm>
            <a:custGeom>
              <a:avLst/>
              <a:gdLst>
                <a:gd name="T0" fmla="*/ 66 w 314"/>
                <a:gd name="T1" fmla="*/ 41 h 290"/>
                <a:gd name="T2" fmla="*/ 55 w 314"/>
                <a:gd name="T3" fmla="*/ 26 h 290"/>
                <a:gd name="T4" fmla="*/ 53 w 314"/>
                <a:gd name="T5" fmla="*/ 28 h 290"/>
                <a:gd name="T6" fmla="*/ 41 w 314"/>
                <a:gd name="T7" fmla="*/ 45 h 290"/>
                <a:gd name="T8" fmla="*/ 34 w 314"/>
                <a:gd name="T9" fmla="*/ 58 h 290"/>
                <a:gd name="T10" fmla="*/ 34 w 314"/>
                <a:gd name="T11" fmla="*/ 58 h 290"/>
                <a:gd name="T12" fmla="*/ 34 w 314"/>
                <a:gd name="T13" fmla="*/ 58 h 290"/>
                <a:gd name="T14" fmla="*/ 33 w 314"/>
                <a:gd name="T15" fmla="*/ 59 h 290"/>
                <a:gd name="T16" fmla="*/ 33 w 314"/>
                <a:gd name="T17" fmla="*/ 59 h 290"/>
                <a:gd name="T18" fmla="*/ 33 w 314"/>
                <a:gd name="T19" fmla="*/ 60 h 290"/>
                <a:gd name="T20" fmla="*/ 26 w 314"/>
                <a:gd name="T21" fmla="*/ 72 h 290"/>
                <a:gd name="T22" fmla="*/ 9 w 314"/>
                <a:gd name="T23" fmla="*/ 77 h 290"/>
                <a:gd name="T24" fmla="*/ 4 w 314"/>
                <a:gd name="T25" fmla="*/ 59 h 290"/>
                <a:gd name="T26" fmla="*/ 11 w 314"/>
                <a:gd name="T27" fmla="*/ 47 h 290"/>
                <a:gd name="T28" fmla="*/ 12 w 314"/>
                <a:gd name="T29" fmla="*/ 45 h 290"/>
                <a:gd name="T30" fmla="*/ 19 w 314"/>
                <a:gd name="T31" fmla="*/ 33 h 290"/>
                <a:gd name="T32" fmla="*/ 56 w 314"/>
                <a:gd name="T33" fmla="*/ 0 h 290"/>
                <a:gd name="T34" fmla="*/ 88 w 314"/>
                <a:gd name="T35" fmla="*/ 30 h 290"/>
                <a:gd name="T36" fmla="*/ 195 w 314"/>
                <a:gd name="T37" fmla="*/ 252 h 290"/>
                <a:gd name="T38" fmla="*/ 203 w 314"/>
                <a:gd name="T39" fmla="*/ 263 h 290"/>
                <a:gd name="T40" fmla="*/ 205 w 314"/>
                <a:gd name="T41" fmla="*/ 265 h 290"/>
                <a:gd name="T42" fmla="*/ 215 w 314"/>
                <a:gd name="T43" fmla="*/ 258 h 290"/>
                <a:gd name="T44" fmla="*/ 236 w 314"/>
                <a:gd name="T45" fmla="*/ 225 h 290"/>
                <a:gd name="T46" fmla="*/ 288 w 314"/>
                <a:gd name="T47" fmla="*/ 126 h 290"/>
                <a:gd name="T48" fmla="*/ 305 w 314"/>
                <a:gd name="T49" fmla="*/ 121 h 290"/>
                <a:gd name="T50" fmla="*/ 311 w 314"/>
                <a:gd name="T51" fmla="*/ 138 h 290"/>
                <a:gd name="T52" fmla="*/ 258 w 314"/>
                <a:gd name="T53" fmla="*/ 237 h 290"/>
                <a:gd name="T54" fmla="*/ 205 w 314"/>
                <a:gd name="T55" fmla="*/ 290 h 290"/>
                <a:gd name="T56" fmla="*/ 10 w 314"/>
                <a:gd name="T57" fmla="*/ 51 h 290"/>
                <a:gd name="T58" fmla="*/ 10 w 314"/>
                <a:gd name="T59" fmla="*/ 51 h 290"/>
                <a:gd name="T60" fmla="*/ 10 w 314"/>
                <a:gd name="T61" fmla="*/ 51 h 290"/>
                <a:gd name="T62" fmla="*/ 10 w 314"/>
                <a:gd name="T63" fmla="*/ 49 h 290"/>
                <a:gd name="T64" fmla="*/ 10 w 314"/>
                <a:gd name="T65" fmla="*/ 49 h 290"/>
                <a:gd name="T66" fmla="*/ 11 w 314"/>
                <a:gd name="T67" fmla="*/ 48 h 290"/>
                <a:gd name="T68" fmla="*/ 11 w 314"/>
                <a:gd name="T69" fmla="*/ 48 h 290"/>
                <a:gd name="T70" fmla="*/ 11 w 314"/>
                <a:gd name="T71" fmla="*/ 48 h 2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314" h="290">
                  <a:moveTo>
                    <a:pt x="172" y="264"/>
                  </a:moveTo>
                  <a:cubicBezTo>
                    <a:pt x="158" y="237"/>
                    <a:pt x="84" y="77"/>
                    <a:pt x="66" y="41"/>
                  </a:cubicBezTo>
                  <a:cubicBezTo>
                    <a:pt x="66" y="41"/>
                    <a:pt x="66" y="41"/>
                    <a:pt x="66" y="41"/>
                  </a:cubicBezTo>
                  <a:cubicBezTo>
                    <a:pt x="61" y="32"/>
                    <a:pt x="57" y="27"/>
                    <a:pt x="55" y="26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5" y="26"/>
                    <a:pt x="54" y="27"/>
                    <a:pt x="53" y="28"/>
                  </a:cubicBezTo>
                  <a:cubicBezTo>
                    <a:pt x="53" y="28"/>
                    <a:pt x="53" y="28"/>
                    <a:pt x="53" y="28"/>
                  </a:cubicBezTo>
                  <a:cubicBezTo>
                    <a:pt x="50" y="31"/>
                    <a:pt x="46" y="37"/>
                    <a:pt x="41" y="45"/>
                  </a:cubicBezTo>
                  <a:cubicBezTo>
                    <a:pt x="41" y="45"/>
                    <a:pt x="41" y="45"/>
                    <a:pt x="41" y="45"/>
                  </a:cubicBezTo>
                  <a:cubicBezTo>
                    <a:pt x="36" y="55"/>
                    <a:pt x="34" y="57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8"/>
                    <a:pt x="34" y="58"/>
                    <a:pt x="34" y="58"/>
                  </a:cubicBezTo>
                  <a:cubicBezTo>
                    <a:pt x="34" y="59"/>
                    <a:pt x="34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59"/>
                  </a:cubicBezTo>
                  <a:cubicBezTo>
                    <a:pt x="33" y="59"/>
                    <a:pt x="33" y="59"/>
                    <a:pt x="33" y="60"/>
                  </a:cubicBezTo>
                  <a:cubicBezTo>
                    <a:pt x="33" y="60"/>
                    <a:pt x="33" y="60"/>
                    <a:pt x="33" y="60"/>
                  </a:cubicBezTo>
                  <a:cubicBezTo>
                    <a:pt x="32" y="62"/>
                    <a:pt x="30" y="65"/>
                    <a:pt x="26" y="72"/>
                  </a:cubicBezTo>
                  <a:cubicBezTo>
                    <a:pt x="26" y="72"/>
                    <a:pt x="26" y="72"/>
                    <a:pt x="26" y="72"/>
                  </a:cubicBezTo>
                  <a:cubicBezTo>
                    <a:pt x="22" y="78"/>
                    <a:pt x="15" y="80"/>
                    <a:pt x="9" y="77"/>
                  </a:cubicBezTo>
                  <a:cubicBezTo>
                    <a:pt x="9" y="77"/>
                    <a:pt x="9" y="77"/>
                    <a:pt x="9" y="77"/>
                  </a:cubicBezTo>
                  <a:cubicBezTo>
                    <a:pt x="2" y="73"/>
                    <a:pt x="0" y="65"/>
                    <a:pt x="4" y="59"/>
                  </a:cubicBezTo>
                  <a:cubicBezTo>
                    <a:pt x="4" y="59"/>
                    <a:pt x="4" y="59"/>
                    <a:pt x="4" y="59"/>
                  </a:cubicBezTo>
                  <a:cubicBezTo>
                    <a:pt x="9" y="51"/>
                    <a:pt x="11" y="48"/>
                    <a:pt x="11" y="47"/>
                  </a:cubicBezTo>
                  <a:cubicBezTo>
                    <a:pt x="11" y="47"/>
                    <a:pt x="11" y="47"/>
                    <a:pt x="11" y="47"/>
                  </a:cubicBezTo>
                  <a:cubicBezTo>
                    <a:pt x="11" y="46"/>
                    <a:pt x="12" y="45"/>
                    <a:pt x="12" y="45"/>
                  </a:cubicBezTo>
                  <a:cubicBezTo>
                    <a:pt x="12" y="45"/>
                    <a:pt x="12" y="45"/>
                    <a:pt x="12" y="45"/>
                  </a:cubicBezTo>
                  <a:cubicBezTo>
                    <a:pt x="13" y="44"/>
                    <a:pt x="15" y="40"/>
                    <a:pt x="19" y="33"/>
                  </a:cubicBezTo>
                  <a:cubicBezTo>
                    <a:pt x="19" y="33"/>
                    <a:pt x="19" y="33"/>
                    <a:pt x="19" y="33"/>
                  </a:cubicBezTo>
                  <a:cubicBezTo>
                    <a:pt x="30" y="16"/>
                    <a:pt x="36" y="2"/>
                    <a:pt x="56" y="0"/>
                  </a:cubicBezTo>
                  <a:cubicBezTo>
                    <a:pt x="56" y="0"/>
                    <a:pt x="56" y="0"/>
                    <a:pt x="56" y="0"/>
                  </a:cubicBezTo>
                  <a:cubicBezTo>
                    <a:pt x="72" y="1"/>
                    <a:pt x="80" y="14"/>
                    <a:pt x="88" y="30"/>
                  </a:cubicBezTo>
                  <a:cubicBezTo>
                    <a:pt x="88" y="30"/>
                    <a:pt x="88" y="30"/>
                    <a:pt x="88" y="30"/>
                  </a:cubicBezTo>
                  <a:cubicBezTo>
                    <a:pt x="106" y="66"/>
                    <a:pt x="181" y="226"/>
                    <a:pt x="195" y="252"/>
                  </a:cubicBezTo>
                  <a:cubicBezTo>
                    <a:pt x="195" y="252"/>
                    <a:pt x="195" y="252"/>
                    <a:pt x="195" y="252"/>
                  </a:cubicBezTo>
                  <a:cubicBezTo>
                    <a:pt x="198" y="258"/>
                    <a:pt x="201" y="262"/>
                    <a:pt x="203" y="263"/>
                  </a:cubicBezTo>
                  <a:cubicBezTo>
                    <a:pt x="203" y="263"/>
                    <a:pt x="203" y="263"/>
                    <a:pt x="203" y="263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5" y="265"/>
                    <a:pt x="205" y="265"/>
                  </a:cubicBezTo>
                  <a:cubicBezTo>
                    <a:pt x="205" y="265"/>
                    <a:pt x="209" y="264"/>
                    <a:pt x="215" y="258"/>
                  </a:cubicBezTo>
                  <a:cubicBezTo>
                    <a:pt x="215" y="258"/>
                    <a:pt x="215" y="258"/>
                    <a:pt x="215" y="258"/>
                  </a:cubicBezTo>
                  <a:cubicBezTo>
                    <a:pt x="221" y="251"/>
                    <a:pt x="228" y="241"/>
                    <a:pt x="236" y="225"/>
                  </a:cubicBezTo>
                  <a:cubicBezTo>
                    <a:pt x="236" y="225"/>
                    <a:pt x="236" y="225"/>
                    <a:pt x="236" y="225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88" y="126"/>
                    <a:pt x="288" y="126"/>
                    <a:pt x="288" y="126"/>
                  </a:cubicBezTo>
                  <a:cubicBezTo>
                    <a:pt x="291" y="120"/>
                    <a:pt x="299" y="117"/>
                    <a:pt x="305" y="121"/>
                  </a:cubicBezTo>
                  <a:cubicBezTo>
                    <a:pt x="305" y="121"/>
                    <a:pt x="305" y="121"/>
                    <a:pt x="305" y="121"/>
                  </a:cubicBezTo>
                  <a:cubicBezTo>
                    <a:pt x="311" y="124"/>
                    <a:pt x="314" y="132"/>
                    <a:pt x="311" y="138"/>
                  </a:cubicBezTo>
                  <a:cubicBezTo>
                    <a:pt x="311" y="138"/>
                    <a:pt x="311" y="138"/>
                    <a:pt x="311" y="138"/>
                  </a:cubicBezTo>
                  <a:cubicBezTo>
                    <a:pt x="310" y="138"/>
                    <a:pt x="311" y="138"/>
                    <a:pt x="258" y="237"/>
                  </a:cubicBezTo>
                  <a:cubicBezTo>
                    <a:pt x="258" y="237"/>
                    <a:pt x="258" y="237"/>
                    <a:pt x="258" y="237"/>
                  </a:cubicBezTo>
                  <a:cubicBezTo>
                    <a:pt x="240" y="269"/>
                    <a:pt x="228" y="288"/>
                    <a:pt x="205" y="290"/>
                  </a:cubicBezTo>
                  <a:cubicBezTo>
                    <a:pt x="205" y="290"/>
                    <a:pt x="205" y="290"/>
                    <a:pt x="205" y="290"/>
                  </a:cubicBezTo>
                  <a:cubicBezTo>
                    <a:pt x="189" y="290"/>
                    <a:pt x="180" y="278"/>
                    <a:pt x="172" y="264"/>
                  </a:cubicBezTo>
                  <a:close/>
                  <a:moveTo>
                    <a:pt x="10" y="51"/>
                  </a:move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ubicBezTo>
                    <a:pt x="10" y="51"/>
                    <a:pt x="10" y="51"/>
                    <a:pt x="10" y="51"/>
                  </a:cubicBezTo>
                  <a:close/>
                  <a:moveTo>
                    <a:pt x="10" y="49"/>
                  </a:move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ubicBezTo>
                    <a:pt x="10" y="49"/>
                    <a:pt x="10" y="49"/>
                    <a:pt x="10" y="49"/>
                  </a:cubicBezTo>
                  <a:close/>
                  <a:moveTo>
                    <a:pt x="11" y="48"/>
                  </a:move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ubicBezTo>
                    <a:pt x="11" y="48"/>
                    <a:pt x="11" y="48"/>
                    <a:pt x="11" y="48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09" name="Freeform 12">
              <a:extLst>
                <a:ext uri="{FF2B5EF4-FFF2-40B4-BE49-F238E27FC236}">
                  <a16:creationId xmlns:a16="http://schemas.microsoft.com/office/drawing/2014/main" id="{DBBE40C7-AC9D-19C6-4984-1D9442EFA7B4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1265" y="2103"/>
              <a:ext cx="191" cy="297"/>
            </a:xfrm>
            <a:custGeom>
              <a:avLst/>
              <a:gdLst>
                <a:gd name="T0" fmla="*/ 9 w 81"/>
                <a:gd name="T1" fmla="*/ 124 h 126"/>
                <a:gd name="T2" fmla="*/ 4 w 81"/>
                <a:gd name="T3" fmla="*/ 107 h 126"/>
                <a:gd name="T4" fmla="*/ 4 w 81"/>
                <a:gd name="T5" fmla="*/ 107 h 126"/>
                <a:gd name="T6" fmla="*/ 56 w 81"/>
                <a:gd name="T7" fmla="*/ 8 h 126"/>
                <a:gd name="T8" fmla="*/ 56 w 81"/>
                <a:gd name="T9" fmla="*/ 8 h 126"/>
                <a:gd name="T10" fmla="*/ 56 w 81"/>
                <a:gd name="T11" fmla="*/ 8 h 126"/>
                <a:gd name="T12" fmla="*/ 73 w 81"/>
                <a:gd name="T13" fmla="*/ 3 h 126"/>
                <a:gd name="T14" fmla="*/ 73 w 81"/>
                <a:gd name="T15" fmla="*/ 3 h 126"/>
                <a:gd name="T16" fmla="*/ 78 w 81"/>
                <a:gd name="T17" fmla="*/ 20 h 126"/>
                <a:gd name="T18" fmla="*/ 78 w 81"/>
                <a:gd name="T19" fmla="*/ 20 h 126"/>
                <a:gd name="T20" fmla="*/ 26 w 81"/>
                <a:gd name="T21" fmla="*/ 119 h 126"/>
                <a:gd name="T22" fmla="*/ 26 w 81"/>
                <a:gd name="T23" fmla="*/ 119 h 126"/>
                <a:gd name="T24" fmla="*/ 15 w 81"/>
                <a:gd name="T25" fmla="*/ 126 h 126"/>
                <a:gd name="T26" fmla="*/ 15 w 81"/>
                <a:gd name="T27" fmla="*/ 126 h 126"/>
                <a:gd name="T28" fmla="*/ 9 w 81"/>
                <a:gd name="T29" fmla="*/ 124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81" h="126">
                  <a:moveTo>
                    <a:pt x="9" y="124"/>
                  </a:moveTo>
                  <a:cubicBezTo>
                    <a:pt x="3" y="121"/>
                    <a:pt x="0" y="114"/>
                    <a:pt x="4" y="107"/>
                  </a:cubicBezTo>
                  <a:cubicBezTo>
                    <a:pt x="4" y="107"/>
                    <a:pt x="4" y="107"/>
                    <a:pt x="4" y="107"/>
                  </a:cubicBezTo>
                  <a:cubicBezTo>
                    <a:pt x="4" y="107"/>
                    <a:pt x="4" y="107"/>
                    <a:pt x="56" y="8"/>
                  </a:cubicBezTo>
                  <a:cubicBezTo>
                    <a:pt x="56" y="8"/>
                    <a:pt x="56" y="8"/>
                    <a:pt x="56" y="8"/>
                  </a:cubicBezTo>
                  <a:cubicBezTo>
                    <a:pt x="56" y="8"/>
                    <a:pt x="56" y="8"/>
                    <a:pt x="56" y="8"/>
                  </a:cubicBezTo>
                  <a:cubicBezTo>
                    <a:pt x="59" y="2"/>
                    <a:pt x="67" y="0"/>
                    <a:pt x="73" y="3"/>
                  </a:cubicBezTo>
                  <a:cubicBezTo>
                    <a:pt x="73" y="3"/>
                    <a:pt x="73" y="3"/>
                    <a:pt x="73" y="3"/>
                  </a:cubicBezTo>
                  <a:cubicBezTo>
                    <a:pt x="79" y="6"/>
                    <a:pt x="81" y="14"/>
                    <a:pt x="78" y="20"/>
                  </a:cubicBezTo>
                  <a:cubicBezTo>
                    <a:pt x="78" y="20"/>
                    <a:pt x="78" y="20"/>
                    <a:pt x="78" y="20"/>
                  </a:cubicBezTo>
                  <a:cubicBezTo>
                    <a:pt x="26" y="119"/>
                    <a:pt x="26" y="119"/>
                    <a:pt x="26" y="119"/>
                  </a:cubicBezTo>
                  <a:cubicBezTo>
                    <a:pt x="26" y="119"/>
                    <a:pt x="26" y="119"/>
                    <a:pt x="26" y="119"/>
                  </a:cubicBezTo>
                  <a:cubicBezTo>
                    <a:pt x="24" y="123"/>
                    <a:pt x="19" y="126"/>
                    <a:pt x="15" y="126"/>
                  </a:cubicBezTo>
                  <a:cubicBezTo>
                    <a:pt x="15" y="126"/>
                    <a:pt x="15" y="126"/>
                    <a:pt x="15" y="126"/>
                  </a:cubicBezTo>
                  <a:cubicBezTo>
                    <a:pt x="13" y="126"/>
                    <a:pt x="11" y="125"/>
                    <a:pt x="9" y="124"/>
                  </a:cubicBezTo>
                  <a:close/>
                </a:path>
              </a:pathLst>
            </a:custGeom>
            <a:solidFill>
              <a:srgbClr val="3366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  <p:sp>
          <p:nvSpPr>
            <p:cNvPr id="310" name="Freeform 13">
              <a:extLst>
                <a:ext uri="{FF2B5EF4-FFF2-40B4-BE49-F238E27FC236}">
                  <a16:creationId xmlns:a16="http://schemas.microsoft.com/office/drawing/2014/main" id="{FA3C227E-5AD7-0AFA-7E47-0B969C257255}"/>
                </a:ext>
              </a:extLst>
            </p:cNvPr>
            <p:cNvSpPr>
              <a:spLocks noChangeAspect="1"/>
            </p:cNvSpPr>
            <p:nvPr/>
          </p:nvSpPr>
          <p:spPr bwMode="auto">
            <a:xfrm>
              <a:off x="4192" y="1893"/>
              <a:ext cx="191" cy="297"/>
            </a:xfrm>
            <a:custGeom>
              <a:avLst/>
              <a:gdLst>
                <a:gd name="T0" fmla="*/ 9 w 81"/>
                <a:gd name="T1" fmla="*/ 125 h 126"/>
                <a:gd name="T2" fmla="*/ 4 w 81"/>
                <a:gd name="T3" fmla="*/ 108 h 126"/>
                <a:gd name="T4" fmla="*/ 4 w 81"/>
                <a:gd name="T5" fmla="*/ 108 h 126"/>
                <a:gd name="T6" fmla="*/ 56 w 81"/>
                <a:gd name="T7" fmla="*/ 9 h 126"/>
                <a:gd name="T8" fmla="*/ 56 w 81"/>
                <a:gd name="T9" fmla="*/ 9 h 126"/>
                <a:gd name="T10" fmla="*/ 73 w 81"/>
                <a:gd name="T11" fmla="*/ 3 h 126"/>
                <a:gd name="T12" fmla="*/ 73 w 81"/>
                <a:gd name="T13" fmla="*/ 3 h 126"/>
                <a:gd name="T14" fmla="*/ 78 w 81"/>
                <a:gd name="T15" fmla="*/ 20 h 126"/>
                <a:gd name="T16" fmla="*/ 78 w 81"/>
                <a:gd name="T17" fmla="*/ 20 h 126"/>
                <a:gd name="T18" fmla="*/ 26 w 81"/>
                <a:gd name="T19" fmla="*/ 120 h 126"/>
                <a:gd name="T20" fmla="*/ 26 w 81"/>
                <a:gd name="T21" fmla="*/ 120 h 126"/>
                <a:gd name="T22" fmla="*/ 15 w 81"/>
                <a:gd name="T23" fmla="*/ 126 h 126"/>
                <a:gd name="T24" fmla="*/ 15 w 81"/>
                <a:gd name="T25" fmla="*/ 126 h 126"/>
                <a:gd name="T26" fmla="*/ 9 w 81"/>
                <a:gd name="T27" fmla="*/ 125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81" h="126">
                  <a:moveTo>
                    <a:pt x="9" y="125"/>
                  </a:moveTo>
                  <a:cubicBezTo>
                    <a:pt x="3" y="122"/>
                    <a:pt x="0" y="114"/>
                    <a:pt x="4" y="108"/>
                  </a:cubicBezTo>
                  <a:cubicBezTo>
                    <a:pt x="4" y="108"/>
                    <a:pt x="4" y="108"/>
                    <a:pt x="4" y="108"/>
                  </a:cubicBezTo>
                  <a:cubicBezTo>
                    <a:pt x="4" y="108"/>
                    <a:pt x="4" y="108"/>
                    <a:pt x="56" y="9"/>
                  </a:cubicBezTo>
                  <a:cubicBezTo>
                    <a:pt x="56" y="9"/>
                    <a:pt x="56" y="9"/>
                    <a:pt x="56" y="9"/>
                  </a:cubicBezTo>
                  <a:cubicBezTo>
                    <a:pt x="59" y="3"/>
                    <a:pt x="67" y="0"/>
                    <a:pt x="73" y="3"/>
                  </a:cubicBezTo>
                  <a:cubicBezTo>
                    <a:pt x="73" y="3"/>
                    <a:pt x="73" y="3"/>
                    <a:pt x="73" y="3"/>
                  </a:cubicBezTo>
                  <a:cubicBezTo>
                    <a:pt x="79" y="7"/>
                    <a:pt x="81" y="14"/>
                    <a:pt x="78" y="20"/>
                  </a:cubicBezTo>
                  <a:cubicBezTo>
                    <a:pt x="78" y="20"/>
                    <a:pt x="78" y="20"/>
                    <a:pt x="78" y="20"/>
                  </a:cubicBezTo>
                  <a:cubicBezTo>
                    <a:pt x="26" y="120"/>
                    <a:pt x="26" y="120"/>
                    <a:pt x="26" y="120"/>
                  </a:cubicBezTo>
                  <a:cubicBezTo>
                    <a:pt x="26" y="120"/>
                    <a:pt x="26" y="120"/>
                    <a:pt x="26" y="120"/>
                  </a:cubicBezTo>
                  <a:cubicBezTo>
                    <a:pt x="24" y="124"/>
                    <a:pt x="19" y="126"/>
                    <a:pt x="15" y="126"/>
                  </a:cubicBezTo>
                  <a:cubicBezTo>
                    <a:pt x="15" y="126"/>
                    <a:pt x="15" y="126"/>
                    <a:pt x="15" y="126"/>
                  </a:cubicBezTo>
                  <a:cubicBezTo>
                    <a:pt x="13" y="126"/>
                    <a:pt x="11" y="126"/>
                    <a:pt x="9" y="125"/>
                  </a:cubicBezTo>
                  <a:close/>
                </a:path>
              </a:pathLst>
            </a:cu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6350">
                  <a:solidFill>
                    <a:srgbClr val="FF66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defPPr>
                <a:defRPr lang="en-US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+mn-cs"/>
                </a:defRPr>
              </a:lvl9pPr>
            </a:lstStyle>
            <a:p>
              <a:endParaRPr lang="en-GB" sz="600" b="1">
                <a:cs typeface="Arial" panose="020B0604020202020204" pitchFamily="34" charset="0"/>
              </a:endParaRPr>
            </a:p>
          </p:txBody>
        </p:sp>
      </p:grpSp>
      <p:sp>
        <p:nvSpPr>
          <p:cNvPr id="311" name="Rectangle 310">
            <a:extLst>
              <a:ext uri="{FF2B5EF4-FFF2-40B4-BE49-F238E27FC236}">
                <a16:creationId xmlns:a16="http://schemas.microsoft.com/office/drawing/2014/main" id="{2054FDE4-8D8E-0F2F-2698-08C1A230269A}"/>
              </a:ext>
            </a:extLst>
          </p:cNvPr>
          <p:cNvSpPr/>
          <p:nvPr/>
        </p:nvSpPr>
        <p:spPr>
          <a:xfrm>
            <a:off x="2082265" y="2578148"/>
            <a:ext cx="414770" cy="116850"/>
          </a:xfrm>
          <a:prstGeom prst="rect">
            <a:avLst/>
          </a:prstGeom>
          <a:solidFill>
            <a:srgbClr val="CC6600"/>
          </a:solidFill>
          <a:ln>
            <a:solidFill>
              <a:srgbClr val="CC66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lIns="36000" tIns="0" rIns="36000" bIns="0" rtlCol="0" anchor="ctr"/>
          <a:lstStyle/>
          <a:p>
            <a:pPr algn="ctr"/>
            <a:r>
              <a:rPr lang="en-GB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</a:p>
        </p:txBody>
      </p:sp>
      <p:sp>
        <p:nvSpPr>
          <p:cNvPr id="312" name="Rectangle: Rounded Corners 311">
            <a:extLst>
              <a:ext uri="{FF2B5EF4-FFF2-40B4-BE49-F238E27FC236}">
                <a16:creationId xmlns:a16="http://schemas.microsoft.com/office/drawing/2014/main" id="{848357FB-84FC-DF16-9A31-BB285A34A436}"/>
              </a:ext>
            </a:extLst>
          </p:cNvPr>
          <p:cNvSpPr/>
          <p:nvPr/>
        </p:nvSpPr>
        <p:spPr>
          <a:xfrm>
            <a:off x="1022320" y="2447957"/>
            <a:ext cx="216000" cy="126000"/>
          </a:xfrm>
          <a:prstGeom prst="roundRect">
            <a:avLst>
              <a:gd name="adj" fmla="val 37456"/>
            </a:avLst>
          </a:prstGeom>
          <a:solidFill>
            <a:srgbClr val="CC00FF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313" name="Rectangle: Rounded Corners 312">
            <a:extLst>
              <a:ext uri="{FF2B5EF4-FFF2-40B4-BE49-F238E27FC236}">
                <a16:creationId xmlns:a16="http://schemas.microsoft.com/office/drawing/2014/main" id="{07F1354A-547F-DC52-0181-16AD8286600C}"/>
              </a:ext>
            </a:extLst>
          </p:cNvPr>
          <p:cNvSpPr/>
          <p:nvPr/>
        </p:nvSpPr>
        <p:spPr>
          <a:xfrm>
            <a:off x="1637262" y="2444566"/>
            <a:ext cx="216000" cy="126000"/>
          </a:xfrm>
          <a:prstGeom prst="roundRect">
            <a:avLst>
              <a:gd name="adj" fmla="val 37456"/>
            </a:avLst>
          </a:prstGeom>
          <a:solidFill>
            <a:srgbClr val="CC00FF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314" name="Cross 313">
            <a:extLst>
              <a:ext uri="{FF2B5EF4-FFF2-40B4-BE49-F238E27FC236}">
                <a16:creationId xmlns:a16="http://schemas.microsoft.com/office/drawing/2014/main" id="{FE71B5CE-9B4C-DE4B-399E-CD9BDCA70C96}"/>
              </a:ext>
            </a:extLst>
          </p:cNvPr>
          <p:cNvSpPr/>
          <p:nvPr/>
        </p:nvSpPr>
        <p:spPr>
          <a:xfrm rot="18891464">
            <a:off x="1693374" y="2522326"/>
            <a:ext cx="90000" cy="90000"/>
          </a:xfrm>
          <a:prstGeom prst="plus">
            <a:avLst>
              <a:gd name="adj" fmla="val 4062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Cross 314">
            <a:extLst>
              <a:ext uri="{FF2B5EF4-FFF2-40B4-BE49-F238E27FC236}">
                <a16:creationId xmlns:a16="http://schemas.microsoft.com/office/drawing/2014/main" id="{9F3A0566-EFC2-3836-1B88-9BA9C23B9F4A}"/>
              </a:ext>
            </a:extLst>
          </p:cNvPr>
          <p:cNvSpPr/>
          <p:nvPr/>
        </p:nvSpPr>
        <p:spPr>
          <a:xfrm rot="18891464">
            <a:off x="1078325" y="2533148"/>
            <a:ext cx="90000" cy="90000"/>
          </a:xfrm>
          <a:prstGeom prst="plus">
            <a:avLst>
              <a:gd name="adj" fmla="val 4062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6" name="Group 315">
            <a:extLst>
              <a:ext uri="{FF2B5EF4-FFF2-40B4-BE49-F238E27FC236}">
                <a16:creationId xmlns:a16="http://schemas.microsoft.com/office/drawing/2014/main" id="{F724A070-79D3-EADE-3107-C626645E5F66}"/>
              </a:ext>
            </a:extLst>
          </p:cNvPr>
          <p:cNvGrpSpPr/>
          <p:nvPr/>
        </p:nvGrpSpPr>
        <p:grpSpPr>
          <a:xfrm>
            <a:off x="3646359" y="2625137"/>
            <a:ext cx="1441270" cy="166339"/>
            <a:chOff x="26973664" y="10029825"/>
            <a:chExt cx="6088173" cy="419686"/>
          </a:xfrm>
        </p:grpSpPr>
        <p:cxnSp>
          <p:nvCxnSpPr>
            <p:cNvPr id="317" name="Straight Connector 316">
              <a:extLst>
                <a:ext uri="{FF2B5EF4-FFF2-40B4-BE49-F238E27FC236}">
                  <a16:creationId xmlns:a16="http://schemas.microsoft.com/office/drawing/2014/main" id="{F90000BF-D862-CFA7-4553-1E0B10A5EB93}"/>
                </a:ext>
              </a:extLst>
            </p:cNvPr>
            <p:cNvCxnSpPr>
              <a:cxnSpLocks/>
            </p:cNvCxnSpPr>
            <p:nvPr/>
          </p:nvCxnSpPr>
          <p:spPr>
            <a:xfrm>
              <a:off x="26973664" y="10407462"/>
              <a:ext cx="6088173" cy="0"/>
            </a:xfrm>
            <a:prstGeom prst="line">
              <a:avLst/>
            </a:prstGeom>
            <a:ln w="381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8" name="Straight Connector 317">
              <a:extLst>
                <a:ext uri="{FF2B5EF4-FFF2-40B4-BE49-F238E27FC236}">
                  <a16:creationId xmlns:a16="http://schemas.microsoft.com/office/drawing/2014/main" id="{5C863C27-8748-4295-F275-97047C0EDA55}"/>
                </a:ext>
              </a:extLst>
            </p:cNvPr>
            <p:cNvCxnSpPr>
              <a:cxnSpLocks/>
            </p:cNvCxnSpPr>
            <p:nvPr/>
          </p:nvCxnSpPr>
          <p:spPr>
            <a:xfrm>
              <a:off x="32899350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9" name="Straight Connector 318">
              <a:extLst>
                <a:ext uri="{FF2B5EF4-FFF2-40B4-BE49-F238E27FC236}">
                  <a16:creationId xmlns:a16="http://schemas.microsoft.com/office/drawing/2014/main" id="{CC23DB33-1EAF-23C1-A4CE-138789BD2C3C}"/>
                </a:ext>
              </a:extLst>
            </p:cNvPr>
            <p:cNvCxnSpPr>
              <a:cxnSpLocks/>
            </p:cNvCxnSpPr>
            <p:nvPr/>
          </p:nvCxnSpPr>
          <p:spPr>
            <a:xfrm>
              <a:off x="32632650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Straight Connector 319">
              <a:extLst>
                <a:ext uri="{FF2B5EF4-FFF2-40B4-BE49-F238E27FC236}">
                  <a16:creationId xmlns:a16="http://schemas.microsoft.com/office/drawing/2014/main" id="{798B2992-3307-B41F-93E8-C51528D73546}"/>
                </a:ext>
              </a:extLst>
            </p:cNvPr>
            <p:cNvCxnSpPr>
              <a:cxnSpLocks/>
            </p:cNvCxnSpPr>
            <p:nvPr/>
          </p:nvCxnSpPr>
          <p:spPr>
            <a:xfrm>
              <a:off x="32372300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1" name="Straight Connector 320">
              <a:extLst>
                <a:ext uri="{FF2B5EF4-FFF2-40B4-BE49-F238E27FC236}">
                  <a16:creationId xmlns:a16="http://schemas.microsoft.com/office/drawing/2014/main" id="{12651148-A533-FF09-C48B-7C0C02EC4C43}"/>
                </a:ext>
              </a:extLst>
            </p:cNvPr>
            <p:cNvCxnSpPr>
              <a:cxnSpLocks/>
            </p:cNvCxnSpPr>
            <p:nvPr/>
          </p:nvCxnSpPr>
          <p:spPr>
            <a:xfrm>
              <a:off x="32105600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2" name="Straight Connector 321">
              <a:extLst>
                <a:ext uri="{FF2B5EF4-FFF2-40B4-BE49-F238E27FC236}">
                  <a16:creationId xmlns:a16="http://schemas.microsoft.com/office/drawing/2014/main" id="{C10ED406-003B-90BD-B458-03D2D2A15AEE}"/>
                </a:ext>
              </a:extLst>
            </p:cNvPr>
            <p:cNvCxnSpPr>
              <a:cxnSpLocks/>
            </p:cNvCxnSpPr>
            <p:nvPr/>
          </p:nvCxnSpPr>
          <p:spPr>
            <a:xfrm>
              <a:off x="31838900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3" name="Straight Connector 322">
              <a:extLst>
                <a:ext uri="{FF2B5EF4-FFF2-40B4-BE49-F238E27FC236}">
                  <a16:creationId xmlns:a16="http://schemas.microsoft.com/office/drawing/2014/main" id="{864A0D48-BD97-261B-B0B9-3823C3E1A923}"/>
                </a:ext>
              </a:extLst>
            </p:cNvPr>
            <p:cNvCxnSpPr>
              <a:cxnSpLocks/>
            </p:cNvCxnSpPr>
            <p:nvPr/>
          </p:nvCxnSpPr>
          <p:spPr>
            <a:xfrm>
              <a:off x="31567437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4" name="Straight Connector 323">
              <a:extLst>
                <a:ext uri="{FF2B5EF4-FFF2-40B4-BE49-F238E27FC236}">
                  <a16:creationId xmlns:a16="http://schemas.microsoft.com/office/drawing/2014/main" id="{FF8B3A19-27DF-24C4-BC9D-41F46F4C4755}"/>
                </a:ext>
              </a:extLst>
            </p:cNvPr>
            <p:cNvCxnSpPr>
              <a:cxnSpLocks/>
            </p:cNvCxnSpPr>
            <p:nvPr/>
          </p:nvCxnSpPr>
          <p:spPr>
            <a:xfrm>
              <a:off x="31310262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5" name="Straight Connector 324">
              <a:extLst>
                <a:ext uri="{FF2B5EF4-FFF2-40B4-BE49-F238E27FC236}">
                  <a16:creationId xmlns:a16="http://schemas.microsoft.com/office/drawing/2014/main" id="{4A9B8B41-A507-1779-509E-A148176E6C27}"/>
                </a:ext>
              </a:extLst>
            </p:cNvPr>
            <p:cNvCxnSpPr>
              <a:cxnSpLocks/>
            </p:cNvCxnSpPr>
            <p:nvPr/>
          </p:nvCxnSpPr>
          <p:spPr>
            <a:xfrm>
              <a:off x="31054675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6" name="Straight Connector 325">
              <a:extLst>
                <a:ext uri="{FF2B5EF4-FFF2-40B4-BE49-F238E27FC236}">
                  <a16:creationId xmlns:a16="http://schemas.microsoft.com/office/drawing/2014/main" id="{53652B23-8313-C753-1E13-793ED1AD94A2}"/>
                </a:ext>
              </a:extLst>
            </p:cNvPr>
            <p:cNvCxnSpPr>
              <a:cxnSpLocks/>
            </p:cNvCxnSpPr>
            <p:nvPr/>
          </p:nvCxnSpPr>
          <p:spPr>
            <a:xfrm>
              <a:off x="30780037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7" name="Straight Connector 326">
              <a:extLst>
                <a:ext uri="{FF2B5EF4-FFF2-40B4-BE49-F238E27FC236}">
                  <a16:creationId xmlns:a16="http://schemas.microsoft.com/office/drawing/2014/main" id="{505F8201-F151-4F8E-4AB5-BBEFC433C66E}"/>
                </a:ext>
              </a:extLst>
            </p:cNvPr>
            <p:cNvCxnSpPr>
              <a:cxnSpLocks/>
            </p:cNvCxnSpPr>
            <p:nvPr/>
          </p:nvCxnSpPr>
          <p:spPr>
            <a:xfrm>
              <a:off x="30510162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8" name="Straight Connector 327">
              <a:extLst>
                <a:ext uri="{FF2B5EF4-FFF2-40B4-BE49-F238E27FC236}">
                  <a16:creationId xmlns:a16="http://schemas.microsoft.com/office/drawing/2014/main" id="{9091347F-FD0D-10F8-99EA-6760BC7BA53A}"/>
                </a:ext>
              </a:extLst>
            </p:cNvPr>
            <p:cNvCxnSpPr>
              <a:cxnSpLocks/>
            </p:cNvCxnSpPr>
            <p:nvPr/>
          </p:nvCxnSpPr>
          <p:spPr>
            <a:xfrm>
              <a:off x="30248224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9" name="Straight Connector 328">
              <a:extLst>
                <a:ext uri="{FF2B5EF4-FFF2-40B4-BE49-F238E27FC236}">
                  <a16:creationId xmlns:a16="http://schemas.microsoft.com/office/drawing/2014/main" id="{5E1C250F-E061-AB5B-70BF-1D6D9EBACD8F}"/>
                </a:ext>
              </a:extLst>
            </p:cNvPr>
            <p:cNvCxnSpPr>
              <a:cxnSpLocks/>
            </p:cNvCxnSpPr>
            <p:nvPr/>
          </p:nvCxnSpPr>
          <p:spPr>
            <a:xfrm>
              <a:off x="29984699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Straight Connector 329">
              <a:extLst>
                <a:ext uri="{FF2B5EF4-FFF2-40B4-BE49-F238E27FC236}">
                  <a16:creationId xmlns:a16="http://schemas.microsoft.com/office/drawing/2014/main" id="{0351072C-BD43-627D-25AA-6680C8318EBB}"/>
                </a:ext>
              </a:extLst>
            </p:cNvPr>
            <p:cNvCxnSpPr>
              <a:cxnSpLocks/>
            </p:cNvCxnSpPr>
            <p:nvPr/>
          </p:nvCxnSpPr>
          <p:spPr>
            <a:xfrm>
              <a:off x="29719586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Straight Connector 330">
              <a:extLst>
                <a:ext uri="{FF2B5EF4-FFF2-40B4-BE49-F238E27FC236}">
                  <a16:creationId xmlns:a16="http://schemas.microsoft.com/office/drawing/2014/main" id="{3812A662-7AFA-26BF-2A3B-CC2D8DDA95B2}"/>
                </a:ext>
              </a:extLst>
            </p:cNvPr>
            <p:cNvCxnSpPr>
              <a:cxnSpLocks/>
            </p:cNvCxnSpPr>
            <p:nvPr/>
          </p:nvCxnSpPr>
          <p:spPr>
            <a:xfrm>
              <a:off x="29449711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Straight Connector 331">
              <a:extLst>
                <a:ext uri="{FF2B5EF4-FFF2-40B4-BE49-F238E27FC236}">
                  <a16:creationId xmlns:a16="http://schemas.microsoft.com/office/drawing/2014/main" id="{45DBF527-13E4-916A-0DA1-AA9E1D68FAFC}"/>
                </a:ext>
              </a:extLst>
            </p:cNvPr>
            <p:cNvCxnSpPr>
              <a:cxnSpLocks/>
            </p:cNvCxnSpPr>
            <p:nvPr/>
          </p:nvCxnSpPr>
          <p:spPr>
            <a:xfrm>
              <a:off x="29189361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3" name="Straight Connector 332">
              <a:extLst>
                <a:ext uri="{FF2B5EF4-FFF2-40B4-BE49-F238E27FC236}">
                  <a16:creationId xmlns:a16="http://schemas.microsoft.com/office/drawing/2014/main" id="{989D0271-35C8-60B6-9A4A-B091288A4209}"/>
                </a:ext>
              </a:extLst>
            </p:cNvPr>
            <p:cNvCxnSpPr>
              <a:cxnSpLocks/>
            </p:cNvCxnSpPr>
            <p:nvPr/>
          </p:nvCxnSpPr>
          <p:spPr>
            <a:xfrm>
              <a:off x="28925836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Straight Connector 333">
              <a:extLst>
                <a:ext uri="{FF2B5EF4-FFF2-40B4-BE49-F238E27FC236}">
                  <a16:creationId xmlns:a16="http://schemas.microsoft.com/office/drawing/2014/main" id="{2E1082C2-5DF0-2425-A2B3-FBB6C5519657}"/>
                </a:ext>
              </a:extLst>
            </p:cNvPr>
            <p:cNvCxnSpPr>
              <a:cxnSpLocks/>
            </p:cNvCxnSpPr>
            <p:nvPr/>
          </p:nvCxnSpPr>
          <p:spPr>
            <a:xfrm>
              <a:off x="28657549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Straight Connector 334">
              <a:extLst>
                <a:ext uri="{FF2B5EF4-FFF2-40B4-BE49-F238E27FC236}">
                  <a16:creationId xmlns:a16="http://schemas.microsoft.com/office/drawing/2014/main" id="{0705D3B6-4EC6-29EA-B433-719803A4062A}"/>
                </a:ext>
              </a:extLst>
            </p:cNvPr>
            <p:cNvCxnSpPr>
              <a:cxnSpLocks/>
            </p:cNvCxnSpPr>
            <p:nvPr/>
          </p:nvCxnSpPr>
          <p:spPr>
            <a:xfrm>
              <a:off x="28400374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Straight Connector 335">
              <a:extLst>
                <a:ext uri="{FF2B5EF4-FFF2-40B4-BE49-F238E27FC236}">
                  <a16:creationId xmlns:a16="http://schemas.microsoft.com/office/drawing/2014/main" id="{F6D55AA8-7E3C-A31D-6C91-2611CF364BF2}"/>
                </a:ext>
              </a:extLst>
            </p:cNvPr>
            <p:cNvCxnSpPr>
              <a:cxnSpLocks/>
            </p:cNvCxnSpPr>
            <p:nvPr/>
          </p:nvCxnSpPr>
          <p:spPr>
            <a:xfrm>
              <a:off x="28132086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7" name="Straight Connector 336">
              <a:extLst>
                <a:ext uri="{FF2B5EF4-FFF2-40B4-BE49-F238E27FC236}">
                  <a16:creationId xmlns:a16="http://schemas.microsoft.com/office/drawing/2014/main" id="{19A670B9-77E2-7ED4-5A34-B577D1E1409C}"/>
                </a:ext>
              </a:extLst>
            </p:cNvPr>
            <p:cNvCxnSpPr>
              <a:cxnSpLocks/>
            </p:cNvCxnSpPr>
            <p:nvPr/>
          </p:nvCxnSpPr>
          <p:spPr>
            <a:xfrm>
              <a:off x="27868561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Connector 337">
              <a:extLst>
                <a:ext uri="{FF2B5EF4-FFF2-40B4-BE49-F238E27FC236}">
                  <a16:creationId xmlns:a16="http://schemas.microsoft.com/office/drawing/2014/main" id="{A236505F-916F-FB93-669B-E467F0ADEA55}"/>
                </a:ext>
              </a:extLst>
            </p:cNvPr>
            <p:cNvCxnSpPr>
              <a:cxnSpLocks/>
            </p:cNvCxnSpPr>
            <p:nvPr/>
          </p:nvCxnSpPr>
          <p:spPr>
            <a:xfrm>
              <a:off x="27601861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Connector 338">
              <a:extLst>
                <a:ext uri="{FF2B5EF4-FFF2-40B4-BE49-F238E27FC236}">
                  <a16:creationId xmlns:a16="http://schemas.microsoft.com/office/drawing/2014/main" id="{5FE672B7-052E-52DF-1C49-AE018F6760B8}"/>
                </a:ext>
              </a:extLst>
            </p:cNvPr>
            <p:cNvCxnSpPr>
              <a:cxnSpLocks/>
            </p:cNvCxnSpPr>
            <p:nvPr/>
          </p:nvCxnSpPr>
          <p:spPr>
            <a:xfrm>
              <a:off x="27335161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Straight Connector 339">
              <a:extLst>
                <a:ext uri="{FF2B5EF4-FFF2-40B4-BE49-F238E27FC236}">
                  <a16:creationId xmlns:a16="http://schemas.microsoft.com/office/drawing/2014/main" id="{C344486F-A082-19A5-4DAF-769A36028190}"/>
                </a:ext>
              </a:extLst>
            </p:cNvPr>
            <p:cNvCxnSpPr>
              <a:cxnSpLocks/>
            </p:cNvCxnSpPr>
            <p:nvPr/>
          </p:nvCxnSpPr>
          <p:spPr>
            <a:xfrm>
              <a:off x="27073224" y="10029825"/>
              <a:ext cx="0" cy="419686"/>
            </a:xfrm>
            <a:prstGeom prst="line">
              <a:avLst/>
            </a:prstGeom>
            <a:ln w="25400">
              <a:solidFill>
                <a:srgbClr val="CC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41" name="Straight Connector 340">
            <a:extLst>
              <a:ext uri="{FF2B5EF4-FFF2-40B4-BE49-F238E27FC236}">
                <a16:creationId xmlns:a16="http://schemas.microsoft.com/office/drawing/2014/main" id="{B1F64A73-74B7-9F33-73D7-03FBAC5312D5}"/>
              </a:ext>
            </a:extLst>
          </p:cNvPr>
          <p:cNvCxnSpPr>
            <a:cxnSpLocks/>
          </p:cNvCxnSpPr>
          <p:nvPr/>
        </p:nvCxnSpPr>
        <p:spPr>
          <a:xfrm flipH="1">
            <a:off x="3922614" y="2452171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2" name="Straight Connector 341">
            <a:extLst>
              <a:ext uri="{FF2B5EF4-FFF2-40B4-BE49-F238E27FC236}">
                <a16:creationId xmlns:a16="http://schemas.microsoft.com/office/drawing/2014/main" id="{C20BA318-D9E9-CAE0-9BD5-0F8BE47466F1}"/>
              </a:ext>
            </a:extLst>
          </p:cNvPr>
          <p:cNvCxnSpPr>
            <a:cxnSpLocks/>
          </p:cNvCxnSpPr>
          <p:nvPr/>
        </p:nvCxnSpPr>
        <p:spPr>
          <a:xfrm flipH="1">
            <a:off x="3984719" y="2448454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3" name="Straight Connector 342">
            <a:extLst>
              <a:ext uri="{FF2B5EF4-FFF2-40B4-BE49-F238E27FC236}">
                <a16:creationId xmlns:a16="http://schemas.microsoft.com/office/drawing/2014/main" id="{97CFCC25-DAB1-7D19-BD85-D04B3C399E6A}"/>
              </a:ext>
            </a:extLst>
          </p:cNvPr>
          <p:cNvCxnSpPr>
            <a:cxnSpLocks/>
          </p:cNvCxnSpPr>
          <p:nvPr/>
        </p:nvCxnSpPr>
        <p:spPr>
          <a:xfrm flipH="1">
            <a:off x="4048956" y="2452171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Straight Connector 343">
            <a:extLst>
              <a:ext uri="{FF2B5EF4-FFF2-40B4-BE49-F238E27FC236}">
                <a16:creationId xmlns:a16="http://schemas.microsoft.com/office/drawing/2014/main" id="{9FB6C05D-553A-46F1-D034-B0F8C0476211}"/>
              </a:ext>
            </a:extLst>
          </p:cNvPr>
          <p:cNvCxnSpPr>
            <a:cxnSpLocks/>
          </p:cNvCxnSpPr>
          <p:nvPr/>
        </p:nvCxnSpPr>
        <p:spPr>
          <a:xfrm flipH="1">
            <a:off x="4235798" y="2455920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Straight Connector 344">
            <a:extLst>
              <a:ext uri="{FF2B5EF4-FFF2-40B4-BE49-F238E27FC236}">
                <a16:creationId xmlns:a16="http://schemas.microsoft.com/office/drawing/2014/main" id="{EA0BAB3F-03BF-E7BC-10B6-C5ABAE0BDE9A}"/>
              </a:ext>
            </a:extLst>
          </p:cNvPr>
          <p:cNvCxnSpPr>
            <a:cxnSpLocks/>
          </p:cNvCxnSpPr>
          <p:nvPr/>
        </p:nvCxnSpPr>
        <p:spPr>
          <a:xfrm flipH="1">
            <a:off x="4299742" y="2456933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6" name="Straight Connector 345">
            <a:extLst>
              <a:ext uri="{FF2B5EF4-FFF2-40B4-BE49-F238E27FC236}">
                <a16:creationId xmlns:a16="http://schemas.microsoft.com/office/drawing/2014/main" id="{4E72CC6B-0A36-E996-F16D-BFA82A57403D}"/>
              </a:ext>
            </a:extLst>
          </p:cNvPr>
          <p:cNvCxnSpPr>
            <a:cxnSpLocks/>
          </p:cNvCxnSpPr>
          <p:nvPr/>
        </p:nvCxnSpPr>
        <p:spPr>
          <a:xfrm flipH="1">
            <a:off x="4361188" y="2458810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7" name="Straight Connector 346">
            <a:extLst>
              <a:ext uri="{FF2B5EF4-FFF2-40B4-BE49-F238E27FC236}">
                <a16:creationId xmlns:a16="http://schemas.microsoft.com/office/drawing/2014/main" id="{3ABC7011-E983-9EE9-ED2F-65CCF6317BC1}"/>
              </a:ext>
            </a:extLst>
          </p:cNvPr>
          <p:cNvCxnSpPr>
            <a:cxnSpLocks/>
          </p:cNvCxnSpPr>
          <p:nvPr/>
        </p:nvCxnSpPr>
        <p:spPr>
          <a:xfrm flipH="1">
            <a:off x="4420287" y="2454048"/>
            <a:ext cx="96" cy="16560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" name="Freeform: Shape 77">
            <a:extLst>
              <a:ext uri="{FF2B5EF4-FFF2-40B4-BE49-F238E27FC236}">
                <a16:creationId xmlns:a16="http://schemas.microsoft.com/office/drawing/2014/main" id="{4AA3D02A-3ACB-9CCB-37B9-DA5FE2714F2A}"/>
              </a:ext>
            </a:extLst>
          </p:cNvPr>
          <p:cNvSpPr/>
          <p:nvPr/>
        </p:nvSpPr>
        <p:spPr>
          <a:xfrm>
            <a:off x="3916202" y="2346779"/>
            <a:ext cx="511970" cy="127328"/>
          </a:xfrm>
          <a:custGeom>
            <a:avLst/>
            <a:gdLst>
              <a:gd name="connsiteX0" fmla="*/ 0 w 457200"/>
              <a:gd name="connsiteY0" fmla="*/ 133357 h 150055"/>
              <a:gd name="connsiteX1" fmla="*/ 165100 w 457200"/>
              <a:gd name="connsiteY1" fmla="*/ 133357 h 150055"/>
              <a:gd name="connsiteX2" fmla="*/ 215900 w 457200"/>
              <a:gd name="connsiteY2" fmla="*/ 7 h 150055"/>
              <a:gd name="connsiteX3" fmla="*/ 279400 w 457200"/>
              <a:gd name="connsiteY3" fmla="*/ 139707 h 150055"/>
              <a:gd name="connsiteX4" fmla="*/ 412750 w 457200"/>
              <a:gd name="connsiteY4" fmla="*/ 139707 h 150055"/>
              <a:gd name="connsiteX5" fmla="*/ 457200 w 457200"/>
              <a:gd name="connsiteY5" fmla="*/ 139707 h 150055"/>
              <a:gd name="connsiteX0" fmla="*/ 0 w 485775"/>
              <a:gd name="connsiteY0" fmla="*/ 146057 h 153403"/>
              <a:gd name="connsiteX1" fmla="*/ 193675 w 485775"/>
              <a:gd name="connsiteY1" fmla="*/ 133357 h 153403"/>
              <a:gd name="connsiteX2" fmla="*/ 244475 w 485775"/>
              <a:gd name="connsiteY2" fmla="*/ 7 h 153403"/>
              <a:gd name="connsiteX3" fmla="*/ 307975 w 485775"/>
              <a:gd name="connsiteY3" fmla="*/ 139707 h 153403"/>
              <a:gd name="connsiteX4" fmla="*/ 441325 w 485775"/>
              <a:gd name="connsiteY4" fmla="*/ 139707 h 153403"/>
              <a:gd name="connsiteX5" fmla="*/ 485775 w 485775"/>
              <a:gd name="connsiteY5" fmla="*/ 139707 h 153403"/>
              <a:gd name="connsiteX0" fmla="*/ 0 w 485775"/>
              <a:gd name="connsiteY0" fmla="*/ 146057 h 159787"/>
              <a:gd name="connsiteX1" fmla="*/ 200025 w 485775"/>
              <a:gd name="connsiteY1" fmla="*/ 146057 h 159787"/>
              <a:gd name="connsiteX2" fmla="*/ 244475 w 485775"/>
              <a:gd name="connsiteY2" fmla="*/ 7 h 159787"/>
              <a:gd name="connsiteX3" fmla="*/ 307975 w 485775"/>
              <a:gd name="connsiteY3" fmla="*/ 139707 h 159787"/>
              <a:gd name="connsiteX4" fmla="*/ 441325 w 485775"/>
              <a:gd name="connsiteY4" fmla="*/ 139707 h 159787"/>
              <a:gd name="connsiteX5" fmla="*/ 485775 w 485775"/>
              <a:gd name="connsiteY5" fmla="*/ 139707 h 159787"/>
              <a:gd name="connsiteX0" fmla="*/ 0 w 485775"/>
              <a:gd name="connsiteY0" fmla="*/ 146066 h 159796"/>
              <a:gd name="connsiteX1" fmla="*/ 200025 w 485775"/>
              <a:gd name="connsiteY1" fmla="*/ 146066 h 159796"/>
              <a:gd name="connsiteX2" fmla="*/ 244475 w 485775"/>
              <a:gd name="connsiteY2" fmla="*/ 16 h 159796"/>
              <a:gd name="connsiteX3" fmla="*/ 358775 w 485775"/>
              <a:gd name="connsiteY3" fmla="*/ 136541 h 159796"/>
              <a:gd name="connsiteX4" fmla="*/ 441325 w 485775"/>
              <a:gd name="connsiteY4" fmla="*/ 139716 h 159796"/>
              <a:gd name="connsiteX5" fmla="*/ 485775 w 485775"/>
              <a:gd name="connsiteY5" fmla="*/ 139716 h 159796"/>
              <a:gd name="connsiteX0" fmla="*/ 0 w 485775"/>
              <a:gd name="connsiteY0" fmla="*/ 146066 h 159796"/>
              <a:gd name="connsiteX1" fmla="*/ 200025 w 485775"/>
              <a:gd name="connsiteY1" fmla="*/ 146066 h 159796"/>
              <a:gd name="connsiteX2" fmla="*/ 244475 w 485775"/>
              <a:gd name="connsiteY2" fmla="*/ 16 h 159796"/>
              <a:gd name="connsiteX3" fmla="*/ 358775 w 485775"/>
              <a:gd name="connsiteY3" fmla="*/ 136541 h 159796"/>
              <a:gd name="connsiteX4" fmla="*/ 485775 w 485775"/>
              <a:gd name="connsiteY4" fmla="*/ 139716 h 159796"/>
              <a:gd name="connsiteX0" fmla="*/ 0 w 571500"/>
              <a:gd name="connsiteY0" fmla="*/ 146066 h 159796"/>
              <a:gd name="connsiteX1" fmla="*/ 200025 w 571500"/>
              <a:gd name="connsiteY1" fmla="*/ 146066 h 159796"/>
              <a:gd name="connsiteX2" fmla="*/ 244475 w 571500"/>
              <a:gd name="connsiteY2" fmla="*/ 16 h 159796"/>
              <a:gd name="connsiteX3" fmla="*/ 358775 w 571500"/>
              <a:gd name="connsiteY3" fmla="*/ 136541 h 159796"/>
              <a:gd name="connsiteX4" fmla="*/ 571500 w 571500"/>
              <a:gd name="connsiteY4" fmla="*/ 146066 h 159796"/>
              <a:gd name="connsiteX0" fmla="*/ 0 w 571500"/>
              <a:gd name="connsiteY0" fmla="*/ 142892 h 156396"/>
              <a:gd name="connsiteX1" fmla="*/ 200025 w 571500"/>
              <a:gd name="connsiteY1" fmla="*/ 142892 h 156396"/>
              <a:gd name="connsiteX2" fmla="*/ 304800 w 571500"/>
              <a:gd name="connsiteY2" fmla="*/ 17 h 156396"/>
              <a:gd name="connsiteX3" fmla="*/ 358775 w 571500"/>
              <a:gd name="connsiteY3" fmla="*/ 133367 h 156396"/>
              <a:gd name="connsiteX4" fmla="*/ 571500 w 571500"/>
              <a:gd name="connsiteY4" fmla="*/ 142892 h 156396"/>
              <a:gd name="connsiteX0" fmla="*/ 0 w 571500"/>
              <a:gd name="connsiteY0" fmla="*/ 142875 h 156379"/>
              <a:gd name="connsiteX1" fmla="*/ 200025 w 571500"/>
              <a:gd name="connsiteY1" fmla="*/ 142875 h 156379"/>
              <a:gd name="connsiteX2" fmla="*/ 304800 w 571500"/>
              <a:gd name="connsiteY2" fmla="*/ 0 h 156379"/>
              <a:gd name="connsiteX3" fmla="*/ 390525 w 571500"/>
              <a:gd name="connsiteY3" fmla="*/ 142875 h 156379"/>
              <a:gd name="connsiteX4" fmla="*/ 571500 w 571500"/>
              <a:gd name="connsiteY4" fmla="*/ 142875 h 156379"/>
              <a:gd name="connsiteX0" fmla="*/ 0 w 571500"/>
              <a:gd name="connsiteY0" fmla="*/ 142875 h 153312"/>
              <a:gd name="connsiteX1" fmla="*/ 200025 w 571500"/>
              <a:gd name="connsiteY1" fmla="*/ 142875 h 153312"/>
              <a:gd name="connsiteX2" fmla="*/ 304800 w 571500"/>
              <a:gd name="connsiteY2" fmla="*/ 0 h 153312"/>
              <a:gd name="connsiteX3" fmla="*/ 390525 w 571500"/>
              <a:gd name="connsiteY3" fmla="*/ 142875 h 153312"/>
              <a:gd name="connsiteX4" fmla="*/ 571500 w 571500"/>
              <a:gd name="connsiteY4" fmla="*/ 142875 h 153312"/>
              <a:gd name="connsiteX0" fmla="*/ 0 w 571500"/>
              <a:gd name="connsiteY0" fmla="*/ 142875 h 153312"/>
              <a:gd name="connsiteX1" fmla="*/ 200025 w 571500"/>
              <a:gd name="connsiteY1" fmla="*/ 142875 h 153312"/>
              <a:gd name="connsiteX2" fmla="*/ 304800 w 571500"/>
              <a:gd name="connsiteY2" fmla="*/ 0 h 153312"/>
              <a:gd name="connsiteX3" fmla="*/ 390525 w 571500"/>
              <a:gd name="connsiteY3" fmla="*/ 142875 h 153312"/>
              <a:gd name="connsiteX4" fmla="*/ 571500 w 571500"/>
              <a:gd name="connsiteY4" fmla="*/ 142875 h 153312"/>
              <a:gd name="connsiteX0" fmla="*/ 0 w 523875"/>
              <a:gd name="connsiteY0" fmla="*/ 142875 h 154416"/>
              <a:gd name="connsiteX1" fmla="*/ 200025 w 523875"/>
              <a:gd name="connsiteY1" fmla="*/ 142875 h 154416"/>
              <a:gd name="connsiteX2" fmla="*/ 304800 w 523875"/>
              <a:gd name="connsiteY2" fmla="*/ 0 h 154416"/>
              <a:gd name="connsiteX3" fmla="*/ 390525 w 523875"/>
              <a:gd name="connsiteY3" fmla="*/ 142875 h 154416"/>
              <a:gd name="connsiteX4" fmla="*/ 523875 w 523875"/>
              <a:gd name="connsiteY4" fmla="*/ 146050 h 154416"/>
              <a:gd name="connsiteX0" fmla="*/ 0 w 507207"/>
              <a:gd name="connsiteY0" fmla="*/ 142875 h 156351"/>
              <a:gd name="connsiteX1" fmla="*/ 200025 w 507207"/>
              <a:gd name="connsiteY1" fmla="*/ 142875 h 156351"/>
              <a:gd name="connsiteX2" fmla="*/ 304800 w 507207"/>
              <a:gd name="connsiteY2" fmla="*/ 0 h 156351"/>
              <a:gd name="connsiteX3" fmla="*/ 390525 w 507207"/>
              <a:gd name="connsiteY3" fmla="*/ 142875 h 156351"/>
              <a:gd name="connsiteX4" fmla="*/ 507207 w 507207"/>
              <a:gd name="connsiteY4" fmla="*/ 150813 h 156351"/>
              <a:gd name="connsiteX0" fmla="*/ 0 w 507207"/>
              <a:gd name="connsiteY0" fmla="*/ 142875 h 156351"/>
              <a:gd name="connsiteX1" fmla="*/ 200025 w 507207"/>
              <a:gd name="connsiteY1" fmla="*/ 142875 h 156351"/>
              <a:gd name="connsiteX2" fmla="*/ 304800 w 507207"/>
              <a:gd name="connsiteY2" fmla="*/ 0 h 156351"/>
              <a:gd name="connsiteX3" fmla="*/ 390525 w 507207"/>
              <a:gd name="connsiteY3" fmla="*/ 142875 h 156351"/>
              <a:gd name="connsiteX4" fmla="*/ 507207 w 507207"/>
              <a:gd name="connsiteY4" fmla="*/ 150813 h 156351"/>
              <a:gd name="connsiteX0" fmla="*/ 0 w 507207"/>
              <a:gd name="connsiteY0" fmla="*/ 142878 h 159534"/>
              <a:gd name="connsiteX1" fmla="*/ 200025 w 507207"/>
              <a:gd name="connsiteY1" fmla="*/ 142878 h 159534"/>
              <a:gd name="connsiteX2" fmla="*/ 304800 w 507207"/>
              <a:gd name="connsiteY2" fmla="*/ 3 h 159534"/>
              <a:gd name="connsiteX3" fmla="*/ 314325 w 507207"/>
              <a:gd name="connsiteY3" fmla="*/ 147641 h 159534"/>
              <a:gd name="connsiteX4" fmla="*/ 507207 w 507207"/>
              <a:gd name="connsiteY4" fmla="*/ 150816 h 159534"/>
              <a:gd name="connsiteX0" fmla="*/ 0 w 507207"/>
              <a:gd name="connsiteY0" fmla="*/ 142879 h 153645"/>
              <a:gd name="connsiteX1" fmla="*/ 200025 w 507207"/>
              <a:gd name="connsiteY1" fmla="*/ 142879 h 153645"/>
              <a:gd name="connsiteX2" fmla="*/ 304800 w 507207"/>
              <a:gd name="connsiteY2" fmla="*/ 4 h 153645"/>
              <a:gd name="connsiteX3" fmla="*/ 319087 w 507207"/>
              <a:gd name="connsiteY3" fmla="*/ 138117 h 153645"/>
              <a:gd name="connsiteX4" fmla="*/ 507207 w 507207"/>
              <a:gd name="connsiteY4" fmla="*/ 150817 h 153645"/>
              <a:gd name="connsiteX0" fmla="*/ 0 w 507207"/>
              <a:gd name="connsiteY0" fmla="*/ 142879 h 153645"/>
              <a:gd name="connsiteX1" fmla="*/ 200025 w 507207"/>
              <a:gd name="connsiteY1" fmla="*/ 142879 h 153645"/>
              <a:gd name="connsiteX2" fmla="*/ 304800 w 507207"/>
              <a:gd name="connsiteY2" fmla="*/ 4 h 153645"/>
              <a:gd name="connsiteX3" fmla="*/ 319087 w 507207"/>
              <a:gd name="connsiteY3" fmla="*/ 138117 h 153645"/>
              <a:gd name="connsiteX4" fmla="*/ 507207 w 507207"/>
              <a:gd name="connsiteY4" fmla="*/ 150817 h 153645"/>
              <a:gd name="connsiteX0" fmla="*/ 0 w 507207"/>
              <a:gd name="connsiteY0" fmla="*/ 142879 h 153645"/>
              <a:gd name="connsiteX1" fmla="*/ 200025 w 507207"/>
              <a:gd name="connsiteY1" fmla="*/ 142879 h 153645"/>
              <a:gd name="connsiteX2" fmla="*/ 304800 w 507207"/>
              <a:gd name="connsiteY2" fmla="*/ 4 h 153645"/>
              <a:gd name="connsiteX3" fmla="*/ 319087 w 507207"/>
              <a:gd name="connsiteY3" fmla="*/ 138117 h 153645"/>
              <a:gd name="connsiteX4" fmla="*/ 507207 w 507207"/>
              <a:gd name="connsiteY4" fmla="*/ 150817 h 153645"/>
              <a:gd name="connsiteX0" fmla="*/ 0 w 507207"/>
              <a:gd name="connsiteY0" fmla="*/ 142879 h 150817"/>
              <a:gd name="connsiteX1" fmla="*/ 200025 w 507207"/>
              <a:gd name="connsiteY1" fmla="*/ 142879 h 150817"/>
              <a:gd name="connsiteX2" fmla="*/ 304800 w 507207"/>
              <a:gd name="connsiteY2" fmla="*/ 4 h 150817"/>
              <a:gd name="connsiteX3" fmla="*/ 319087 w 507207"/>
              <a:gd name="connsiteY3" fmla="*/ 138117 h 150817"/>
              <a:gd name="connsiteX4" fmla="*/ 507207 w 507207"/>
              <a:gd name="connsiteY4" fmla="*/ 150817 h 150817"/>
              <a:gd name="connsiteX0" fmla="*/ 0 w 507207"/>
              <a:gd name="connsiteY0" fmla="*/ 142879 h 150817"/>
              <a:gd name="connsiteX1" fmla="*/ 200025 w 507207"/>
              <a:gd name="connsiteY1" fmla="*/ 142879 h 150817"/>
              <a:gd name="connsiteX2" fmla="*/ 304800 w 507207"/>
              <a:gd name="connsiteY2" fmla="*/ 4 h 150817"/>
              <a:gd name="connsiteX3" fmla="*/ 319087 w 507207"/>
              <a:gd name="connsiteY3" fmla="*/ 138117 h 150817"/>
              <a:gd name="connsiteX4" fmla="*/ 507207 w 507207"/>
              <a:gd name="connsiteY4" fmla="*/ 150817 h 150817"/>
              <a:gd name="connsiteX0" fmla="*/ 0 w 507207"/>
              <a:gd name="connsiteY0" fmla="*/ 142879 h 150817"/>
              <a:gd name="connsiteX1" fmla="*/ 200025 w 507207"/>
              <a:gd name="connsiteY1" fmla="*/ 142879 h 150817"/>
              <a:gd name="connsiteX2" fmla="*/ 304800 w 507207"/>
              <a:gd name="connsiteY2" fmla="*/ 4 h 150817"/>
              <a:gd name="connsiteX3" fmla="*/ 319087 w 507207"/>
              <a:gd name="connsiteY3" fmla="*/ 138117 h 150817"/>
              <a:gd name="connsiteX4" fmla="*/ 507207 w 507207"/>
              <a:gd name="connsiteY4" fmla="*/ 150817 h 150817"/>
              <a:gd name="connsiteX0" fmla="*/ 0 w 507207"/>
              <a:gd name="connsiteY0" fmla="*/ 142879 h 150817"/>
              <a:gd name="connsiteX1" fmla="*/ 200025 w 507207"/>
              <a:gd name="connsiteY1" fmla="*/ 142879 h 150817"/>
              <a:gd name="connsiteX2" fmla="*/ 304800 w 507207"/>
              <a:gd name="connsiteY2" fmla="*/ 4 h 150817"/>
              <a:gd name="connsiteX3" fmla="*/ 319087 w 507207"/>
              <a:gd name="connsiteY3" fmla="*/ 138117 h 150817"/>
              <a:gd name="connsiteX4" fmla="*/ 507207 w 507207"/>
              <a:gd name="connsiteY4" fmla="*/ 150817 h 150817"/>
              <a:gd name="connsiteX0" fmla="*/ 0 w 507207"/>
              <a:gd name="connsiteY0" fmla="*/ 142879 h 150817"/>
              <a:gd name="connsiteX1" fmla="*/ 200025 w 507207"/>
              <a:gd name="connsiteY1" fmla="*/ 142879 h 150817"/>
              <a:gd name="connsiteX2" fmla="*/ 304800 w 507207"/>
              <a:gd name="connsiteY2" fmla="*/ 4 h 150817"/>
              <a:gd name="connsiteX3" fmla="*/ 319087 w 507207"/>
              <a:gd name="connsiteY3" fmla="*/ 138117 h 150817"/>
              <a:gd name="connsiteX4" fmla="*/ 507207 w 507207"/>
              <a:gd name="connsiteY4" fmla="*/ 150817 h 150817"/>
              <a:gd name="connsiteX0" fmla="*/ 0 w 507207"/>
              <a:gd name="connsiteY0" fmla="*/ 142879 h 148189"/>
              <a:gd name="connsiteX1" fmla="*/ 200025 w 507207"/>
              <a:gd name="connsiteY1" fmla="*/ 142879 h 148189"/>
              <a:gd name="connsiteX2" fmla="*/ 304800 w 507207"/>
              <a:gd name="connsiteY2" fmla="*/ 4 h 148189"/>
              <a:gd name="connsiteX3" fmla="*/ 319087 w 507207"/>
              <a:gd name="connsiteY3" fmla="*/ 138117 h 148189"/>
              <a:gd name="connsiteX4" fmla="*/ 507207 w 507207"/>
              <a:gd name="connsiteY4" fmla="*/ 141292 h 148189"/>
              <a:gd name="connsiteX0" fmla="*/ 0 w 507207"/>
              <a:gd name="connsiteY0" fmla="*/ 142879 h 148189"/>
              <a:gd name="connsiteX1" fmla="*/ 200025 w 507207"/>
              <a:gd name="connsiteY1" fmla="*/ 142879 h 148189"/>
              <a:gd name="connsiteX2" fmla="*/ 304800 w 507207"/>
              <a:gd name="connsiteY2" fmla="*/ 4 h 148189"/>
              <a:gd name="connsiteX3" fmla="*/ 316705 w 507207"/>
              <a:gd name="connsiteY3" fmla="*/ 147642 h 148189"/>
              <a:gd name="connsiteX4" fmla="*/ 507207 w 507207"/>
              <a:gd name="connsiteY4" fmla="*/ 141292 h 148189"/>
              <a:gd name="connsiteX0" fmla="*/ 0 w 507207"/>
              <a:gd name="connsiteY0" fmla="*/ 142879 h 148189"/>
              <a:gd name="connsiteX1" fmla="*/ 200025 w 507207"/>
              <a:gd name="connsiteY1" fmla="*/ 142879 h 148189"/>
              <a:gd name="connsiteX2" fmla="*/ 304800 w 507207"/>
              <a:gd name="connsiteY2" fmla="*/ 4 h 148189"/>
              <a:gd name="connsiteX3" fmla="*/ 316705 w 507207"/>
              <a:gd name="connsiteY3" fmla="*/ 147642 h 148189"/>
              <a:gd name="connsiteX4" fmla="*/ 507207 w 507207"/>
              <a:gd name="connsiteY4" fmla="*/ 141292 h 148189"/>
              <a:gd name="connsiteX0" fmla="*/ 0 w 514351"/>
              <a:gd name="connsiteY0" fmla="*/ 142879 h 150068"/>
              <a:gd name="connsiteX1" fmla="*/ 200025 w 514351"/>
              <a:gd name="connsiteY1" fmla="*/ 142879 h 150068"/>
              <a:gd name="connsiteX2" fmla="*/ 304800 w 514351"/>
              <a:gd name="connsiteY2" fmla="*/ 4 h 150068"/>
              <a:gd name="connsiteX3" fmla="*/ 316705 w 514351"/>
              <a:gd name="connsiteY3" fmla="*/ 147642 h 150068"/>
              <a:gd name="connsiteX4" fmla="*/ 514351 w 514351"/>
              <a:gd name="connsiteY4" fmla="*/ 148436 h 150068"/>
              <a:gd name="connsiteX0" fmla="*/ 0 w 514351"/>
              <a:gd name="connsiteY0" fmla="*/ 142875 h 151835"/>
              <a:gd name="connsiteX1" fmla="*/ 126207 w 514351"/>
              <a:gd name="connsiteY1" fmla="*/ 147638 h 151835"/>
              <a:gd name="connsiteX2" fmla="*/ 304800 w 514351"/>
              <a:gd name="connsiteY2" fmla="*/ 0 h 151835"/>
              <a:gd name="connsiteX3" fmla="*/ 316705 w 514351"/>
              <a:gd name="connsiteY3" fmla="*/ 147638 h 151835"/>
              <a:gd name="connsiteX4" fmla="*/ 514351 w 514351"/>
              <a:gd name="connsiteY4" fmla="*/ 148432 h 151835"/>
              <a:gd name="connsiteX0" fmla="*/ 0 w 514351"/>
              <a:gd name="connsiteY0" fmla="*/ 142875 h 157411"/>
              <a:gd name="connsiteX1" fmla="*/ 126207 w 514351"/>
              <a:gd name="connsiteY1" fmla="*/ 147638 h 157411"/>
              <a:gd name="connsiteX2" fmla="*/ 245269 w 514351"/>
              <a:gd name="connsiteY2" fmla="*/ 0 h 157411"/>
              <a:gd name="connsiteX3" fmla="*/ 316705 w 514351"/>
              <a:gd name="connsiteY3" fmla="*/ 147638 h 157411"/>
              <a:gd name="connsiteX4" fmla="*/ 514351 w 514351"/>
              <a:gd name="connsiteY4" fmla="*/ 148432 h 157411"/>
              <a:gd name="connsiteX0" fmla="*/ 0 w 514351"/>
              <a:gd name="connsiteY0" fmla="*/ 142883 h 152140"/>
              <a:gd name="connsiteX1" fmla="*/ 126207 w 514351"/>
              <a:gd name="connsiteY1" fmla="*/ 140502 h 152140"/>
              <a:gd name="connsiteX2" fmla="*/ 245269 w 514351"/>
              <a:gd name="connsiteY2" fmla="*/ 8 h 152140"/>
              <a:gd name="connsiteX3" fmla="*/ 316705 w 514351"/>
              <a:gd name="connsiteY3" fmla="*/ 147646 h 152140"/>
              <a:gd name="connsiteX4" fmla="*/ 514351 w 514351"/>
              <a:gd name="connsiteY4" fmla="*/ 148440 h 152140"/>
              <a:gd name="connsiteX0" fmla="*/ 0 w 514351"/>
              <a:gd name="connsiteY0" fmla="*/ 142883 h 150072"/>
              <a:gd name="connsiteX1" fmla="*/ 126207 w 514351"/>
              <a:gd name="connsiteY1" fmla="*/ 140502 h 150072"/>
              <a:gd name="connsiteX2" fmla="*/ 245269 w 514351"/>
              <a:gd name="connsiteY2" fmla="*/ 8 h 150072"/>
              <a:gd name="connsiteX3" fmla="*/ 316705 w 514351"/>
              <a:gd name="connsiteY3" fmla="*/ 147646 h 150072"/>
              <a:gd name="connsiteX4" fmla="*/ 514351 w 514351"/>
              <a:gd name="connsiteY4" fmla="*/ 148440 h 150072"/>
              <a:gd name="connsiteX0" fmla="*/ 0 w 514351"/>
              <a:gd name="connsiteY0" fmla="*/ 142883 h 150072"/>
              <a:gd name="connsiteX1" fmla="*/ 126207 w 514351"/>
              <a:gd name="connsiteY1" fmla="*/ 140502 h 150072"/>
              <a:gd name="connsiteX2" fmla="*/ 245269 w 514351"/>
              <a:gd name="connsiteY2" fmla="*/ 8 h 150072"/>
              <a:gd name="connsiteX3" fmla="*/ 316705 w 514351"/>
              <a:gd name="connsiteY3" fmla="*/ 147646 h 150072"/>
              <a:gd name="connsiteX4" fmla="*/ 514351 w 514351"/>
              <a:gd name="connsiteY4" fmla="*/ 148440 h 150072"/>
              <a:gd name="connsiteX0" fmla="*/ 0 w 514351"/>
              <a:gd name="connsiteY0" fmla="*/ 142891 h 150080"/>
              <a:gd name="connsiteX1" fmla="*/ 126207 w 514351"/>
              <a:gd name="connsiteY1" fmla="*/ 140510 h 150080"/>
              <a:gd name="connsiteX2" fmla="*/ 245269 w 514351"/>
              <a:gd name="connsiteY2" fmla="*/ 16 h 150080"/>
              <a:gd name="connsiteX3" fmla="*/ 316705 w 514351"/>
              <a:gd name="connsiteY3" fmla="*/ 147654 h 150080"/>
              <a:gd name="connsiteX4" fmla="*/ 514351 w 514351"/>
              <a:gd name="connsiteY4" fmla="*/ 148448 h 150080"/>
              <a:gd name="connsiteX0" fmla="*/ 0 w 459583"/>
              <a:gd name="connsiteY0" fmla="*/ 142891 h 147654"/>
              <a:gd name="connsiteX1" fmla="*/ 126207 w 459583"/>
              <a:gd name="connsiteY1" fmla="*/ 140510 h 147654"/>
              <a:gd name="connsiteX2" fmla="*/ 245269 w 459583"/>
              <a:gd name="connsiteY2" fmla="*/ 16 h 147654"/>
              <a:gd name="connsiteX3" fmla="*/ 316705 w 459583"/>
              <a:gd name="connsiteY3" fmla="*/ 147654 h 147654"/>
              <a:gd name="connsiteX4" fmla="*/ 459583 w 459583"/>
              <a:gd name="connsiteY4" fmla="*/ 143686 h 147654"/>
              <a:gd name="connsiteX0" fmla="*/ 0 w 511970"/>
              <a:gd name="connsiteY0" fmla="*/ 142891 h 147654"/>
              <a:gd name="connsiteX1" fmla="*/ 126207 w 511970"/>
              <a:gd name="connsiteY1" fmla="*/ 140510 h 147654"/>
              <a:gd name="connsiteX2" fmla="*/ 245269 w 511970"/>
              <a:gd name="connsiteY2" fmla="*/ 16 h 147654"/>
              <a:gd name="connsiteX3" fmla="*/ 316705 w 511970"/>
              <a:gd name="connsiteY3" fmla="*/ 147654 h 147654"/>
              <a:gd name="connsiteX4" fmla="*/ 511970 w 511970"/>
              <a:gd name="connsiteY4" fmla="*/ 143686 h 147654"/>
              <a:gd name="connsiteX0" fmla="*/ 0 w 511970"/>
              <a:gd name="connsiteY0" fmla="*/ 142891 h 147654"/>
              <a:gd name="connsiteX1" fmla="*/ 126207 w 511970"/>
              <a:gd name="connsiteY1" fmla="*/ 140510 h 147654"/>
              <a:gd name="connsiteX2" fmla="*/ 245269 w 511970"/>
              <a:gd name="connsiteY2" fmla="*/ 16 h 147654"/>
              <a:gd name="connsiteX3" fmla="*/ 316705 w 511970"/>
              <a:gd name="connsiteY3" fmla="*/ 147654 h 147654"/>
              <a:gd name="connsiteX4" fmla="*/ 511970 w 511970"/>
              <a:gd name="connsiteY4" fmla="*/ 143686 h 147654"/>
              <a:gd name="connsiteX0" fmla="*/ 0 w 511970"/>
              <a:gd name="connsiteY0" fmla="*/ 142891 h 148448"/>
              <a:gd name="connsiteX1" fmla="*/ 126207 w 511970"/>
              <a:gd name="connsiteY1" fmla="*/ 140510 h 148448"/>
              <a:gd name="connsiteX2" fmla="*/ 245269 w 511970"/>
              <a:gd name="connsiteY2" fmla="*/ 16 h 148448"/>
              <a:gd name="connsiteX3" fmla="*/ 316705 w 511970"/>
              <a:gd name="connsiteY3" fmla="*/ 147654 h 148448"/>
              <a:gd name="connsiteX4" fmla="*/ 511970 w 511970"/>
              <a:gd name="connsiteY4" fmla="*/ 148448 h 148448"/>
              <a:gd name="connsiteX0" fmla="*/ 0 w 511970"/>
              <a:gd name="connsiteY0" fmla="*/ 142891 h 148448"/>
              <a:gd name="connsiteX1" fmla="*/ 126207 w 511970"/>
              <a:gd name="connsiteY1" fmla="*/ 140510 h 148448"/>
              <a:gd name="connsiteX2" fmla="*/ 245269 w 511970"/>
              <a:gd name="connsiteY2" fmla="*/ 16 h 148448"/>
              <a:gd name="connsiteX3" fmla="*/ 316705 w 511970"/>
              <a:gd name="connsiteY3" fmla="*/ 147654 h 148448"/>
              <a:gd name="connsiteX4" fmla="*/ 511970 w 511970"/>
              <a:gd name="connsiteY4" fmla="*/ 148448 h 148448"/>
              <a:gd name="connsiteX0" fmla="*/ 0 w 511970"/>
              <a:gd name="connsiteY0" fmla="*/ 142891 h 148448"/>
              <a:gd name="connsiteX1" fmla="*/ 126207 w 511970"/>
              <a:gd name="connsiteY1" fmla="*/ 140510 h 148448"/>
              <a:gd name="connsiteX2" fmla="*/ 245269 w 511970"/>
              <a:gd name="connsiteY2" fmla="*/ 16 h 148448"/>
              <a:gd name="connsiteX3" fmla="*/ 316705 w 511970"/>
              <a:gd name="connsiteY3" fmla="*/ 147654 h 148448"/>
              <a:gd name="connsiteX4" fmla="*/ 511970 w 511970"/>
              <a:gd name="connsiteY4" fmla="*/ 148448 h 148448"/>
              <a:gd name="connsiteX0" fmla="*/ 0 w 511970"/>
              <a:gd name="connsiteY0" fmla="*/ 142876 h 148433"/>
              <a:gd name="connsiteX1" fmla="*/ 126207 w 511970"/>
              <a:gd name="connsiteY1" fmla="*/ 140495 h 148433"/>
              <a:gd name="connsiteX2" fmla="*/ 245269 w 511970"/>
              <a:gd name="connsiteY2" fmla="*/ 1 h 148433"/>
              <a:gd name="connsiteX3" fmla="*/ 319086 w 511970"/>
              <a:gd name="connsiteY3" fmla="*/ 138114 h 148433"/>
              <a:gd name="connsiteX4" fmla="*/ 511970 w 511970"/>
              <a:gd name="connsiteY4" fmla="*/ 148433 h 148433"/>
              <a:gd name="connsiteX0" fmla="*/ 0 w 511970"/>
              <a:gd name="connsiteY0" fmla="*/ 142939 h 154845"/>
              <a:gd name="connsiteX1" fmla="*/ 126207 w 511970"/>
              <a:gd name="connsiteY1" fmla="*/ 140558 h 154845"/>
              <a:gd name="connsiteX2" fmla="*/ 245269 w 511970"/>
              <a:gd name="connsiteY2" fmla="*/ 64 h 154845"/>
              <a:gd name="connsiteX3" fmla="*/ 319086 w 511970"/>
              <a:gd name="connsiteY3" fmla="*/ 154845 h 154845"/>
              <a:gd name="connsiteX4" fmla="*/ 511970 w 511970"/>
              <a:gd name="connsiteY4" fmla="*/ 148496 h 1548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48477 h 1524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48477 h 1524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50858 h 1524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50858 h 1524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50858 h 1524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50858 h 152445"/>
              <a:gd name="connsiteX0" fmla="*/ 0 w 511970"/>
              <a:gd name="connsiteY0" fmla="*/ 142920 h 152445"/>
              <a:gd name="connsiteX1" fmla="*/ 126207 w 511970"/>
              <a:gd name="connsiteY1" fmla="*/ 140539 h 152445"/>
              <a:gd name="connsiteX2" fmla="*/ 245269 w 511970"/>
              <a:gd name="connsiteY2" fmla="*/ 45 h 152445"/>
              <a:gd name="connsiteX3" fmla="*/ 321468 w 511970"/>
              <a:gd name="connsiteY3" fmla="*/ 152445 h 152445"/>
              <a:gd name="connsiteX4" fmla="*/ 511970 w 511970"/>
              <a:gd name="connsiteY4" fmla="*/ 150858 h 152445"/>
              <a:gd name="connsiteX0" fmla="*/ 0 w 511970"/>
              <a:gd name="connsiteY0" fmla="*/ 145299 h 154824"/>
              <a:gd name="connsiteX1" fmla="*/ 126207 w 511970"/>
              <a:gd name="connsiteY1" fmla="*/ 142918 h 154824"/>
              <a:gd name="connsiteX2" fmla="*/ 228600 w 511970"/>
              <a:gd name="connsiteY2" fmla="*/ 43 h 154824"/>
              <a:gd name="connsiteX3" fmla="*/ 321468 w 511970"/>
              <a:gd name="connsiteY3" fmla="*/ 154824 h 154824"/>
              <a:gd name="connsiteX4" fmla="*/ 511970 w 511970"/>
              <a:gd name="connsiteY4" fmla="*/ 153237 h 154824"/>
              <a:gd name="connsiteX0" fmla="*/ 0 w 511970"/>
              <a:gd name="connsiteY0" fmla="*/ 145299 h 154824"/>
              <a:gd name="connsiteX1" fmla="*/ 126207 w 511970"/>
              <a:gd name="connsiteY1" fmla="*/ 142918 h 154824"/>
              <a:gd name="connsiteX2" fmla="*/ 233362 w 511970"/>
              <a:gd name="connsiteY2" fmla="*/ 43 h 154824"/>
              <a:gd name="connsiteX3" fmla="*/ 321468 w 511970"/>
              <a:gd name="connsiteY3" fmla="*/ 154824 h 154824"/>
              <a:gd name="connsiteX4" fmla="*/ 511970 w 511970"/>
              <a:gd name="connsiteY4" fmla="*/ 153237 h 154824"/>
              <a:gd name="connsiteX0" fmla="*/ 0 w 511970"/>
              <a:gd name="connsiteY0" fmla="*/ 145299 h 154824"/>
              <a:gd name="connsiteX1" fmla="*/ 126207 w 511970"/>
              <a:gd name="connsiteY1" fmla="*/ 142918 h 154824"/>
              <a:gd name="connsiteX2" fmla="*/ 233362 w 511970"/>
              <a:gd name="connsiteY2" fmla="*/ 43 h 154824"/>
              <a:gd name="connsiteX3" fmla="*/ 321468 w 511970"/>
              <a:gd name="connsiteY3" fmla="*/ 154824 h 154824"/>
              <a:gd name="connsiteX4" fmla="*/ 511970 w 511970"/>
              <a:gd name="connsiteY4" fmla="*/ 153237 h 154824"/>
              <a:gd name="connsiteX0" fmla="*/ 0 w 511970"/>
              <a:gd name="connsiteY0" fmla="*/ 140540 h 150065"/>
              <a:gd name="connsiteX1" fmla="*/ 126207 w 511970"/>
              <a:gd name="connsiteY1" fmla="*/ 138159 h 150065"/>
              <a:gd name="connsiteX2" fmla="*/ 219075 w 511970"/>
              <a:gd name="connsiteY2" fmla="*/ 47 h 150065"/>
              <a:gd name="connsiteX3" fmla="*/ 321468 w 511970"/>
              <a:gd name="connsiteY3" fmla="*/ 150065 h 150065"/>
              <a:gd name="connsiteX4" fmla="*/ 511970 w 511970"/>
              <a:gd name="connsiteY4" fmla="*/ 148478 h 150065"/>
              <a:gd name="connsiteX0" fmla="*/ 0 w 511970"/>
              <a:gd name="connsiteY0" fmla="*/ 128644 h 138169"/>
              <a:gd name="connsiteX1" fmla="*/ 126207 w 511970"/>
              <a:gd name="connsiteY1" fmla="*/ 126263 h 138169"/>
              <a:gd name="connsiteX2" fmla="*/ 233363 w 511970"/>
              <a:gd name="connsiteY2" fmla="*/ 58 h 138169"/>
              <a:gd name="connsiteX3" fmla="*/ 321468 w 511970"/>
              <a:gd name="connsiteY3" fmla="*/ 138169 h 138169"/>
              <a:gd name="connsiteX4" fmla="*/ 511970 w 511970"/>
              <a:gd name="connsiteY4" fmla="*/ 136582 h 138169"/>
              <a:gd name="connsiteX0" fmla="*/ 0 w 511970"/>
              <a:gd name="connsiteY0" fmla="*/ 128644 h 138169"/>
              <a:gd name="connsiteX1" fmla="*/ 126207 w 511970"/>
              <a:gd name="connsiteY1" fmla="*/ 126263 h 138169"/>
              <a:gd name="connsiteX2" fmla="*/ 233363 w 511970"/>
              <a:gd name="connsiteY2" fmla="*/ 58 h 138169"/>
              <a:gd name="connsiteX3" fmla="*/ 326231 w 511970"/>
              <a:gd name="connsiteY3" fmla="*/ 138169 h 138169"/>
              <a:gd name="connsiteX4" fmla="*/ 511970 w 511970"/>
              <a:gd name="connsiteY4" fmla="*/ 136582 h 138169"/>
              <a:gd name="connsiteX0" fmla="*/ 0 w 511970"/>
              <a:gd name="connsiteY0" fmla="*/ 128644 h 138169"/>
              <a:gd name="connsiteX1" fmla="*/ 126207 w 511970"/>
              <a:gd name="connsiteY1" fmla="*/ 126263 h 138169"/>
              <a:gd name="connsiteX2" fmla="*/ 233363 w 511970"/>
              <a:gd name="connsiteY2" fmla="*/ 58 h 138169"/>
              <a:gd name="connsiteX3" fmla="*/ 326231 w 511970"/>
              <a:gd name="connsiteY3" fmla="*/ 138169 h 138169"/>
              <a:gd name="connsiteX4" fmla="*/ 511970 w 511970"/>
              <a:gd name="connsiteY4" fmla="*/ 136582 h 138169"/>
              <a:gd name="connsiteX0" fmla="*/ 0 w 511970"/>
              <a:gd name="connsiteY0" fmla="*/ 128697 h 138222"/>
              <a:gd name="connsiteX1" fmla="*/ 126207 w 511970"/>
              <a:gd name="connsiteY1" fmla="*/ 126316 h 138222"/>
              <a:gd name="connsiteX2" fmla="*/ 233363 w 511970"/>
              <a:gd name="connsiteY2" fmla="*/ 111 h 138222"/>
              <a:gd name="connsiteX3" fmla="*/ 326231 w 511970"/>
              <a:gd name="connsiteY3" fmla="*/ 138222 h 138222"/>
              <a:gd name="connsiteX4" fmla="*/ 511970 w 511970"/>
              <a:gd name="connsiteY4" fmla="*/ 136635 h 138222"/>
              <a:gd name="connsiteX0" fmla="*/ 0 w 511970"/>
              <a:gd name="connsiteY0" fmla="*/ 128697 h 138222"/>
              <a:gd name="connsiteX1" fmla="*/ 126207 w 511970"/>
              <a:gd name="connsiteY1" fmla="*/ 126316 h 138222"/>
              <a:gd name="connsiteX2" fmla="*/ 233363 w 511970"/>
              <a:gd name="connsiteY2" fmla="*/ 111 h 138222"/>
              <a:gd name="connsiteX3" fmla="*/ 326231 w 511970"/>
              <a:gd name="connsiteY3" fmla="*/ 138222 h 138222"/>
              <a:gd name="connsiteX4" fmla="*/ 511970 w 511970"/>
              <a:gd name="connsiteY4" fmla="*/ 136635 h 1382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11970" h="138222">
                <a:moveTo>
                  <a:pt x="0" y="128697"/>
                </a:moveTo>
                <a:cubicBezTo>
                  <a:pt x="80433" y="130284"/>
                  <a:pt x="80566" y="128698"/>
                  <a:pt x="126207" y="126316"/>
                </a:cubicBezTo>
                <a:cubicBezTo>
                  <a:pt x="155180" y="21884"/>
                  <a:pt x="200026" y="-1873"/>
                  <a:pt x="233363" y="111"/>
                </a:cubicBezTo>
                <a:cubicBezTo>
                  <a:pt x="266700" y="2095"/>
                  <a:pt x="325832" y="51926"/>
                  <a:pt x="326231" y="138222"/>
                </a:cubicBezTo>
                <a:cubicBezTo>
                  <a:pt x="389732" y="137693"/>
                  <a:pt x="367507" y="134782"/>
                  <a:pt x="511970" y="136635"/>
                </a:cubicBezTo>
              </a:path>
            </a:pathLst>
          </a:custGeom>
          <a:noFill/>
          <a:ln w="38100">
            <a:solidFill>
              <a:srgbClr val="4472C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9" name="Cross 348">
            <a:extLst>
              <a:ext uri="{FF2B5EF4-FFF2-40B4-BE49-F238E27FC236}">
                <a16:creationId xmlns:a16="http://schemas.microsoft.com/office/drawing/2014/main" id="{CF6106A7-413E-0119-1613-E2582C0539AC}"/>
              </a:ext>
            </a:extLst>
          </p:cNvPr>
          <p:cNvSpPr/>
          <p:nvPr/>
        </p:nvSpPr>
        <p:spPr>
          <a:xfrm rot="18891464">
            <a:off x="4255187" y="2713491"/>
            <a:ext cx="90000" cy="90000"/>
          </a:xfrm>
          <a:prstGeom prst="plus">
            <a:avLst>
              <a:gd name="adj" fmla="val 4062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97C386E7-B6E4-C3D5-7648-664D45BA4512}"/>
              </a:ext>
            </a:extLst>
          </p:cNvPr>
          <p:cNvSpPr txBox="1"/>
          <p:nvPr/>
        </p:nvSpPr>
        <p:spPr>
          <a:xfrm>
            <a:off x="720663" y="2759420"/>
            <a:ext cx="2017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F-binding site with SNP</a:t>
            </a: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7230AA60-7DC2-ADF5-28BF-AE28065560CC}"/>
              </a:ext>
            </a:extLst>
          </p:cNvPr>
          <p:cNvSpPr txBox="1"/>
          <p:nvPr/>
        </p:nvSpPr>
        <p:spPr>
          <a:xfrm>
            <a:off x="3386969" y="2757085"/>
            <a:ext cx="201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miRNA target site with SNP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05B1BD63-9CA0-AB69-7640-34F33C2404E9}"/>
              </a:ext>
            </a:extLst>
          </p:cNvPr>
          <p:cNvSpPr txBox="1"/>
          <p:nvPr/>
        </p:nvSpPr>
        <p:spPr>
          <a:xfrm>
            <a:off x="2395857" y="3268841"/>
            <a:ext cx="1314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NP-affected gene</a:t>
            </a:r>
          </a:p>
        </p:txBody>
      </p:sp>
      <p:sp>
        <p:nvSpPr>
          <p:cNvPr id="353" name="TextBox 352">
            <a:extLst>
              <a:ext uri="{FF2B5EF4-FFF2-40B4-BE49-F238E27FC236}">
                <a16:creationId xmlns:a16="http://schemas.microsoft.com/office/drawing/2014/main" id="{E763752D-8C4D-C616-ECBF-496CFE75C7DD}"/>
              </a:ext>
            </a:extLst>
          </p:cNvPr>
          <p:cNvSpPr txBox="1"/>
          <p:nvPr/>
        </p:nvSpPr>
        <p:spPr>
          <a:xfrm>
            <a:off x="2325053" y="3876788"/>
            <a:ext cx="14510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NP-affected protein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604B53EE-8409-7037-CAD7-BC5BC83EEDD9}"/>
              </a:ext>
            </a:extLst>
          </p:cNvPr>
          <p:cNvSpPr txBox="1"/>
          <p:nvPr/>
        </p:nvSpPr>
        <p:spPr>
          <a:xfrm>
            <a:off x="187851" y="4248131"/>
            <a:ext cx="5637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Heat propagation</a:t>
            </a:r>
          </a:p>
        </p:txBody>
      </p:sp>
      <p:cxnSp>
        <p:nvCxnSpPr>
          <p:cNvPr id="355" name="Straight Arrow Connector 354">
            <a:extLst>
              <a:ext uri="{FF2B5EF4-FFF2-40B4-BE49-F238E27FC236}">
                <a16:creationId xmlns:a16="http://schemas.microsoft.com/office/drawing/2014/main" id="{D5722A5F-87AB-A173-7F3D-9244A0A39F2A}"/>
              </a:ext>
            </a:extLst>
          </p:cNvPr>
          <p:cNvCxnSpPr>
            <a:cxnSpLocks/>
            <a:stCxn id="273" idx="2"/>
            <a:endCxn id="274" idx="0"/>
          </p:cNvCxnSpPr>
          <p:nvPr/>
        </p:nvCxnSpPr>
        <p:spPr>
          <a:xfrm>
            <a:off x="2988000" y="604361"/>
            <a:ext cx="3689" cy="27216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Straight Arrow Connector 355">
            <a:extLst>
              <a:ext uri="{FF2B5EF4-FFF2-40B4-BE49-F238E27FC236}">
                <a16:creationId xmlns:a16="http://schemas.microsoft.com/office/drawing/2014/main" id="{B2E93CA5-978D-EAF0-24D4-37A895FCEE84}"/>
              </a:ext>
            </a:extLst>
          </p:cNvPr>
          <p:cNvCxnSpPr>
            <a:cxnSpLocks/>
            <a:stCxn id="350" idx="2"/>
            <a:endCxn id="352" idx="1"/>
          </p:cNvCxnSpPr>
          <p:nvPr/>
        </p:nvCxnSpPr>
        <p:spPr>
          <a:xfrm>
            <a:off x="1729490" y="3005641"/>
            <a:ext cx="666367" cy="38631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7" name="Straight Arrow Connector 356">
            <a:extLst>
              <a:ext uri="{FF2B5EF4-FFF2-40B4-BE49-F238E27FC236}">
                <a16:creationId xmlns:a16="http://schemas.microsoft.com/office/drawing/2014/main" id="{C9524A37-3C7E-D1A1-CB41-5D5FCA0B4C9E}"/>
              </a:ext>
            </a:extLst>
          </p:cNvPr>
          <p:cNvCxnSpPr>
            <a:cxnSpLocks/>
            <a:stCxn id="351" idx="2"/>
            <a:endCxn id="352" idx="3"/>
          </p:cNvCxnSpPr>
          <p:nvPr/>
        </p:nvCxnSpPr>
        <p:spPr>
          <a:xfrm flipH="1">
            <a:off x="3710641" y="3003306"/>
            <a:ext cx="684328" cy="38864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TextBox 357">
            <a:extLst>
              <a:ext uri="{FF2B5EF4-FFF2-40B4-BE49-F238E27FC236}">
                <a16:creationId xmlns:a16="http://schemas.microsoft.com/office/drawing/2014/main" id="{4B6B077F-E661-8E09-1061-F2FCE4A3D9CB}"/>
              </a:ext>
            </a:extLst>
          </p:cNvPr>
          <p:cNvSpPr txBox="1"/>
          <p:nvPr/>
        </p:nvSpPr>
        <p:spPr>
          <a:xfrm>
            <a:off x="382477" y="5708664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=0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BF1D07B3-C571-EB62-A6BC-129E16086B3F}"/>
              </a:ext>
            </a:extLst>
          </p:cNvPr>
          <p:cNvSpPr txBox="1"/>
          <p:nvPr/>
        </p:nvSpPr>
        <p:spPr>
          <a:xfrm>
            <a:off x="1433087" y="5708664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=1</a:t>
            </a: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E37D709A-2488-FABF-7C96-A210C714D35B}"/>
              </a:ext>
            </a:extLst>
          </p:cNvPr>
          <p:cNvSpPr txBox="1"/>
          <p:nvPr/>
        </p:nvSpPr>
        <p:spPr>
          <a:xfrm>
            <a:off x="2523069" y="5708664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=2</a:t>
            </a:r>
          </a:p>
        </p:txBody>
      </p:sp>
      <p:sp>
        <p:nvSpPr>
          <p:cNvPr id="361" name="TextBox 360">
            <a:extLst>
              <a:ext uri="{FF2B5EF4-FFF2-40B4-BE49-F238E27FC236}">
                <a16:creationId xmlns:a16="http://schemas.microsoft.com/office/drawing/2014/main" id="{751ED276-8F7B-2E0D-74F6-1FB9131FB789}"/>
              </a:ext>
            </a:extLst>
          </p:cNvPr>
          <p:cNvSpPr txBox="1"/>
          <p:nvPr/>
        </p:nvSpPr>
        <p:spPr>
          <a:xfrm>
            <a:off x="3588123" y="574522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=∞</a:t>
            </a:r>
          </a:p>
        </p:txBody>
      </p:sp>
      <p:sp>
        <p:nvSpPr>
          <p:cNvPr id="362" name="Arrow: Right 361">
            <a:extLst>
              <a:ext uri="{FF2B5EF4-FFF2-40B4-BE49-F238E27FC236}">
                <a16:creationId xmlns:a16="http://schemas.microsoft.com/office/drawing/2014/main" id="{57AA7BEB-C401-4C40-964F-38F5F86D1940}"/>
              </a:ext>
            </a:extLst>
          </p:cNvPr>
          <p:cNvSpPr/>
          <p:nvPr/>
        </p:nvSpPr>
        <p:spPr>
          <a:xfrm>
            <a:off x="1074308" y="5045456"/>
            <a:ext cx="270000" cy="180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Arrow: Right 362">
            <a:extLst>
              <a:ext uri="{FF2B5EF4-FFF2-40B4-BE49-F238E27FC236}">
                <a16:creationId xmlns:a16="http://schemas.microsoft.com/office/drawing/2014/main" id="{35DECBFB-C4AB-5505-BFC1-CF58E94484DB}"/>
              </a:ext>
            </a:extLst>
          </p:cNvPr>
          <p:cNvSpPr/>
          <p:nvPr/>
        </p:nvSpPr>
        <p:spPr>
          <a:xfrm>
            <a:off x="2131971" y="5035854"/>
            <a:ext cx="270000" cy="180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Arrow: Right 363">
            <a:extLst>
              <a:ext uri="{FF2B5EF4-FFF2-40B4-BE49-F238E27FC236}">
                <a16:creationId xmlns:a16="http://schemas.microsoft.com/office/drawing/2014/main" id="{100287CC-6A30-99A0-3FE6-A0E5D359BACA}"/>
              </a:ext>
            </a:extLst>
          </p:cNvPr>
          <p:cNvSpPr/>
          <p:nvPr/>
        </p:nvSpPr>
        <p:spPr>
          <a:xfrm>
            <a:off x="3169644" y="5035854"/>
            <a:ext cx="270000" cy="180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Arrow: Right 364">
            <a:extLst>
              <a:ext uri="{FF2B5EF4-FFF2-40B4-BE49-F238E27FC236}">
                <a16:creationId xmlns:a16="http://schemas.microsoft.com/office/drawing/2014/main" id="{693A1332-931C-53AB-932F-8CC4DB51022A}"/>
              </a:ext>
            </a:extLst>
          </p:cNvPr>
          <p:cNvSpPr/>
          <p:nvPr/>
        </p:nvSpPr>
        <p:spPr>
          <a:xfrm>
            <a:off x="2411530" y="6645069"/>
            <a:ext cx="270000" cy="180000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C38EF8A4-F624-476D-6583-1DEF7614EDAF}"/>
              </a:ext>
            </a:extLst>
          </p:cNvPr>
          <p:cNvSpPr txBox="1"/>
          <p:nvPr/>
        </p:nvSpPr>
        <p:spPr>
          <a:xfrm>
            <a:off x="1424659" y="7040083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=0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9997A2CD-D9D0-89E9-4720-A2856BA02042}"/>
              </a:ext>
            </a:extLst>
          </p:cNvPr>
          <p:cNvSpPr txBox="1"/>
          <p:nvPr/>
        </p:nvSpPr>
        <p:spPr>
          <a:xfrm>
            <a:off x="3035513" y="7053033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=1</a:t>
            </a: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27F5F6C7-566D-E858-5751-B556A2ABF2D5}"/>
              </a:ext>
            </a:extLst>
          </p:cNvPr>
          <p:cNvSpPr txBox="1"/>
          <p:nvPr/>
        </p:nvSpPr>
        <p:spPr>
          <a:xfrm>
            <a:off x="4402456" y="4753232"/>
            <a:ext cx="1394380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NP-propagated signalling network</a:t>
            </a: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74F67426-B604-8810-5615-D4C5F801C256}"/>
              </a:ext>
            </a:extLst>
          </p:cNvPr>
          <p:cNvSpPr txBox="1"/>
          <p:nvPr/>
        </p:nvSpPr>
        <p:spPr>
          <a:xfrm>
            <a:off x="4040704" y="6352301"/>
            <a:ext cx="1727615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NP-propagated </a:t>
            </a:r>
            <a:b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gene regulatory network</a:t>
            </a:r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D382C133-BFF5-7BF6-6795-49188869DA4B}"/>
              </a:ext>
            </a:extLst>
          </p:cNvPr>
          <p:cNvSpPr txBox="1"/>
          <p:nvPr/>
        </p:nvSpPr>
        <p:spPr>
          <a:xfrm>
            <a:off x="436910" y="7613196"/>
            <a:ext cx="12519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GB" sz="1000" b="1" dirty="0"/>
              <a:t>Functional analysis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142E1838-5003-0545-4774-51AB79C8EC6C}"/>
              </a:ext>
            </a:extLst>
          </p:cNvPr>
          <p:cNvSpPr txBox="1"/>
          <p:nvPr/>
        </p:nvSpPr>
        <p:spPr>
          <a:xfrm>
            <a:off x="4447021" y="7610540"/>
            <a:ext cx="1259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ranscriptomic validation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2" name="Straight Arrow Connector 371">
            <a:extLst>
              <a:ext uri="{FF2B5EF4-FFF2-40B4-BE49-F238E27FC236}">
                <a16:creationId xmlns:a16="http://schemas.microsoft.com/office/drawing/2014/main" id="{DF455535-EF65-EB74-7BA4-F7032DCFFB71}"/>
              </a:ext>
            </a:extLst>
          </p:cNvPr>
          <p:cNvCxnSpPr>
            <a:cxnSpLocks/>
            <a:stCxn id="352" idx="2"/>
          </p:cNvCxnSpPr>
          <p:nvPr/>
        </p:nvCxnSpPr>
        <p:spPr>
          <a:xfrm flipH="1">
            <a:off x="3050572" y="3515062"/>
            <a:ext cx="2677" cy="20961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" name="Straight Arrow Connector 372">
            <a:extLst>
              <a:ext uri="{FF2B5EF4-FFF2-40B4-BE49-F238E27FC236}">
                <a16:creationId xmlns:a16="http://schemas.microsoft.com/office/drawing/2014/main" id="{4A318ACB-3866-3EEA-6F09-B3552B37E810}"/>
              </a:ext>
            </a:extLst>
          </p:cNvPr>
          <p:cNvCxnSpPr>
            <a:cxnSpLocks/>
          </p:cNvCxnSpPr>
          <p:nvPr/>
        </p:nvCxnSpPr>
        <p:spPr>
          <a:xfrm flipH="1">
            <a:off x="1025893" y="4063026"/>
            <a:ext cx="1994420" cy="64581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4" name="TextBox 373">
            <a:extLst>
              <a:ext uri="{FF2B5EF4-FFF2-40B4-BE49-F238E27FC236}">
                <a16:creationId xmlns:a16="http://schemas.microsoft.com/office/drawing/2014/main" id="{C80C2F42-8B96-D50D-A166-6AC77D4D8DD3}"/>
              </a:ext>
            </a:extLst>
          </p:cNvPr>
          <p:cNvSpPr txBox="1"/>
          <p:nvPr/>
        </p:nvSpPr>
        <p:spPr>
          <a:xfrm>
            <a:off x="196435" y="36276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75" name="TextBox 374">
            <a:extLst>
              <a:ext uri="{FF2B5EF4-FFF2-40B4-BE49-F238E27FC236}">
                <a16:creationId xmlns:a16="http://schemas.microsoft.com/office/drawing/2014/main" id="{6742A961-C41C-27B5-0AD8-4EC469318675}"/>
              </a:ext>
            </a:extLst>
          </p:cNvPr>
          <p:cNvSpPr txBox="1"/>
          <p:nvPr/>
        </p:nvSpPr>
        <p:spPr>
          <a:xfrm>
            <a:off x="207406" y="4285698"/>
            <a:ext cx="292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6B10A98B-6950-C080-2883-E376B55280DB}"/>
              </a:ext>
            </a:extLst>
          </p:cNvPr>
          <p:cNvSpPr txBox="1"/>
          <p:nvPr/>
        </p:nvSpPr>
        <p:spPr>
          <a:xfrm>
            <a:off x="143095" y="755852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cxnSp>
        <p:nvCxnSpPr>
          <p:cNvPr id="377" name="Straight Arrow Connector 376">
            <a:extLst>
              <a:ext uri="{FF2B5EF4-FFF2-40B4-BE49-F238E27FC236}">
                <a16:creationId xmlns:a16="http://schemas.microsoft.com/office/drawing/2014/main" id="{C2CEDDA3-C384-3BE7-4690-DDFA6F799B49}"/>
              </a:ext>
            </a:extLst>
          </p:cNvPr>
          <p:cNvCxnSpPr>
            <a:cxnSpLocks/>
            <a:endCxn id="393" idx="0"/>
          </p:cNvCxnSpPr>
          <p:nvPr/>
        </p:nvCxnSpPr>
        <p:spPr>
          <a:xfrm flipH="1">
            <a:off x="1607563" y="5655250"/>
            <a:ext cx="2337919" cy="670716"/>
          </a:xfrm>
          <a:prstGeom prst="straightConnector1">
            <a:avLst/>
          </a:prstGeom>
          <a:ln w="1905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8" name="TextBox 377">
            <a:extLst>
              <a:ext uri="{FF2B5EF4-FFF2-40B4-BE49-F238E27FC236}">
                <a16:creationId xmlns:a16="http://schemas.microsoft.com/office/drawing/2014/main" id="{C4CCB425-2E97-61A3-03BD-4B772A7B9E67}"/>
              </a:ext>
            </a:extLst>
          </p:cNvPr>
          <p:cNvSpPr txBox="1"/>
          <p:nvPr/>
        </p:nvSpPr>
        <p:spPr>
          <a:xfrm>
            <a:off x="3945559" y="5560022"/>
            <a:ext cx="2712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solidFill>
                  <a:schemeClr val="bg1"/>
                </a:solidFill>
              </a:rPr>
              <a:t>TF</a:t>
            </a:r>
            <a:endParaRPr lang="en-GB" sz="2000" b="1" dirty="0">
              <a:solidFill>
                <a:schemeClr val="bg1"/>
              </a:solidFill>
            </a:endParaRP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351A1FE5-7EF6-D26A-C9AA-B9A586FECD91}"/>
              </a:ext>
            </a:extLst>
          </p:cNvPr>
          <p:cNvSpPr txBox="1"/>
          <p:nvPr/>
        </p:nvSpPr>
        <p:spPr>
          <a:xfrm>
            <a:off x="3035513" y="6439521"/>
            <a:ext cx="2712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solidFill>
                  <a:schemeClr val="bg1"/>
                </a:solidFill>
              </a:rPr>
              <a:t>TF</a:t>
            </a:r>
            <a:endParaRPr lang="en-GB" sz="2000" b="1" dirty="0">
              <a:solidFill>
                <a:schemeClr val="bg1"/>
              </a:solidFill>
            </a:endParaRPr>
          </a:p>
        </p:txBody>
      </p:sp>
      <p:cxnSp>
        <p:nvCxnSpPr>
          <p:cNvPr id="380" name="Straight Connector 379">
            <a:extLst>
              <a:ext uri="{FF2B5EF4-FFF2-40B4-BE49-F238E27FC236}">
                <a16:creationId xmlns:a16="http://schemas.microsoft.com/office/drawing/2014/main" id="{B2137087-FA75-6783-1F0E-6C75E4F8F4A2}"/>
              </a:ext>
            </a:extLst>
          </p:cNvPr>
          <p:cNvCxnSpPr>
            <a:cxnSpLocks/>
          </p:cNvCxnSpPr>
          <p:nvPr/>
        </p:nvCxnSpPr>
        <p:spPr>
          <a:xfrm>
            <a:off x="182409" y="6065043"/>
            <a:ext cx="5643104" cy="0"/>
          </a:xfrm>
          <a:prstGeom prst="line">
            <a:avLst/>
          </a:prstGeom>
          <a:ln w="127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TextBox 380">
            <a:extLst>
              <a:ext uri="{FF2B5EF4-FFF2-40B4-BE49-F238E27FC236}">
                <a16:creationId xmlns:a16="http://schemas.microsoft.com/office/drawing/2014/main" id="{FC53AFF5-3ED9-32EE-6C7E-F3E4E05FE1A5}"/>
              </a:ext>
            </a:extLst>
          </p:cNvPr>
          <p:cNvSpPr txBox="1"/>
          <p:nvPr/>
        </p:nvSpPr>
        <p:spPr>
          <a:xfrm>
            <a:off x="220854" y="6077235"/>
            <a:ext cx="292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382" name="Rectangle 381">
            <a:extLst>
              <a:ext uri="{FF2B5EF4-FFF2-40B4-BE49-F238E27FC236}">
                <a16:creationId xmlns:a16="http://schemas.microsoft.com/office/drawing/2014/main" id="{B80DE9DC-AA38-0B47-DA2A-82BFB144399F}"/>
              </a:ext>
            </a:extLst>
          </p:cNvPr>
          <p:cNvSpPr/>
          <p:nvPr/>
        </p:nvSpPr>
        <p:spPr>
          <a:xfrm>
            <a:off x="2831094" y="3193537"/>
            <a:ext cx="414770" cy="116850"/>
          </a:xfrm>
          <a:prstGeom prst="rect">
            <a:avLst/>
          </a:prstGeom>
          <a:solidFill>
            <a:srgbClr val="CC6600"/>
          </a:solidFill>
          <a:ln>
            <a:solidFill>
              <a:srgbClr val="CC66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lIns="36000" tIns="0" rIns="36000" bIns="0" rtlCol="0" anchor="ctr"/>
          <a:lstStyle/>
          <a:p>
            <a:pPr algn="ctr"/>
            <a:endParaRPr lang="en-GB" sz="6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3" name="Group 382">
            <a:extLst>
              <a:ext uri="{FF2B5EF4-FFF2-40B4-BE49-F238E27FC236}">
                <a16:creationId xmlns:a16="http://schemas.microsoft.com/office/drawing/2014/main" id="{D2C59250-51EA-D476-7601-432B52F0560D}"/>
              </a:ext>
            </a:extLst>
          </p:cNvPr>
          <p:cNvGrpSpPr/>
          <p:nvPr/>
        </p:nvGrpSpPr>
        <p:grpSpPr>
          <a:xfrm>
            <a:off x="1188183" y="6325966"/>
            <a:ext cx="1183361" cy="625568"/>
            <a:chOff x="1364522" y="5785463"/>
            <a:chExt cx="1183361" cy="625568"/>
          </a:xfrm>
        </p:grpSpPr>
        <p:sp>
          <p:nvSpPr>
            <p:cNvPr id="384" name="Oval 383">
              <a:extLst>
                <a:ext uri="{FF2B5EF4-FFF2-40B4-BE49-F238E27FC236}">
                  <a16:creationId xmlns:a16="http://schemas.microsoft.com/office/drawing/2014/main" id="{24B0F493-DC52-20D6-28C2-AD2BC4ED232B}"/>
                </a:ext>
              </a:extLst>
            </p:cNvPr>
            <p:cNvSpPr/>
            <p:nvPr/>
          </p:nvSpPr>
          <p:spPr>
            <a:xfrm rot="5400000">
              <a:off x="1715877" y="5817211"/>
              <a:ext cx="144000" cy="144000"/>
            </a:xfrm>
            <a:prstGeom prst="ellipse">
              <a:avLst/>
            </a:prstGeom>
            <a:solidFill>
              <a:srgbClr val="CC00FF"/>
            </a:solidFill>
            <a:ln w="6350">
              <a:solidFill>
                <a:schemeClr val="tx1"/>
              </a:solidFill>
              <a:tailEnd w="sm" len="sm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385" name="Straight Arrow Connector 384">
              <a:extLst>
                <a:ext uri="{FF2B5EF4-FFF2-40B4-BE49-F238E27FC236}">
                  <a16:creationId xmlns:a16="http://schemas.microsoft.com/office/drawing/2014/main" id="{E86F56F4-7208-7665-2D41-D0AFEF00504E}"/>
                </a:ext>
              </a:extLst>
            </p:cNvPr>
            <p:cNvCxnSpPr>
              <a:cxnSpLocks/>
              <a:stCxn id="384" idx="4"/>
              <a:endCxn id="395" idx="0"/>
            </p:cNvCxnSpPr>
            <p:nvPr/>
          </p:nvCxnSpPr>
          <p:spPr>
            <a:xfrm flipH="1">
              <a:off x="1454522" y="5889211"/>
              <a:ext cx="261355" cy="153317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6" name="Straight Arrow Connector 385">
              <a:extLst>
                <a:ext uri="{FF2B5EF4-FFF2-40B4-BE49-F238E27FC236}">
                  <a16:creationId xmlns:a16="http://schemas.microsoft.com/office/drawing/2014/main" id="{94FCD457-C92E-C0A7-4759-80BF477FDC7D}"/>
                </a:ext>
              </a:extLst>
            </p:cNvPr>
            <p:cNvCxnSpPr>
              <a:cxnSpLocks/>
              <a:stCxn id="384" idx="5"/>
              <a:endCxn id="396" idx="0"/>
            </p:cNvCxnSpPr>
            <p:nvPr/>
          </p:nvCxnSpPr>
          <p:spPr>
            <a:xfrm flipH="1">
              <a:off x="1592878" y="5940123"/>
              <a:ext cx="144087" cy="234186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7" name="Straight Arrow Connector 386">
              <a:extLst>
                <a:ext uri="{FF2B5EF4-FFF2-40B4-BE49-F238E27FC236}">
                  <a16:creationId xmlns:a16="http://schemas.microsoft.com/office/drawing/2014/main" id="{FCEC4DB7-50FE-66D7-9968-D475C3D6AFA1}"/>
                </a:ext>
              </a:extLst>
            </p:cNvPr>
            <p:cNvCxnSpPr>
              <a:cxnSpLocks/>
              <a:stCxn id="384" idx="6"/>
              <a:endCxn id="397" idx="0"/>
            </p:cNvCxnSpPr>
            <p:nvPr/>
          </p:nvCxnSpPr>
          <p:spPr>
            <a:xfrm flipH="1">
              <a:off x="1783902" y="5961211"/>
              <a:ext cx="3975" cy="359820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8" name="Straight Arrow Connector 387">
              <a:extLst>
                <a:ext uri="{FF2B5EF4-FFF2-40B4-BE49-F238E27FC236}">
                  <a16:creationId xmlns:a16="http://schemas.microsoft.com/office/drawing/2014/main" id="{8055FA13-AD99-A05E-449D-E0B50789D2DC}"/>
                </a:ext>
              </a:extLst>
            </p:cNvPr>
            <p:cNvCxnSpPr>
              <a:cxnSpLocks/>
              <a:stCxn id="384" idx="0"/>
              <a:endCxn id="399" idx="0"/>
            </p:cNvCxnSpPr>
            <p:nvPr/>
          </p:nvCxnSpPr>
          <p:spPr>
            <a:xfrm>
              <a:off x="1859877" y="5889211"/>
              <a:ext cx="207949" cy="139588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9" name="Straight Arrow Connector 388">
              <a:extLst>
                <a:ext uri="{FF2B5EF4-FFF2-40B4-BE49-F238E27FC236}">
                  <a16:creationId xmlns:a16="http://schemas.microsoft.com/office/drawing/2014/main" id="{5AD2B49A-D06A-56A4-5D9D-DFC5240CA938}"/>
                </a:ext>
              </a:extLst>
            </p:cNvPr>
            <p:cNvCxnSpPr>
              <a:cxnSpLocks/>
              <a:stCxn id="384" idx="7"/>
              <a:endCxn id="398" idx="1"/>
            </p:cNvCxnSpPr>
            <p:nvPr/>
          </p:nvCxnSpPr>
          <p:spPr>
            <a:xfrm>
              <a:off x="1838789" y="5940123"/>
              <a:ext cx="136691" cy="283366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0" name="Oval 389">
              <a:extLst>
                <a:ext uri="{FF2B5EF4-FFF2-40B4-BE49-F238E27FC236}">
                  <a16:creationId xmlns:a16="http://schemas.microsoft.com/office/drawing/2014/main" id="{01E9DD5C-5461-1D6A-3114-7FC87BAE0D99}"/>
                </a:ext>
              </a:extLst>
            </p:cNvPr>
            <p:cNvSpPr/>
            <p:nvPr/>
          </p:nvSpPr>
          <p:spPr>
            <a:xfrm rot="5400000">
              <a:off x="2336212" y="5822577"/>
              <a:ext cx="144000" cy="144001"/>
            </a:xfrm>
            <a:prstGeom prst="ellipse">
              <a:avLst/>
            </a:prstGeom>
            <a:solidFill>
              <a:srgbClr val="E67DFF"/>
            </a:solidFill>
            <a:ln w="6350">
              <a:solidFill>
                <a:schemeClr val="tx1"/>
              </a:solidFill>
              <a:tailEnd w="sm" len="sm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391" name="Straight Arrow Connector 390">
              <a:extLst>
                <a:ext uri="{FF2B5EF4-FFF2-40B4-BE49-F238E27FC236}">
                  <a16:creationId xmlns:a16="http://schemas.microsoft.com/office/drawing/2014/main" id="{F3960291-129F-6628-3F1E-692F2824ECBD}"/>
                </a:ext>
              </a:extLst>
            </p:cNvPr>
            <p:cNvCxnSpPr>
              <a:cxnSpLocks/>
              <a:stCxn id="390" idx="5"/>
              <a:endCxn id="398" idx="3"/>
            </p:cNvCxnSpPr>
            <p:nvPr/>
          </p:nvCxnSpPr>
          <p:spPr>
            <a:xfrm flipH="1">
              <a:off x="2155480" y="5945490"/>
              <a:ext cx="201820" cy="277999"/>
            </a:xfrm>
            <a:prstGeom prst="straightConnector1">
              <a:avLst/>
            </a:prstGeom>
            <a:ln w="28575">
              <a:solidFill>
                <a:srgbClr val="00CC33"/>
              </a:solidFill>
              <a:headEnd w="lg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2" name="Straight Arrow Connector 391">
              <a:extLst>
                <a:ext uri="{FF2B5EF4-FFF2-40B4-BE49-F238E27FC236}">
                  <a16:creationId xmlns:a16="http://schemas.microsoft.com/office/drawing/2014/main" id="{6E1FB539-ADFC-5375-9D80-9235149EBDFE}"/>
                </a:ext>
              </a:extLst>
            </p:cNvPr>
            <p:cNvCxnSpPr>
              <a:cxnSpLocks/>
              <a:stCxn id="390" idx="4"/>
              <a:endCxn id="399" idx="0"/>
            </p:cNvCxnSpPr>
            <p:nvPr/>
          </p:nvCxnSpPr>
          <p:spPr>
            <a:xfrm flipH="1">
              <a:off x="2067826" y="5894578"/>
              <a:ext cx="268386" cy="134221"/>
            </a:xfrm>
            <a:prstGeom prst="straightConnector1">
              <a:avLst/>
            </a:prstGeom>
            <a:ln w="28575">
              <a:solidFill>
                <a:srgbClr val="00CC33"/>
              </a:solidFill>
              <a:headEnd w="lg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3" name="TextBox 392">
              <a:extLst>
                <a:ext uri="{FF2B5EF4-FFF2-40B4-BE49-F238E27FC236}">
                  <a16:creationId xmlns:a16="http://schemas.microsoft.com/office/drawing/2014/main" id="{6DEF1B4C-26F2-1502-9D1D-F3025FE2A1EC}"/>
                </a:ext>
              </a:extLst>
            </p:cNvPr>
            <p:cNvSpPr txBox="1"/>
            <p:nvPr/>
          </p:nvSpPr>
          <p:spPr>
            <a:xfrm>
              <a:off x="1648288" y="5785463"/>
              <a:ext cx="2712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bg1"/>
                  </a:solidFill>
                </a:rPr>
                <a:t>TF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id="{7CD91514-07F0-B4AF-6984-C9DB2AEC6A70}"/>
                </a:ext>
              </a:extLst>
            </p:cNvPr>
            <p:cNvSpPr txBox="1"/>
            <p:nvPr/>
          </p:nvSpPr>
          <p:spPr>
            <a:xfrm>
              <a:off x="2276655" y="5792722"/>
              <a:ext cx="2712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bg1"/>
                  </a:solidFill>
                </a:rPr>
                <a:t>TF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395" name="Rectangle 394">
              <a:extLst>
                <a:ext uri="{FF2B5EF4-FFF2-40B4-BE49-F238E27FC236}">
                  <a16:creationId xmlns:a16="http://schemas.microsoft.com/office/drawing/2014/main" id="{F4158D2D-F3AD-E1B8-A612-D96F561468A9}"/>
                </a:ext>
              </a:extLst>
            </p:cNvPr>
            <p:cNvSpPr/>
            <p:nvPr/>
          </p:nvSpPr>
          <p:spPr>
            <a:xfrm>
              <a:off x="1364522" y="6042528"/>
              <a:ext cx="180000" cy="9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6" name="Rectangle 395">
              <a:extLst>
                <a:ext uri="{FF2B5EF4-FFF2-40B4-BE49-F238E27FC236}">
                  <a16:creationId xmlns:a16="http://schemas.microsoft.com/office/drawing/2014/main" id="{183F4886-9D47-C6F6-6210-9D04A76159BA}"/>
                </a:ext>
              </a:extLst>
            </p:cNvPr>
            <p:cNvSpPr/>
            <p:nvPr/>
          </p:nvSpPr>
          <p:spPr>
            <a:xfrm>
              <a:off x="1502878" y="6174309"/>
              <a:ext cx="180000" cy="9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7" name="Rectangle 396">
              <a:extLst>
                <a:ext uri="{FF2B5EF4-FFF2-40B4-BE49-F238E27FC236}">
                  <a16:creationId xmlns:a16="http://schemas.microsoft.com/office/drawing/2014/main" id="{C6117773-43FE-8658-6A14-60635D6CE0CC}"/>
                </a:ext>
              </a:extLst>
            </p:cNvPr>
            <p:cNvSpPr/>
            <p:nvPr/>
          </p:nvSpPr>
          <p:spPr>
            <a:xfrm>
              <a:off x="1693902" y="6321031"/>
              <a:ext cx="180000" cy="9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8" name="Rectangle 397">
              <a:extLst>
                <a:ext uri="{FF2B5EF4-FFF2-40B4-BE49-F238E27FC236}">
                  <a16:creationId xmlns:a16="http://schemas.microsoft.com/office/drawing/2014/main" id="{8BC35004-0BD1-3429-9CDB-65227B105108}"/>
                </a:ext>
              </a:extLst>
            </p:cNvPr>
            <p:cNvSpPr/>
            <p:nvPr/>
          </p:nvSpPr>
          <p:spPr>
            <a:xfrm>
              <a:off x="1975480" y="6178489"/>
              <a:ext cx="180000" cy="9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9" name="Rectangle 398">
              <a:extLst>
                <a:ext uri="{FF2B5EF4-FFF2-40B4-BE49-F238E27FC236}">
                  <a16:creationId xmlns:a16="http://schemas.microsoft.com/office/drawing/2014/main" id="{C355A1C1-A46B-0CC9-CB9C-44BF1AE4FCF6}"/>
                </a:ext>
              </a:extLst>
            </p:cNvPr>
            <p:cNvSpPr/>
            <p:nvPr/>
          </p:nvSpPr>
          <p:spPr>
            <a:xfrm>
              <a:off x="1977826" y="6028799"/>
              <a:ext cx="180000" cy="9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00" name="Group 399">
            <a:extLst>
              <a:ext uri="{FF2B5EF4-FFF2-40B4-BE49-F238E27FC236}">
                <a16:creationId xmlns:a16="http://schemas.microsoft.com/office/drawing/2014/main" id="{C98E9B66-90BA-FD59-5683-8E6093294948}"/>
              </a:ext>
            </a:extLst>
          </p:cNvPr>
          <p:cNvGrpSpPr/>
          <p:nvPr/>
        </p:nvGrpSpPr>
        <p:grpSpPr>
          <a:xfrm>
            <a:off x="2773244" y="6311733"/>
            <a:ext cx="1183361" cy="625568"/>
            <a:chOff x="1364522" y="5785463"/>
            <a:chExt cx="1183361" cy="625568"/>
          </a:xfrm>
        </p:grpSpPr>
        <p:sp>
          <p:nvSpPr>
            <p:cNvPr id="401" name="Oval 400">
              <a:extLst>
                <a:ext uri="{FF2B5EF4-FFF2-40B4-BE49-F238E27FC236}">
                  <a16:creationId xmlns:a16="http://schemas.microsoft.com/office/drawing/2014/main" id="{901C86AC-CEEB-D87C-6CBE-773E27207ED3}"/>
                </a:ext>
              </a:extLst>
            </p:cNvPr>
            <p:cNvSpPr/>
            <p:nvPr/>
          </p:nvSpPr>
          <p:spPr>
            <a:xfrm rot="5400000">
              <a:off x="1715877" y="5817211"/>
              <a:ext cx="144000" cy="144000"/>
            </a:xfrm>
            <a:prstGeom prst="ellipse">
              <a:avLst/>
            </a:prstGeom>
            <a:solidFill>
              <a:srgbClr val="CC00FF"/>
            </a:solidFill>
            <a:ln w="6350">
              <a:solidFill>
                <a:schemeClr val="tx1"/>
              </a:solidFill>
              <a:tailEnd w="sm" len="sm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402" name="Straight Arrow Connector 401">
              <a:extLst>
                <a:ext uri="{FF2B5EF4-FFF2-40B4-BE49-F238E27FC236}">
                  <a16:creationId xmlns:a16="http://schemas.microsoft.com/office/drawing/2014/main" id="{CB8C1D02-382D-7AAB-5D8E-59ECBC5A1066}"/>
                </a:ext>
              </a:extLst>
            </p:cNvPr>
            <p:cNvCxnSpPr>
              <a:cxnSpLocks/>
              <a:stCxn id="401" idx="4"/>
              <a:endCxn id="412" idx="0"/>
            </p:cNvCxnSpPr>
            <p:nvPr/>
          </p:nvCxnSpPr>
          <p:spPr>
            <a:xfrm flipH="1">
              <a:off x="1454522" y="5889211"/>
              <a:ext cx="261355" cy="153317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Straight Arrow Connector 402">
              <a:extLst>
                <a:ext uri="{FF2B5EF4-FFF2-40B4-BE49-F238E27FC236}">
                  <a16:creationId xmlns:a16="http://schemas.microsoft.com/office/drawing/2014/main" id="{6FA98004-B581-874F-DBF1-8AA8F0FEC21B}"/>
                </a:ext>
              </a:extLst>
            </p:cNvPr>
            <p:cNvCxnSpPr>
              <a:cxnSpLocks/>
              <a:stCxn id="401" idx="5"/>
              <a:endCxn id="413" idx="0"/>
            </p:cNvCxnSpPr>
            <p:nvPr/>
          </p:nvCxnSpPr>
          <p:spPr>
            <a:xfrm flipH="1">
              <a:off x="1592878" y="5940123"/>
              <a:ext cx="144087" cy="234186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Straight Arrow Connector 403">
              <a:extLst>
                <a:ext uri="{FF2B5EF4-FFF2-40B4-BE49-F238E27FC236}">
                  <a16:creationId xmlns:a16="http://schemas.microsoft.com/office/drawing/2014/main" id="{91EDADEC-3144-6179-19D6-8C85118927F9}"/>
                </a:ext>
              </a:extLst>
            </p:cNvPr>
            <p:cNvCxnSpPr>
              <a:cxnSpLocks/>
              <a:stCxn id="401" idx="6"/>
              <a:endCxn id="414" idx="0"/>
            </p:cNvCxnSpPr>
            <p:nvPr/>
          </p:nvCxnSpPr>
          <p:spPr>
            <a:xfrm flipH="1">
              <a:off x="1783902" y="5961211"/>
              <a:ext cx="3975" cy="359820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Straight Arrow Connector 404">
              <a:extLst>
                <a:ext uri="{FF2B5EF4-FFF2-40B4-BE49-F238E27FC236}">
                  <a16:creationId xmlns:a16="http://schemas.microsoft.com/office/drawing/2014/main" id="{704716E6-2BF4-DD8F-B3E6-DA1AA044B37A}"/>
                </a:ext>
              </a:extLst>
            </p:cNvPr>
            <p:cNvCxnSpPr>
              <a:cxnSpLocks/>
              <a:stCxn id="401" idx="0"/>
              <a:endCxn id="416" idx="0"/>
            </p:cNvCxnSpPr>
            <p:nvPr/>
          </p:nvCxnSpPr>
          <p:spPr>
            <a:xfrm>
              <a:off x="1859877" y="5889211"/>
              <a:ext cx="207949" cy="139588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Straight Arrow Connector 405">
              <a:extLst>
                <a:ext uri="{FF2B5EF4-FFF2-40B4-BE49-F238E27FC236}">
                  <a16:creationId xmlns:a16="http://schemas.microsoft.com/office/drawing/2014/main" id="{F42FD2A1-840B-D849-102E-ED6D8615CC62}"/>
                </a:ext>
              </a:extLst>
            </p:cNvPr>
            <p:cNvCxnSpPr>
              <a:cxnSpLocks/>
              <a:stCxn id="401" idx="7"/>
              <a:endCxn id="415" idx="1"/>
            </p:cNvCxnSpPr>
            <p:nvPr/>
          </p:nvCxnSpPr>
          <p:spPr>
            <a:xfrm>
              <a:off x="1838789" y="5940123"/>
              <a:ext cx="136691" cy="283366"/>
            </a:xfrm>
            <a:prstGeom prst="straightConnector1">
              <a:avLst/>
            </a:prstGeom>
            <a:ln w="28575">
              <a:solidFill>
                <a:srgbClr val="00CC33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7" name="Oval 406">
              <a:extLst>
                <a:ext uri="{FF2B5EF4-FFF2-40B4-BE49-F238E27FC236}">
                  <a16:creationId xmlns:a16="http://schemas.microsoft.com/office/drawing/2014/main" id="{2D12A225-DA26-F85C-1BB5-0AEFE136B628}"/>
                </a:ext>
              </a:extLst>
            </p:cNvPr>
            <p:cNvSpPr/>
            <p:nvPr/>
          </p:nvSpPr>
          <p:spPr>
            <a:xfrm rot="5400000">
              <a:off x="2336212" y="5822577"/>
              <a:ext cx="144000" cy="144001"/>
            </a:xfrm>
            <a:prstGeom prst="ellipse">
              <a:avLst/>
            </a:prstGeom>
            <a:solidFill>
              <a:srgbClr val="E67DFF"/>
            </a:solidFill>
            <a:ln w="6350">
              <a:solidFill>
                <a:schemeClr val="tx1"/>
              </a:solidFill>
              <a:tailEnd w="sm" len="sm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cxnSp>
          <p:nvCxnSpPr>
            <p:cNvPr id="408" name="Straight Arrow Connector 407">
              <a:extLst>
                <a:ext uri="{FF2B5EF4-FFF2-40B4-BE49-F238E27FC236}">
                  <a16:creationId xmlns:a16="http://schemas.microsoft.com/office/drawing/2014/main" id="{45C76729-499F-B224-F0F0-9D2668D63E80}"/>
                </a:ext>
              </a:extLst>
            </p:cNvPr>
            <p:cNvCxnSpPr>
              <a:cxnSpLocks/>
              <a:stCxn id="407" idx="5"/>
              <a:endCxn id="415" idx="3"/>
            </p:cNvCxnSpPr>
            <p:nvPr/>
          </p:nvCxnSpPr>
          <p:spPr>
            <a:xfrm flipH="1">
              <a:off x="2155480" y="5945490"/>
              <a:ext cx="201820" cy="277999"/>
            </a:xfrm>
            <a:prstGeom prst="straightConnector1">
              <a:avLst/>
            </a:prstGeom>
            <a:ln w="28575">
              <a:solidFill>
                <a:srgbClr val="00CC33"/>
              </a:solidFill>
              <a:headEnd w="lg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" name="Straight Arrow Connector 408">
              <a:extLst>
                <a:ext uri="{FF2B5EF4-FFF2-40B4-BE49-F238E27FC236}">
                  <a16:creationId xmlns:a16="http://schemas.microsoft.com/office/drawing/2014/main" id="{8EEB6D77-C039-2CAF-3A19-3B4517518437}"/>
                </a:ext>
              </a:extLst>
            </p:cNvPr>
            <p:cNvCxnSpPr>
              <a:cxnSpLocks/>
              <a:stCxn id="407" idx="4"/>
              <a:endCxn id="416" idx="0"/>
            </p:cNvCxnSpPr>
            <p:nvPr/>
          </p:nvCxnSpPr>
          <p:spPr>
            <a:xfrm flipH="1">
              <a:off x="2067826" y="5894578"/>
              <a:ext cx="268386" cy="134221"/>
            </a:xfrm>
            <a:prstGeom prst="straightConnector1">
              <a:avLst/>
            </a:prstGeom>
            <a:ln w="28575">
              <a:solidFill>
                <a:srgbClr val="00CC33"/>
              </a:solidFill>
              <a:headEnd w="lg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0" name="TextBox 409">
              <a:extLst>
                <a:ext uri="{FF2B5EF4-FFF2-40B4-BE49-F238E27FC236}">
                  <a16:creationId xmlns:a16="http://schemas.microsoft.com/office/drawing/2014/main" id="{37815796-B70A-BAA7-F316-F0D4F9340921}"/>
                </a:ext>
              </a:extLst>
            </p:cNvPr>
            <p:cNvSpPr txBox="1"/>
            <p:nvPr/>
          </p:nvSpPr>
          <p:spPr>
            <a:xfrm>
              <a:off x="1648288" y="5785463"/>
              <a:ext cx="2712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bg1"/>
                  </a:solidFill>
                </a:rPr>
                <a:t>TF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411" name="TextBox 410">
              <a:extLst>
                <a:ext uri="{FF2B5EF4-FFF2-40B4-BE49-F238E27FC236}">
                  <a16:creationId xmlns:a16="http://schemas.microsoft.com/office/drawing/2014/main" id="{4FC32DBE-76B2-1199-552F-DD25AFDD0A6F}"/>
                </a:ext>
              </a:extLst>
            </p:cNvPr>
            <p:cNvSpPr txBox="1"/>
            <p:nvPr/>
          </p:nvSpPr>
          <p:spPr>
            <a:xfrm>
              <a:off x="2276655" y="5792722"/>
              <a:ext cx="2712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>
                  <a:solidFill>
                    <a:schemeClr val="bg1"/>
                  </a:solidFill>
                </a:rPr>
                <a:t>TF</a:t>
              </a:r>
              <a:endParaRPr lang="en-GB" sz="2000" b="1" dirty="0">
                <a:solidFill>
                  <a:schemeClr val="bg1"/>
                </a:solidFill>
              </a:endParaRPr>
            </a:p>
          </p:txBody>
        </p:sp>
        <p:sp>
          <p:nvSpPr>
            <p:cNvPr id="412" name="Rectangle 411">
              <a:extLst>
                <a:ext uri="{FF2B5EF4-FFF2-40B4-BE49-F238E27FC236}">
                  <a16:creationId xmlns:a16="http://schemas.microsoft.com/office/drawing/2014/main" id="{444EEE74-8F77-7AE3-CF90-23B7636EAAC6}"/>
                </a:ext>
              </a:extLst>
            </p:cNvPr>
            <p:cNvSpPr/>
            <p:nvPr/>
          </p:nvSpPr>
          <p:spPr>
            <a:xfrm>
              <a:off x="1364522" y="6042528"/>
              <a:ext cx="180000" cy="90000"/>
            </a:xfrm>
            <a:prstGeom prst="rect">
              <a:avLst/>
            </a:prstGeom>
            <a:solidFill>
              <a:srgbClr val="C1FFD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3" name="Rectangle 412">
              <a:extLst>
                <a:ext uri="{FF2B5EF4-FFF2-40B4-BE49-F238E27FC236}">
                  <a16:creationId xmlns:a16="http://schemas.microsoft.com/office/drawing/2014/main" id="{ADEEDEBB-31A0-39DB-B3A4-B1BE215AA25C}"/>
                </a:ext>
              </a:extLst>
            </p:cNvPr>
            <p:cNvSpPr/>
            <p:nvPr/>
          </p:nvSpPr>
          <p:spPr>
            <a:xfrm>
              <a:off x="1502878" y="6174309"/>
              <a:ext cx="180000" cy="90000"/>
            </a:xfrm>
            <a:prstGeom prst="rect">
              <a:avLst/>
            </a:prstGeom>
            <a:solidFill>
              <a:srgbClr val="C1FFD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4" name="Rectangle 413">
              <a:extLst>
                <a:ext uri="{FF2B5EF4-FFF2-40B4-BE49-F238E27FC236}">
                  <a16:creationId xmlns:a16="http://schemas.microsoft.com/office/drawing/2014/main" id="{E0C8C848-2BC6-48AE-A29F-AD9EC220EDCA}"/>
                </a:ext>
              </a:extLst>
            </p:cNvPr>
            <p:cNvSpPr/>
            <p:nvPr/>
          </p:nvSpPr>
          <p:spPr>
            <a:xfrm>
              <a:off x="1693902" y="6321031"/>
              <a:ext cx="180000" cy="90000"/>
            </a:xfrm>
            <a:prstGeom prst="rect">
              <a:avLst/>
            </a:prstGeom>
            <a:solidFill>
              <a:srgbClr val="C1FFD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5" name="Rectangle 414">
              <a:extLst>
                <a:ext uri="{FF2B5EF4-FFF2-40B4-BE49-F238E27FC236}">
                  <a16:creationId xmlns:a16="http://schemas.microsoft.com/office/drawing/2014/main" id="{086EDB09-25DA-8F07-3144-FA497F08F3A5}"/>
                </a:ext>
              </a:extLst>
            </p:cNvPr>
            <p:cNvSpPr/>
            <p:nvPr/>
          </p:nvSpPr>
          <p:spPr>
            <a:xfrm>
              <a:off x="1975480" y="6178489"/>
              <a:ext cx="180000" cy="90000"/>
            </a:xfrm>
            <a:prstGeom prst="rect">
              <a:avLst/>
            </a:prstGeom>
            <a:solidFill>
              <a:srgbClr val="00CC33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6" name="Rectangle 415">
              <a:extLst>
                <a:ext uri="{FF2B5EF4-FFF2-40B4-BE49-F238E27FC236}">
                  <a16:creationId xmlns:a16="http://schemas.microsoft.com/office/drawing/2014/main" id="{42EF8F37-50D5-7C05-9ABA-80A7E82DF84C}"/>
                </a:ext>
              </a:extLst>
            </p:cNvPr>
            <p:cNvSpPr/>
            <p:nvPr/>
          </p:nvSpPr>
          <p:spPr>
            <a:xfrm>
              <a:off x="1977826" y="6028799"/>
              <a:ext cx="180000" cy="90000"/>
            </a:xfrm>
            <a:prstGeom prst="rect">
              <a:avLst/>
            </a:prstGeom>
            <a:solidFill>
              <a:srgbClr val="00CC33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417" name="TextBox 416">
            <a:extLst>
              <a:ext uri="{FF2B5EF4-FFF2-40B4-BE49-F238E27FC236}">
                <a16:creationId xmlns:a16="http://schemas.microsoft.com/office/drawing/2014/main" id="{1304C066-E34B-602C-DA3D-542E84E18BA2}"/>
              </a:ext>
            </a:extLst>
          </p:cNvPr>
          <p:cNvSpPr txBox="1"/>
          <p:nvPr/>
        </p:nvSpPr>
        <p:spPr>
          <a:xfrm>
            <a:off x="1765867" y="7612106"/>
            <a:ext cx="1259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GB" dirty="0"/>
              <a:t>Patient stratification</a:t>
            </a:r>
          </a:p>
        </p:txBody>
      </p:sp>
      <p:sp>
        <p:nvSpPr>
          <p:cNvPr id="418" name="TextBox 417">
            <a:extLst>
              <a:ext uri="{FF2B5EF4-FFF2-40B4-BE49-F238E27FC236}">
                <a16:creationId xmlns:a16="http://schemas.microsoft.com/office/drawing/2014/main" id="{B8B00E83-83E5-027F-6CB9-AB3E6E3E4F07}"/>
              </a:ext>
            </a:extLst>
          </p:cNvPr>
          <p:cNvSpPr txBox="1"/>
          <p:nvPr/>
        </p:nvSpPr>
        <p:spPr>
          <a:xfrm>
            <a:off x="3109248" y="7627520"/>
            <a:ext cx="12412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algn="ctr"/>
            <a:r>
              <a:rPr lang="en-GB" sz="1000" b="1" dirty="0"/>
              <a:t>Cell type-specific comparison</a:t>
            </a:r>
          </a:p>
        </p:txBody>
      </p:sp>
      <p:pic>
        <p:nvPicPr>
          <p:cNvPr id="419" name="Picture 418">
            <a:extLst>
              <a:ext uri="{FF2B5EF4-FFF2-40B4-BE49-F238E27FC236}">
                <a16:creationId xmlns:a16="http://schemas.microsoft.com/office/drawing/2014/main" id="{686099E2-093D-3293-1E26-3E7232BC52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96915" y="7983834"/>
            <a:ext cx="746206" cy="342437"/>
          </a:xfrm>
          <a:prstGeom prst="rect">
            <a:avLst/>
          </a:prstGeom>
        </p:spPr>
      </p:pic>
      <p:sp>
        <p:nvSpPr>
          <p:cNvPr id="420" name="TextBox 419">
            <a:extLst>
              <a:ext uri="{FF2B5EF4-FFF2-40B4-BE49-F238E27FC236}">
                <a16:creationId xmlns:a16="http://schemas.microsoft.com/office/drawing/2014/main" id="{1DED946E-FD18-4731-B542-E1E6D294B8D1}"/>
              </a:ext>
            </a:extLst>
          </p:cNvPr>
          <p:cNvSpPr txBox="1"/>
          <p:nvPr/>
        </p:nvSpPr>
        <p:spPr>
          <a:xfrm>
            <a:off x="4415780" y="8433288"/>
            <a:ext cx="125322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 err="1">
                <a:solidFill>
                  <a:srgbClr val="87B13F"/>
                </a:solidFill>
                <a:latin typeface="Helvetica" panose="020B0604020202020204" pitchFamily="34" charset="0"/>
              </a:rPr>
              <a:t>limma</a:t>
            </a:r>
            <a:endParaRPr lang="en-GB" dirty="0">
              <a:solidFill>
                <a:srgbClr val="87B13F"/>
              </a:solidFill>
              <a:latin typeface="Helvetica" panose="020B0604020202020204" pitchFamily="34" charset="0"/>
            </a:endParaRPr>
          </a:p>
        </p:txBody>
      </p:sp>
      <p:sp>
        <p:nvSpPr>
          <p:cNvPr id="421" name="Cross 420">
            <a:extLst>
              <a:ext uri="{FF2B5EF4-FFF2-40B4-BE49-F238E27FC236}">
                <a16:creationId xmlns:a16="http://schemas.microsoft.com/office/drawing/2014/main" id="{650B9803-B625-A441-AF9C-D229AA26FF61}"/>
              </a:ext>
            </a:extLst>
          </p:cNvPr>
          <p:cNvSpPr/>
          <p:nvPr/>
        </p:nvSpPr>
        <p:spPr>
          <a:xfrm>
            <a:off x="4974130" y="8359557"/>
            <a:ext cx="144000" cy="144000"/>
          </a:xfrm>
          <a:prstGeom prst="plus">
            <a:avLst>
              <a:gd name="adj" fmla="val 38229"/>
            </a:avLst>
          </a:prstGeom>
          <a:solidFill>
            <a:srgbClr val="F4FFF4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75088CA3-C2D6-08AA-8170-ACEE70A4ED45}"/>
              </a:ext>
            </a:extLst>
          </p:cNvPr>
          <p:cNvSpPr txBox="1"/>
          <p:nvPr/>
        </p:nvSpPr>
        <p:spPr>
          <a:xfrm>
            <a:off x="4402456" y="5341631"/>
            <a:ext cx="1395769" cy="35116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lIns="0" tIns="0" rIns="0" bIns="0" rtlCol="0">
            <a:noAutofit/>
          </a:bodyPr>
          <a:lstStyle/>
          <a:p>
            <a:pPr algn="ctr"/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Heat in signalling proteins</a:t>
            </a:r>
          </a:p>
          <a:p>
            <a:pPr algn="ctr"/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Heat in t</a:t>
            </a:r>
            <a:r>
              <a:rPr lang="hu-HU" sz="500" dirty="0" err="1">
                <a:latin typeface="Arial" panose="020B0604020202020204" pitchFamily="34" charset="0"/>
                <a:cs typeface="Arial" panose="020B0604020202020204" pitchFamily="34" charset="0"/>
              </a:rPr>
              <a:t>ranscription</a:t>
            </a:r>
            <a:r>
              <a:rPr lang="hu-HU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500" dirty="0" err="1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hu-HU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(TF) </a:t>
            </a:r>
          </a:p>
        </p:txBody>
      </p:sp>
      <p:sp>
        <p:nvSpPr>
          <p:cNvPr id="423" name="Rectangle 422">
            <a:extLst>
              <a:ext uri="{FF2B5EF4-FFF2-40B4-BE49-F238E27FC236}">
                <a16:creationId xmlns:a16="http://schemas.microsoft.com/office/drawing/2014/main" id="{D19C7C36-E591-CCFE-7E07-B814FD1C23DF}"/>
              </a:ext>
            </a:extLst>
          </p:cNvPr>
          <p:cNvSpPr/>
          <p:nvPr/>
        </p:nvSpPr>
        <p:spPr>
          <a:xfrm>
            <a:off x="4485360" y="5357631"/>
            <a:ext cx="1187908" cy="72000"/>
          </a:xfrm>
          <a:prstGeom prst="rect">
            <a:avLst/>
          </a:prstGeom>
          <a:gradFill flip="none" rotWithShape="1">
            <a:gsLst>
              <a:gs pos="0">
                <a:srgbClr val="CC6600"/>
              </a:gs>
              <a:gs pos="50000">
                <a:srgbClr val="FFCF9F"/>
              </a:gs>
              <a:gs pos="100000">
                <a:schemeClr val="bg1"/>
              </a:gs>
            </a:gsLst>
            <a:lin ang="10800000" scaled="1"/>
            <a:tileRect/>
          </a:gra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Rectangle 423">
            <a:extLst>
              <a:ext uri="{FF2B5EF4-FFF2-40B4-BE49-F238E27FC236}">
                <a16:creationId xmlns:a16="http://schemas.microsoft.com/office/drawing/2014/main" id="{B1D180B5-1386-6251-B5EC-7F80B3A200D4}"/>
              </a:ext>
            </a:extLst>
          </p:cNvPr>
          <p:cNvSpPr/>
          <p:nvPr/>
        </p:nvSpPr>
        <p:spPr>
          <a:xfrm>
            <a:off x="4485360" y="5519926"/>
            <a:ext cx="1187908" cy="72000"/>
          </a:xfrm>
          <a:prstGeom prst="rect">
            <a:avLst/>
          </a:prstGeom>
          <a:gradFill flip="none" rotWithShape="1">
            <a:gsLst>
              <a:gs pos="0">
                <a:srgbClr val="CC00FF"/>
              </a:gs>
              <a:gs pos="50000">
                <a:srgbClr val="E67DFF"/>
              </a:gs>
              <a:gs pos="100000">
                <a:schemeClr val="bg1"/>
              </a:gs>
            </a:gsLst>
            <a:lin ang="10800000" scaled="1"/>
            <a:tileRect/>
          </a:gra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5" name="TextBox 424">
            <a:extLst>
              <a:ext uri="{FF2B5EF4-FFF2-40B4-BE49-F238E27FC236}">
                <a16:creationId xmlns:a16="http://schemas.microsoft.com/office/drawing/2014/main" id="{F69DFB02-5890-227C-0D40-9D4455BB28E9}"/>
              </a:ext>
            </a:extLst>
          </p:cNvPr>
          <p:cNvSpPr txBox="1"/>
          <p:nvPr/>
        </p:nvSpPr>
        <p:spPr>
          <a:xfrm>
            <a:off x="4042169" y="6891929"/>
            <a:ext cx="1726150" cy="2926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/>
            <a:endParaRPr lang="en-GB" sz="700" dirty="0"/>
          </a:p>
        </p:txBody>
      </p:sp>
      <p:sp>
        <p:nvSpPr>
          <p:cNvPr id="426" name="Rectangle 425">
            <a:extLst>
              <a:ext uri="{FF2B5EF4-FFF2-40B4-BE49-F238E27FC236}">
                <a16:creationId xmlns:a16="http://schemas.microsoft.com/office/drawing/2014/main" id="{413165A1-4C37-D815-4CAD-737990A218C8}"/>
              </a:ext>
            </a:extLst>
          </p:cNvPr>
          <p:cNvSpPr/>
          <p:nvPr/>
        </p:nvSpPr>
        <p:spPr>
          <a:xfrm>
            <a:off x="4306218" y="6953967"/>
            <a:ext cx="1188000" cy="90000"/>
          </a:xfrm>
          <a:prstGeom prst="rect">
            <a:avLst/>
          </a:prstGeom>
          <a:gradFill flip="none" rotWithShape="1">
            <a:gsLst>
              <a:gs pos="0">
                <a:srgbClr val="00CC33"/>
              </a:gs>
              <a:gs pos="50000">
                <a:srgbClr val="C1FFD0"/>
              </a:gs>
              <a:gs pos="100000">
                <a:schemeClr val="bg1"/>
              </a:gs>
            </a:gsLst>
            <a:lin ang="10800000" scaled="1"/>
            <a:tileRect/>
          </a:gradFill>
          <a:ln w="63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7" name="TextBox 426">
            <a:extLst>
              <a:ext uri="{FF2B5EF4-FFF2-40B4-BE49-F238E27FC236}">
                <a16:creationId xmlns:a16="http://schemas.microsoft.com/office/drawing/2014/main" id="{994C4BA8-9946-FD32-6362-77CB760526CE}"/>
              </a:ext>
            </a:extLst>
          </p:cNvPr>
          <p:cNvSpPr txBox="1"/>
          <p:nvPr/>
        </p:nvSpPr>
        <p:spPr>
          <a:xfrm>
            <a:off x="4049763" y="7024986"/>
            <a:ext cx="1718557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500" dirty="0">
                <a:latin typeface="Arial" panose="020B0604020202020204" pitchFamily="34" charset="0"/>
                <a:cs typeface="Arial" panose="020B0604020202020204" pitchFamily="34" charset="0"/>
              </a:rPr>
              <a:t>Heat in transcription factor targets</a:t>
            </a:r>
          </a:p>
        </p:txBody>
      </p:sp>
      <p:sp>
        <p:nvSpPr>
          <p:cNvPr id="428" name="TextBox 427">
            <a:extLst>
              <a:ext uri="{FF2B5EF4-FFF2-40B4-BE49-F238E27FC236}">
                <a16:creationId xmlns:a16="http://schemas.microsoft.com/office/drawing/2014/main" id="{5CF4BE69-0FA3-9E00-2993-85EA9F06B32A}"/>
              </a:ext>
            </a:extLst>
          </p:cNvPr>
          <p:cNvSpPr txBox="1"/>
          <p:nvPr/>
        </p:nvSpPr>
        <p:spPr>
          <a:xfrm>
            <a:off x="498633" y="1534124"/>
            <a:ext cx="2493614" cy="42560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36000" rIns="36000" rtlCol="0" anchor="ctr"/>
          <a:lstStyle>
            <a:defPPr>
              <a:defRPr lang="en-US"/>
            </a:defPPr>
            <a:lvl1pPr algn="ctr"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r>
              <a:rPr lang="en-GB" dirty="0">
                <a:solidFill>
                  <a:schemeClr val="tx1"/>
                </a:solidFill>
              </a:rPr>
              <a:t>Epigenetically active regulatory regions </a:t>
            </a:r>
            <a:br>
              <a:rPr lang="en-GB" dirty="0">
                <a:solidFill>
                  <a:schemeClr val="tx1"/>
                </a:solidFill>
              </a:rPr>
            </a:br>
            <a:r>
              <a:rPr lang="en-GB" dirty="0" err="1">
                <a:solidFill>
                  <a:schemeClr val="tx1"/>
                </a:solidFill>
              </a:rPr>
              <a:t>ChIP-seq</a:t>
            </a:r>
            <a:r>
              <a:rPr lang="en-GB" dirty="0">
                <a:solidFill>
                  <a:schemeClr val="tx1"/>
                </a:solidFill>
              </a:rPr>
              <a:t> &amp; histone modification data 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429" name="Straight Arrow Connector 428">
            <a:extLst>
              <a:ext uri="{FF2B5EF4-FFF2-40B4-BE49-F238E27FC236}">
                <a16:creationId xmlns:a16="http://schemas.microsoft.com/office/drawing/2014/main" id="{069D86EB-7327-9FCC-1A83-EBD5224D3D8C}"/>
              </a:ext>
            </a:extLst>
          </p:cNvPr>
          <p:cNvCxnSpPr>
            <a:cxnSpLocks/>
            <a:stCxn id="428" idx="2"/>
            <a:endCxn id="313" idx="0"/>
          </p:cNvCxnSpPr>
          <p:nvPr/>
        </p:nvCxnSpPr>
        <p:spPr>
          <a:xfrm flipH="1">
            <a:off x="1745262" y="1959730"/>
            <a:ext cx="178" cy="48483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0" name="TextBox 429">
            <a:extLst>
              <a:ext uri="{FF2B5EF4-FFF2-40B4-BE49-F238E27FC236}">
                <a16:creationId xmlns:a16="http://schemas.microsoft.com/office/drawing/2014/main" id="{5FA8EC20-9CFC-F442-7B7D-A18759431898}"/>
              </a:ext>
            </a:extLst>
          </p:cNvPr>
          <p:cNvSpPr txBox="1"/>
          <p:nvPr/>
        </p:nvSpPr>
        <p:spPr>
          <a:xfrm>
            <a:off x="175057" y="235188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cxnSp>
        <p:nvCxnSpPr>
          <p:cNvPr id="431" name="Connector: Elbow 430">
            <a:extLst>
              <a:ext uri="{FF2B5EF4-FFF2-40B4-BE49-F238E27FC236}">
                <a16:creationId xmlns:a16="http://schemas.microsoft.com/office/drawing/2014/main" id="{845666AE-C7F8-1F21-0537-B893946AB6A8}"/>
              </a:ext>
            </a:extLst>
          </p:cNvPr>
          <p:cNvCxnSpPr>
            <a:cxnSpLocks/>
            <a:stCxn id="274" idx="2"/>
            <a:endCxn id="428" idx="0"/>
          </p:cNvCxnSpPr>
          <p:nvPr/>
        </p:nvCxnSpPr>
        <p:spPr>
          <a:xfrm rot="5400000">
            <a:off x="2198173" y="740608"/>
            <a:ext cx="340784" cy="1246249"/>
          </a:xfrm>
          <a:prstGeom prst="bentConnector3">
            <a:avLst>
              <a:gd name="adj1" fmla="val 50000"/>
            </a:avLst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2" name="Connector: Elbow 431">
            <a:extLst>
              <a:ext uri="{FF2B5EF4-FFF2-40B4-BE49-F238E27FC236}">
                <a16:creationId xmlns:a16="http://schemas.microsoft.com/office/drawing/2014/main" id="{7A2846FE-976C-A676-7D65-410139245D2D}"/>
              </a:ext>
            </a:extLst>
          </p:cNvPr>
          <p:cNvCxnSpPr>
            <a:cxnSpLocks/>
            <a:stCxn id="274" idx="2"/>
            <a:endCxn id="348" idx="2"/>
          </p:cNvCxnSpPr>
          <p:nvPr/>
        </p:nvCxnSpPr>
        <p:spPr>
          <a:xfrm rot="16200000" flipH="1">
            <a:off x="2993857" y="1191172"/>
            <a:ext cx="1153541" cy="1157876"/>
          </a:xfrm>
          <a:prstGeom prst="bentConnector4">
            <a:avLst>
              <a:gd name="adj1" fmla="val 14984"/>
              <a:gd name="adj2" fmla="val 99679"/>
            </a:avLst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3" name="Picture 432">
            <a:extLst>
              <a:ext uri="{FF2B5EF4-FFF2-40B4-BE49-F238E27FC236}">
                <a16:creationId xmlns:a16="http://schemas.microsoft.com/office/drawing/2014/main" id="{819028E6-A7DA-1C69-1E48-AB9ED80DE5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306" y="7983834"/>
            <a:ext cx="802748" cy="800486"/>
          </a:xfrm>
          <a:prstGeom prst="rect">
            <a:avLst/>
          </a:prstGeom>
        </p:spPr>
      </p:pic>
      <p:pic>
        <p:nvPicPr>
          <p:cNvPr id="434" name="Picture 433" descr="A screen shot of a graph&#10;&#10;AI-generated content may be incorrect.">
            <a:extLst>
              <a:ext uri="{FF2B5EF4-FFF2-40B4-BE49-F238E27FC236}">
                <a16:creationId xmlns:a16="http://schemas.microsoft.com/office/drawing/2014/main" id="{998A353F-2D15-7DE7-DC79-E086065BD8B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" t="10902" r="9712"/>
          <a:stretch/>
        </p:blipFill>
        <p:spPr>
          <a:xfrm>
            <a:off x="2032111" y="7969798"/>
            <a:ext cx="803650" cy="793067"/>
          </a:xfrm>
          <a:prstGeom prst="rect">
            <a:avLst/>
          </a:prstGeom>
        </p:spPr>
      </p:pic>
      <p:pic>
        <p:nvPicPr>
          <p:cNvPr id="435" name="Picture 434">
            <a:extLst>
              <a:ext uri="{FF2B5EF4-FFF2-40B4-BE49-F238E27FC236}">
                <a16:creationId xmlns:a16="http://schemas.microsoft.com/office/drawing/2014/main" id="{C3E07656-2127-EE94-ABEE-1096D5587F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05297" y="8030345"/>
            <a:ext cx="1225927" cy="690120"/>
          </a:xfrm>
          <a:prstGeom prst="rect">
            <a:avLst/>
          </a:prstGeom>
        </p:spPr>
      </p:pic>
      <p:grpSp>
        <p:nvGrpSpPr>
          <p:cNvPr id="436" name="Group 435">
            <a:extLst>
              <a:ext uri="{FF2B5EF4-FFF2-40B4-BE49-F238E27FC236}">
                <a16:creationId xmlns:a16="http://schemas.microsoft.com/office/drawing/2014/main" id="{AB0EB2CF-F231-5040-920D-226825365BF7}"/>
              </a:ext>
            </a:extLst>
          </p:cNvPr>
          <p:cNvGrpSpPr/>
          <p:nvPr/>
        </p:nvGrpSpPr>
        <p:grpSpPr>
          <a:xfrm>
            <a:off x="206469" y="4698116"/>
            <a:ext cx="817673" cy="1015198"/>
            <a:chOff x="206469" y="4698116"/>
            <a:chExt cx="817673" cy="1015198"/>
          </a:xfrm>
        </p:grpSpPr>
        <p:sp>
          <p:nvSpPr>
            <p:cNvPr id="437" name="Oval 436">
              <a:extLst>
                <a:ext uri="{FF2B5EF4-FFF2-40B4-BE49-F238E27FC236}">
                  <a16:creationId xmlns:a16="http://schemas.microsoft.com/office/drawing/2014/main" id="{8DB631E3-E3C8-E572-8B51-F887A5487072}"/>
                </a:ext>
              </a:extLst>
            </p:cNvPr>
            <p:cNvSpPr/>
            <p:nvPr/>
          </p:nvSpPr>
          <p:spPr>
            <a:xfrm>
              <a:off x="373980" y="4698116"/>
              <a:ext cx="144000" cy="144000"/>
            </a:xfrm>
            <a:prstGeom prst="ellipse">
              <a:avLst/>
            </a:prstGeom>
            <a:solidFill>
              <a:srgbClr val="CC6600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Oval 437">
              <a:extLst>
                <a:ext uri="{FF2B5EF4-FFF2-40B4-BE49-F238E27FC236}">
                  <a16:creationId xmlns:a16="http://schemas.microsoft.com/office/drawing/2014/main" id="{59F162B9-55D4-7491-2066-B63E1B9C12F3}"/>
                </a:ext>
              </a:extLst>
            </p:cNvPr>
            <p:cNvSpPr/>
            <p:nvPr/>
          </p:nvSpPr>
          <p:spPr>
            <a:xfrm>
              <a:off x="403271" y="5286995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9" name="Oval 438">
              <a:extLst>
                <a:ext uri="{FF2B5EF4-FFF2-40B4-BE49-F238E27FC236}">
                  <a16:creationId xmlns:a16="http://schemas.microsoft.com/office/drawing/2014/main" id="{BB49A110-A666-4F1A-F601-56ED0D5494BF}"/>
                </a:ext>
              </a:extLst>
            </p:cNvPr>
            <p:cNvSpPr/>
            <p:nvPr/>
          </p:nvSpPr>
          <p:spPr>
            <a:xfrm>
              <a:off x="670210" y="4861691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Oval 439">
              <a:extLst>
                <a:ext uri="{FF2B5EF4-FFF2-40B4-BE49-F238E27FC236}">
                  <a16:creationId xmlns:a16="http://schemas.microsoft.com/office/drawing/2014/main" id="{3A57C406-38CF-DF3E-143B-B1CD037E3307}"/>
                </a:ext>
              </a:extLst>
            </p:cNvPr>
            <p:cNvSpPr/>
            <p:nvPr/>
          </p:nvSpPr>
          <p:spPr>
            <a:xfrm>
              <a:off x="879470" y="4698116"/>
              <a:ext cx="144000" cy="144000"/>
            </a:xfrm>
            <a:prstGeom prst="ellipse">
              <a:avLst/>
            </a:prstGeom>
            <a:solidFill>
              <a:srgbClr val="CC6600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1" name="Oval 440">
              <a:extLst>
                <a:ext uri="{FF2B5EF4-FFF2-40B4-BE49-F238E27FC236}">
                  <a16:creationId xmlns:a16="http://schemas.microsoft.com/office/drawing/2014/main" id="{05816B43-A00C-C55A-886B-7FDB015F0378}"/>
                </a:ext>
              </a:extLst>
            </p:cNvPr>
            <p:cNvSpPr/>
            <p:nvPr/>
          </p:nvSpPr>
          <p:spPr>
            <a:xfrm>
              <a:off x="661938" y="5037994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Oval 441">
              <a:extLst>
                <a:ext uri="{FF2B5EF4-FFF2-40B4-BE49-F238E27FC236}">
                  <a16:creationId xmlns:a16="http://schemas.microsoft.com/office/drawing/2014/main" id="{A34F3480-FB6A-2220-D9E2-DB00706160D8}"/>
                </a:ext>
              </a:extLst>
            </p:cNvPr>
            <p:cNvSpPr/>
            <p:nvPr/>
          </p:nvSpPr>
          <p:spPr>
            <a:xfrm>
              <a:off x="879470" y="5275663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Oval 442">
              <a:extLst>
                <a:ext uri="{FF2B5EF4-FFF2-40B4-BE49-F238E27FC236}">
                  <a16:creationId xmlns:a16="http://schemas.microsoft.com/office/drawing/2014/main" id="{7A3F4C89-D045-5535-7249-D407275D4505}"/>
                </a:ext>
              </a:extLst>
            </p:cNvPr>
            <p:cNvSpPr/>
            <p:nvPr/>
          </p:nvSpPr>
          <p:spPr>
            <a:xfrm>
              <a:off x="406956" y="5569314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F</a:t>
              </a:r>
            </a:p>
          </p:txBody>
        </p:sp>
        <p:sp>
          <p:nvSpPr>
            <p:cNvPr id="444" name="Oval 443">
              <a:extLst>
                <a:ext uri="{FF2B5EF4-FFF2-40B4-BE49-F238E27FC236}">
                  <a16:creationId xmlns:a16="http://schemas.microsoft.com/office/drawing/2014/main" id="{CEFA4EF6-6351-DA09-EBA3-5CFF68BE6AEA}"/>
                </a:ext>
              </a:extLst>
            </p:cNvPr>
            <p:cNvSpPr/>
            <p:nvPr/>
          </p:nvSpPr>
          <p:spPr>
            <a:xfrm>
              <a:off x="880142" y="5563150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5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F</a:t>
              </a:r>
            </a:p>
          </p:txBody>
        </p:sp>
        <p:cxnSp>
          <p:nvCxnSpPr>
            <p:cNvPr id="445" name="Straight Arrow Connector 444">
              <a:extLst>
                <a:ext uri="{FF2B5EF4-FFF2-40B4-BE49-F238E27FC236}">
                  <a16:creationId xmlns:a16="http://schemas.microsoft.com/office/drawing/2014/main" id="{C90B1D13-1136-BC7C-AE48-83D4F5395E92}"/>
                </a:ext>
              </a:extLst>
            </p:cNvPr>
            <p:cNvCxnSpPr>
              <a:stCxn id="437" idx="4"/>
              <a:endCxn id="438" idx="0"/>
            </p:cNvCxnSpPr>
            <p:nvPr/>
          </p:nvCxnSpPr>
          <p:spPr>
            <a:xfrm>
              <a:off x="445980" y="4842116"/>
              <a:ext cx="29291" cy="444879"/>
            </a:xfrm>
            <a:prstGeom prst="straightConnector1">
              <a:avLst/>
            </a:prstGeom>
            <a:ln w="28575">
              <a:solidFill>
                <a:srgbClr val="CC66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6" name="Straight Arrow Connector 445">
              <a:extLst>
                <a:ext uri="{FF2B5EF4-FFF2-40B4-BE49-F238E27FC236}">
                  <a16:creationId xmlns:a16="http://schemas.microsoft.com/office/drawing/2014/main" id="{BE56CEF2-2AF9-4CEA-D03C-C0A142C3FBB6}"/>
                </a:ext>
              </a:extLst>
            </p:cNvPr>
            <p:cNvCxnSpPr>
              <a:cxnSpLocks/>
              <a:stCxn id="437" idx="5"/>
              <a:endCxn id="441" idx="1"/>
            </p:cNvCxnSpPr>
            <p:nvPr/>
          </p:nvCxnSpPr>
          <p:spPr>
            <a:xfrm>
              <a:off x="496892" y="4821028"/>
              <a:ext cx="186134" cy="238054"/>
            </a:xfrm>
            <a:prstGeom prst="straightConnector1">
              <a:avLst/>
            </a:prstGeom>
            <a:ln w="28575">
              <a:solidFill>
                <a:srgbClr val="CC66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7" name="Straight Arrow Connector 446">
              <a:extLst>
                <a:ext uri="{FF2B5EF4-FFF2-40B4-BE49-F238E27FC236}">
                  <a16:creationId xmlns:a16="http://schemas.microsoft.com/office/drawing/2014/main" id="{F0DC1E7C-41CE-45FC-BEA0-EE0AEBBAC3E7}"/>
                </a:ext>
              </a:extLst>
            </p:cNvPr>
            <p:cNvCxnSpPr>
              <a:cxnSpLocks/>
              <a:stCxn id="437" idx="6"/>
              <a:endCxn id="439" idx="1"/>
            </p:cNvCxnSpPr>
            <p:nvPr/>
          </p:nvCxnSpPr>
          <p:spPr>
            <a:xfrm>
              <a:off x="517980" y="4770116"/>
              <a:ext cx="173318" cy="112663"/>
            </a:xfrm>
            <a:prstGeom prst="straightConnector1">
              <a:avLst/>
            </a:prstGeom>
            <a:ln w="28575">
              <a:solidFill>
                <a:srgbClr val="CC66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8" name="Straight Arrow Connector 447">
              <a:extLst>
                <a:ext uri="{FF2B5EF4-FFF2-40B4-BE49-F238E27FC236}">
                  <a16:creationId xmlns:a16="http://schemas.microsoft.com/office/drawing/2014/main" id="{DC81B2C8-65BA-4206-BC42-0EE1A6D1447E}"/>
                </a:ext>
              </a:extLst>
            </p:cNvPr>
            <p:cNvCxnSpPr>
              <a:cxnSpLocks/>
              <a:stCxn id="439" idx="5"/>
              <a:endCxn id="442" idx="0"/>
            </p:cNvCxnSpPr>
            <p:nvPr/>
          </p:nvCxnSpPr>
          <p:spPr>
            <a:xfrm>
              <a:off x="793122" y="4984603"/>
              <a:ext cx="158348" cy="29106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9" name="Straight Arrow Connector 448">
              <a:extLst>
                <a:ext uri="{FF2B5EF4-FFF2-40B4-BE49-F238E27FC236}">
                  <a16:creationId xmlns:a16="http://schemas.microsoft.com/office/drawing/2014/main" id="{8BFE25E6-DB35-78A7-8937-5B8C93253FDD}"/>
                </a:ext>
              </a:extLst>
            </p:cNvPr>
            <p:cNvCxnSpPr>
              <a:cxnSpLocks/>
              <a:stCxn id="438" idx="6"/>
              <a:endCxn id="442" idx="2"/>
            </p:cNvCxnSpPr>
            <p:nvPr/>
          </p:nvCxnSpPr>
          <p:spPr>
            <a:xfrm flipV="1">
              <a:off x="547271" y="5347663"/>
              <a:ext cx="332199" cy="11332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0" name="Straight Arrow Connector 449">
              <a:extLst>
                <a:ext uri="{FF2B5EF4-FFF2-40B4-BE49-F238E27FC236}">
                  <a16:creationId xmlns:a16="http://schemas.microsoft.com/office/drawing/2014/main" id="{A215F3BE-2B43-DD95-0176-F7C1B0E3EDD0}"/>
                </a:ext>
              </a:extLst>
            </p:cNvPr>
            <p:cNvCxnSpPr>
              <a:cxnSpLocks/>
              <a:stCxn id="438" idx="7"/>
              <a:endCxn id="441" idx="3"/>
            </p:cNvCxnSpPr>
            <p:nvPr/>
          </p:nvCxnSpPr>
          <p:spPr>
            <a:xfrm flipV="1">
              <a:off x="526183" y="5160906"/>
              <a:ext cx="156843" cy="147177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1" name="Straight Arrow Connector 450">
              <a:extLst>
                <a:ext uri="{FF2B5EF4-FFF2-40B4-BE49-F238E27FC236}">
                  <a16:creationId xmlns:a16="http://schemas.microsoft.com/office/drawing/2014/main" id="{C333CADE-AD93-97DD-5812-4A57CF3C970D}"/>
                </a:ext>
              </a:extLst>
            </p:cNvPr>
            <p:cNvCxnSpPr>
              <a:cxnSpLocks/>
              <a:stCxn id="441" idx="5"/>
              <a:endCxn id="442" idx="1"/>
            </p:cNvCxnSpPr>
            <p:nvPr/>
          </p:nvCxnSpPr>
          <p:spPr>
            <a:xfrm>
              <a:off x="784850" y="5160906"/>
              <a:ext cx="115708" cy="135845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2" name="Straight Arrow Connector 451">
              <a:extLst>
                <a:ext uri="{FF2B5EF4-FFF2-40B4-BE49-F238E27FC236}">
                  <a16:creationId xmlns:a16="http://schemas.microsoft.com/office/drawing/2014/main" id="{7490D6DF-E732-16D6-8BC9-8E2AD9A006B7}"/>
                </a:ext>
              </a:extLst>
            </p:cNvPr>
            <p:cNvCxnSpPr>
              <a:cxnSpLocks/>
              <a:stCxn id="440" idx="4"/>
              <a:endCxn id="442" idx="0"/>
            </p:cNvCxnSpPr>
            <p:nvPr/>
          </p:nvCxnSpPr>
          <p:spPr>
            <a:xfrm>
              <a:off x="951470" y="4842116"/>
              <a:ext cx="0" cy="433547"/>
            </a:xfrm>
            <a:prstGeom prst="straightConnector1">
              <a:avLst/>
            </a:prstGeom>
            <a:ln w="28575">
              <a:solidFill>
                <a:srgbClr val="CC66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3" name="Straight Arrow Connector 452">
              <a:extLst>
                <a:ext uri="{FF2B5EF4-FFF2-40B4-BE49-F238E27FC236}">
                  <a16:creationId xmlns:a16="http://schemas.microsoft.com/office/drawing/2014/main" id="{2E2E3570-A5CA-FA25-0F85-A3EC1EF4D023}"/>
                </a:ext>
              </a:extLst>
            </p:cNvPr>
            <p:cNvCxnSpPr>
              <a:cxnSpLocks/>
              <a:stCxn id="442" idx="4"/>
              <a:endCxn id="444" idx="0"/>
            </p:cNvCxnSpPr>
            <p:nvPr/>
          </p:nvCxnSpPr>
          <p:spPr>
            <a:xfrm>
              <a:off x="951470" y="5419663"/>
              <a:ext cx="672" cy="143487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4" name="Straight Arrow Connector 453">
              <a:extLst>
                <a:ext uri="{FF2B5EF4-FFF2-40B4-BE49-F238E27FC236}">
                  <a16:creationId xmlns:a16="http://schemas.microsoft.com/office/drawing/2014/main" id="{5E5400E5-587E-4219-7522-54C7FBA34CC6}"/>
                </a:ext>
              </a:extLst>
            </p:cNvPr>
            <p:cNvCxnSpPr>
              <a:cxnSpLocks/>
              <a:stCxn id="438" idx="4"/>
              <a:endCxn id="443" idx="0"/>
            </p:cNvCxnSpPr>
            <p:nvPr/>
          </p:nvCxnSpPr>
          <p:spPr>
            <a:xfrm>
              <a:off x="475271" y="5430995"/>
              <a:ext cx="3685" cy="138319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5" name="Straight Arrow Connector 454">
              <a:extLst>
                <a:ext uri="{FF2B5EF4-FFF2-40B4-BE49-F238E27FC236}">
                  <a16:creationId xmlns:a16="http://schemas.microsoft.com/office/drawing/2014/main" id="{143928B3-23F8-2040-FC22-0FAFFE496A5B}"/>
                </a:ext>
              </a:extLst>
            </p:cNvPr>
            <p:cNvCxnSpPr>
              <a:cxnSpLocks/>
              <a:stCxn id="443" idx="6"/>
              <a:endCxn id="444" idx="2"/>
            </p:cNvCxnSpPr>
            <p:nvPr/>
          </p:nvCxnSpPr>
          <p:spPr>
            <a:xfrm flipV="1">
              <a:off x="550956" y="5635150"/>
              <a:ext cx="329186" cy="6164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6" name="Straight Arrow Connector 455">
              <a:extLst>
                <a:ext uri="{FF2B5EF4-FFF2-40B4-BE49-F238E27FC236}">
                  <a16:creationId xmlns:a16="http://schemas.microsoft.com/office/drawing/2014/main" id="{DEFB71CD-219A-F749-45E1-9C771072B64F}"/>
                </a:ext>
              </a:extLst>
            </p:cNvPr>
            <p:cNvCxnSpPr>
              <a:cxnSpLocks/>
              <a:stCxn id="440" idx="2"/>
              <a:endCxn id="439" idx="7"/>
            </p:cNvCxnSpPr>
            <p:nvPr/>
          </p:nvCxnSpPr>
          <p:spPr>
            <a:xfrm flipH="1">
              <a:off x="793122" y="4770117"/>
              <a:ext cx="86348" cy="112663"/>
            </a:xfrm>
            <a:prstGeom prst="straightConnector1">
              <a:avLst/>
            </a:prstGeom>
            <a:ln w="28575">
              <a:solidFill>
                <a:srgbClr val="CC66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7" name="Oval 456">
              <a:extLst>
                <a:ext uri="{FF2B5EF4-FFF2-40B4-BE49-F238E27FC236}">
                  <a16:creationId xmlns:a16="http://schemas.microsoft.com/office/drawing/2014/main" id="{2AAA03C8-8CCD-F371-968C-459B37BBD52C}"/>
                </a:ext>
              </a:extLst>
            </p:cNvPr>
            <p:cNvSpPr/>
            <p:nvPr/>
          </p:nvSpPr>
          <p:spPr>
            <a:xfrm>
              <a:off x="206469" y="5285631"/>
              <a:ext cx="144000" cy="144000"/>
            </a:xfrm>
            <a:prstGeom prst="ellips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  <a:tailEnd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8" name="Straight Arrow Connector 457">
              <a:extLst>
                <a:ext uri="{FF2B5EF4-FFF2-40B4-BE49-F238E27FC236}">
                  <a16:creationId xmlns:a16="http://schemas.microsoft.com/office/drawing/2014/main" id="{4DBEBF80-44C2-5DDF-418E-512C151BA86D}"/>
                </a:ext>
              </a:extLst>
            </p:cNvPr>
            <p:cNvCxnSpPr>
              <a:cxnSpLocks/>
              <a:stCxn id="437" idx="4"/>
              <a:endCxn id="457" idx="0"/>
            </p:cNvCxnSpPr>
            <p:nvPr/>
          </p:nvCxnSpPr>
          <p:spPr>
            <a:xfrm flipH="1">
              <a:off x="278469" y="4842116"/>
              <a:ext cx="167511" cy="443515"/>
            </a:xfrm>
            <a:prstGeom prst="straightConnector1">
              <a:avLst/>
            </a:prstGeom>
            <a:ln w="28575">
              <a:solidFill>
                <a:srgbClr val="CC6600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9" name="Oval 458">
            <a:extLst>
              <a:ext uri="{FF2B5EF4-FFF2-40B4-BE49-F238E27FC236}">
                <a16:creationId xmlns:a16="http://schemas.microsoft.com/office/drawing/2014/main" id="{F71BB1C1-96AB-F777-B36F-CFE9BD72689B}"/>
              </a:ext>
            </a:extLst>
          </p:cNvPr>
          <p:cNvSpPr/>
          <p:nvPr/>
        </p:nvSpPr>
        <p:spPr>
          <a:xfrm>
            <a:off x="1467848" y="4648197"/>
            <a:ext cx="144000" cy="144000"/>
          </a:xfrm>
          <a:prstGeom prst="ellipse">
            <a:avLst/>
          </a:prstGeom>
          <a:solidFill>
            <a:srgbClr val="CC66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Oval 459">
            <a:extLst>
              <a:ext uri="{FF2B5EF4-FFF2-40B4-BE49-F238E27FC236}">
                <a16:creationId xmlns:a16="http://schemas.microsoft.com/office/drawing/2014/main" id="{15F87E47-CF15-414B-FCD8-FF9DBAEB7485}"/>
              </a:ext>
            </a:extLst>
          </p:cNvPr>
          <p:cNvSpPr/>
          <p:nvPr/>
        </p:nvSpPr>
        <p:spPr>
          <a:xfrm>
            <a:off x="1497139" y="5237076"/>
            <a:ext cx="144000" cy="144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1" name="Oval 460">
            <a:extLst>
              <a:ext uri="{FF2B5EF4-FFF2-40B4-BE49-F238E27FC236}">
                <a16:creationId xmlns:a16="http://schemas.microsoft.com/office/drawing/2014/main" id="{0FD27FF8-81B0-04A4-611C-8969DD57E50B}"/>
              </a:ext>
            </a:extLst>
          </p:cNvPr>
          <p:cNvSpPr/>
          <p:nvPr/>
        </p:nvSpPr>
        <p:spPr>
          <a:xfrm>
            <a:off x="1764078" y="4811772"/>
            <a:ext cx="144000" cy="14400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2" name="Oval 461">
            <a:extLst>
              <a:ext uri="{FF2B5EF4-FFF2-40B4-BE49-F238E27FC236}">
                <a16:creationId xmlns:a16="http://schemas.microsoft.com/office/drawing/2014/main" id="{587BBC13-F65F-0D56-E61F-CE31F3D5E266}"/>
              </a:ext>
            </a:extLst>
          </p:cNvPr>
          <p:cNvSpPr/>
          <p:nvPr/>
        </p:nvSpPr>
        <p:spPr>
          <a:xfrm>
            <a:off x="1973338" y="4648197"/>
            <a:ext cx="144000" cy="144000"/>
          </a:xfrm>
          <a:prstGeom prst="ellipse">
            <a:avLst/>
          </a:prstGeom>
          <a:solidFill>
            <a:srgbClr val="CC66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Oval 462">
            <a:extLst>
              <a:ext uri="{FF2B5EF4-FFF2-40B4-BE49-F238E27FC236}">
                <a16:creationId xmlns:a16="http://schemas.microsoft.com/office/drawing/2014/main" id="{3C9789D7-43AB-03DC-65E9-0E027AA37D06}"/>
              </a:ext>
            </a:extLst>
          </p:cNvPr>
          <p:cNvSpPr/>
          <p:nvPr/>
        </p:nvSpPr>
        <p:spPr>
          <a:xfrm>
            <a:off x="1755806" y="4988075"/>
            <a:ext cx="144000" cy="144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Oval 463">
            <a:extLst>
              <a:ext uri="{FF2B5EF4-FFF2-40B4-BE49-F238E27FC236}">
                <a16:creationId xmlns:a16="http://schemas.microsoft.com/office/drawing/2014/main" id="{326AACBE-109A-088B-FDE2-E86088D9C523}"/>
              </a:ext>
            </a:extLst>
          </p:cNvPr>
          <p:cNvSpPr/>
          <p:nvPr/>
        </p:nvSpPr>
        <p:spPr>
          <a:xfrm>
            <a:off x="1973338" y="5225744"/>
            <a:ext cx="144000" cy="144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5" name="Oval 464">
            <a:extLst>
              <a:ext uri="{FF2B5EF4-FFF2-40B4-BE49-F238E27FC236}">
                <a16:creationId xmlns:a16="http://schemas.microsoft.com/office/drawing/2014/main" id="{4C428F67-3479-6F24-681F-EC70CFBF51E2}"/>
              </a:ext>
            </a:extLst>
          </p:cNvPr>
          <p:cNvSpPr/>
          <p:nvPr/>
        </p:nvSpPr>
        <p:spPr>
          <a:xfrm>
            <a:off x="1493262" y="5544868"/>
            <a:ext cx="144000" cy="144000"/>
          </a:xfrm>
          <a:prstGeom prst="ellipse">
            <a:avLst/>
          </a:prstGeom>
          <a:solidFill>
            <a:schemeClr val="bg1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466" name="Oval 465">
            <a:extLst>
              <a:ext uri="{FF2B5EF4-FFF2-40B4-BE49-F238E27FC236}">
                <a16:creationId xmlns:a16="http://schemas.microsoft.com/office/drawing/2014/main" id="{3E290EDE-8417-CFB5-A75A-F4B7D685A2AE}"/>
              </a:ext>
            </a:extLst>
          </p:cNvPr>
          <p:cNvSpPr/>
          <p:nvPr/>
        </p:nvSpPr>
        <p:spPr>
          <a:xfrm>
            <a:off x="1974010" y="5536021"/>
            <a:ext cx="144000" cy="144000"/>
          </a:xfrm>
          <a:prstGeom prst="ellipse">
            <a:avLst/>
          </a:prstGeom>
          <a:solidFill>
            <a:schemeClr val="bg1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cxnSp>
        <p:nvCxnSpPr>
          <p:cNvPr id="467" name="Straight Arrow Connector 466">
            <a:extLst>
              <a:ext uri="{FF2B5EF4-FFF2-40B4-BE49-F238E27FC236}">
                <a16:creationId xmlns:a16="http://schemas.microsoft.com/office/drawing/2014/main" id="{0F9A144F-4A64-FAAF-F03E-970D02BD0E1B}"/>
              </a:ext>
            </a:extLst>
          </p:cNvPr>
          <p:cNvCxnSpPr>
            <a:stCxn id="459" idx="4"/>
            <a:endCxn id="460" idx="0"/>
          </p:cNvCxnSpPr>
          <p:nvPr/>
        </p:nvCxnSpPr>
        <p:spPr>
          <a:xfrm>
            <a:off x="1539848" y="4792197"/>
            <a:ext cx="29291" cy="444879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8" name="Straight Arrow Connector 467">
            <a:extLst>
              <a:ext uri="{FF2B5EF4-FFF2-40B4-BE49-F238E27FC236}">
                <a16:creationId xmlns:a16="http://schemas.microsoft.com/office/drawing/2014/main" id="{AACBBA54-4413-1290-5506-D19152EBF240}"/>
              </a:ext>
            </a:extLst>
          </p:cNvPr>
          <p:cNvCxnSpPr>
            <a:cxnSpLocks/>
            <a:stCxn id="459" idx="5"/>
            <a:endCxn id="463" idx="1"/>
          </p:cNvCxnSpPr>
          <p:nvPr/>
        </p:nvCxnSpPr>
        <p:spPr>
          <a:xfrm>
            <a:off x="1590760" y="4771109"/>
            <a:ext cx="186134" cy="238054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9" name="Straight Arrow Connector 468">
            <a:extLst>
              <a:ext uri="{FF2B5EF4-FFF2-40B4-BE49-F238E27FC236}">
                <a16:creationId xmlns:a16="http://schemas.microsoft.com/office/drawing/2014/main" id="{5F47632C-8EF2-8164-317F-8E1957AEE450}"/>
              </a:ext>
            </a:extLst>
          </p:cNvPr>
          <p:cNvCxnSpPr>
            <a:cxnSpLocks/>
            <a:stCxn id="459" idx="6"/>
            <a:endCxn id="461" idx="1"/>
          </p:cNvCxnSpPr>
          <p:nvPr/>
        </p:nvCxnSpPr>
        <p:spPr>
          <a:xfrm>
            <a:off x="1611848" y="4720197"/>
            <a:ext cx="173318" cy="112663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Straight Arrow Connector 469">
            <a:extLst>
              <a:ext uri="{FF2B5EF4-FFF2-40B4-BE49-F238E27FC236}">
                <a16:creationId xmlns:a16="http://schemas.microsoft.com/office/drawing/2014/main" id="{2B34E74A-E520-186E-706F-B389E7DD327C}"/>
              </a:ext>
            </a:extLst>
          </p:cNvPr>
          <p:cNvCxnSpPr>
            <a:cxnSpLocks/>
            <a:stCxn id="461" idx="5"/>
            <a:endCxn id="464" idx="0"/>
          </p:cNvCxnSpPr>
          <p:nvPr/>
        </p:nvCxnSpPr>
        <p:spPr>
          <a:xfrm>
            <a:off x="1886990" y="4934684"/>
            <a:ext cx="158348" cy="291060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Straight Arrow Connector 470">
            <a:extLst>
              <a:ext uri="{FF2B5EF4-FFF2-40B4-BE49-F238E27FC236}">
                <a16:creationId xmlns:a16="http://schemas.microsoft.com/office/drawing/2014/main" id="{97EDF550-3B21-2042-06B7-74BCFD4ADC17}"/>
              </a:ext>
            </a:extLst>
          </p:cNvPr>
          <p:cNvCxnSpPr>
            <a:cxnSpLocks/>
            <a:stCxn id="460" idx="6"/>
            <a:endCxn id="464" idx="2"/>
          </p:cNvCxnSpPr>
          <p:nvPr/>
        </p:nvCxnSpPr>
        <p:spPr>
          <a:xfrm flipV="1">
            <a:off x="1641139" y="5297744"/>
            <a:ext cx="332199" cy="11332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2" name="Straight Arrow Connector 471">
            <a:extLst>
              <a:ext uri="{FF2B5EF4-FFF2-40B4-BE49-F238E27FC236}">
                <a16:creationId xmlns:a16="http://schemas.microsoft.com/office/drawing/2014/main" id="{E8CF995D-B58E-9152-90B1-83E96BB4D940}"/>
              </a:ext>
            </a:extLst>
          </p:cNvPr>
          <p:cNvCxnSpPr>
            <a:cxnSpLocks/>
            <a:stCxn id="460" idx="7"/>
            <a:endCxn id="463" idx="3"/>
          </p:cNvCxnSpPr>
          <p:nvPr/>
        </p:nvCxnSpPr>
        <p:spPr>
          <a:xfrm flipV="1">
            <a:off x="1620051" y="5110987"/>
            <a:ext cx="156843" cy="147177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3" name="Straight Arrow Connector 472">
            <a:extLst>
              <a:ext uri="{FF2B5EF4-FFF2-40B4-BE49-F238E27FC236}">
                <a16:creationId xmlns:a16="http://schemas.microsoft.com/office/drawing/2014/main" id="{32B5450C-4ADF-B865-68FC-17E0422C11F0}"/>
              </a:ext>
            </a:extLst>
          </p:cNvPr>
          <p:cNvCxnSpPr>
            <a:cxnSpLocks/>
            <a:stCxn id="463" idx="5"/>
            <a:endCxn id="464" idx="1"/>
          </p:cNvCxnSpPr>
          <p:nvPr/>
        </p:nvCxnSpPr>
        <p:spPr>
          <a:xfrm>
            <a:off x="1878718" y="5110987"/>
            <a:ext cx="115708" cy="135845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4" name="Straight Arrow Connector 473">
            <a:extLst>
              <a:ext uri="{FF2B5EF4-FFF2-40B4-BE49-F238E27FC236}">
                <a16:creationId xmlns:a16="http://schemas.microsoft.com/office/drawing/2014/main" id="{5FB671EE-481B-D42A-45E3-66A33DC7ACD0}"/>
              </a:ext>
            </a:extLst>
          </p:cNvPr>
          <p:cNvCxnSpPr>
            <a:cxnSpLocks/>
            <a:stCxn id="462" idx="4"/>
            <a:endCxn id="464" idx="0"/>
          </p:cNvCxnSpPr>
          <p:nvPr/>
        </p:nvCxnSpPr>
        <p:spPr>
          <a:xfrm>
            <a:off x="2045338" y="4792197"/>
            <a:ext cx="0" cy="433547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5" name="Straight Arrow Connector 474">
            <a:extLst>
              <a:ext uri="{FF2B5EF4-FFF2-40B4-BE49-F238E27FC236}">
                <a16:creationId xmlns:a16="http://schemas.microsoft.com/office/drawing/2014/main" id="{764BE1C6-26C4-3334-4214-361F471552DE}"/>
              </a:ext>
            </a:extLst>
          </p:cNvPr>
          <p:cNvCxnSpPr>
            <a:cxnSpLocks/>
            <a:stCxn id="464" idx="4"/>
            <a:endCxn id="466" idx="0"/>
          </p:cNvCxnSpPr>
          <p:nvPr/>
        </p:nvCxnSpPr>
        <p:spPr>
          <a:xfrm>
            <a:off x="2045338" y="5369744"/>
            <a:ext cx="672" cy="166277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6" name="Straight Arrow Connector 475">
            <a:extLst>
              <a:ext uri="{FF2B5EF4-FFF2-40B4-BE49-F238E27FC236}">
                <a16:creationId xmlns:a16="http://schemas.microsoft.com/office/drawing/2014/main" id="{48D43ADA-F4D1-81B5-DAD7-6045193B4F2D}"/>
              </a:ext>
            </a:extLst>
          </p:cNvPr>
          <p:cNvCxnSpPr>
            <a:cxnSpLocks/>
            <a:stCxn id="460" idx="4"/>
            <a:endCxn id="465" idx="0"/>
          </p:cNvCxnSpPr>
          <p:nvPr/>
        </p:nvCxnSpPr>
        <p:spPr>
          <a:xfrm flipH="1">
            <a:off x="1565262" y="5381076"/>
            <a:ext cx="3877" cy="163792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7" name="Straight Arrow Connector 476">
            <a:extLst>
              <a:ext uri="{FF2B5EF4-FFF2-40B4-BE49-F238E27FC236}">
                <a16:creationId xmlns:a16="http://schemas.microsoft.com/office/drawing/2014/main" id="{946F2CA9-3F9E-4B18-39FB-D34E1F99F26D}"/>
              </a:ext>
            </a:extLst>
          </p:cNvPr>
          <p:cNvCxnSpPr>
            <a:cxnSpLocks/>
            <a:stCxn id="465" idx="6"/>
            <a:endCxn id="466" idx="2"/>
          </p:cNvCxnSpPr>
          <p:nvPr/>
        </p:nvCxnSpPr>
        <p:spPr>
          <a:xfrm flipV="1">
            <a:off x="1637262" y="5608021"/>
            <a:ext cx="336748" cy="8847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8" name="Straight Arrow Connector 477">
            <a:extLst>
              <a:ext uri="{FF2B5EF4-FFF2-40B4-BE49-F238E27FC236}">
                <a16:creationId xmlns:a16="http://schemas.microsoft.com/office/drawing/2014/main" id="{2CE08694-735C-8F12-D603-592B88B179CD}"/>
              </a:ext>
            </a:extLst>
          </p:cNvPr>
          <p:cNvCxnSpPr>
            <a:cxnSpLocks/>
            <a:stCxn id="462" idx="2"/>
            <a:endCxn id="461" idx="7"/>
          </p:cNvCxnSpPr>
          <p:nvPr/>
        </p:nvCxnSpPr>
        <p:spPr>
          <a:xfrm flipH="1">
            <a:off x="1886990" y="4720198"/>
            <a:ext cx="86348" cy="112663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9" name="Oval 478">
            <a:extLst>
              <a:ext uri="{FF2B5EF4-FFF2-40B4-BE49-F238E27FC236}">
                <a16:creationId xmlns:a16="http://schemas.microsoft.com/office/drawing/2014/main" id="{1002AA34-72B3-AB53-3F08-9F1825AEADDB}"/>
              </a:ext>
            </a:extLst>
          </p:cNvPr>
          <p:cNvSpPr/>
          <p:nvPr/>
        </p:nvSpPr>
        <p:spPr>
          <a:xfrm>
            <a:off x="1300337" y="5235712"/>
            <a:ext cx="144000" cy="144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0" name="Straight Arrow Connector 479">
            <a:extLst>
              <a:ext uri="{FF2B5EF4-FFF2-40B4-BE49-F238E27FC236}">
                <a16:creationId xmlns:a16="http://schemas.microsoft.com/office/drawing/2014/main" id="{A8F93070-FCC5-ADC7-6C33-F3D1F0440690}"/>
              </a:ext>
            </a:extLst>
          </p:cNvPr>
          <p:cNvCxnSpPr>
            <a:cxnSpLocks/>
            <a:stCxn id="459" idx="4"/>
            <a:endCxn id="479" idx="0"/>
          </p:cNvCxnSpPr>
          <p:nvPr/>
        </p:nvCxnSpPr>
        <p:spPr>
          <a:xfrm flipH="1">
            <a:off x="1372337" y="4792197"/>
            <a:ext cx="167511" cy="443515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1" name="Oval 480">
            <a:extLst>
              <a:ext uri="{FF2B5EF4-FFF2-40B4-BE49-F238E27FC236}">
                <a16:creationId xmlns:a16="http://schemas.microsoft.com/office/drawing/2014/main" id="{061779C3-FBB6-7971-E91C-C90DBBC9C80F}"/>
              </a:ext>
            </a:extLst>
          </p:cNvPr>
          <p:cNvSpPr/>
          <p:nvPr/>
        </p:nvSpPr>
        <p:spPr>
          <a:xfrm>
            <a:off x="2514151" y="4630309"/>
            <a:ext cx="144000" cy="144000"/>
          </a:xfrm>
          <a:prstGeom prst="ellipse">
            <a:avLst/>
          </a:prstGeom>
          <a:solidFill>
            <a:srgbClr val="CC66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Oval 481">
            <a:extLst>
              <a:ext uri="{FF2B5EF4-FFF2-40B4-BE49-F238E27FC236}">
                <a16:creationId xmlns:a16="http://schemas.microsoft.com/office/drawing/2014/main" id="{C64FC2E6-8178-66C3-9FC1-5DFB9B4B05A9}"/>
              </a:ext>
            </a:extLst>
          </p:cNvPr>
          <p:cNvSpPr/>
          <p:nvPr/>
        </p:nvSpPr>
        <p:spPr>
          <a:xfrm>
            <a:off x="2543442" y="5219188"/>
            <a:ext cx="144000" cy="144000"/>
          </a:xfrm>
          <a:prstGeom prst="ellipse">
            <a:avLst/>
          </a:prstGeom>
          <a:solidFill>
            <a:schemeClr val="accent2">
              <a:lumMod val="75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3" name="Oval 482">
            <a:extLst>
              <a:ext uri="{FF2B5EF4-FFF2-40B4-BE49-F238E27FC236}">
                <a16:creationId xmlns:a16="http://schemas.microsoft.com/office/drawing/2014/main" id="{66B4A391-EFD0-D50E-CA03-CE3A0E50B55A}"/>
              </a:ext>
            </a:extLst>
          </p:cNvPr>
          <p:cNvSpPr/>
          <p:nvPr/>
        </p:nvSpPr>
        <p:spPr>
          <a:xfrm>
            <a:off x="2810381" y="4793884"/>
            <a:ext cx="144000" cy="144000"/>
          </a:xfrm>
          <a:prstGeom prst="ellipse">
            <a:avLst/>
          </a:prstGeom>
          <a:solidFill>
            <a:schemeClr val="accent2">
              <a:lumMod val="75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Oval 483">
            <a:extLst>
              <a:ext uri="{FF2B5EF4-FFF2-40B4-BE49-F238E27FC236}">
                <a16:creationId xmlns:a16="http://schemas.microsoft.com/office/drawing/2014/main" id="{99E58DA2-32C9-1724-8FCE-CE6B8CC45B6C}"/>
              </a:ext>
            </a:extLst>
          </p:cNvPr>
          <p:cNvSpPr/>
          <p:nvPr/>
        </p:nvSpPr>
        <p:spPr>
          <a:xfrm>
            <a:off x="3019641" y="4630309"/>
            <a:ext cx="144000" cy="144000"/>
          </a:xfrm>
          <a:prstGeom prst="ellipse">
            <a:avLst/>
          </a:prstGeom>
          <a:solidFill>
            <a:srgbClr val="CC66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Oval 484">
            <a:extLst>
              <a:ext uri="{FF2B5EF4-FFF2-40B4-BE49-F238E27FC236}">
                <a16:creationId xmlns:a16="http://schemas.microsoft.com/office/drawing/2014/main" id="{787A34E2-BBD5-E33B-4837-59C1AFA65A9F}"/>
              </a:ext>
            </a:extLst>
          </p:cNvPr>
          <p:cNvSpPr/>
          <p:nvPr/>
        </p:nvSpPr>
        <p:spPr>
          <a:xfrm>
            <a:off x="2802109" y="4970187"/>
            <a:ext cx="144000" cy="144000"/>
          </a:xfrm>
          <a:prstGeom prst="ellipse">
            <a:avLst/>
          </a:prstGeom>
          <a:solidFill>
            <a:schemeClr val="accent2">
              <a:lumMod val="75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Oval 485">
            <a:extLst>
              <a:ext uri="{FF2B5EF4-FFF2-40B4-BE49-F238E27FC236}">
                <a16:creationId xmlns:a16="http://schemas.microsoft.com/office/drawing/2014/main" id="{F180806E-93A2-7D4B-DE0C-F61782AB8774}"/>
              </a:ext>
            </a:extLst>
          </p:cNvPr>
          <p:cNvSpPr/>
          <p:nvPr/>
        </p:nvSpPr>
        <p:spPr>
          <a:xfrm>
            <a:off x="3007432" y="5219717"/>
            <a:ext cx="144000" cy="144000"/>
          </a:xfrm>
          <a:prstGeom prst="ellipse">
            <a:avLst/>
          </a:prstGeom>
          <a:solidFill>
            <a:schemeClr val="accent2">
              <a:lumMod val="75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7" name="Oval 486">
            <a:extLst>
              <a:ext uri="{FF2B5EF4-FFF2-40B4-BE49-F238E27FC236}">
                <a16:creationId xmlns:a16="http://schemas.microsoft.com/office/drawing/2014/main" id="{B524FCE4-ECC8-25DA-BF0B-E0D4BFFED5F7}"/>
              </a:ext>
            </a:extLst>
          </p:cNvPr>
          <p:cNvSpPr/>
          <p:nvPr/>
        </p:nvSpPr>
        <p:spPr>
          <a:xfrm>
            <a:off x="2540626" y="5507334"/>
            <a:ext cx="144000" cy="144000"/>
          </a:xfrm>
          <a:prstGeom prst="ellipse">
            <a:avLst/>
          </a:prstGeom>
          <a:solidFill>
            <a:srgbClr val="EFAAFF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488" name="Oval 487">
            <a:extLst>
              <a:ext uri="{FF2B5EF4-FFF2-40B4-BE49-F238E27FC236}">
                <a16:creationId xmlns:a16="http://schemas.microsoft.com/office/drawing/2014/main" id="{A88FD0FC-1801-6D1A-4A0E-85C31A945634}"/>
              </a:ext>
            </a:extLst>
          </p:cNvPr>
          <p:cNvSpPr/>
          <p:nvPr/>
        </p:nvSpPr>
        <p:spPr>
          <a:xfrm>
            <a:off x="3010787" y="5509632"/>
            <a:ext cx="144000" cy="144000"/>
          </a:xfrm>
          <a:prstGeom prst="ellipse">
            <a:avLst/>
          </a:prstGeom>
          <a:solidFill>
            <a:srgbClr val="EFAAFF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cxnSp>
        <p:nvCxnSpPr>
          <p:cNvPr id="489" name="Straight Arrow Connector 488">
            <a:extLst>
              <a:ext uri="{FF2B5EF4-FFF2-40B4-BE49-F238E27FC236}">
                <a16:creationId xmlns:a16="http://schemas.microsoft.com/office/drawing/2014/main" id="{87C6C8D8-549E-C0BE-D07F-9E208F8D80C8}"/>
              </a:ext>
            </a:extLst>
          </p:cNvPr>
          <p:cNvCxnSpPr>
            <a:stCxn id="481" idx="4"/>
            <a:endCxn id="482" idx="0"/>
          </p:cNvCxnSpPr>
          <p:nvPr/>
        </p:nvCxnSpPr>
        <p:spPr>
          <a:xfrm>
            <a:off x="2586151" y="4774309"/>
            <a:ext cx="29291" cy="444879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0" name="Straight Arrow Connector 489">
            <a:extLst>
              <a:ext uri="{FF2B5EF4-FFF2-40B4-BE49-F238E27FC236}">
                <a16:creationId xmlns:a16="http://schemas.microsoft.com/office/drawing/2014/main" id="{01EB8246-6EE9-8F06-7B41-BA360C6483AB}"/>
              </a:ext>
            </a:extLst>
          </p:cNvPr>
          <p:cNvCxnSpPr>
            <a:cxnSpLocks/>
            <a:stCxn id="481" idx="5"/>
            <a:endCxn id="485" idx="1"/>
          </p:cNvCxnSpPr>
          <p:nvPr/>
        </p:nvCxnSpPr>
        <p:spPr>
          <a:xfrm>
            <a:off x="2637063" y="4753221"/>
            <a:ext cx="186134" cy="238054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1" name="Straight Arrow Connector 490">
            <a:extLst>
              <a:ext uri="{FF2B5EF4-FFF2-40B4-BE49-F238E27FC236}">
                <a16:creationId xmlns:a16="http://schemas.microsoft.com/office/drawing/2014/main" id="{50E73FFA-B74D-9708-8771-127D0CECD50C}"/>
              </a:ext>
            </a:extLst>
          </p:cNvPr>
          <p:cNvCxnSpPr>
            <a:cxnSpLocks/>
            <a:stCxn id="481" idx="6"/>
            <a:endCxn id="483" idx="1"/>
          </p:cNvCxnSpPr>
          <p:nvPr/>
        </p:nvCxnSpPr>
        <p:spPr>
          <a:xfrm>
            <a:off x="2658151" y="4702309"/>
            <a:ext cx="173318" cy="112663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2" name="Straight Arrow Connector 491">
            <a:extLst>
              <a:ext uri="{FF2B5EF4-FFF2-40B4-BE49-F238E27FC236}">
                <a16:creationId xmlns:a16="http://schemas.microsoft.com/office/drawing/2014/main" id="{132396F8-22FE-3BF4-5BA9-101D06E173DF}"/>
              </a:ext>
            </a:extLst>
          </p:cNvPr>
          <p:cNvCxnSpPr>
            <a:cxnSpLocks/>
            <a:stCxn id="483" idx="5"/>
            <a:endCxn id="486" idx="0"/>
          </p:cNvCxnSpPr>
          <p:nvPr/>
        </p:nvCxnSpPr>
        <p:spPr>
          <a:xfrm>
            <a:off x="2933293" y="4916796"/>
            <a:ext cx="146139" cy="302921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Straight Arrow Connector 492">
            <a:extLst>
              <a:ext uri="{FF2B5EF4-FFF2-40B4-BE49-F238E27FC236}">
                <a16:creationId xmlns:a16="http://schemas.microsoft.com/office/drawing/2014/main" id="{A0914811-4FA7-2C10-AF46-07C611125D1B}"/>
              </a:ext>
            </a:extLst>
          </p:cNvPr>
          <p:cNvCxnSpPr>
            <a:cxnSpLocks/>
            <a:stCxn id="482" idx="6"/>
            <a:endCxn id="486" idx="2"/>
          </p:cNvCxnSpPr>
          <p:nvPr/>
        </p:nvCxnSpPr>
        <p:spPr>
          <a:xfrm>
            <a:off x="2687442" y="5291188"/>
            <a:ext cx="319990" cy="529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4" name="Straight Arrow Connector 493">
            <a:extLst>
              <a:ext uri="{FF2B5EF4-FFF2-40B4-BE49-F238E27FC236}">
                <a16:creationId xmlns:a16="http://schemas.microsoft.com/office/drawing/2014/main" id="{DC1FCECA-8AB9-842B-C832-1C514D0CCAFB}"/>
              </a:ext>
            </a:extLst>
          </p:cNvPr>
          <p:cNvCxnSpPr>
            <a:cxnSpLocks/>
            <a:stCxn id="482" idx="7"/>
            <a:endCxn id="485" idx="3"/>
          </p:cNvCxnSpPr>
          <p:nvPr/>
        </p:nvCxnSpPr>
        <p:spPr>
          <a:xfrm flipV="1">
            <a:off x="2666354" y="5093099"/>
            <a:ext cx="156843" cy="147177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Straight Arrow Connector 494">
            <a:extLst>
              <a:ext uri="{FF2B5EF4-FFF2-40B4-BE49-F238E27FC236}">
                <a16:creationId xmlns:a16="http://schemas.microsoft.com/office/drawing/2014/main" id="{19222142-181D-5D4C-9825-F150CCE866BC}"/>
              </a:ext>
            </a:extLst>
          </p:cNvPr>
          <p:cNvCxnSpPr>
            <a:cxnSpLocks/>
            <a:stCxn id="485" idx="5"/>
            <a:endCxn id="486" idx="1"/>
          </p:cNvCxnSpPr>
          <p:nvPr/>
        </p:nvCxnSpPr>
        <p:spPr>
          <a:xfrm>
            <a:off x="2925021" y="5093099"/>
            <a:ext cx="103499" cy="147706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6" name="Straight Arrow Connector 495">
            <a:extLst>
              <a:ext uri="{FF2B5EF4-FFF2-40B4-BE49-F238E27FC236}">
                <a16:creationId xmlns:a16="http://schemas.microsoft.com/office/drawing/2014/main" id="{29D2DDB6-9F74-6C45-069C-1E6E212CD484}"/>
              </a:ext>
            </a:extLst>
          </p:cNvPr>
          <p:cNvCxnSpPr>
            <a:cxnSpLocks/>
            <a:stCxn id="484" idx="4"/>
            <a:endCxn id="486" idx="0"/>
          </p:cNvCxnSpPr>
          <p:nvPr/>
        </p:nvCxnSpPr>
        <p:spPr>
          <a:xfrm flipH="1">
            <a:off x="3079432" y="4774309"/>
            <a:ext cx="12209" cy="445408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Straight Arrow Connector 496">
            <a:extLst>
              <a:ext uri="{FF2B5EF4-FFF2-40B4-BE49-F238E27FC236}">
                <a16:creationId xmlns:a16="http://schemas.microsoft.com/office/drawing/2014/main" id="{7C29E027-9517-B3DA-A9BB-AB8E0168C185}"/>
              </a:ext>
            </a:extLst>
          </p:cNvPr>
          <p:cNvCxnSpPr>
            <a:cxnSpLocks/>
            <a:stCxn id="486" idx="4"/>
            <a:endCxn id="488" idx="0"/>
          </p:cNvCxnSpPr>
          <p:nvPr/>
        </p:nvCxnSpPr>
        <p:spPr>
          <a:xfrm>
            <a:off x="3079432" y="5363717"/>
            <a:ext cx="3355" cy="145915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8" name="Straight Arrow Connector 497">
            <a:extLst>
              <a:ext uri="{FF2B5EF4-FFF2-40B4-BE49-F238E27FC236}">
                <a16:creationId xmlns:a16="http://schemas.microsoft.com/office/drawing/2014/main" id="{68240444-3852-672C-BEF1-7EAE39154645}"/>
              </a:ext>
            </a:extLst>
          </p:cNvPr>
          <p:cNvCxnSpPr>
            <a:cxnSpLocks/>
            <a:stCxn id="482" idx="4"/>
            <a:endCxn id="487" idx="0"/>
          </p:cNvCxnSpPr>
          <p:nvPr/>
        </p:nvCxnSpPr>
        <p:spPr>
          <a:xfrm flipH="1">
            <a:off x="2612626" y="5363188"/>
            <a:ext cx="2816" cy="144146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9" name="Straight Arrow Connector 498">
            <a:extLst>
              <a:ext uri="{FF2B5EF4-FFF2-40B4-BE49-F238E27FC236}">
                <a16:creationId xmlns:a16="http://schemas.microsoft.com/office/drawing/2014/main" id="{33FC5CA4-70DA-5165-0535-F25FD1BDEDFA}"/>
              </a:ext>
            </a:extLst>
          </p:cNvPr>
          <p:cNvCxnSpPr>
            <a:cxnSpLocks/>
            <a:stCxn id="487" idx="6"/>
            <a:endCxn id="488" idx="2"/>
          </p:cNvCxnSpPr>
          <p:nvPr/>
        </p:nvCxnSpPr>
        <p:spPr>
          <a:xfrm>
            <a:off x="2684626" y="5579334"/>
            <a:ext cx="326161" cy="2298"/>
          </a:xfrm>
          <a:prstGeom prst="straightConnector1">
            <a:avLst/>
          </a:prstGeom>
          <a:ln w="635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0" name="Straight Arrow Connector 499">
            <a:extLst>
              <a:ext uri="{FF2B5EF4-FFF2-40B4-BE49-F238E27FC236}">
                <a16:creationId xmlns:a16="http://schemas.microsoft.com/office/drawing/2014/main" id="{5931A894-AC02-B7D3-A018-CC2D153F4483}"/>
              </a:ext>
            </a:extLst>
          </p:cNvPr>
          <p:cNvCxnSpPr>
            <a:cxnSpLocks/>
            <a:stCxn id="484" idx="2"/>
            <a:endCxn id="483" idx="7"/>
          </p:cNvCxnSpPr>
          <p:nvPr/>
        </p:nvCxnSpPr>
        <p:spPr>
          <a:xfrm flipH="1">
            <a:off x="2933293" y="4702310"/>
            <a:ext cx="86348" cy="112663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1" name="Oval 500">
            <a:extLst>
              <a:ext uri="{FF2B5EF4-FFF2-40B4-BE49-F238E27FC236}">
                <a16:creationId xmlns:a16="http://schemas.microsoft.com/office/drawing/2014/main" id="{D476208B-7B78-069B-59B0-C62892A0D1FE}"/>
              </a:ext>
            </a:extLst>
          </p:cNvPr>
          <p:cNvSpPr/>
          <p:nvPr/>
        </p:nvSpPr>
        <p:spPr>
          <a:xfrm>
            <a:off x="2346640" y="5217824"/>
            <a:ext cx="144000" cy="144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2" name="Straight Arrow Connector 501">
            <a:extLst>
              <a:ext uri="{FF2B5EF4-FFF2-40B4-BE49-F238E27FC236}">
                <a16:creationId xmlns:a16="http://schemas.microsoft.com/office/drawing/2014/main" id="{F7369B39-A70C-3CF0-9E42-A660ACE7C472}"/>
              </a:ext>
            </a:extLst>
          </p:cNvPr>
          <p:cNvCxnSpPr>
            <a:cxnSpLocks/>
            <a:stCxn id="481" idx="4"/>
            <a:endCxn id="501" idx="0"/>
          </p:cNvCxnSpPr>
          <p:nvPr/>
        </p:nvCxnSpPr>
        <p:spPr>
          <a:xfrm flipH="1">
            <a:off x="2418640" y="4774309"/>
            <a:ext cx="167511" cy="443515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3" name="Oval 502">
            <a:extLst>
              <a:ext uri="{FF2B5EF4-FFF2-40B4-BE49-F238E27FC236}">
                <a16:creationId xmlns:a16="http://schemas.microsoft.com/office/drawing/2014/main" id="{C946EABF-301E-1AA6-3391-F2A85B3715E3}"/>
              </a:ext>
            </a:extLst>
          </p:cNvPr>
          <p:cNvSpPr/>
          <p:nvPr/>
        </p:nvSpPr>
        <p:spPr>
          <a:xfrm>
            <a:off x="3601594" y="4624349"/>
            <a:ext cx="144000" cy="144000"/>
          </a:xfrm>
          <a:prstGeom prst="ellipse">
            <a:avLst/>
          </a:prstGeom>
          <a:solidFill>
            <a:srgbClr val="CC66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4" name="Oval 503">
            <a:extLst>
              <a:ext uri="{FF2B5EF4-FFF2-40B4-BE49-F238E27FC236}">
                <a16:creationId xmlns:a16="http://schemas.microsoft.com/office/drawing/2014/main" id="{6E5DB06A-0F03-26CD-5CB2-D7B4C52A45F0}"/>
              </a:ext>
            </a:extLst>
          </p:cNvPr>
          <p:cNvSpPr/>
          <p:nvPr/>
        </p:nvSpPr>
        <p:spPr>
          <a:xfrm>
            <a:off x="3630885" y="5213228"/>
            <a:ext cx="144000" cy="144000"/>
          </a:xfrm>
          <a:prstGeom prst="ellipse">
            <a:avLst/>
          </a:prstGeom>
          <a:solidFill>
            <a:srgbClr val="C55A11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5" name="Oval 504">
            <a:extLst>
              <a:ext uri="{FF2B5EF4-FFF2-40B4-BE49-F238E27FC236}">
                <a16:creationId xmlns:a16="http://schemas.microsoft.com/office/drawing/2014/main" id="{863032B2-98BC-3435-DF63-0084835EE100}"/>
              </a:ext>
            </a:extLst>
          </p:cNvPr>
          <p:cNvSpPr/>
          <p:nvPr/>
        </p:nvSpPr>
        <p:spPr>
          <a:xfrm>
            <a:off x="3897824" y="4787924"/>
            <a:ext cx="144000" cy="144000"/>
          </a:xfrm>
          <a:prstGeom prst="ellipse">
            <a:avLst/>
          </a:prstGeom>
          <a:solidFill>
            <a:srgbClr val="C55A11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Oval 505">
            <a:extLst>
              <a:ext uri="{FF2B5EF4-FFF2-40B4-BE49-F238E27FC236}">
                <a16:creationId xmlns:a16="http://schemas.microsoft.com/office/drawing/2014/main" id="{E3C80259-3A02-1372-183A-28362A64C3F6}"/>
              </a:ext>
            </a:extLst>
          </p:cNvPr>
          <p:cNvSpPr/>
          <p:nvPr/>
        </p:nvSpPr>
        <p:spPr>
          <a:xfrm>
            <a:off x="4107084" y="4624349"/>
            <a:ext cx="144000" cy="144000"/>
          </a:xfrm>
          <a:prstGeom prst="ellipse">
            <a:avLst/>
          </a:prstGeom>
          <a:solidFill>
            <a:srgbClr val="CC6600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Oval 506">
            <a:extLst>
              <a:ext uri="{FF2B5EF4-FFF2-40B4-BE49-F238E27FC236}">
                <a16:creationId xmlns:a16="http://schemas.microsoft.com/office/drawing/2014/main" id="{38C4F3A0-82B7-E635-1C22-D4072959BC18}"/>
              </a:ext>
            </a:extLst>
          </p:cNvPr>
          <p:cNvSpPr/>
          <p:nvPr/>
        </p:nvSpPr>
        <p:spPr>
          <a:xfrm>
            <a:off x="3889552" y="4964227"/>
            <a:ext cx="144000" cy="144000"/>
          </a:xfrm>
          <a:prstGeom prst="ellipse">
            <a:avLst/>
          </a:prstGeom>
          <a:solidFill>
            <a:srgbClr val="C55A11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Oval 507">
            <a:extLst>
              <a:ext uri="{FF2B5EF4-FFF2-40B4-BE49-F238E27FC236}">
                <a16:creationId xmlns:a16="http://schemas.microsoft.com/office/drawing/2014/main" id="{A5457B16-4EE0-7A10-C146-0AEF0EF44D38}"/>
              </a:ext>
            </a:extLst>
          </p:cNvPr>
          <p:cNvSpPr/>
          <p:nvPr/>
        </p:nvSpPr>
        <p:spPr>
          <a:xfrm>
            <a:off x="4107084" y="5201896"/>
            <a:ext cx="144000" cy="144000"/>
          </a:xfrm>
          <a:prstGeom prst="ellipse">
            <a:avLst/>
          </a:prstGeom>
          <a:solidFill>
            <a:srgbClr val="C55A11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Oval 508">
            <a:extLst>
              <a:ext uri="{FF2B5EF4-FFF2-40B4-BE49-F238E27FC236}">
                <a16:creationId xmlns:a16="http://schemas.microsoft.com/office/drawing/2014/main" id="{A8D1CEA7-8EB4-052D-8BF5-323D4ADBA567}"/>
              </a:ext>
            </a:extLst>
          </p:cNvPr>
          <p:cNvSpPr/>
          <p:nvPr/>
        </p:nvSpPr>
        <p:spPr>
          <a:xfrm>
            <a:off x="3629660" y="5501374"/>
            <a:ext cx="144000" cy="144000"/>
          </a:xfrm>
          <a:prstGeom prst="ellipse">
            <a:avLst/>
          </a:prstGeom>
          <a:solidFill>
            <a:srgbClr val="F2BAFF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sp>
        <p:nvSpPr>
          <p:cNvPr id="510" name="Oval 509">
            <a:extLst>
              <a:ext uri="{FF2B5EF4-FFF2-40B4-BE49-F238E27FC236}">
                <a16:creationId xmlns:a16="http://schemas.microsoft.com/office/drawing/2014/main" id="{DA76F77B-FE9B-E4FE-3F66-BF3FE8DF769E}"/>
              </a:ext>
            </a:extLst>
          </p:cNvPr>
          <p:cNvSpPr/>
          <p:nvPr/>
        </p:nvSpPr>
        <p:spPr>
          <a:xfrm>
            <a:off x="4107756" y="5489383"/>
            <a:ext cx="144000" cy="144000"/>
          </a:xfrm>
          <a:prstGeom prst="ellipse">
            <a:avLst/>
          </a:prstGeom>
          <a:solidFill>
            <a:srgbClr val="CE08FF"/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1" name="Straight Arrow Connector 510">
            <a:extLst>
              <a:ext uri="{FF2B5EF4-FFF2-40B4-BE49-F238E27FC236}">
                <a16:creationId xmlns:a16="http://schemas.microsoft.com/office/drawing/2014/main" id="{978CEF71-1B71-5FE3-2E6D-397B8A848A9E}"/>
              </a:ext>
            </a:extLst>
          </p:cNvPr>
          <p:cNvCxnSpPr>
            <a:stCxn id="503" idx="4"/>
            <a:endCxn id="504" idx="0"/>
          </p:cNvCxnSpPr>
          <p:nvPr/>
        </p:nvCxnSpPr>
        <p:spPr>
          <a:xfrm>
            <a:off x="3673594" y="4768349"/>
            <a:ext cx="29291" cy="444879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2" name="Straight Arrow Connector 511">
            <a:extLst>
              <a:ext uri="{FF2B5EF4-FFF2-40B4-BE49-F238E27FC236}">
                <a16:creationId xmlns:a16="http://schemas.microsoft.com/office/drawing/2014/main" id="{E3C8D656-4DA7-E3F9-10B1-2E318384191D}"/>
              </a:ext>
            </a:extLst>
          </p:cNvPr>
          <p:cNvCxnSpPr>
            <a:cxnSpLocks/>
            <a:stCxn id="503" idx="5"/>
            <a:endCxn id="507" idx="1"/>
          </p:cNvCxnSpPr>
          <p:nvPr/>
        </p:nvCxnSpPr>
        <p:spPr>
          <a:xfrm>
            <a:off x="3724506" y="4747261"/>
            <a:ext cx="186134" cy="238054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3" name="Straight Arrow Connector 512">
            <a:extLst>
              <a:ext uri="{FF2B5EF4-FFF2-40B4-BE49-F238E27FC236}">
                <a16:creationId xmlns:a16="http://schemas.microsoft.com/office/drawing/2014/main" id="{03271D42-1019-F131-92B4-8E9B8058EA5B}"/>
              </a:ext>
            </a:extLst>
          </p:cNvPr>
          <p:cNvCxnSpPr>
            <a:cxnSpLocks/>
            <a:stCxn id="503" idx="6"/>
            <a:endCxn id="505" idx="1"/>
          </p:cNvCxnSpPr>
          <p:nvPr/>
        </p:nvCxnSpPr>
        <p:spPr>
          <a:xfrm>
            <a:off x="3745594" y="4696349"/>
            <a:ext cx="173318" cy="112663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4" name="Straight Arrow Connector 513">
            <a:extLst>
              <a:ext uri="{FF2B5EF4-FFF2-40B4-BE49-F238E27FC236}">
                <a16:creationId xmlns:a16="http://schemas.microsoft.com/office/drawing/2014/main" id="{4FD6CA96-C578-5E7E-09A3-A896B4EA9295}"/>
              </a:ext>
            </a:extLst>
          </p:cNvPr>
          <p:cNvCxnSpPr>
            <a:cxnSpLocks/>
            <a:stCxn id="505" idx="5"/>
            <a:endCxn id="508" idx="0"/>
          </p:cNvCxnSpPr>
          <p:nvPr/>
        </p:nvCxnSpPr>
        <p:spPr>
          <a:xfrm>
            <a:off x="4020736" y="4910836"/>
            <a:ext cx="158348" cy="291060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5" name="Straight Arrow Connector 514">
            <a:extLst>
              <a:ext uri="{FF2B5EF4-FFF2-40B4-BE49-F238E27FC236}">
                <a16:creationId xmlns:a16="http://schemas.microsoft.com/office/drawing/2014/main" id="{4057AF31-C9D9-9A88-B184-E504472F7C5F}"/>
              </a:ext>
            </a:extLst>
          </p:cNvPr>
          <p:cNvCxnSpPr>
            <a:cxnSpLocks/>
            <a:stCxn id="504" idx="6"/>
            <a:endCxn id="508" idx="2"/>
          </p:cNvCxnSpPr>
          <p:nvPr/>
        </p:nvCxnSpPr>
        <p:spPr>
          <a:xfrm flipV="1">
            <a:off x="3774885" y="5273896"/>
            <a:ext cx="332199" cy="11332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6" name="Straight Arrow Connector 515">
            <a:extLst>
              <a:ext uri="{FF2B5EF4-FFF2-40B4-BE49-F238E27FC236}">
                <a16:creationId xmlns:a16="http://schemas.microsoft.com/office/drawing/2014/main" id="{D8E261F4-0898-1662-EB39-8403703A2CB8}"/>
              </a:ext>
            </a:extLst>
          </p:cNvPr>
          <p:cNvCxnSpPr>
            <a:cxnSpLocks/>
            <a:stCxn id="504" idx="7"/>
            <a:endCxn id="507" idx="3"/>
          </p:cNvCxnSpPr>
          <p:nvPr/>
        </p:nvCxnSpPr>
        <p:spPr>
          <a:xfrm flipV="1">
            <a:off x="3753797" y="5087139"/>
            <a:ext cx="156843" cy="147177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7" name="Straight Arrow Connector 516">
            <a:extLst>
              <a:ext uri="{FF2B5EF4-FFF2-40B4-BE49-F238E27FC236}">
                <a16:creationId xmlns:a16="http://schemas.microsoft.com/office/drawing/2014/main" id="{84B64BBA-0483-F538-1365-A18F7A31E861}"/>
              </a:ext>
            </a:extLst>
          </p:cNvPr>
          <p:cNvCxnSpPr>
            <a:cxnSpLocks/>
            <a:stCxn id="507" idx="5"/>
            <a:endCxn id="508" idx="1"/>
          </p:cNvCxnSpPr>
          <p:nvPr/>
        </p:nvCxnSpPr>
        <p:spPr>
          <a:xfrm>
            <a:off x="4012464" y="5087139"/>
            <a:ext cx="115708" cy="135845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8" name="Straight Arrow Connector 517">
            <a:extLst>
              <a:ext uri="{FF2B5EF4-FFF2-40B4-BE49-F238E27FC236}">
                <a16:creationId xmlns:a16="http://schemas.microsoft.com/office/drawing/2014/main" id="{76DE0D87-EFCA-488F-B259-1963195BE33D}"/>
              </a:ext>
            </a:extLst>
          </p:cNvPr>
          <p:cNvCxnSpPr>
            <a:cxnSpLocks/>
            <a:stCxn id="506" idx="4"/>
            <a:endCxn id="508" idx="0"/>
          </p:cNvCxnSpPr>
          <p:nvPr/>
        </p:nvCxnSpPr>
        <p:spPr>
          <a:xfrm>
            <a:off x="4179084" y="4768349"/>
            <a:ext cx="0" cy="433547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9" name="Straight Arrow Connector 518">
            <a:extLst>
              <a:ext uri="{FF2B5EF4-FFF2-40B4-BE49-F238E27FC236}">
                <a16:creationId xmlns:a16="http://schemas.microsoft.com/office/drawing/2014/main" id="{1923D351-B74E-71A1-8C5E-4F41299683F4}"/>
              </a:ext>
            </a:extLst>
          </p:cNvPr>
          <p:cNvCxnSpPr>
            <a:cxnSpLocks/>
            <a:stCxn id="508" idx="4"/>
            <a:endCxn id="510" idx="0"/>
          </p:cNvCxnSpPr>
          <p:nvPr/>
        </p:nvCxnSpPr>
        <p:spPr>
          <a:xfrm>
            <a:off x="4179084" y="5345896"/>
            <a:ext cx="672" cy="143487"/>
          </a:xfrm>
          <a:prstGeom prst="straightConnector1">
            <a:avLst/>
          </a:prstGeom>
          <a:ln w="28575">
            <a:solidFill>
              <a:srgbClr val="C55A1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0" name="Straight Arrow Connector 519">
            <a:extLst>
              <a:ext uri="{FF2B5EF4-FFF2-40B4-BE49-F238E27FC236}">
                <a16:creationId xmlns:a16="http://schemas.microsoft.com/office/drawing/2014/main" id="{87346844-78F3-8DA8-7179-3D4ABA433153}"/>
              </a:ext>
            </a:extLst>
          </p:cNvPr>
          <p:cNvCxnSpPr>
            <a:cxnSpLocks/>
            <a:stCxn id="504" idx="4"/>
            <a:endCxn id="509" idx="0"/>
          </p:cNvCxnSpPr>
          <p:nvPr/>
        </p:nvCxnSpPr>
        <p:spPr>
          <a:xfrm flipH="1">
            <a:off x="3701660" y="5357228"/>
            <a:ext cx="1225" cy="144146"/>
          </a:xfrm>
          <a:prstGeom prst="straightConnector1">
            <a:avLst/>
          </a:prstGeom>
          <a:ln w="28575">
            <a:solidFill>
              <a:srgbClr val="C55A1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1" name="Straight Arrow Connector 520">
            <a:extLst>
              <a:ext uri="{FF2B5EF4-FFF2-40B4-BE49-F238E27FC236}">
                <a16:creationId xmlns:a16="http://schemas.microsoft.com/office/drawing/2014/main" id="{AFABAFCC-CB76-6BF8-60EF-5E9C4B8DB486}"/>
              </a:ext>
            </a:extLst>
          </p:cNvPr>
          <p:cNvCxnSpPr>
            <a:cxnSpLocks/>
            <a:stCxn id="509" idx="6"/>
            <a:endCxn id="510" idx="2"/>
          </p:cNvCxnSpPr>
          <p:nvPr/>
        </p:nvCxnSpPr>
        <p:spPr>
          <a:xfrm flipV="1">
            <a:off x="3773660" y="5561383"/>
            <a:ext cx="334096" cy="11991"/>
          </a:xfrm>
          <a:prstGeom prst="straightConnector1">
            <a:avLst/>
          </a:prstGeom>
          <a:ln w="28575">
            <a:solidFill>
              <a:srgbClr val="FFC0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2" name="TextBox 521">
            <a:extLst>
              <a:ext uri="{FF2B5EF4-FFF2-40B4-BE49-F238E27FC236}">
                <a16:creationId xmlns:a16="http://schemas.microsoft.com/office/drawing/2014/main" id="{0063D9CE-ACAF-17CA-B3C5-1AD0F9CF4EAA}"/>
              </a:ext>
            </a:extLst>
          </p:cNvPr>
          <p:cNvSpPr txBox="1"/>
          <p:nvPr/>
        </p:nvSpPr>
        <p:spPr>
          <a:xfrm>
            <a:off x="4051493" y="5471287"/>
            <a:ext cx="26161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500" b="1" dirty="0">
                <a:latin typeface="Arial" panose="020B0604020202020204" pitchFamily="34" charset="0"/>
                <a:cs typeface="Arial" panose="020B0604020202020204" pitchFamily="34" charset="0"/>
              </a:rPr>
              <a:t>TF</a:t>
            </a:r>
          </a:p>
        </p:txBody>
      </p:sp>
      <p:cxnSp>
        <p:nvCxnSpPr>
          <p:cNvPr id="523" name="Straight Arrow Connector 522">
            <a:extLst>
              <a:ext uri="{FF2B5EF4-FFF2-40B4-BE49-F238E27FC236}">
                <a16:creationId xmlns:a16="http://schemas.microsoft.com/office/drawing/2014/main" id="{668A4A12-C5BD-80E9-8B21-484BAE61B502}"/>
              </a:ext>
            </a:extLst>
          </p:cNvPr>
          <p:cNvCxnSpPr>
            <a:cxnSpLocks/>
            <a:stCxn id="506" idx="2"/>
            <a:endCxn id="505" idx="7"/>
          </p:cNvCxnSpPr>
          <p:nvPr/>
        </p:nvCxnSpPr>
        <p:spPr>
          <a:xfrm flipH="1">
            <a:off x="4020736" y="4696350"/>
            <a:ext cx="86348" cy="112663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4" name="Oval 523">
            <a:extLst>
              <a:ext uri="{FF2B5EF4-FFF2-40B4-BE49-F238E27FC236}">
                <a16:creationId xmlns:a16="http://schemas.microsoft.com/office/drawing/2014/main" id="{8DC84C26-774E-5A65-8B21-003DDA4A2B2F}"/>
              </a:ext>
            </a:extLst>
          </p:cNvPr>
          <p:cNvSpPr/>
          <p:nvPr/>
        </p:nvSpPr>
        <p:spPr>
          <a:xfrm>
            <a:off x="3434083" y="5211864"/>
            <a:ext cx="144000" cy="144000"/>
          </a:xfrm>
          <a:prstGeom prst="ellipse">
            <a:avLst/>
          </a:prstGeom>
          <a:solidFill>
            <a:schemeClr val="accent2">
              <a:lumMod val="40000"/>
              <a:lumOff val="60000"/>
            </a:schemeClr>
          </a:solidFill>
          <a:ln w="6350">
            <a:solidFill>
              <a:schemeClr val="tx1"/>
            </a:solidFill>
            <a:tailEnd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5" name="Straight Arrow Connector 524">
            <a:extLst>
              <a:ext uri="{FF2B5EF4-FFF2-40B4-BE49-F238E27FC236}">
                <a16:creationId xmlns:a16="http://schemas.microsoft.com/office/drawing/2014/main" id="{A504D199-F06A-40D6-332A-DDEB95C9863F}"/>
              </a:ext>
            </a:extLst>
          </p:cNvPr>
          <p:cNvCxnSpPr>
            <a:cxnSpLocks/>
            <a:stCxn id="503" idx="4"/>
            <a:endCxn id="524" idx="0"/>
          </p:cNvCxnSpPr>
          <p:nvPr/>
        </p:nvCxnSpPr>
        <p:spPr>
          <a:xfrm flipH="1">
            <a:off x="3506083" y="4768349"/>
            <a:ext cx="167511" cy="443515"/>
          </a:xfrm>
          <a:prstGeom prst="straightConnector1">
            <a:avLst/>
          </a:prstGeom>
          <a:ln w="28575">
            <a:solidFill>
              <a:srgbClr val="CC6600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06672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5</Words>
  <Application>Microsoft Office PowerPoint</Application>
  <PresentationFormat>A4 Paper (210x297 mm)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dos, Dezso</dc:creator>
  <cp:lastModifiedBy>Modos, Dezso</cp:lastModifiedBy>
  <cp:revision>1</cp:revision>
  <dcterms:created xsi:type="dcterms:W3CDTF">2025-10-22T18:07:40Z</dcterms:created>
  <dcterms:modified xsi:type="dcterms:W3CDTF">2025-10-22T18:08:57Z</dcterms:modified>
</cp:coreProperties>
</file>